
<file path=[Content_Types].xml><?xml version="1.0" encoding="utf-8"?>
<Types xmlns="http://schemas.openxmlformats.org/package/2006/content-types">
  <Default Extension="xml" ContentType="application/xml"/>
  <Default Extension="svg" ContentType="image/svg+xml"/>
  <Default Extension="JPG" ContentType="image/jpeg"/>
  <Default Extension="jpeg" ContentType="image/jpeg"/>
  <Default Extension="emf" ContentType="image/x-emf"/>
  <Default Extension="rels" ContentType="application/vnd.openxmlformats-package.relationships+xml"/>
  <Default Extension="tif" ContentType="image/tiff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notesSlides/notesSlide1.xml" ContentType="application/vnd.openxmlformats-officedocument.presentationml.notesSlid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notesSlides/notesSlide2.xml" ContentType="application/vnd.openxmlformats-officedocument.presentationml.notesSlide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11"/>
  </p:notesMasterIdLst>
  <p:sldIdLst>
    <p:sldId id="258" r:id="rId2"/>
    <p:sldId id="261" r:id="rId3"/>
    <p:sldId id="263" r:id="rId4"/>
    <p:sldId id="264" r:id="rId5"/>
    <p:sldId id="265" r:id="rId6"/>
    <p:sldId id="266" r:id="rId7"/>
    <p:sldId id="262" r:id="rId8"/>
    <p:sldId id="260" r:id="rId9"/>
    <p:sldId id="259" r:id="rId10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512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634"/>
    <p:restoredTop sz="96005"/>
  </p:normalViewPr>
  <p:slideViewPr>
    <p:cSldViewPr snapToGrid="0" snapToObjects="1">
      <p:cViewPr>
        <p:scale>
          <a:sx n="54" d="100"/>
          <a:sy n="54" d="100"/>
        </p:scale>
        <p:origin x="-1840" y="-80"/>
      </p:cViewPr>
      <p:guideLst>
        <p:guide orient="horz" pos="512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notesMaster" Target="notesMasters/notesMaster1.xml"/><Relationship Id="rId12" Type="http://schemas.openxmlformats.org/officeDocument/2006/relationships/printerSettings" Target="printerSettings/printerSettings1.bin"/><Relationship Id="rId13" Type="http://schemas.openxmlformats.org/officeDocument/2006/relationships/presProps" Target="presProps.xml"/><Relationship Id="rId14" Type="http://schemas.openxmlformats.org/officeDocument/2006/relationships/viewProps" Target="viewProps.xml"/><Relationship Id="rId15" Type="http://schemas.openxmlformats.org/officeDocument/2006/relationships/theme" Target="theme/them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file:///D:\CELL%20BIOLOGY\A549\A549%20cell%20Growth%20Curv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tomonobunaoko\Desktop\Karolina%20san_revise\cell%20morphology%20check\&#19977;&#22238;&#30446;&#35299;&#26512;\&#12414;&#12392;&#12417;&#26368;&#32066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tomonobunaoko\Desktop\Karolina%20san_revise\cell%20morphology%20check\&#19977;&#22238;&#30446;&#35299;&#26512;\&#12414;&#12392;&#12417;&#26368;&#32066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tomonobunaoko\Desktop\Karolina%20san_revise\cell%20morphology%20check\&#19977;&#22238;&#30446;&#35299;&#26512;\&#12414;&#12392;&#12417;&#26368;&#32066;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localhost////Users/tomonobunaoko/Desktop/Karolina%20san_revise/200301%20qPCR%20DsiSPDEF-2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localhost////Users/tomonobunaoko/Desktop/Karolina%20san_revise/200301%20qPCR%20DsiSPDEF-2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localhost////Users/tomonobunaoko/Desktop/Karolina%20san_revise/200301%20qPCR%20DsiSPDEF-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'0.1% FBS'!$B$9</c:f>
              <c:strCache>
                <c:ptCount val="1"/>
                <c:pt idx="0">
                  <c:v>A549 GFP</c:v>
                </c:pt>
              </c:strCache>
            </c:strRef>
          </c:tx>
          <c:spPr>
            <a:pattFill prst="ltUpDiag">
              <a:fgClr>
                <a:schemeClr val="tx1"/>
              </a:fgClr>
              <a:bgClr>
                <a:schemeClr val="bg1"/>
              </a:bgClr>
            </a:pattFill>
            <a:ln cap="sq">
              <a:solidFill>
                <a:schemeClr val="tx1"/>
              </a:solidFill>
              <a:miter lim="800000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0.1% FBS'!$F$3:$F$4</c:f>
                <c:numCache>
                  <c:formatCode>General</c:formatCode>
                  <c:ptCount val="2"/>
                  <c:pt idx="0">
                    <c:v>2362.907813126304</c:v>
                  </c:pt>
                  <c:pt idx="1">
                    <c:v>6139.014578904337</c:v>
                  </c:pt>
                </c:numCache>
              </c:numRef>
            </c:plus>
            <c:minus>
              <c:numRef>
                <c:f>'0.1% FBS'!$F$3:$F$4</c:f>
                <c:numCache>
                  <c:formatCode>General</c:formatCode>
                  <c:ptCount val="2"/>
                  <c:pt idx="0">
                    <c:v>2362.907813126304</c:v>
                  </c:pt>
                  <c:pt idx="1">
                    <c:v>6139.014578904337</c:v>
                  </c:pt>
                </c:numCache>
              </c:numRef>
            </c:minus>
            <c:spPr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errBars>
          <c:cat>
            <c:numRef>
              <c:f>'0.1% FBS'!$A$10:$A$11</c:f>
              <c:numCache>
                <c:formatCode>General</c:formatCode>
                <c:ptCount val="2"/>
                <c:pt idx="0">
                  <c:v>1.0</c:v>
                </c:pt>
                <c:pt idx="1">
                  <c:v>3.0</c:v>
                </c:pt>
              </c:numCache>
            </c:numRef>
          </c:cat>
          <c:val>
            <c:numRef>
              <c:f>'0.1% FBS'!$B$10:$B$11</c:f>
              <c:numCache>
                <c:formatCode>0.00</c:formatCode>
                <c:ptCount val="2"/>
                <c:pt idx="0">
                  <c:v>37166.66666666658</c:v>
                </c:pt>
                <c:pt idx="1">
                  <c:v>15750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2E0-FA4B-987E-69D3BDF5D0B5}"/>
            </c:ext>
          </c:extLst>
        </c:ser>
        <c:ser>
          <c:idx val="2"/>
          <c:order val="1"/>
          <c:tx>
            <c:strRef>
              <c:f>'0.1% FBS'!$C$9</c:f>
              <c:strCache>
                <c:ptCount val="1"/>
                <c:pt idx="0">
                  <c:v>A549 AS #1</c:v>
                </c:pt>
              </c:strCache>
            </c:strRef>
          </c:tx>
          <c:spPr>
            <a:pattFill prst="pct70">
              <a:fgClr>
                <a:schemeClr val="tx1"/>
              </a:fgClr>
              <a:bgClr>
                <a:schemeClr val="bg1"/>
              </a:bgClr>
            </a:pattFill>
            <a:ln cap="sq">
              <a:solidFill>
                <a:schemeClr val="tx1"/>
              </a:solidFill>
              <a:miter lim="800000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0.1% FBS'!$K$3:$K$4</c:f>
                <c:numCache>
                  <c:formatCode>General</c:formatCode>
                  <c:ptCount val="2"/>
                  <c:pt idx="0">
                    <c:v>5107.18448201487</c:v>
                  </c:pt>
                  <c:pt idx="1">
                    <c:v>13506.9426592401</c:v>
                  </c:pt>
                </c:numCache>
              </c:numRef>
            </c:plus>
            <c:minus>
              <c:numRef>
                <c:f>'0.1% FBS'!$K$3:$K$4</c:f>
                <c:numCache>
                  <c:formatCode>General</c:formatCode>
                  <c:ptCount val="2"/>
                  <c:pt idx="0">
                    <c:v>5107.18448201487</c:v>
                  </c:pt>
                  <c:pt idx="1">
                    <c:v>13506.9426592401</c:v>
                  </c:pt>
                </c:numCache>
              </c:numRef>
            </c:minus>
            <c:spPr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errBars>
          <c:cat>
            <c:numRef>
              <c:f>'0.1% FBS'!$A$10:$A$11</c:f>
              <c:numCache>
                <c:formatCode>General</c:formatCode>
                <c:ptCount val="2"/>
                <c:pt idx="0">
                  <c:v>1.0</c:v>
                </c:pt>
                <c:pt idx="1">
                  <c:v>3.0</c:v>
                </c:pt>
              </c:numCache>
            </c:numRef>
          </c:cat>
          <c:val>
            <c:numRef>
              <c:f>'0.1% FBS'!$C$10:$C$11</c:f>
              <c:numCache>
                <c:formatCode>0.00</c:formatCode>
                <c:ptCount val="2"/>
                <c:pt idx="0">
                  <c:v>39166.66666666658</c:v>
                </c:pt>
                <c:pt idx="1">
                  <c:v>13225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2E0-FA4B-987E-69D3BDF5D0B5}"/>
            </c:ext>
          </c:extLst>
        </c:ser>
        <c:ser>
          <c:idx val="3"/>
          <c:order val="2"/>
          <c:tx>
            <c:strRef>
              <c:f>'0.1% FBS'!$D$9</c:f>
              <c:strCache>
                <c:ptCount val="1"/>
                <c:pt idx="0">
                  <c:v>A549 AS #3</c:v>
                </c:pt>
              </c:strCache>
            </c:strRef>
          </c:tx>
          <c:spPr>
            <a:pattFill prst="pct25">
              <a:fgClr>
                <a:schemeClr val="tx1"/>
              </a:fgClr>
              <a:bgClr>
                <a:schemeClr val="bg1"/>
              </a:bgClr>
            </a:pattFill>
            <a:ln cap="sq">
              <a:solidFill>
                <a:schemeClr val="tx1"/>
              </a:solidFill>
              <a:miter lim="800000"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0.1% FBS'!$P$3:$P$4</c:f>
                <c:numCache>
                  <c:formatCode>General</c:formatCode>
                  <c:ptCount val="2"/>
                  <c:pt idx="0">
                    <c:v>3214.550253664318</c:v>
                  </c:pt>
                  <c:pt idx="1">
                    <c:v>9672.771061076558</c:v>
                  </c:pt>
                </c:numCache>
              </c:numRef>
            </c:plus>
            <c:minus>
              <c:numRef>
                <c:f>'0.1% FBS'!$P$3:$P$4</c:f>
                <c:numCache>
                  <c:formatCode>General</c:formatCode>
                  <c:ptCount val="2"/>
                  <c:pt idx="0">
                    <c:v>3214.550253664318</c:v>
                  </c:pt>
                  <c:pt idx="1">
                    <c:v>9672.771061076558</c:v>
                  </c:pt>
                </c:numCache>
              </c:numRef>
            </c:minus>
            <c:spPr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errBars>
          <c:cat>
            <c:numRef>
              <c:f>'0.1% FBS'!$A$10:$A$11</c:f>
              <c:numCache>
                <c:formatCode>General</c:formatCode>
                <c:ptCount val="2"/>
                <c:pt idx="0">
                  <c:v>1.0</c:v>
                </c:pt>
                <c:pt idx="1">
                  <c:v>3.0</c:v>
                </c:pt>
              </c:numCache>
            </c:numRef>
          </c:cat>
          <c:val>
            <c:numRef>
              <c:f>'0.1% FBS'!$D$10:$D$11</c:f>
              <c:numCache>
                <c:formatCode>0.00</c:formatCode>
                <c:ptCount val="2"/>
                <c:pt idx="0">
                  <c:v>29833.33333333331</c:v>
                </c:pt>
                <c:pt idx="1">
                  <c:v>13700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12E0-FA4B-987E-69D3BDF5D0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19624568"/>
        <c:axId val="2139900856"/>
      </c:barChart>
      <c:catAx>
        <c:axId val="21196245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cap="sq">
            <a:solidFill>
              <a:schemeClr val="tx1"/>
            </a:solidFill>
            <a:miter lim="800000"/>
          </a:ln>
        </c:spPr>
        <c:txPr>
          <a:bodyPr/>
          <a:lstStyle/>
          <a:p>
            <a:pPr>
              <a:defRPr sz="1200">
                <a:solidFill>
                  <a:schemeClr val="tx1"/>
                </a:solidFill>
              </a:defRPr>
            </a:pPr>
            <a:endParaRPr lang="ja-JP"/>
          </a:p>
        </c:txPr>
        <c:crossAx val="2139900856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2139900856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cap="sq">
            <a:solidFill>
              <a:schemeClr val="tx1"/>
            </a:solidFill>
            <a:miter lim="800000"/>
          </a:ln>
        </c:spPr>
        <c:txPr>
          <a:bodyPr/>
          <a:lstStyle/>
          <a:p>
            <a:pPr>
              <a:defRPr>
                <a:solidFill>
                  <a:schemeClr val="tx1"/>
                </a:solidFill>
              </a:defRPr>
            </a:pPr>
            <a:endParaRPr lang="ja-JP"/>
          </a:p>
        </c:txPr>
        <c:crossAx val="2119624568"/>
        <c:crosses val="autoZero"/>
        <c:crossBetween val="between"/>
        <c:majorUnit val="50000.0"/>
      </c:valAx>
    </c:plotArea>
    <c:legend>
      <c:legendPos val="r"/>
      <c:layout/>
      <c:overlay val="0"/>
      <c:txPr>
        <a:bodyPr/>
        <a:lstStyle/>
        <a:p>
          <a:pPr>
            <a:defRPr sz="1200"/>
          </a:pPr>
          <a:endParaRPr lang="ja-JP"/>
        </a:p>
      </c:txPr>
    </c:legend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pattFill prst="ltUpDiag">
              <a:fgClr>
                <a:schemeClr val="tx1"/>
              </a:fgClr>
              <a:bgClr>
                <a:schemeClr val="bg1"/>
              </a:bgClr>
            </a:pattFill>
            <a:ln cap="sq">
              <a:solidFill>
                <a:schemeClr val="tx1"/>
              </a:solidFill>
              <a:miter lim="800000"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D$39:$E$39</c:f>
                <c:numCache>
                  <c:formatCode>General</c:formatCode>
                  <c:ptCount val="2"/>
                  <c:pt idx="0">
                    <c:v>143.5748641348272</c:v>
                  </c:pt>
                  <c:pt idx="1">
                    <c:v>190.6370621869427</c:v>
                  </c:pt>
                </c:numCache>
              </c:numRef>
            </c:plus>
            <c:minus>
              <c:numRef>
                <c:f>Sheet1!$D$39:$E$39</c:f>
                <c:numCache>
                  <c:formatCode>General</c:formatCode>
                  <c:ptCount val="2"/>
                  <c:pt idx="0">
                    <c:v>143.5748641348272</c:v>
                  </c:pt>
                  <c:pt idx="1">
                    <c:v>190.63706218694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37:$E$37</c:f>
              <c:strCache>
                <c:ptCount val="2"/>
                <c:pt idx="0">
                  <c:v>WT</c:v>
                </c:pt>
                <c:pt idx="1">
                  <c:v>AS#3</c:v>
                </c:pt>
              </c:strCache>
            </c:strRef>
          </c:cat>
          <c:val>
            <c:numRef>
              <c:f>Sheet1!$D$38:$E$38</c:f>
              <c:numCache>
                <c:formatCode>0.0</c:formatCode>
                <c:ptCount val="2"/>
                <c:pt idx="0">
                  <c:v>579.4270833333334</c:v>
                </c:pt>
                <c:pt idx="1">
                  <c:v>1208.76736111111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C2F-3E4B-A775-55C411C3B7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39778632"/>
        <c:axId val="2120032984"/>
      </c:barChart>
      <c:catAx>
        <c:axId val="21397786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sq" cmpd="sng" algn="ctr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120032984"/>
        <c:crosses val="autoZero"/>
        <c:auto val="1"/>
        <c:lblAlgn val="ctr"/>
        <c:lblOffset val="100"/>
        <c:noMultiLvlLbl val="0"/>
      </c:catAx>
      <c:valAx>
        <c:axId val="2120032984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cap="sq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139778632"/>
        <c:crosses val="autoZero"/>
        <c:crossBetween val="between"/>
        <c:majorUnit val="400.0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pattFill prst="ltUpDiag">
              <a:fgClr>
                <a:schemeClr val="tx1"/>
              </a:fgClr>
              <a:bgClr>
                <a:schemeClr val="bg1"/>
              </a:bgClr>
            </a:pattFill>
            <a:ln cap="sq">
              <a:solidFill>
                <a:schemeClr val="tx1"/>
              </a:solidFill>
              <a:miter lim="800000"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H$39:$I$39</c:f>
                <c:numCache>
                  <c:formatCode>General</c:formatCode>
                  <c:ptCount val="2"/>
                  <c:pt idx="0">
                    <c:v>5.091945806659107</c:v>
                  </c:pt>
                  <c:pt idx="1">
                    <c:v>12.72615001213993</c:v>
                  </c:pt>
                </c:numCache>
              </c:numRef>
            </c:plus>
            <c:minus>
              <c:numRef>
                <c:f>Sheet1!$H$39:$I$39</c:f>
                <c:numCache>
                  <c:formatCode>General</c:formatCode>
                  <c:ptCount val="2"/>
                  <c:pt idx="0">
                    <c:v>5.091945806659107</c:v>
                  </c:pt>
                  <c:pt idx="1">
                    <c:v>12.726150012139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37:$I$37</c:f>
              <c:strCache>
                <c:ptCount val="2"/>
                <c:pt idx="0">
                  <c:v>WT</c:v>
                </c:pt>
                <c:pt idx="1">
                  <c:v>AS#3</c:v>
                </c:pt>
              </c:strCache>
            </c:strRef>
          </c:cat>
          <c:val>
            <c:numRef>
              <c:f>Sheet1!$H$38:$I$38</c:f>
              <c:numCache>
                <c:formatCode>0.0</c:formatCode>
                <c:ptCount val="2"/>
                <c:pt idx="0">
                  <c:v>32.44791666666642</c:v>
                </c:pt>
                <c:pt idx="1">
                  <c:v>78.0038541666664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28D-234F-A7E1-3512B6D402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39882488"/>
        <c:axId val="2119491432"/>
      </c:barChart>
      <c:catAx>
        <c:axId val="21398824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sq" cmpd="sng" algn="ctr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119491432"/>
        <c:crosses val="autoZero"/>
        <c:auto val="1"/>
        <c:lblAlgn val="ctr"/>
        <c:lblOffset val="100"/>
        <c:noMultiLvlLbl val="0"/>
      </c:catAx>
      <c:valAx>
        <c:axId val="2119491432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cap="sq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139882488"/>
        <c:crosses val="autoZero"/>
        <c:crossBetween val="between"/>
        <c:majorUnit val="20.0"/>
      </c:valAx>
      <c:spPr>
        <a:noFill/>
        <a:ln w="25400"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pattFill prst="ltUpDiag">
              <a:fgClr>
                <a:schemeClr val="tx1"/>
              </a:fgClr>
              <a:bgClr>
                <a:schemeClr val="bg1"/>
              </a:bgClr>
            </a:pattFill>
            <a:ln cap="sq">
              <a:solidFill>
                <a:schemeClr val="tx1"/>
              </a:solidFill>
              <a:miter lim="800000"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L$39:$M$39</c:f>
                <c:numCache>
                  <c:formatCode>General</c:formatCode>
                  <c:ptCount val="2"/>
                  <c:pt idx="0">
                    <c:v>2.970042868298131</c:v>
                  </c:pt>
                  <c:pt idx="1">
                    <c:v>3.75098926400741</c:v>
                  </c:pt>
                </c:numCache>
              </c:numRef>
            </c:plus>
            <c:minus>
              <c:numRef>
                <c:f>Sheet1!$L$39:$M$39</c:f>
                <c:numCache>
                  <c:formatCode>General</c:formatCode>
                  <c:ptCount val="2"/>
                  <c:pt idx="0">
                    <c:v>2.970042868298131</c:v>
                  </c:pt>
                  <c:pt idx="1">
                    <c:v>3.750989264007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L$37:$M$37</c:f>
              <c:strCache>
                <c:ptCount val="2"/>
                <c:pt idx="0">
                  <c:v>WT</c:v>
                </c:pt>
                <c:pt idx="1">
                  <c:v>AS#3</c:v>
                </c:pt>
              </c:strCache>
            </c:strRef>
          </c:cat>
          <c:val>
            <c:numRef>
              <c:f>Sheet1!$L$38:$M$38</c:f>
              <c:numCache>
                <c:formatCode>0.0</c:formatCode>
                <c:ptCount val="2"/>
                <c:pt idx="0">
                  <c:v>22.54864583333315</c:v>
                </c:pt>
                <c:pt idx="1">
                  <c:v>20.043958333333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49A-FD44-AE30-9A9C108AA0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39800936"/>
        <c:axId val="2139292968"/>
      </c:barChart>
      <c:catAx>
        <c:axId val="21398009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sq" cmpd="sng" algn="ctr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139292968"/>
        <c:crosses val="autoZero"/>
        <c:auto val="1"/>
        <c:lblAlgn val="ctr"/>
        <c:lblOffset val="100"/>
        <c:noMultiLvlLbl val="0"/>
      </c:catAx>
      <c:valAx>
        <c:axId val="2139292968"/>
        <c:scaling>
          <c:orientation val="minMax"/>
          <c:max val="30.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cap="sq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139800936"/>
        <c:crosses val="autoZero"/>
        <c:crossBetween val="between"/>
        <c:majorUnit val="10.0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pattFill prst="pct50">
              <a:fgClr>
                <a:schemeClr val="tx1"/>
              </a:fgClr>
              <a:bgClr>
                <a:schemeClr val="bg1"/>
              </a:bgClr>
            </a:pattFill>
            <a:ln cap="sq">
              <a:solidFill>
                <a:schemeClr val="tx1"/>
              </a:solidFill>
              <a:miter lim="800000"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00228 SPDEF (友信解析)'!$E$40:$E$41</c:f>
                <c:numCache>
                  <c:formatCode>General</c:formatCode>
                  <c:ptCount val="2"/>
                  <c:pt idx="0">
                    <c:v>0.0628190244140817</c:v>
                  </c:pt>
                  <c:pt idx="1">
                    <c:v>0.00732547396971716</c:v>
                  </c:pt>
                </c:numCache>
              </c:numRef>
            </c:plus>
            <c:minus>
              <c:numRef>
                <c:f>'200228 SPDEF (友信解析)'!$E$40:$E$41</c:f>
                <c:numCache>
                  <c:formatCode>General</c:formatCode>
                  <c:ptCount val="2"/>
                  <c:pt idx="0">
                    <c:v>0.0628190244140817</c:v>
                  </c:pt>
                  <c:pt idx="1">
                    <c:v>0.007325473969717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0228 SPDEF (友信解析)'!$B$40:$B$41</c:f>
              <c:strCache>
                <c:ptCount val="2"/>
                <c:pt idx="0">
                  <c:v>siCONT</c:v>
                </c:pt>
                <c:pt idx="1">
                  <c:v>siSPDEF</c:v>
                </c:pt>
              </c:strCache>
            </c:strRef>
          </c:cat>
          <c:val>
            <c:numRef>
              <c:f>'200228 SPDEF (友信解析)'!$C$40:$C$41</c:f>
              <c:numCache>
                <c:formatCode>0.0000</c:formatCode>
                <c:ptCount val="2"/>
                <c:pt idx="0">
                  <c:v>1.0</c:v>
                </c:pt>
                <c:pt idx="1">
                  <c:v>0.055028328985965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2C8-5246-A9F3-D62F657984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39390888"/>
        <c:axId val="2055121576"/>
      </c:barChart>
      <c:catAx>
        <c:axId val="21393908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sq" cmpd="sng" algn="ctr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55121576"/>
        <c:crosses val="autoZero"/>
        <c:auto val="1"/>
        <c:lblAlgn val="ctr"/>
        <c:lblOffset val="100"/>
        <c:noMultiLvlLbl val="0"/>
      </c:catAx>
      <c:valAx>
        <c:axId val="2055121576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cap="sq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1393908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pattFill prst="pct50">
              <a:fgClr>
                <a:schemeClr val="tx1"/>
              </a:fgClr>
              <a:bgClr>
                <a:schemeClr val="bg1"/>
              </a:bgClr>
            </a:pattFill>
            <a:ln cap="sq">
              <a:solidFill>
                <a:schemeClr val="tx1"/>
              </a:solidFill>
              <a:miter lim="800000"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00301 EMT (友信解析)'!$U$33:$U$34</c:f>
                <c:numCache>
                  <c:formatCode>General</c:formatCode>
                  <c:ptCount val="2"/>
                  <c:pt idx="0">
                    <c:v>0.232883850051752</c:v>
                  </c:pt>
                  <c:pt idx="1">
                    <c:v>0.0633270515301234</c:v>
                  </c:pt>
                </c:numCache>
              </c:numRef>
            </c:plus>
            <c:minus>
              <c:numRef>
                <c:f>'200301 EMT (友信解析)'!$U$33:$U$34</c:f>
                <c:numCache>
                  <c:formatCode>General</c:formatCode>
                  <c:ptCount val="2"/>
                  <c:pt idx="0">
                    <c:v>0.232883850051752</c:v>
                  </c:pt>
                  <c:pt idx="1">
                    <c:v>0.06332705153012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0301 EMT (友信解析)'!$R$33:$R$34</c:f>
              <c:strCache>
                <c:ptCount val="2"/>
                <c:pt idx="0">
                  <c:v>siCONT</c:v>
                </c:pt>
                <c:pt idx="1">
                  <c:v>siSPDEF</c:v>
                </c:pt>
              </c:strCache>
            </c:strRef>
          </c:cat>
          <c:val>
            <c:numRef>
              <c:f>'200301 EMT (友信解析)'!$S$33:$S$34</c:f>
              <c:numCache>
                <c:formatCode>0.0000</c:formatCode>
                <c:ptCount val="2"/>
                <c:pt idx="0">
                  <c:v>1.0</c:v>
                </c:pt>
                <c:pt idx="1">
                  <c:v>0.42138733542905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94C-074A-BACC-AB0EF24806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40983720"/>
        <c:axId val="2141012472"/>
      </c:barChart>
      <c:catAx>
        <c:axId val="21409837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sq" cmpd="sng" algn="ctr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141012472"/>
        <c:crosses val="autoZero"/>
        <c:auto val="1"/>
        <c:lblAlgn val="ctr"/>
        <c:lblOffset val="100"/>
        <c:noMultiLvlLbl val="0"/>
      </c:catAx>
      <c:valAx>
        <c:axId val="214101247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0"/>
        <c:majorTickMark val="out"/>
        <c:minorTickMark val="none"/>
        <c:tickLblPos val="nextTo"/>
        <c:spPr>
          <a:noFill/>
          <a:ln cap="sq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140983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pattFill prst="pct50">
              <a:fgClr>
                <a:schemeClr val="tx1"/>
              </a:fgClr>
              <a:bgClr>
                <a:schemeClr val="bg1"/>
              </a:bgClr>
            </a:pattFill>
            <a:ln cap="sq">
              <a:solidFill>
                <a:schemeClr val="tx1"/>
              </a:solidFill>
              <a:miter lim="800000"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200301 EMT (友信解析)'!$U$128:$U$129</c:f>
                <c:numCache>
                  <c:formatCode>General</c:formatCode>
                  <c:ptCount val="2"/>
                  <c:pt idx="0">
                    <c:v>0.0850116212830071</c:v>
                  </c:pt>
                  <c:pt idx="1">
                    <c:v>0.152348700867532</c:v>
                  </c:pt>
                </c:numCache>
              </c:numRef>
            </c:plus>
            <c:minus>
              <c:numRef>
                <c:f>'200301 EMT (友信解析)'!$U$128:$U$129</c:f>
                <c:numCache>
                  <c:formatCode>General</c:formatCode>
                  <c:ptCount val="2"/>
                  <c:pt idx="0">
                    <c:v>0.0850116212830071</c:v>
                  </c:pt>
                  <c:pt idx="1">
                    <c:v>0.15234870086753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0301 EMT (友信解析)'!$R$128:$R$129</c:f>
              <c:strCache>
                <c:ptCount val="2"/>
                <c:pt idx="0">
                  <c:v>siCONT</c:v>
                </c:pt>
                <c:pt idx="1">
                  <c:v>siSPDEF</c:v>
                </c:pt>
              </c:strCache>
            </c:strRef>
          </c:cat>
          <c:val>
            <c:numRef>
              <c:f>'200301 EMT (友信解析)'!$S$128:$S$129</c:f>
              <c:numCache>
                <c:formatCode>0.0000</c:formatCode>
                <c:ptCount val="2"/>
                <c:pt idx="0">
                  <c:v>1.0</c:v>
                </c:pt>
                <c:pt idx="1">
                  <c:v>0.88086106406107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7B1-6C4E-AAAD-707AD0950A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40768264"/>
        <c:axId val="2141127144"/>
      </c:barChart>
      <c:catAx>
        <c:axId val="21407682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sq" cmpd="sng" algn="ctr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141127144"/>
        <c:crosses val="autoZero"/>
        <c:auto val="1"/>
        <c:lblAlgn val="ctr"/>
        <c:lblOffset val="100"/>
        <c:noMultiLvlLbl val="0"/>
      </c:catAx>
      <c:valAx>
        <c:axId val="214112714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0"/>
        <c:majorTickMark val="out"/>
        <c:minorTickMark val="none"/>
        <c:tickLblPos val="nextTo"/>
        <c:spPr>
          <a:noFill/>
          <a:ln cap="sq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140768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1FB75F-59CD-3246-88B9-E36BA0DF4878}" type="datetimeFigureOut">
              <a:rPr kumimoji="1" lang="ja-JP" altLang="en-US" smtClean="0"/>
              <a:t>20/03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45C9A3-CD0C-C74E-99A9-5663D5DA72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90138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/>
              <a:t>細胞をそれぞれ</a:t>
            </a:r>
            <a:r>
              <a:rPr kumimoji="1" lang="en-US" altLang="ja-JP" dirty="0"/>
              <a:t>20</a:t>
            </a:r>
            <a:r>
              <a:rPr kumimoji="1" lang="ja-JP" altLang="en-US" dirty="0"/>
              <a:t>個カウントし、</a:t>
            </a:r>
            <a:endParaRPr kumimoji="1" lang="en-US" altLang="ja-JP" dirty="0"/>
          </a:p>
          <a:p>
            <a:r>
              <a:rPr kumimoji="1" lang="en-US" altLang="ja-JP" dirty="0" err="1"/>
              <a:t>ImageJ</a:t>
            </a:r>
            <a:r>
              <a:rPr kumimoji="1" lang="ja-JP" altLang="en-US" dirty="0"/>
              <a:t>で解析した。</a:t>
            </a: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45C9A3-CD0C-C74E-99A9-5663D5DA728E}" type="slidenum">
              <a:rPr kumimoji="1" lang="ja-JP" altLang="en-US" smtClean="0"/>
              <a:t>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91675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45C9A3-CD0C-C74E-99A9-5663D5DA728E}" type="slidenum">
              <a:rPr kumimoji="1" lang="ja-JP" altLang="en-US" smtClean="0"/>
              <a:t>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84025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A17B1-1501-7844-9846-C464E804FC6A}" type="datetimeFigureOut">
              <a:rPr kumimoji="1" lang="ja-JP" altLang="en-US" smtClean="0"/>
              <a:t>20/03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4D070-27EC-9048-AD50-AB3987B48A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33340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A17B1-1501-7844-9846-C464E804FC6A}" type="datetimeFigureOut">
              <a:rPr kumimoji="1" lang="ja-JP" altLang="en-US" smtClean="0"/>
              <a:t>20/03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4D070-27EC-9048-AD50-AB3987B48A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9668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A17B1-1501-7844-9846-C464E804FC6A}" type="datetimeFigureOut">
              <a:rPr kumimoji="1" lang="ja-JP" altLang="en-US" smtClean="0"/>
              <a:t>20/03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4D070-27EC-9048-AD50-AB3987B48A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8176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A17B1-1501-7844-9846-C464E804FC6A}" type="datetimeFigureOut">
              <a:rPr kumimoji="1" lang="ja-JP" altLang="en-US" smtClean="0"/>
              <a:t>20/03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4D070-27EC-9048-AD50-AB3987B48A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594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A17B1-1501-7844-9846-C464E804FC6A}" type="datetimeFigureOut">
              <a:rPr kumimoji="1" lang="ja-JP" altLang="en-US" smtClean="0"/>
              <a:t>20/03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4D070-27EC-9048-AD50-AB3987B48A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03049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A17B1-1501-7844-9846-C464E804FC6A}" type="datetimeFigureOut">
              <a:rPr kumimoji="1" lang="ja-JP" altLang="en-US" smtClean="0"/>
              <a:t>20/03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4D070-27EC-9048-AD50-AB3987B48A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2240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A17B1-1501-7844-9846-C464E804FC6A}" type="datetimeFigureOut">
              <a:rPr kumimoji="1" lang="ja-JP" altLang="en-US" smtClean="0"/>
              <a:t>20/03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4D070-27EC-9048-AD50-AB3987B48A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34498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A17B1-1501-7844-9846-C464E804FC6A}" type="datetimeFigureOut">
              <a:rPr kumimoji="1" lang="ja-JP" altLang="en-US" smtClean="0"/>
              <a:t>20/03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4D070-27EC-9048-AD50-AB3987B48A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1064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A17B1-1501-7844-9846-C464E804FC6A}" type="datetimeFigureOut">
              <a:rPr kumimoji="1" lang="ja-JP" altLang="en-US" smtClean="0"/>
              <a:t>20/03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4D070-27EC-9048-AD50-AB3987B48A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797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A17B1-1501-7844-9846-C464E804FC6A}" type="datetimeFigureOut">
              <a:rPr kumimoji="1" lang="ja-JP" altLang="en-US" smtClean="0"/>
              <a:t>20/03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4D070-27EC-9048-AD50-AB3987B48A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04368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A17B1-1501-7844-9846-C464E804FC6A}" type="datetimeFigureOut">
              <a:rPr kumimoji="1" lang="ja-JP" altLang="en-US" smtClean="0"/>
              <a:t>20/03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64D070-27EC-9048-AD50-AB3987B48A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0111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3A17B1-1501-7844-9846-C464E804FC6A}" type="datetimeFigureOut">
              <a:rPr kumimoji="1" lang="ja-JP" altLang="en-US" smtClean="0"/>
              <a:t>20/03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64D070-27EC-9048-AD50-AB3987B48A0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4969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4" Type="http://schemas.openxmlformats.org/officeDocument/2006/relationships/image" Target="../media/image7.emf"/><Relationship Id="rId5" Type="http://schemas.openxmlformats.org/officeDocument/2006/relationships/image" Target="../media/image8.emf"/><Relationship Id="rId6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4" Type="http://schemas.openxmlformats.org/officeDocument/2006/relationships/image" Target="../media/image11.emf"/><Relationship Id="rId5" Type="http://schemas.openxmlformats.org/officeDocument/2006/relationships/image" Target="../media/image12.emf"/><Relationship Id="rId6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4" Type="http://schemas.openxmlformats.org/officeDocument/2006/relationships/image" Target="../media/image15.tif"/><Relationship Id="rId5" Type="http://schemas.openxmlformats.org/officeDocument/2006/relationships/image" Target="../media/image16.emf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g"/><Relationship Id="rId4" Type="http://schemas.openxmlformats.org/officeDocument/2006/relationships/image" Target="../media/image18.jpg"/><Relationship Id="rId5" Type="http://schemas.openxmlformats.org/officeDocument/2006/relationships/chart" Target="../charts/chart2.xml"/><Relationship Id="rId6" Type="http://schemas.openxmlformats.org/officeDocument/2006/relationships/chart" Target="../charts/chart3.xml"/><Relationship Id="rId7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9.xml.rels><?xml version="1.0" encoding="UTF-8" standalone="yes"?>
<Relationships xmlns="http://schemas.openxmlformats.org/package/2006/relationships"><Relationship Id="rId9" Type="http://schemas.openxmlformats.org/officeDocument/2006/relationships/image" Target="../media/image12.svg"/><Relationship Id="rId20" Type="http://schemas.microsoft.com/office/2007/relationships/hdphoto" Target="../media/hdphoto4.wdp"/><Relationship Id="rId21" Type="http://schemas.openxmlformats.org/officeDocument/2006/relationships/image" Target="../media/image26.jpg"/><Relationship Id="rId22" Type="http://schemas.openxmlformats.org/officeDocument/2006/relationships/image" Target="../media/image27.png"/><Relationship Id="rId23" Type="http://schemas.openxmlformats.org/officeDocument/2006/relationships/image" Target="../media/image19.svg"/><Relationship Id="rId10" Type="http://schemas.openxmlformats.org/officeDocument/2006/relationships/chart" Target="../charts/chart5.xml"/><Relationship Id="rId11" Type="http://schemas.openxmlformats.org/officeDocument/2006/relationships/chart" Target="../charts/chart6.xml"/><Relationship Id="rId12" Type="http://schemas.openxmlformats.org/officeDocument/2006/relationships/chart" Target="../charts/chart7.xml"/><Relationship Id="rId13" Type="http://schemas.openxmlformats.org/officeDocument/2006/relationships/image" Target="../media/image22.png"/><Relationship Id="rId14" Type="http://schemas.microsoft.com/office/2007/relationships/hdphoto" Target="../media/hdphoto1.wdp"/><Relationship Id="rId15" Type="http://schemas.openxmlformats.org/officeDocument/2006/relationships/image" Target="../media/image23.png"/><Relationship Id="rId16" Type="http://schemas.microsoft.com/office/2007/relationships/hdphoto" Target="../media/hdphoto2.wdp"/><Relationship Id="rId17" Type="http://schemas.openxmlformats.org/officeDocument/2006/relationships/image" Target="../media/image24.png"/><Relationship Id="rId18" Type="http://schemas.microsoft.com/office/2007/relationships/hdphoto" Target="../media/hdphoto3.wdp"/><Relationship Id="rId19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19.png"/><Relationship Id="rId4" Type="http://schemas.openxmlformats.org/officeDocument/2006/relationships/image" Target="../media/image7.svg"/><Relationship Id="rId5" Type="http://schemas.openxmlformats.org/officeDocument/2006/relationships/image" Target="../media/image20.png"/><Relationship Id="rId6" Type="http://schemas.openxmlformats.org/officeDocument/2006/relationships/image" Target="../media/image9.svg"/><Relationship Id="rId7" Type="http://schemas.openxmlformats.org/officeDocument/2006/relationships/image" Target="../media/image21.png"/><Relationship Id="rId8" Type="http://schemas.openxmlformats.org/officeDocument/2006/relationships/image" Target="../media/image11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972594" y="4970123"/>
            <a:ext cx="6065482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4800" b="1" dirty="0"/>
              <a:t>Supplementary</a:t>
            </a:r>
            <a:r>
              <a:rPr kumimoji="1" lang="ja-JP" altLang="en-US" sz="4800" b="1" dirty="0"/>
              <a:t> </a:t>
            </a:r>
            <a:r>
              <a:rPr kumimoji="1" lang="en-US" altLang="ja-JP" sz="4800" b="1" dirty="0" smtClean="0"/>
              <a:t>Figures</a:t>
            </a:r>
          </a:p>
          <a:p>
            <a:pPr algn="ctr"/>
            <a:r>
              <a:rPr kumimoji="1" lang="en-US" altLang="ja-JP" sz="4800" b="1" dirty="0" smtClean="0"/>
              <a:t>(Suppl. Fig. S1-S6)</a:t>
            </a:r>
            <a:endParaRPr kumimoji="1" lang="ja-JP" altLang="en-US" sz="4800" b="1" dirty="0"/>
          </a:p>
        </p:txBody>
      </p:sp>
      <p:sp>
        <p:nvSpPr>
          <p:cNvPr id="2" name="正方形/長方形 1"/>
          <p:cNvSpPr/>
          <p:nvPr/>
        </p:nvSpPr>
        <p:spPr>
          <a:xfrm>
            <a:off x="3436775" y="7113723"/>
            <a:ext cx="5137121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3200" dirty="0" err="1"/>
              <a:t>Bajkowska</a:t>
            </a:r>
            <a:r>
              <a:rPr lang="ja-JP" altLang="en-US" sz="3200" dirty="0"/>
              <a:t> </a:t>
            </a:r>
            <a:r>
              <a:rPr lang="en-US" altLang="ja-JP" sz="3200" dirty="0"/>
              <a:t>K, </a:t>
            </a:r>
            <a:r>
              <a:rPr lang="en-US" altLang="ja-JP" sz="3200" dirty="0" err="1"/>
              <a:t>Sumardika</a:t>
            </a:r>
            <a:r>
              <a:rPr lang="en-US" altLang="ja-JP" sz="3200" dirty="0"/>
              <a:t> IW and </a:t>
            </a:r>
            <a:r>
              <a:rPr lang="en-US" altLang="ja-JP" sz="3200" dirty="0" err="1"/>
              <a:t>Tomonobu</a:t>
            </a:r>
            <a:r>
              <a:rPr lang="en-US" altLang="ja-JP" sz="3200" dirty="0"/>
              <a:t> N et al.</a:t>
            </a:r>
            <a:endParaRPr lang="ja-JP" altLang="en-US" sz="3200" dirty="0"/>
          </a:p>
        </p:txBody>
      </p:sp>
    </p:spTree>
    <p:extLst>
      <p:ext uri="{BB962C8B-B14F-4D97-AF65-F5344CB8AC3E}">
        <p14:creationId xmlns:p14="http://schemas.microsoft.com/office/powerpoint/2010/main" val="33172649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0188" y="49294"/>
            <a:ext cx="2430473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b="1" dirty="0" smtClean="0"/>
              <a:t>Suppl</a:t>
            </a:r>
            <a:r>
              <a:rPr kumimoji="1" lang="en-US" altLang="ja-JP" sz="3200" b="1" dirty="0" smtClean="0"/>
              <a:t>.</a:t>
            </a:r>
            <a:r>
              <a:rPr kumimoji="1" lang="ja-JP" altLang="en-US" sz="3200" b="1" dirty="0" smtClean="0"/>
              <a:t> </a:t>
            </a:r>
            <a:r>
              <a:rPr kumimoji="1" lang="en-US" altLang="ja-JP" sz="3200" b="1" dirty="0"/>
              <a:t>Fig.</a:t>
            </a:r>
            <a:r>
              <a:rPr kumimoji="1" lang="ja-JP" altLang="en-US" sz="3200" b="1" dirty="0"/>
              <a:t> </a:t>
            </a:r>
            <a:r>
              <a:rPr kumimoji="1" lang="en-US" altLang="ja-JP" sz="3200" b="1" dirty="0" smtClean="0"/>
              <a:t>S</a:t>
            </a:r>
            <a:r>
              <a:rPr kumimoji="1" lang="en-US" altLang="ja-JP" sz="3200" b="1" dirty="0" smtClean="0"/>
              <a:t>1</a:t>
            </a:r>
            <a:endParaRPr kumimoji="1" lang="ja-JP" altLang="en-US" sz="3200" b="1" dirty="0"/>
          </a:p>
        </p:txBody>
      </p:sp>
      <p:sp>
        <p:nvSpPr>
          <p:cNvPr id="19" name="正方形/長方形 18"/>
          <p:cNvSpPr/>
          <p:nvPr/>
        </p:nvSpPr>
        <p:spPr>
          <a:xfrm>
            <a:off x="1304219" y="2607668"/>
            <a:ext cx="5286317" cy="2862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b="1" dirty="0">
                <a:solidFill>
                  <a:srgbClr val="008000"/>
                </a:solidFill>
              </a:rPr>
              <a:t>MSGSSLPSALALSLLLVSGSLLPG</a:t>
            </a:r>
            <a:r>
              <a:rPr lang="en-US" altLang="ja-JP" b="1" u="sng" dirty="0">
                <a:solidFill>
                  <a:srgbClr val="008000"/>
                </a:solidFill>
              </a:rPr>
              <a:t>PGAA</a:t>
            </a:r>
            <a:r>
              <a:rPr lang="en-US" altLang="ja-JP" b="1" u="sng" dirty="0"/>
              <a:t>QNAGFVKSPMSETKLTGDAFELYCDVVGSPTPEIQWWYAEVNRAESFRQLWDGARKRRVTVNTAYGSNGVSVLRITRLTLEDSGTYECRASNDPKRNDLRQNPSIT</a:t>
            </a:r>
            <a:r>
              <a:rPr lang="en-US" altLang="ja-JP" dirty="0"/>
              <a:t>WIRAQATISVLQK</a:t>
            </a:r>
            <a:r>
              <a:rPr lang="en-US" altLang="ja-JP" b="1" dirty="0">
                <a:solidFill>
                  <a:srgbClr val="3366FF"/>
                </a:solidFill>
              </a:rPr>
              <a:t>PRIVTSEEVIIRDSPVLPVTLQCNLTSSSHTLTYSYWTKNGVELSATRKNASNMEYRINKPRAEDSGEYHCVYHFVSAPKANATIEVK</a:t>
            </a:r>
            <a:r>
              <a:rPr lang="en-US" altLang="ja-JP" dirty="0"/>
              <a:t>AA</a:t>
            </a:r>
            <a:r>
              <a:rPr lang="en-US" altLang="ja-JP" b="1" dirty="0">
                <a:solidFill>
                  <a:srgbClr val="FF6600"/>
                </a:solidFill>
              </a:rPr>
              <a:t>PDITGHKRSENKNEGQDATMYCKSVGYPHPDWIWRKKENGMPMDIVNTSGRFFIINKENYTELNIVNLQITEDPGEYECNATNAIGSASVVT</a:t>
            </a:r>
            <a:r>
              <a:rPr lang="en-US" altLang="ja-JP" dirty="0"/>
              <a:t>VLRVRSHL</a:t>
            </a:r>
            <a:r>
              <a:rPr lang="en-US" altLang="ja-JP" b="1" dirty="0"/>
              <a:t>APLWPFLGILAEIIILVVIIVVY</a:t>
            </a:r>
            <a:r>
              <a:rPr lang="en-US" altLang="ja-JP" b="1" dirty="0">
                <a:solidFill>
                  <a:srgbClr val="FF0000"/>
                </a:solidFill>
              </a:rPr>
              <a:t>EKRKRPDEVPDDDEPAGPMKTNSTNNHKDKNLRQRNTN</a:t>
            </a:r>
            <a:endParaRPr lang="ja-JP" altLang="ja-JP" b="1" dirty="0">
              <a:solidFill>
                <a:srgbClr val="FF0000"/>
              </a:solidFill>
            </a:endParaRPr>
          </a:p>
        </p:txBody>
      </p:sp>
      <p:sp>
        <p:nvSpPr>
          <p:cNvPr id="20" name="正方形/長方形 19"/>
          <p:cNvSpPr/>
          <p:nvPr/>
        </p:nvSpPr>
        <p:spPr>
          <a:xfrm>
            <a:off x="2083477" y="2227217"/>
            <a:ext cx="9489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/>
              <a:t>(398 </a:t>
            </a:r>
            <a:r>
              <a:rPr lang="en-US" altLang="ja-JP" dirty="0" err="1"/>
              <a:t>aa</a:t>
            </a:r>
            <a:r>
              <a:rPr lang="en-US" altLang="ja-JP" dirty="0"/>
              <a:t>)</a:t>
            </a:r>
            <a:r>
              <a:rPr lang="ja-JP" altLang="ja-JP" dirty="0"/>
              <a:t> </a:t>
            </a:r>
            <a:endParaRPr lang="ja-JP" altLang="en-US" dirty="0"/>
          </a:p>
        </p:txBody>
      </p:sp>
      <p:sp>
        <p:nvSpPr>
          <p:cNvPr id="21" name="正方形/長方形 20"/>
          <p:cNvSpPr/>
          <p:nvPr/>
        </p:nvSpPr>
        <p:spPr>
          <a:xfrm>
            <a:off x="7029440" y="2607668"/>
            <a:ext cx="2939638" cy="17543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solidFill>
                  <a:srgbClr val="008000"/>
                </a:solidFill>
              </a:rPr>
              <a:t>Signal peptide</a:t>
            </a:r>
            <a:r>
              <a:rPr lang="en-US" altLang="ja-JP" dirty="0"/>
              <a:t>: 1-28 </a:t>
            </a:r>
            <a:r>
              <a:rPr lang="en-US" altLang="ja-JP" dirty="0" err="1"/>
              <a:t>aa</a:t>
            </a:r>
            <a:endParaRPr lang="ja-JP" altLang="ja-JP" dirty="0"/>
          </a:p>
          <a:p>
            <a:r>
              <a:rPr lang="en-US" altLang="ja-JP" b="1" u="sng" dirty="0" err="1"/>
              <a:t>Ig</a:t>
            </a:r>
            <a:r>
              <a:rPr lang="en-US" altLang="ja-JP" b="1" u="sng" dirty="0"/>
              <a:t>-like </a:t>
            </a:r>
            <a:r>
              <a:rPr lang="en-US" altLang="ja-JP" b="1" dirty="0"/>
              <a:t>(Ig-3)</a:t>
            </a:r>
            <a:r>
              <a:rPr lang="en-US" altLang="ja-JP" dirty="0"/>
              <a:t>: 25-134 </a:t>
            </a:r>
            <a:r>
              <a:rPr lang="en-US" altLang="ja-JP" dirty="0" err="1"/>
              <a:t>aa</a:t>
            </a:r>
            <a:endParaRPr lang="ja-JP" altLang="ja-JP" dirty="0"/>
          </a:p>
          <a:p>
            <a:r>
              <a:rPr lang="en-US" altLang="ja-JP" b="1" dirty="0" err="1">
                <a:solidFill>
                  <a:srgbClr val="3366FF"/>
                </a:solidFill>
              </a:rPr>
              <a:t>Ig</a:t>
            </a:r>
            <a:r>
              <a:rPr lang="en-US" altLang="ja-JP" b="1" dirty="0">
                <a:solidFill>
                  <a:srgbClr val="3366FF"/>
                </a:solidFill>
              </a:rPr>
              <a:t>-like</a:t>
            </a:r>
            <a:r>
              <a:rPr lang="en-US" altLang="ja-JP" b="1" dirty="0"/>
              <a:t> (Ig-1)</a:t>
            </a:r>
            <a:r>
              <a:rPr lang="en-US" altLang="ja-JP" dirty="0"/>
              <a:t>: 48-235 </a:t>
            </a:r>
            <a:r>
              <a:rPr lang="en-US" altLang="ja-JP" dirty="0" err="1"/>
              <a:t>aa</a:t>
            </a:r>
            <a:endParaRPr lang="ja-JP" altLang="ja-JP" dirty="0"/>
          </a:p>
          <a:p>
            <a:r>
              <a:rPr lang="en-US" altLang="ja-JP" b="1" dirty="0" err="1">
                <a:solidFill>
                  <a:srgbClr val="FF6600"/>
                </a:solidFill>
              </a:rPr>
              <a:t>Ig</a:t>
            </a:r>
            <a:r>
              <a:rPr lang="en-US" altLang="ja-JP" b="1" dirty="0">
                <a:solidFill>
                  <a:srgbClr val="FF6600"/>
                </a:solidFill>
              </a:rPr>
              <a:t>-like </a:t>
            </a:r>
            <a:r>
              <a:rPr lang="en-US" altLang="ja-JP" b="1" dirty="0">
                <a:solidFill>
                  <a:srgbClr val="000000"/>
                </a:solidFill>
              </a:rPr>
              <a:t>(Ig-2)</a:t>
            </a:r>
            <a:r>
              <a:rPr lang="en-US" altLang="ja-JP" dirty="0"/>
              <a:t>: 238-329 </a:t>
            </a:r>
            <a:r>
              <a:rPr lang="en-US" altLang="ja-JP" dirty="0" err="1"/>
              <a:t>aa</a:t>
            </a:r>
            <a:r>
              <a:rPr lang="en-US" altLang="ja-JP" dirty="0"/>
              <a:t>  	</a:t>
            </a:r>
            <a:endParaRPr lang="ja-JP" altLang="ja-JP" dirty="0"/>
          </a:p>
          <a:p>
            <a:r>
              <a:rPr lang="en-US" altLang="ja-JP" b="1" dirty="0" err="1"/>
              <a:t>Transmembrane</a:t>
            </a:r>
            <a:r>
              <a:rPr lang="en-US" altLang="ja-JP" dirty="0"/>
              <a:t>: 338-360 </a:t>
            </a:r>
            <a:r>
              <a:rPr lang="en-US" altLang="ja-JP" dirty="0" err="1"/>
              <a:t>aa</a:t>
            </a:r>
            <a:endParaRPr lang="ja-JP" altLang="ja-JP" dirty="0"/>
          </a:p>
          <a:p>
            <a:r>
              <a:rPr lang="en-US" altLang="ja-JP" b="1" dirty="0">
                <a:solidFill>
                  <a:srgbClr val="FF0000"/>
                </a:solidFill>
              </a:rPr>
              <a:t>Cytoplasmic</a:t>
            </a:r>
            <a:r>
              <a:rPr lang="en-US" altLang="ja-JP" dirty="0"/>
              <a:t>: 361-398 </a:t>
            </a:r>
            <a:r>
              <a:rPr lang="en-US" altLang="ja-JP" dirty="0" err="1"/>
              <a:t>aa</a:t>
            </a:r>
            <a:endParaRPr lang="ja-JP" altLang="ja-JP" dirty="0"/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1304219" y="2227217"/>
            <a:ext cx="8410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NPTN</a:t>
            </a:r>
            <a:r>
              <a:rPr kumimoji="1" lang="en-US" altLang="ja-JP" dirty="0" err="1">
                <a:latin typeface="Symbol" charset="2"/>
                <a:cs typeface="Symbol" charset="2"/>
              </a:rPr>
              <a:t>b</a:t>
            </a:r>
            <a:endParaRPr kumimoji="1" lang="ja-JP" altLang="en-US" dirty="0">
              <a:latin typeface="Symbol" charset="2"/>
              <a:cs typeface="Symbol" charset="2"/>
            </a:endParaRPr>
          </a:p>
        </p:txBody>
      </p:sp>
      <p:sp>
        <p:nvSpPr>
          <p:cNvPr id="27" name="右中かっこ 26"/>
          <p:cNvSpPr/>
          <p:nvPr/>
        </p:nvSpPr>
        <p:spPr>
          <a:xfrm>
            <a:off x="4640337" y="6093585"/>
            <a:ext cx="197983" cy="2640257"/>
          </a:xfrm>
          <a:prstGeom prst="rightBrac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右中かっこ 48"/>
          <p:cNvSpPr/>
          <p:nvPr/>
        </p:nvSpPr>
        <p:spPr>
          <a:xfrm>
            <a:off x="4640337" y="8843421"/>
            <a:ext cx="148662" cy="223678"/>
          </a:xfrm>
          <a:prstGeom prst="rightBrac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右中かっこ 49"/>
          <p:cNvSpPr/>
          <p:nvPr/>
        </p:nvSpPr>
        <p:spPr>
          <a:xfrm>
            <a:off x="4640337" y="9202731"/>
            <a:ext cx="131989" cy="1223406"/>
          </a:xfrm>
          <a:prstGeom prst="rightBrac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5" name="図形グループ 34"/>
          <p:cNvGrpSpPr/>
          <p:nvPr/>
        </p:nvGrpSpPr>
        <p:grpSpPr>
          <a:xfrm>
            <a:off x="1539098" y="6093586"/>
            <a:ext cx="2791929" cy="4196918"/>
            <a:chOff x="1511033" y="5677283"/>
            <a:chExt cx="2791929" cy="4196918"/>
          </a:xfrm>
        </p:grpSpPr>
        <p:cxnSp>
          <p:nvCxnSpPr>
            <p:cNvPr id="43" name="直線コネクタ 42"/>
            <p:cNvCxnSpPr/>
            <p:nvPr/>
          </p:nvCxnSpPr>
          <p:spPr>
            <a:xfrm>
              <a:off x="1511033" y="8427117"/>
              <a:ext cx="2791929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線コネクタ 43"/>
            <p:cNvCxnSpPr/>
            <p:nvPr/>
          </p:nvCxnSpPr>
          <p:spPr>
            <a:xfrm>
              <a:off x="1511033" y="8650795"/>
              <a:ext cx="2791929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正方形/長方形 44"/>
            <p:cNvSpPr/>
            <p:nvPr/>
          </p:nvSpPr>
          <p:spPr>
            <a:xfrm>
              <a:off x="2710541" y="8427117"/>
              <a:ext cx="133994" cy="223678"/>
            </a:xfrm>
            <a:prstGeom prst="rect">
              <a:avLst/>
            </a:prstGeom>
            <a:solidFill>
              <a:srgbClr val="000000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47" name="直線コネクタ 46"/>
            <p:cNvCxnSpPr>
              <a:stCxn id="45" idx="2"/>
            </p:cNvCxnSpPr>
            <p:nvPr/>
          </p:nvCxnSpPr>
          <p:spPr>
            <a:xfrm flipH="1">
              <a:off x="2768800" y="8650795"/>
              <a:ext cx="8738" cy="1223406"/>
            </a:xfrm>
            <a:prstGeom prst="line">
              <a:avLst/>
            </a:prstGeom>
            <a:ln w="38100" cmpd="sng"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円/楕円 23"/>
            <p:cNvSpPr/>
            <p:nvPr/>
          </p:nvSpPr>
          <p:spPr>
            <a:xfrm>
              <a:off x="2563944" y="6411199"/>
              <a:ext cx="427187" cy="1007959"/>
            </a:xfrm>
            <a:prstGeom prst="ellipse">
              <a:avLst/>
            </a:prstGeom>
            <a:solidFill>
              <a:srgbClr val="3366FF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8" name="円/楕円 47"/>
            <p:cNvSpPr/>
            <p:nvPr/>
          </p:nvSpPr>
          <p:spPr>
            <a:xfrm>
              <a:off x="2563944" y="7419158"/>
              <a:ext cx="427187" cy="1007959"/>
            </a:xfrm>
            <a:prstGeom prst="ellipse">
              <a:avLst/>
            </a:prstGeom>
            <a:solidFill>
              <a:srgbClr val="FF6600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" name="正方形/長方形 25"/>
            <p:cNvSpPr/>
            <p:nvPr/>
          </p:nvSpPr>
          <p:spPr>
            <a:xfrm>
              <a:off x="2502977" y="5677283"/>
              <a:ext cx="549122" cy="742948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1866162" y="5790111"/>
              <a:ext cx="5391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Ig-3</a:t>
              </a:r>
              <a:endParaRPr kumimoji="1" lang="ja-JP" altLang="en-US" dirty="0"/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1866162" y="7799666"/>
              <a:ext cx="5391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Ig-2</a:t>
              </a:r>
              <a:endParaRPr kumimoji="1" lang="ja-JP" altLang="en-US" dirty="0"/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1866162" y="6763918"/>
              <a:ext cx="5391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Ig-1</a:t>
              </a:r>
              <a:endParaRPr kumimoji="1" lang="ja-JP" altLang="en-US" dirty="0"/>
            </a:p>
          </p:txBody>
        </p:sp>
      </p:grpSp>
      <p:sp>
        <p:nvSpPr>
          <p:cNvPr id="32" name="テキスト ボックス 31"/>
          <p:cNvSpPr txBox="1"/>
          <p:nvPr/>
        </p:nvSpPr>
        <p:spPr>
          <a:xfrm>
            <a:off x="5006611" y="7192264"/>
            <a:ext cx="21138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xtracellular domain</a:t>
            </a:r>
            <a:endParaRPr kumimoji="1" lang="ja-JP" altLang="en-US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5006611" y="8734178"/>
            <a:ext cx="24962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Transmembrane</a:t>
            </a:r>
            <a:r>
              <a:rPr kumimoji="1" lang="en-US" altLang="ja-JP" dirty="0"/>
              <a:t> domain</a:t>
            </a:r>
            <a:endParaRPr kumimoji="1" lang="ja-JP" altLang="en-US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5006611" y="9622204"/>
            <a:ext cx="20857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ytoplasmic domain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85099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0188" y="49294"/>
            <a:ext cx="2430473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b="1" dirty="0"/>
              <a:t>Suppl.</a:t>
            </a:r>
            <a:r>
              <a:rPr kumimoji="1" lang="ja-JP" altLang="en-US" sz="3200" b="1" dirty="0"/>
              <a:t> </a:t>
            </a:r>
            <a:r>
              <a:rPr kumimoji="1" lang="en-US" altLang="ja-JP" sz="3200" b="1" dirty="0"/>
              <a:t>Fig.</a:t>
            </a:r>
            <a:r>
              <a:rPr kumimoji="1" lang="ja-JP" altLang="en-US" sz="3200" b="1" dirty="0"/>
              <a:t> </a:t>
            </a:r>
            <a:r>
              <a:rPr kumimoji="1" lang="en-US" altLang="ja-JP" sz="3200" b="1" dirty="0" smtClean="0"/>
              <a:t>S</a:t>
            </a:r>
            <a:r>
              <a:rPr kumimoji="1" lang="en-US" altLang="ja-JP" sz="3200" b="1" dirty="0" smtClean="0"/>
              <a:t>2</a:t>
            </a:r>
            <a:endParaRPr kumimoji="1" lang="ja-JP" altLang="en-US" sz="3200" b="1" dirty="0"/>
          </a:p>
        </p:txBody>
      </p:sp>
      <p:grpSp>
        <p:nvGrpSpPr>
          <p:cNvPr id="2" name="図形グループ 1"/>
          <p:cNvGrpSpPr/>
          <p:nvPr/>
        </p:nvGrpSpPr>
        <p:grpSpPr>
          <a:xfrm>
            <a:off x="1810157" y="2211315"/>
            <a:ext cx="7176980" cy="8800153"/>
            <a:chOff x="2119744" y="615795"/>
            <a:chExt cx="7176980" cy="8800153"/>
          </a:xfrm>
        </p:grpSpPr>
        <p:sp>
          <p:nvSpPr>
            <p:cNvPr id="42" name="正方形/長方形 41"/>
            <p:cNvSpPr/>
            <p:nvPr/>
          </p:nvSpPr>
          <p:spPr>
            <a:xfrm>
              <a:off x="3933187" y="7484511"/>
              <a:ext cx="3380201" cy="1257694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2119744" y="2908374"/>
              <a:ext cx="20761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(Extracellular space)</a:t>
              </a:r>
              <a:endParaRPr kumimoji="1" lang="ja-JP" altLang="en-US" dirty="0"/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6361914" y="4094045"/>
              <a:ext cx="20429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(Intracellular space)</a:t>
              </a:r>
              <a:endParaRPr kumimoji="1" lang="ja-JP" altLang="en-US" dirty="0"/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3845897" y="1668647"/>
              <a:ext cx="8410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/>
                <a:t>NPTN</a:t>
              </a:r>
              <a:r>
                <a:rPr kumimoji="1" lang="en-US" altLang="ja-JP" dirty="0" err="1">
                  <a:latin typeface="Symbol" charset="2"/>
                  <a:cs typeface="Symbol" charset="2"/>
                </a:rPr>
                <a:t>b</a:t>
              </a:r>
              <a:endParaRPr kumimoji="1" lang="ja-JP" altLang="en-US" dirty="0">
                <a:latin typeface="Symbol" charset="2"/>
                <a:cs typeface="Symbol" charset="2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4102841" y="4502745"/>
              <a:ext cx="6981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GRB2</a:t>
              </a:r>
              <a:endParaRPr kumimoji="1" lang="ja-JP" altLang="en-US" dirty="0"/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4137368" y="5066085"/>
              <a:ext cx="54962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RAS</a:t>
              </a:r>
              <a:endParaRPr kumimoji="1" lang="ja-JP" altLang="en-US" dirty="0"/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5492077" y="4480372"/>
              <a:ext cx="7791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TRAF2</a:t>
              </a:r>
              <a:endParaRPr kumimoji="1" lang="ja-JP" altLang="en-US" dirty="0"/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4652915" y="5587262"/>
              <a:ext cx="115939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NFIA/NFIB</a:t>
              </a:r>
              <a:endParaRPr kumimoji="1" lang="ja-JP" altLang="en-US" dirty="0"/>
            </a:p>
          </p:txBody>
        </p:sp>
        <p:sp>
          <p:nvSpPr>
            <p:cNvPr id="62" name="テキスト ボックス 61"/>
            <p:cNvSpPr txBox="1"/>
            <p:nvPr/>
          </p:nvSpPr>
          <p:spPr>
            <a:xfrm>
              <a:off x="4814310" y="6207104"/>
              <a:ext cx="770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SPDEF</a:t>
              </a:r>
              <a:endParaRPr kumimoji="1" lang="ja-JP" altLang="en-US" dirty="0"/>
            </a:p>
          </p:txBody>
        </p:sp>
        <p:cxnSp>
          <p:nvCxnSpPr>
            <p:cNvPr id="17" name="直線コネクタ 16"/>
            <p:cNvCxnSpPr/>
            <p:nvPr/>
          </p:nvCxnSpPr>
          <p:spPr>
            <a:xfrm flipH="1">
              <a:off x="4462725" y="4299396"/>
              <a:ext cx="506847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コネクタ 75"/>
            <p:cNvCxnSpPr/>
            <p:nvPr/>
          </p:nvCxnSpPr>
          <p:spPr>
            <a:xfrm flipH="1">
              <a:off x="5398647" y="4299396"/>
              <a:ext cx="506847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矢印コネクタ 24"/>
            <p:cNvCxnSpPr/>
            <p:nvPr/>
          </p:nvCxnSpPr>
          <p:spPr>
            <a:xfrm>
              <a:off x="4462725" y="4299396"/>
              <a:ext cx="0" cy="28194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線矢印コネクタ 80"/>
            <p:cNvCxnSpPr/>
            <p:nvPr/>
          </p:nvCxnSpPr>
          <p:spPr>
            <a:xfrm>
              <a:off x="5905494" y="4299396"/>
              <a:ext cx="0" cy="28194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線矢印コネクタ 81"/>
            <p:cNvCxnSpPr/>
            <p:nvPr/>
          </p:nvCxnSpPr>
          <p:spPr>
            <a:xfrm flipH="1">
              <a:off x="5585074" y="4849704"/>
              <a:ext cx="277681" cy="737558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線矢印コネクタ 82"/>
            <p:cNvCxnSpPr/>
            <p:nvPr/>
          </p:nvCxnSpPr>
          <p:spPr>
            <a:xfrm>
              <a:off x="4462725" y="4849704"/>
              <a:ext cx="0" cy="28194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線矢印コネクタ 27"/>
            <p:cNvCxnSpPr/>
            <p:nvPr/>
          </p:nvCxnSpPr>
          <p:spPr>
            <a:xfrm>
              <a:off x="4629363" y="5313265"/>
              <a:ext cx="240306" cy="273997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直線矢印コネクタ 85"/>
            <p:cNvCxnSpPr/>
            <p:nvPr/>
          </p:nvCxnSpPr>
          <p:spPr>
            <a:xfrm>
              <a:off x="5199692" y="6611392"/>
              <a:ext cx="0" cy="873119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直線矢印コネクタ 96"/>
            <p:cNvCxnSpPr/>
            <p:nvPr/>
          </p:nvCxnSpPr>
          <p:spPr>
            <a:xfrm>
              <a:off x="5190954" y="5956594"/>
              <a:ext cx="0" cy="28194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テキスト ボックス 131"/>
            <p:cNvSpPr txBox="1"/>
            <p:nvPr/>
          </p:nvSpPr>
          <p:spPr>
            <a:xfrm>
              <a:off x="4255451" y="7488512"/>
              <a:ext cx="2843647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/>
                <a:t>Anchorage independent growth</a:t>
              </a:r>
            </a:p>
            <a:p>
              <a:r>
                <a:rPr kumimoji="1" lang="en-US" altLang="ja-JP" sz="1600" dirty="0"/>
                <a:t>Migration</a:t>
              </a:r>
            </a:p>
            <a:p>
              <a:r>
                <a:rPr kumimoji="1" lang="en-US" altLang="ja-JP" sz="1600" dirty="0"/>
                <a:t>Invasion</a:t>
              </a:r>
              <a:endParaRPr kumimoji="1" lang="ja-JP" altLang="en-US" sz="1600" dirty="0"/>
            </a:p>
          </p:txBody>
        </p:sp>
        <p:sp>
          <p:nvSpPr>
            <p:cNvPr id="40" name="正方形/長方形 39"/>
            <p:cNvSpPr/>
            <p:nvPr/>
          </p:nvSpPr>
          <p:spPr>
            <a:xfrm>
              <a:off x="6547253" y="8954283"/>
              <a:ext cx="2262158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altLang="ja-JP" sz="1200" dirty="0" err="1"/>
                <a:t>Sumardika</a:t>
              </a:r>
              <a:r>
                <a:rPr lang="it-IT" altLang="ja-JP" sz="1200" dirty="0"/>
                <a:t> IW et al. </a:t>
              </a:r>
            </a:p>
            <a:p>
              <a:r>
                <a:rPr lang="it-IT" altLang="ja-JP" sz="1200" dirty="0" err="1"/>
                <a:t>Mol</a:t>
              </a:r>
              <a:r>
                <a:rPr lang="it-IT" altLang="ja-JP" sz="1200" dirty="0"/>
                <a:t> </a:t>
              </a:r>
              <a:r>
                <a:rPr lang="it-IT" altLang="ja-JP" sz="1200" dirty="0" err="1"/>
                <a:t>Carcinog</a:t>
              </a:r>
              <a:r>
                <a:rPr lang="it-IT" altLang="ja-JP" sz="1200" dirty="0"/>
                <a:t>. 58: 980-995, 2019.</a:t>
              </a:r>
              <a:endParaRPr lang="ja-JP" altLang="en-US" sz="1200" dirty="0"/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4173817" y="8309067"/>
              <a:ext cx="300282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b="1" dirty="0"/>
                <a:t>Lung cancer dissemination</a:t>
              </a:r>
              <a:endParaRPr kumimoji="1" lang="ja-JP" altLang="en-US" sz="2000" b="1" dirty="0"/>
            </a:p>
          </p:txBody>
        </p:sp>
        <p:cxnSp>
          <p:nvCxnSpPr>
            <p:cNvPr id="5" name="直線矢印コネクタ 4"/>
            <p:cNvCxnSpPr/>
            <p:nvPr/>
          </p:nvCxnSpPr>
          <p:spPr>
            <a:xfrm flipH="1">
              <a:off x="6176575" y="1031193"/>
              <a:ext cx="370678" cy="373754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テキスト ボックス 8"/>
            <p:cNvSpPr txBox="1"/>
            <p:nvPr/>
          </p:nvSpPr>
          <p:spPr>
            <a:xfrm>
              <a:off x="6483109" y="615795"/>
              <a:ext cx="12319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S100A8/A9</a:t>
              </a:r>
              <a:endParaRPr kumimoji="1" lang="ja-JP" altLang="en-US" dirty="0"/>
            </a:p>
          </p:txBody>
        </p:sp>
        <p:sp>
          <p:nvSpPr>
            <p:cNvPr id="16" name="正方形/長方形 15"/>
            <p:cNvSpPr/>
            <p:nvPr/>
          </p:nvSpPr>
          <p:spPr>
            <a:xfrm>
              <a:off x="6547253" y="1242147"/>
              <a:ext cx="2749471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t-IT" altLang="ja-JP" sz="1200" dirty="0" err="1"/>
                <a:t>Sakaguchi</a:t>
              </a:r>
              <a:r>
                <a:rPr lang="it-IT" altLang="ja-JP" sz="1200" dirty="0"/>
                <a:t> M et al.</a:t>
              </a:r>
            </a:p>
            <a:p>
              <a:r>
                <a:rPr lang="it-IT" altLang="ja-JP" sz="1200" dirty="0" err="1"/>
                <a:t>J</a:t>
              </a:r>
              <a:r>
                <a:rPr lang="it-IT" altLang="ja-JP" sz="1200" dirty="0"/>
                <a:t> </a:t>
              </a:r>
              <a:r>
                <a:rPr lang="it-IT" altLang="ja-JP" sz="1200" dirty="0" err="1"/>
                <a:t>Invest</a:t>
              </a:r>
              <a:r>
                <a:rPr lang="it-IT" altLang="ja-JP" sz="1200" dirty="0"/>
                <a:t> </a:t>
              </a:r>
              <a:r>
                <a:rPr lang="it-IT" altLang="ja-JP" sz="1200" dirty="0" err="1"/>
                <a:t>Dermatol</a:t>
              </a:r>
              <a:r>
                <a:rPr lang="it-IT" altLang="ja-JP" sz="1200" dirty="0"/>
                <a:t>. 136: 2240-2250, 2016.</a:t>
              </a:r>
              <a:endParaRPr lang="ja-JP" altLang="en-US" sz="1200" dirty="0"/>
            </a:p>
          </p:txBody>
        </p:sp>
        <p:grpSp>
          <p:nvGrpSpPr>
            <p:cNvPr id="32" name="図形グループ 31"/>
            <p:cNvGrpSpPr/>
            <p:nvPr/>
          </p:nvGrpSpPr>
          <p:grpSpPr>
            <a:xfrm>
              <a:off x="3933187" y="934731"/>
              <a:ext cx="2791929" cy="4196918"/>
              <a:chOff x="1511033" y="5677283"/>
              <a:chExt cx="2791929" cy="4196918"/>
            </a:xfrm>
          </p:grpSpPr>
          <p:cxnSp>
            <p:nvCxnSpPr>
              <p:cNvPr id="33" name="直線コネクタ 32"/>
              <p:cNvCxnSpPr/>
              <p:nvPr/>
            </p:nvCxnSpPr>
            <p:spPr>
              <a:xfrm>
                <a:off x="1511033" y="8427117"/>
                <a:ext cx="2791929" cy="0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線コネクタ 33"/>
              <p:cNvCxnSpPr/>
              <p:nvPr/>
            </p:nvCxnSpPr>
            <p:spPr>
              <a:xfrm>
                <a:off x="1511033" y="8650795"/>
                <a:ext cx="2791929" cy="0"/>
              </a:xfrm>
              <a:prstGeom prst="line">
                <a:avLst/>
              </a:prstGeom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正方形/長方形 34"/>
              <p:cNvSpPr/>
              <p:nvPr/>
            </p:nvSpPr>
            <p:spPr>
              <a:xfrm>
                <a:off x="2710541" y="8427117"/>
                <a:ext cx="133994" cy="223678"/>
              </a:xfrm>
              <a:prstGeom prst="rect">
                <a:avLst/>
              </a:prstGeom>
              <a:solidFill>
                <a:srgbClr val="000000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36" name="直線コネクタ 35"/>
              <p:cNvCxnSpPr>
                <a:stCxn id="35" idx="2"/>
              </p:cNvCxnSpPr>
              <p:nvPr/>
            </p:nvCxnSpPr>
            <p:spPr>
              <a:xfrm flipH="1">
                <a:off x="2768800" y="8650795"/>
                <a:ext cx="8738" cy="1223406"/>
              </a:xfrm>
              <a:prstGeom prst="line">
                <a:avLst/>
              </a:prstGeom>
              <a:ln w="38100" cmpd="sng"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円/楕円 36"/>
              <p:cNvSpPr/>
              <p:nvPr/>
            </p:nvSpPr>
            <p:spPr>
              <a:xfrm>
                <a:off x="2563944" y="6411199"/>
                <a:ext cx="427187" cy="1007959"/>
              </a:xfrm>
              <a:prstGeom prst="ellipse">
                <a:avLst/>
              </a:prstGeom>
              <a:solidFill>
                <a:srgbClr val="3366FF"/>
              </a:solidFill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8" name="円/楕円 37"/>
              <p:cNvSpPr/>
              <p:nvPr/>
            </p:nvSpPr>
            <p:spPr>
              <a:xfrm>
                <a:off x="2563944" y="7419158"/>
                <a:ext cx="427187" cy="1007959"/>
              </a:xfrm>
              <a:prstGeom prst="ellipse">
                <a:avLst/>
              </a:prstGeom>
              <a:solidFill>
                <a:srgbClr val="FF6600"/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9" name="正方形/長方形 38"/>
              <p:cNvSpPr/>
              <p:nvPr/>
            </p:nvSpPr>
            <p:spPr>
              <a:xfrm>
                <a:off x="2502977" y="5677283"/>
                <a:ext cx="549122" cy="742948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7378159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0188" y="49294"/>
            <a:ext cx="2430473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b="1" dirty="0"/>
              <a:t>Suppl.</a:t>
            </a:r>
            <a:r>
              <a:rPr kumimoji="1" lang="ja-JP" altLang="en-US" sz="3200" b="1" dirty="0"/>
              <a:t> </a:t>
            </a:r>
            <a:r>
              <a:rPr kumimoji="1" lang="en-US" altLang="ja-JP" sz="3200" b="1" dirty="0"/>
              <a:t>Fig.</a:t>
            </a:r>
            <a:r>
              <a:rPr kumimoji="1" lang="ja-JP" altLang="en-US" sz="3200" b="1" dirty="0"/>
              <a:t> </a:t>
            </a:r>
            <a:r>
              <a:rPr kumimoji="1" lang="en-US" altLang="ja-JP" sz="3200" b="1" dirty="0" smtClean="0"/>
              <a:t>S</a:t>
            </a:r>
            <a:r>
              <a:rPr kumimoji="1" lang="en-US" altLang="ja-JP" sz="3200" b="1" dirty="0" smtClean="0"/>
              <a:t>3</a:t>
            </a:r>
            <a:endParaRPr kumimoji="1" lang="ja-JP" altLang="en-US" sz="3200" b="1" dirty="0"/>
          </a:p>
        </p:txBody>
      </p:sp>
      <p:sp>
        <p:nvSpPr>
          <p:cNvPr id="8" name="正方形/長方形 7"/>
          <p:cNvSpPr/>
          <p:nvPr/>
        </p:nvSpPr>
        <p:spPr>
          <a:xfrm>
            <a:off x="1643360" y="1842370"/>
            <a:ext cx="2289859" cy="2494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lnSpc>
                <a:spcPts val="1000"/>
              </a:lnSpc>
            </a:pPr>
            <a:r>
              <a:rPr lang="en-US" altLang="ja-JP" b="1" u="sng" dirty="0">
                <a:cs typeface="Arial" panose="020B0604020202020204" pitchFamily="34" charset="0"/>
              </a:rPr>
              <a:t>PHARMACOGENOMIC</a:t>
            </a:r>
          </a:p>
        </p:txBody>
      </p:sp>
      <p:sp>
        <p:nvSpPr>
          <p:cNvPr id="9" name="正方形/長方形 8"/>
          <p:cNvSpPr/>
          <p:nvPr/>
        </p:nvSpPr>
        <p:spPr>
          <a:xfrm>
            <a:off x="7425771" y="1848643"/>
            <a:ext cx="1299843" cy="2494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lnSpc>
                <a:spcPts val="1000"/>
              </a:lnSpc>
            </a:pPr>
            <a:r>
              <a:rPr lang="en-US" altLang="ja-JP" b="1" u="sng" dirty="0">
                <a:cs typeface="Arial" panose="020B0604020202020204" pitchFamily="34" charset="0"/>
              </a:rPr>
              <a:t>METABOLIC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00520" y="1565010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5817075" y="1565010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grpSp>
        <p:nvGrpSpPr>
          <p:cNvPr id="12" name="グループ化 41">
            <a:extLst>
              <a:ext uri="{FF2B5EF4-FFF2-40B4-BE49-F238E27FC236}">
                <a16:creationId xmlns:a16="http://schemas.microsoft.com/office/drawing/2014/main" xmlns="" id="{EF30D734-AE6B-486A-8011-499730296FD2}"/>
              </a:ext>
            </a:extLst>
          </p:cNvPr>
          <p:cNvGrpSpPr/>
          <p:nvPr/>
        </p:nvGrpSpPr>
        <p:grpSpPr>
          <a:xfrm>
            <a:off x="1667686" y="9615428"/>
            <a:ext cx="2083218" cy="629260"/>
            <a:chOff x="1153701" y="7842250"/>
            <a:chExt cx="2083218" cy="629260"/>
          </a:xfrm>
        </p:grpSpPr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xmlns="" id="{AA8D2C10-95C3-4353-88CD-4A8384E35844}"/>
                </a:ext>
              </a:extLst>
            </p:cNvPr>
            <p:cNvCxnSpPr/>
            <p:nvPr/>
          </p:nvCxnSpPr>
          <p:spPr>
            <a:xfrm rot="5400000" flipV="1">
              <a:off x="3047524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xmlns="" id="{CB3E687A-75C6-4953-AEF0-A9E0055F2714}"/>
                </a:ext>
              </a:extLst>
            </p:cNvPr>
            <p:cNvCxnSpPr/>
            <p:nvPr/>
          </p:nvCxnSpPr>
          <p:spPr>
            <a:xfrm rot="5400000" flipV="1">
              <a:off x="2173260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xmlns="" id="{1C2576F2-A9CE-4272-A807-F95BBCC1D9D7}"/>
                </a:ext>
              </a:extLst>
            </p:cNvPr>
            <p:cNvCxnSpPr/>
            <p:nvPr/>
          </p:nvCxnSpPr>
          <p:spPr>
            <a:xfrm rot="5400000" flipV="1">
              <a:off x="1298999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xmlns="" id="{F71FBE79-FE7D-484F-8F57-EC4F97F996F1}"/>
                </a:ext>
              </a:extLst>
            </p:cNvPr>
            <p:cNvCxnSpPr/>
            <p:nvPr/>
          </p:nvCxnSpPr>
          <p:spPr>
            <a:xfrm rot="5400000" flipV="1">
              <a:off x="2522966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xmlns="" id="{0A5AE046-4D79-4BBB-8C99-B63FBEEBDDCA}"/>
                </a:ext>
              </a:extLst>
            </p:cNvPr>
            <p:cNvCxnSpPr/>
            <p:nvPr/>
          </p:nvCxnSpPr>
          <p:spPr>
            <a:xfrm rot="5400000" flipV="1">
              <a:off x="1823555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xmlns="" id="{8C2562B2-254D-401F-80DB-58FC66242B1B}"/>
                </a:ext>
              </a:extLst>
            </p:cNvPr>
            <p:cNvCxnSpPr/>
            <p:nvPr/>
          </p:nvCxnSpPr>
          <p:spPr>
            <a:xfrm rot="5400000" flipV="1">
              <a:off x="1473851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xmlns="" id="{987EAC42-C346-4D21-9028-8C12069FE7DE}"/>
                </a:ext>
              </a:extLst>
            </p:cNvPr>
            <p:cNvCxnSpPr/>
            <p:nvPr/>
          </p:nvCxnSpPr>
          <p:spPr>
            <a:xfrm rot="5400000" flipV="1">
              <a:off x="1998407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xmlns="" id="{E2C0346D-A7BD-4B10-A9D4-15AB683A85F6}"/>
                </a:ext>
              </a:extLst>
            </p:cNvPr>
            <p:cNvCxnSpPr/>
            <p:nvPr/>
          </p:nvCxnSpPr>
          <p:spPr>
            <a:xfrm rot="5400000" flipV="1">
              <a:off x="2872672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xmlns="" id="{6F48866C-5992-4D78-AF2A-06E8568DF640}"/>
                </a:ext>
              </a:extLst>
            </p:cNvPr>
            <p:cNvCxnSpPr/>
            <p:nvPr/>
          </p:nvCxnSpPr>
          <p:spPr>
            <a:xfrm rot="5400000" flipV="1">
              <a:off x="2348113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xmlns="" id="{EBE6DB8C-A79F-45CE-B819-24AD5E452819}"/>
                </a:ext>
              </a:extLst>
            </p:cNvPr>
            <p:cNvCxnSpPr/>
            <p:nvPr/>
          </p:nvCxnSpPr>
          <p:spPr>
            <a:xfrm rot="5400000" flipV="1">
              <a:off x="1648703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xmlns="" id="{AC6AEE98-850E-445F-AD95-4E7682D25623}"/>
                </a:ext>
              </a:extLst>
            </p:cNvPr>
            <p:cNvCxnSpPr/>
            <p:nvPr/>
          </p:nvCxnSpPr>
          <p:spPr>
            <a:xfrm rot="5400000" flipV="1">
              <a:off x="2697819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xmlns="" id="{FA8AA930-95D6-4EC0-848E-63ADAC7C884D}"/>
                </a:ext>
              </a:extLst>
            </p:cNvPr>
            <p:cNvSpPr txBox="1"/>
            <p:nvPr/>
          </p:nvSpPr>
          <p:spPr>
            <a:xfrm>
              <a:off x="1153701" y="8012996"/>
              <a:ext cx="3214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>
                  <a:cs typeface="Arial" panose="020B0604020202020204" pitchFamily="34" charset="0"/>
                </a:rPr>
                <a:t>-5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xmlns="" id="{9343F632-CBD9-4C0D-BA33-0B1CC8167FFB}"/>
                </a:ext>
              </a:extLst>
            </p:cNvPr>
            <p:cNvSpPr txBox="1"/>
            <p:nvPr/>
          </p:nvSpPr>
          <p:spPr>
            <a:xfrm>
              <a:off x="2966668" y="801299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>
                  <a:cs typeface="Arial" panose="020B0604020202020204" pitchFamily="34" charset="0"/>
                </a:rPr>
                <a:t>5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xmlns="" id="{8F60A88F-8EA4-43BB-B72F-2A7B132DEC58}"/>
                </a:ext>
              </a:extLst>
            </p:cNvPr>
            <p:cNvSpPr txBox="1"/>
            <p:nvPr/>
          </p:nvSpPr>
          <p:spPr>
            <a:xfrm>
              <a:off x="2080155" y="801299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>
                  <a:cs typeface="Arial" panose="020B0604020202020204" pitchFamily="34" charset="0"/>
                </a:rPr>
                <a:t>0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xmlns="" id="{B4EA13CD-876A-4727-B546-901CD6D18E99}"/>
                </a:ext>
              </a:extLst>
            </p:cNvPr>
            <p:cNvSpPr txBox="1"/>
            <p:nvPr/>
          </p:nvSpPr>
          <p:spPr>
            <a:xfrm>
              <a:off x="1678749" y="8194511"/>
              <a:ext cx="10704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cs typeface="Arial" panose="020B0604020202020204" pitchFamily="34" charset="0"/>
                </a:rPr>
                <a:t>log2</a:t>
              </a:r>
              <a:r>
                <a:rPr kumimoji="1" lang="en-US" altLang="ja-JP" sz="1200" baseline="-25000" dirty="0">
                  <a:cs typeface="Arial" panose="020B0604020202020204" pitchFamily="34" charset="0"/>
                </a:rPr>
                <a:t> </a:t>
              </a:r>
              <a:r>
                <a:rPr kumimoji="1" lang="en-US" altLang="ja-JP" sz="1200" dirty="0">
                  <a:cs typeface="Arial" panose="020B0604020202020204" pitchFamily="34" charset="0"/>
                </a:rPr>
                <a:t>(M value)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pic>
          <p:nvPicPr>
            <p:cNvPr id="28" name="図 27">
              <a:extLst>
                <a:ext uri="{FF2B5EF4-FFF2-40B4-BE49-F238E27FC236}">
                  <a16:creationId xmlns:a16="http://schemas.microsoft.com/office/drawing/2014/main" xmlns="" id="{2B9B3070-42DE-40F6-9547-68BDDCFD6C6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14450" y="7842250"/>
              <a:ext cx="1800000" cy="107570"/>
            </a:xfrm>
            <a:prstGeom prst="rect">
              <a:avLst/>
            </a:prstGeom>
          </p:spPr>
        </p:pic>
      </p:grpSp>
      <p:grpSp>
        <p:nvGrpSpPr>
          <p:cNvPr id="29" name="グループ化 43">
            <a:extLst>
              <a:ext uri="{FF2B5EF4-FFF2-40B4-BE49-F238E27FC236}">
                <a16:creationId xmlns:a16="http://schemas.microsoft.com/office/drawing/2014/main" xmlns="" id="{D6C1ED0F-A860-4065-AFF8-811CDEC1696C}"/>
              </a:ext>
            </a:extLst>
          </p:cNvPr>
          <p:cNvGrpSpPr/>
          <p:nvPr/>
        </p:nvGrpSpPr>
        <p:grpSpPr>
          <a:xfrm>
            <a:off x="7065510" y="13458423"/>
            <a:ext cx="2083218" cy="629260"/>
            <a:chOff x="1153701" y="7842250"/>
            <a:chExt cx="2083218" cy="629260"/>
          </a:xfrm>
        </p:grpSpPr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xmlns="" id="{B5A49574-6C75-4325-85B7-DE95FF80FBE3}"/>
                </a:ext>
              </a:extLst>
            </p:cNvPr>
            <p:cNvCxnSpPr/>
            <p:nvPr/>
          </p:nvCxnSpPr>
          <p:spPr>
            <a:xfrm rot="5400000" flipV="1">
              <a:off x="3047524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xmlns="" id="{E4158207-CE81-4611-9073-F23DF093DD5B}"/>
                </a:ext>
              </a:extLst>
            </p:cNvPr>
            <p:cNvCxnSpPr/>
            <p:nvPr/>
          </p:nvCxnSpPr>
          <p:spPr>
            <a:xfrm rot="5400000" flipV="1">
              <a:off x="2173260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xmlns="" id="{B8B8903A-9645-46D3-B0D6-754DD0432E73}"/>
                </a:ext>
              </a:extLst>
            </p:cNvPr>
            <p:cNvCxnSpPr/>
            <p:nvPr/>
          </p:nvCxnSpPr>
          <p:spPr>
            <a:xfrm rot="5400000" flipV="1">
              <a:off x="1298999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xmlns="" id="{74C8D10C-5FEE-4B47-B839-7B8425173963}"/>
                </a:ext>
              </a:extLst>
            </p:cNvPr>
            <p:cNvCxnSpPr/>
            <p:nvPr/>
          </p:nvCxnSpPr>
          <p:spPr>
            <a:xfrm rot="5400000" flipV="1">
              <a:off x="2522966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xmlns="" id="{7E4DA0C2-82A7-478D-B73E-8189698919D1}"/>
                </a:ext>
              </a:extLst>
            </p:cNvPr>
            <p:cNvCxnSpPr/>
            <p:nvPr/>
          </p:nvCxnSpPr>
          <p:spPr>
            <a:xfrm rot="5400000" flipV="1">
              <a:off x="1823555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xmlns="" id="{CD2F0EB9-FB92-450D-835C-7321865274F7}"/>
                </a:ext>
              </a:extLst>
            </p:cNvPr>
            <p:cNvCxnSpPr/>
            <p:nvPr/>
          </p:nvCxnSpPr>
          <p:spPr>
            <a:xfrm rot="5400000" flipV="1">
              <a:off x="1473851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xmlns="" id="{0BC84CBF-A316-40BD-A4E4-6AD2A1D244D3}"/>
                </a:ext>
              </a:extLst>
            </p:cNvPr>
            <p:cNvCxnSpPr/>
            <p:nvPr/>
          </p:nvCxnSpPr>
          <p:spPr>
            <a:xfrm rot="5400000" flipV="1">
              <a:off x="1998407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xmlns="" id="{1DF98706-9DCC-433C-ACD1-75F8C5BB6DF3}"/>
                </a:ext>
              </a:extLst>
            </p:cNvPr>
            <p:cNvCxnSpPr/>
            <p:nvPr/>
          </p:nvCxnSpPr>
          <p:spPr>
            <a:xfrm rot="5400000" flipV="1">
              <a:off x="2872672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xmlns="" id="{1170A162-986D-4C20-990F-06B07623D074}"/>
                </a:ext>
              </a:extLst>
            </p:cNvPr>
            <p:cNvCxnSpPr/>
            <p:nvPr/>
          </p:nvCxnSpPr>
          <p:spPr>
            <a:xfrm rot="5400000" flipV="1">
              <a:off x="2348113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xmlns="" id="{7D1593D4-3089-47F9-AC48-D1AA379319D6}"/>
                </a:ext>
              </a:extLst>
            </p:cNvPr>
            <p:cNvCxnSpPr/>
            <p:nvPr/>
          </p:nvCxnSpPr>
          <p:spPr>
            <a:xfrm rot="5400000" flipV="1">
              <a:off x="1648703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xmlns="" id="{9CA32AAE-BAA7-4805-B45C-E04BBCD3DC2A}"/>
                </a:ext>
              </a:extLst>
            </p:cNvPr>
            <p:cNvCxnSpPr/>
            <p:nvPr/>
          </p:nvCxnSpPr>
          <p:spPr>
            <a:xfrm rot="5400000" flipV="1">
              <a:off x="2697819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xmlns="" id="{49F6AD28-B7AA-4BBA-B91F-6F19B900BBC2}"/>
                </a:ext>
              </a:extLst>
            </p:cNvPr>
            <p:cNvSpPr txBox="1"/>
            <p:nvPr/>
          </p:nvSpPr>
          <p:spPr>
            <a:xfrm>
              <a:off x="1153701" y="8012996"/>
              <a:ext cx="3214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>
                  <a:cs typeface="Arial" panose="020B0604020202020204" pitchFamily="34" charset="0"/>
                </a:rPr>
                <a:t>-5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xmlns="" id="{F4BCFB57-E9DF-48C0-83C7-E065B22B98FB}"/>
                </a:ext>
              </a:extLst>
            </p:cNvPr>
            <p:cNvSpPr txBox="1"/>
            <p:nvPr/>
          </p:nvSpPr>
          <p:spPr>
            <a:xfrm>
              <a:off x="2966668" y="801299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>
                  <a:cs typeface="Arial" panose="020B0604020202020204" pitchFamily="34" charset="0"/>
                </a:rPr>
                <a:t>5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xmlns="" id="{EFAF6946-4B51-4B19-AA5E-25B6FD64E78B}"/>
                </a:ext>
              </a:extLst>
            </p:cNvPr>
            <p:cNvSpPr txBox="1"/>
            <p:nvPr/>
          </p:nvSpPr>
          <p:spPr>
            <a:xfrm>
              <a:off x="2080155" y="801299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>
                  <a:cs typeface="Arial" panose="020B0604020202020204" pitchFamily="34" charset="0"/>
                </a:rPr>
                <a:t>0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xmlns="" id="{173680AA-75B5-46F9-9C3B-F5701ABD370E}"/>
                </a:ext>
              </a:extLst>
            </p:cNvPr>
            <p:cNvSpPr txBox="1"/>
            <p:nvPr/>
          </p:nvSpPr>
          <p:spPr>
            <a:xfrm>
              <a:off x="1678749" y="8194511"/>
              <a:ext cx="10704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cs typeface="Arial" panose="020B0604020202020204" pitchFamily="34" charset="0"/>
                </a:rPr>
                <a:t>log2</a:t>
              </a:r>
              <a:r>
                <a:rPr kumimoji="1" lang="en-US" altLang="ja-JP" sz="1200" baseline="-25000" dirty="0">
                  <a:cs typeface="Arial" panose="020B0604020202020204" pitchFamily="34" charset="0"/>
                </a:rPr>
                <a:t> </a:t>
              </a:r>
              <a:r>
                <a:rPr kumimoji="1" lang="en-US" altLang="ja-JP" sz="1200" dirty="0">
                  <a:cs typeface="Arial" panose="020B0604020202020204" pitchFamily="34" charset="0"/>
                </a:rPr>
                <a:t>(M value)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pic>
          <p:nvPicPr>
            <p:cNvPr id="46" name="図 45">
              <a:extLst>
                <a:ext uri="{FF2B5EF4-FFF2-40B4-BE49-F238E27FC236}">
                  <a16:creationId xmlns:a16="http://schemas.microsoft.com/office/drawing/2014/main" xmlns="" id="{A74EBE1C-79A3-4D63-8CD8-88D3C5EC43A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14450" y="7842250"/>
              <a:ext cx="1800000" cy="107570"/>
            </a:xfrm>
            <a:prstGeom prst="rect">
              <a:avLst/>
            </a:prstGeom>
          </p:spPr>
        </p:pic>
      </p:grpSp>
      <p:pic>
        <p:nvPicPr>
          <p:cNvPr id="47" name="図 46">
            <a:extLst>
              <a:ext uri="{FF2B5EF4-FFF2-40B4-BE49-F238E27FC236}">
                <a16:creationId xmlns:a16="http://schemas.microsoft.com/office/drawing/2014/main" xmlns="" id="{1EF24F23-9D10-4B0D-A629-023C4AA5E39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17676" y="2410882"/>
            <a:ext cx="655200" cy="6892800"/>
          </a:xfrm>
          <a:prstGeom prst="rect">
            <a:avLst/>
          </a:prstGeom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xmlns="" id="{DFF41C34-1D8F-4F92-A9B8-4848F22A4A5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66228" y="2410882"/>
            <a:ext cx="655200" cy="6462671"/>
          </a:xfrm>
          <a:prstGeom prst="rect">
            <a:avLst/>
          </a:prstGeom>
        </p:spPr>
      </p:pic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xmlns="" id="{793E2F82-3670-45DB-916B-2748B0757BAE}"/>
              </a:ext>
            </a:extLst>
          </p:cNvPr>
          <p:cNvSpPr/>
          <p:nvPr/>
        </p:nvSpPr>
        <p:spPr>
          <a:xfrm>
            <a:off x="440521" y="2358541"/>
            <a:ext cx="1321786" cy="70547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ts val="1700"/>
              </a:lnSpc>
            </a:pPr>
            <a:r>
              <a:rPr lang="en-US" altLang="ja-JP" sz="1200" b="1" dirty="0"/>
              <a:t>ABCC6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KR1B10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NXA4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SS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ES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FI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PS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YP4F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CGBP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GPX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HNF1A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ITG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ITGB4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MAP2K6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MGLL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MYO1D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NAMPT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LCD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RARB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RIPK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HROOM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TARD1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10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4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5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6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7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8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9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VAV3</a:t>
            </a:r>
          </a:p>
        </p:txBody>
      </p: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xmlns="" id="{4CE84996-2C1F-4D41-BCD5-EABE9E06D267}"/>
              </a:ext>
            </a:extLst>
          </p:cNvPr>
          <p:cNvSpPr/>
          <p:nvPr/>
        </p:nvSpPr>
        <p:spPr>
          <a:xfrm>
            <a:off x="1829983" y="2358541"/>
            <a:ext cx="1457760" cy="66187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ts val="1700"/>
              </a:lnSpc>
            </a:pPr>
            <a:r>
              <a:rPr lang="en-US" altLang="ja-JP" sz="1200" b="1" dirty="0"/>
              <a:t>ANGPTL4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BCHE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BDNF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BMP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ADM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CL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OL4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OL4A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SF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XCL8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DIO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ECE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2R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2RL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BN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BN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GB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HAS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ITGB5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KITLG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LMAN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MGAT5B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MT2A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NFE2L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CDH9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DGFC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TGES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XDN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1PR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ERPINE1</a:t>
            </a:r>
          </a:p>
        </p:txBody>
      </p:sp>
      <p:pic>
        <p:nvPicPr>
          <p:cNvPr id="51" name="図 50">
            <a:extLst>
              <a:ext uri="{FF2B5EF4-FFF2-40B4-BE49-F238E27FC236}">
                <a16:creationId xmlns:a16="http://schemas.microsoft.com/office/drawing/2014/main" xmlns="" id="{6F5F305B-5F40-4351-B228-2C27DF7EADA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78598" y="2410882"/>
            <a:ext cx="655200" cy="8398246"/>
          </a:xfrm>
          <a:prstGeom prst="rect">
            <a:avLst/>
          </a:prstGeom>
        </p:spPr>
      </p:pic>
      <p:pic>
        <p:nvPicPr>
          <p:cNvPr id="52" name="図 51">
            <a:extLst>
              <a:ext uri="{FF2B5EF4-FFF2-40B4-BE49-F238E27FC236}">
                <a16:creationId xmlns:a16="http://schemas.microsoft.com/office/drawing/2014/main" xmlns="" id="{7261C298-1BE8-4177-BED5-4659D731BDA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29722" y="2410882"/>
            <a:ext cx="655200" cy="10333822"/>
          </a:xfrm>
          <a:prstGeom prst="rect">
            <a:avLst/>
          </a:prstGeom>
        </p:spPr>
      </p:pic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xmlns="" id="{1220C1C4-4784-44F4-BB59-9804B1A71B56}"/>
              </a:ext>
            </a:extLst>
          </p:cNvPr>
          <p:cNvSpPr/>
          <p:nvPr/>
        </p:nvSpPr>
        <p:spPr>
          <a:xfrm>
            <a:off x="5563268" y="2358541"/>
            <a:ext cx="1420151" cy="85808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ts val="1700"/>
              </a:lnSpc>
            </a:pPr>
            <a:r>
              <a:rPr lang="en-US" altLang="ja-JP" sz="1200" b="1" dirty="0"/>
              <a:t>ABCC6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DAMTS9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KR1B15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RRB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SS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FI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OBL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ORO2A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PS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EPB41L4A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GNG4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H19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HNF1A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IGFBP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ITG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KLF1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KLF5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MGLL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MYO1D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NAMPT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OAS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ART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KDCC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LS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RAP1GAP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RARB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HROOM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TARD1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YBU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TM4SF4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TNS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4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6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7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8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9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VAV3</a:t>
            </a:r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xmlns="" id="{8AFFC65F-B498-4F39-92B1-7D87B3DBEF5D}"/>
              </a:ext>
            </a:extLst>
          </p:cNvPr>
          <p:cNvSpPr/>
          <p:nvPr/>
        </p:nvSpPr>
        <p:spPr>
          <a:xfrm>
            <a:off x="7506449" y="2358541"/>
            <a:ext cx="1238618" cy="10542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ts val="1700"/>
              </a:lnSpc>
            </a:pPr>
            <a:r>
              <a:rPr lang="en-US" altLang="ja-JP" sz="1200" b="1" dirty="0"/>
              <a:t>ADAM19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DAMTS15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DGRG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KAP1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NGPTL4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TP8B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TRNL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BCAM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BCHE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BDNF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BMP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BMP5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ADM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CL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OL18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OL4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OL4A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SF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TGF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XCL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XCL8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DIO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DIP2A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ECE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BN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BN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GB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ST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STL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GFR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HAS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IGFBP7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LAMA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LTBP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MGAT5B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MT2A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CDH9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CDHB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MEP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RSS2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RPS18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EMA3A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ERPINE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LC2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OX4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TENM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THSD4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NC5D</a:t>
            </a:r>
          </a:p>
        </p:txBody>
      </p:sp>
    </p:spTree>
    <p:extLst>
      <p:ext uri="{BB962C8B-B14F-4D97-AF65-F5344CB8AC3E}">
        <p14:creationId xmlns:p14="http://schemas.microsoft.com/office/powerpoint/2010/main" val="23441047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0188" y="49294"/>
            <a:ext cx="2430473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b="1" dirty="0"/>
              <a:t>Suppl.</a:t>
            </a:r>
            <a:r>
              <a:rPr kumimoji="1" lang="ja-JP" altLang="en-US" sz="3200" b="1" dirty="0"/>
              <a:t> </a:t>
            </a:r>
            <a:r>
              <a:rPr kumimoji="1" lang="en-US" altLang="ja-JP" sz="3200" b="1" dirty="0"/>
              <a:t>Fig.</a:t>
            </a:r>
            <a:r>
              <a:rPr kumimoji="1" lang="ja-JP" altLang="en-US" sz="3200" b="1" dirty="0"/>
              <a:t> </a:t>
            </a:r>
            <a:r>
              <a:rPr kumimoji="1" lang="en-US" altLang="ja-JP" sz="3200" b="1" dirty="0" smtClean="0"/>
              <a:t>S</a:t>
            </a:r>
            <a:r>
              <a:rPr kumimoji="1" lang="en-US" altLang="ja-JP" sz="3200" b="1" dirty="0" smtClean="0"/>
              <a:t>3</a:t>
            </a:r>
            <a:endParaRPr kumimoji="1" lang="ja-JP" altLang="en-US" sz="3200" b="1" dirty="0"/>
          </a:p>
        </p:txBody>
      </p:sp>
      <p:sp>
        <p:nvSpPr>
          <p:cNvPr id="8" name="正方形/長方形 7"/>
          <p:cNvSpPr/>
          <p:nvPr/>
        </p:nvSpPr>
        <p:spPr>
          <a:xfrm>
            <a:off x="2118330" y="1802373"/>
            <a:ext cx="816249" cy="2494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lnSpc>
                <a:spcPts val="1000"/>
              </a:lnSpc>
            </a:pPr>
            <a:r>
              <a:rPr lang="en-US" altLang="ja-JP" b="1" u="sng" dirty="0">
                <a:cs typeface="Arial" panose="020B0604020202020204" pitchFamily="34" charset="0"/>
              </a:rPr>
              <a:t>RENAL</a:t>
            </a:r>
          </a:p>
        </p:txBody>
      </p:sp>
      <p:sp>
        <p:nvSpPr>
          <p:cNvPr id="9" name="正方形/長方形 8"/>
          <p:cNvSpPr/>
          <p:nvPr/>
        </p:nvSpPr>
        <p:spPr>
          <a:xfrm>
            <a:off x="7246924" y="1802373"/>
            <a:ext cx="1946110" cy="2494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lnSpc>
                <a:spcPts val="1000"/>
              </a:lnSpc>
            </a:pPr>
            <a:r>
              <a:rPr lang="en-US" altLang="ja-JP" b="1" u="sng" dirty="0">
                <a:cs typeface="Arial" panose="020B0604020202020204" pitchFamily="34" charset="0"/>
              </a:rPr>
              <a:t>CARDIOVASCULAR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605631" y="1442327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</a:t>
            </a:r>
            <a:endParaRPr kumimoji="1" lang="ja-JP" altLang="en-US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5817075" y="1442327"/>
            <a:ext cx="32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D</a:t>
            </a:r>
            <a:endParaRPr kumimoji="1" lang="ja-JP" altLang="en-US" dirty="0"/>
          </a:p>
        </p:txBody>
      </p:sp>
      <p:grpSp>
        <p:nvGrpSpPr>
          <p:cNvPr id="12" name="グループ化 7">
            <a:extLst>
              <a:ext uri="{FF2B5EF4-FFF2-40B4-BE49-F238E27FC236}">
                <a16:creationId xmlns:a16="http://schemas.microsoft.com/office/drawing/2014/main" xmlns="" id="{5D686E05-0FBB-4A02-B42F-72A386E1476A}"/>
              </a:ext>
            </a:extLst>
          </p:cNvPr>
          <p:cNvGrpSpPr/>
          <p:nvPr/>
        </p:nvGrpSpPr>
        <p:grpSpPr>
          <a:xfrm>
            <a:off x="7334584" y="12678449"/>
            <a:ext cx="2083218" cy="629260"/>
            <a:chOff x="1153701" y="7842250"/>
            <a:chExt cx="2083218" cy="629260"/>
          </a:xfrm>
        </p:grpSpPr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xmlns="" id="{6A63FDEC-4087-4D85-A797-F190913C7880}"/>
                </a:ext>
              </a:extLst>
            </p:cNvPr>
            <p:cNvCxnSpPr/>
            <p:nvPr/>
          </p:nvCxnSpPr>
          <p:spPr>
            <a:xfrm rot="5400000" flipV="1">
              <a:off x="3047524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xmlns="" id="{384F49D6-7961-4040-B2F5-B62EFC478C75}"/>
                </a:ext>
              </a:extLst>
            </p:cNvPr>
            <p:cNvCxnSpPr/>
            <p:nvPr/>
          </p:nvCxnSpPr>
          <p:spPr>
            <a:xfrm rot="5400000" flipV="1">
              <a:off x="2173260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xmlns="" id="{0B167B4B-5CDB-4D1D-A612-6F0E36F4653A}"/>
                </a:ext>
              </a:extLst>
            </p:cNvPr>
            <p:cNvCxnSpPr/>
            <p:nvPr/>
          </p:nvCxnSpPr>
          <p:spPr>
            <a:xfrm rot="5400000" flipV="1">
              <a:off x="1298999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xmlns="" id="{ECAA211C-AE1B-48AC-80FA-FE0F786CECB0}"/>
                </a:ext>
              </a:extLst>
            </p:cNvPr>
            <p:cNvCxnSpPr/>
            <p:nvPr/>
          </p:nvCxnSpPr>
          <p:spPr>
            <a:xfrm rot="5400000" flipV="1">
              <a:off x="2522966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xmlns="" id="{8DEF4AB2-7193-4177-AF5D-E5574639BA8C}"/>
                </a:ext>
              </a:extLst>
            </p:cNvPr>
            <p:cNvCxnSpPr/>
            <p:nvPr/>
          </p:nvCxnSpPr>
          <p:spPr>
            <a:xfrm rot="5400000" flipV="1">
              <a:off x="1823555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xmlns="" id="{B89C4643-EBF0-423C-ADB1-C755BBAD0F39}"/>
                </a:ext>
              </a:extLst>
            </p:cNvPr>
            <p:cNvCxnSpPr/>
            <p:nvPr/>
          </p:nvCxnSpPr>
          <p:spPr>
            <a:xfrm rot="5400000" flipV="1">
              <a:off x="1473851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xmlns="" id="{E2DAC5FD-2F38-4A51-8ACB-9E764E161290}"/>
                </a:ext>
              </a:extLst>
            </p:cNvPr>
            <p:cNvCxnSpPr/>
            <p:nvPr/>
          </p:nvCxnSpPr>
          <p:spPr>
            <a:xfrm rot="5400000" flipV="1">
              <a:off x="1998407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xmlns="" id="{1517EF46-19A9-451D-B46D-7C5A18A159A8}"/>
                </a:ext>
              </a:extLst>
            </p:cNvPr>
            <p:cNvCxnSpPr/>
            <p:nvPr/>
          </p:nvCxnSpPr>
          <p:spPr>
            <a:xfrm rot="5400000" flipV="1">
              <a:off x="2872672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xmlns="" id="{2977756F-B008-4A91-ADB2-C927AB8D5615}"/>
                </a:ext>
              </a:extLst>
            </p:cNvPr>
            <p:cNvCxnSpPr/>
            <p:nvPr/>
          </p:nvCxnSpPr>
          <p:spPr>
            <a:xfrm rot="5400000" flipV="1">
              <a:off x="2348113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xmlns="" id="{D3D2264F-C9E1-47A9-8CF8-038EFD25EC82}"/>
                </a:ext>
              </a:extLst>
            </p:cNvPr>
            <p:cNvCxnSpPr/>
            <p:nvPr/>
          </p:nvCxnSpPr>
          <p:spPr>
            <a:xfrm rot="5400000" flipV="1">
              <a:off x="1648703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xmlns="" id="{71DCD78D-DE36-4FB2-BE25-92F001EFC780}"/>
                </a:ext>
              </a:extLst>
            </p:cNvPr>
            <p:cNvCxnSpPr/>
            <p:nvPr/>
          </p:nvCxnSpPr>
          <p:spPr>
            <a:xfrm rot="5400000" flipV="1">
              <a:off x="2697819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xmlns="" id="{B8A0BC42-AF67-481D-99E8-A097EC8A320F}"/>
                </a:ext>
              </a:extLst>
            </p:cNvPr>
            <p:cNvSpPr txBox="1"/>
            <p:nvPr/>
          </p:nvSpPr>
          <p:spPr>
            <a:xfrm>
              <a:off x="1153701" y="8012996"/>
              <a:ext cx="3214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>
                  <a:cs typeface="Arial" panose="020B0604020202020204" pitchFamily="34" charset="0"/>
                </a:rPr>
                <a:t>-5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xmlns="" id="{07BC5077-0533-4D3B-9544-D4DF8EAC182B}"/>
                </a:ext>
              </a:extLst>
            </p:cNvPr>
            <p:cNvSpPr txBox="1"/>
            <p:nvPr/>
          </p:nvSpPr>
          <p:spPr>
            <a:xfrm>
              <a:off x="2966668" y="801299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>
                  <a:cs typeface="Arial" panose="020B0604020202020204" pitchFamily="34" charset="0"/>
                </a:rPr>
                <a:t>5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xmlns="" id="{1B612375-C86B-4C50-9D06-3DFF8FEE63A5}"/>
                </a:ext>
              </a:extLst>
            </p:cNvPr>
            <p:cNvSpPr txBox="1"/>
            <p:nvPr/>
          </p:nvSpPr>
          <p:spPr>
            <a:xfrm>
              <a:off x="2080155" y="801299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>
                  <a:cs typeface="Arial" panose="020B0604020202020204" pitchFamily="34" charset="0"/>
                </a:rPr>
                <a:t>0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xmlns="" id="{7FBDA802-2215-4DF4-B5F3-9816494FC676}"/>
                </a:ext>
              </a:extLst>
            </p:cNvPr>
            <p:cNvSpPr txBox="1"/>
            <p:nvPr/>
          </p:nvSpPr>
          <p:spPr>
            <a:xfrm>
              <a:off x="1678749" y="8194511"/>
              <a:ext cx="10704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cs typeface="Arial" panose="020B0604020202020204" pitchFamily="34" charset="0"/>
                </a:rPr>
                <a:t>log2</a:t>
              </a:r>
              <a:r>
                <a:rPr kumimoji="1" lang="en-US" altLang="ja-JP" sz="1200" baseline="-25000" dirty="0">
                  <a:cs typeface="Arial" panose="020B0604020202020204" pitchFamily="34" charset="0"/>
                </a:rPr>
                <a:t> </a:t>
              </a:r>
              <a:r>
                <a:rPr kumimoji="1" lang="en-US" altLang="ja-JP" sz="1200" dirty="0">
                  <a:cs typeface="Arial" panose="020B0604020202020204" pitchFamily="34" charset="0"/>
                </a:rPr>
                <a:t>(M value)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pic>
          <p:nvPicPr>
            <p:cNvPr id="28" name="図 27">
              <a:extLst>
                <a:ext uri="{FF2B5EF4-FFF2-40B4-BE49-F238E27FC236}">
                  <a16:creationId xmlns:a16="http://schemas.microsoft.com/office/drawing/2014/main" xmlns="" id="{654D3D46-35BF-4009-A6AE-ACF88397101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14450" y="7842250"/>
              <a:ext cx="1800000" cy="107570"/>
            </a:xfrm>
            <a:prstGeom prst="rect">
              <a:avLst/>
            </a:prstGeom>
          </p:spPr>
        </p:pic>
      </p:grpSp>
      <p:grpSp>
        <p:nvGrpSpPr>
          <p:cNvPr id="29" name="グループ化 24">
            <a:extLst>
              <a:ext uri="{FF2B5EF4-FFF2-40B4-BE49-F238E27FC236}">
                <a16:creationId xmlns:a16="http://schemas.microsoft.com/office/drawing/2014/main" xmlns="" id="{97AFF29E-3CBF-4DD7-847F-52CAEF1989F1}"/>
              </a:ext>
            </a:extLst>
          </p:cNvPr>
          <p:cNvGrpSpPr/>
          <p:nvPr/>
        </p:nvGrpSpPr>
        <p:grpSpPr>
          <a:xfrm>
            <a:off x="1525015" y="7333186"/>
            <a:ext cx="2083218" cy="629260"/>
            <a:chOff x="1153701" y="7842250"/>
            <a:chExt cx="2083218" cy="629260"/>
          </a:xfrm>
        </p:grpSpPr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xmlns="" id="{B84F0938-5DBA-49E4-93C6-084181F8D247}"/>
                </a:ext>
              </a:extLst>
            </p:cNvPr>
            <p:cNvCxnSpPr/>
            <p:nvPr/>
          </p:nvCxnSpPr>
          <p:spPr>
            <a:xfrm rot="5400000" flipV="1">
              <a:off x="3047524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xmlns="" id="{22E1DFB1-AC31-4BD3-B4D8-AF20D0607B5F}"/>
                </a:ext>
              </a:extLst>
            </p:cNvPr>
            <p:cNvCxnSpPr/>
            <p:nvPr/>
          </p:nvCxnSpPr>
          <p:spPr>
            <a:xfrm rot="5400000" flipV="1">
              <a:off x="2173260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xmlns="" id="{7EF4F75F-365E-4E33-BE71-6A29C4A9CED2}"/>
                </a:ext>
              </a:extLst>
            </p:cNvPr>
            <p:cNvCxnSpPr/>
            <p:nvPr/>
          </p:nvCxnSpPr>
          <p:spPr>
            <a:xfrm rot="5400000" flipV="1">
              <a:off x="1298999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xmlns="" id="{B5501394-870A-4803-A9C2-18C6CC078F0B}"/>
                </a:ext>
              </a:extLst>
            </p:cNvPr>
            <p:cNvCxnSpPr/>
            <p:nvPr/>
          </p:nvCxnSpPr>
          <p:spPr>
            <a:xfrm rot="5400000" flipV="1">
              <a:off x="2522966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xmlns="" id="{2A004324-7515-42E5-83D9-7C4059212851}"/>
                </a:ext>
              </a:extLst>
            </p:cNvPr>
            <p:cNvCxnSpPr/>
            <p:nvPr/>
          </p:nvCxnSpPr>
          <p:spPr>
            <a:xfrm rot="5400000" flipV="1">
              <a:off x="1823555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xmlns="" id="{5E990615-DFE3-4DDB-AD0B-8BCC9079B100}"/>
                </a:ext>
              </a:extLst>
            </p:cNvPr>
            <p:cNvCxnSpPr/>
            <p:nvPr/>
          </p:nvCxnSpPr>
          <p:spPr>
            <a:xfrm rot="5400000" flipV="1">
              <a:off x="1473851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xmlns="" id="{5633AB0F-5051-478B-BD33-4838CA70DFDA}"/>
                </a:ext>
              </a:extLst>
            </p:cNvPr>
            <p:cNvCxnSpPr/>
            <p:nvPr/>
          </p:nvCxnSpPr>
          <p:spPr>
            <a:xfrm rot="5400000" flipV="1">
              <a:off x="1998407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xmlns="" id="{F56DCD1F-D638-4E7B-A10E-BF19568A667E}"/>
                </a:ext>
              </a:extLst>
            </p:cNvPr>
            <p:cNvCxnSpPr/>
            <p:nvPr/>
          </p:nvCxnSpPr>
          <p:spPr>
            <a:xfrm rot="5400000" flipV="1">
              <a:off x="2872672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xmlns="" id="{12531F9E-5C76-4B82-84A5-E920110FC49D}"/>
                </a:ext>
              </a:extLst>
            </p:cNvPr>
            <p:cNvCxnSpPr/>
            <p:nvPr/>
          </p:nvCxnSpPr>
          <p:spPr>
            <a:xfrm rot="5400000" flipV="1">
              <a:off x="2348113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xmlns="" id="{41651E5C-E0C0-402D-A436-0DC2E38BD5EE}"/>
                </a:ext>
              </a:extLst>
            </p:cNvPr>
            <p:cNvCxnSpPr/>
            <p:nvPr/>
          </p:nvCxnSpPr>
          <p:spPr>
            <a:xfrm rot="5400000" flipV="1">
              <a:off x="1648703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xmlns="" id="{9C277208-FBEC-491F-BA1B-C0CE48671DDC}"/>
                </a:ext>
              </a:extLst>
            </p:cNvPr>
            <p:cNvCxnSpPr/>
            <p:nvPr/>
          </p:nvCxnSpPr>
          <p:spPr>
            <a:xfrm rot="5400000" flipV="1">
              <a:off x="2697819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xmlns="" id="{164B7122-18C4-44A0-A316-56DCF957B358}"/>
                </a:ext>
              </a:extLst>
            </p:cNvPr>
            <p:cNvSpPr txBox="1"/>
            <p:nvPr/>
          </p:nvSpPr>
          <p:spPr>
            <a:xfrm>
              <a:off x="1153701" y="8012996"/>
              <a:ext cx="3214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>
                  <a:cs typeface="Arial" panose="020B0604020202020204" pitchFamily="34" charset="0"/>
                </a:rPr>
                <a:t>-5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xmlns="" id="{F1C8779C-0D97-4998-B49D-78740DF66CD9}"/>
                </a:ext>
              </a:extLst>
            </p:cNvPr>
            <p:cNvSpPr txBox="1"/>
            <p:nvPr/>
          </p:nvSpPr>
          <p:spPr>
            <a:xfrm>
              <a:off x="2966668" y="801299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>
                  <a:cs typeface="Arial" panose="020B0604020202020204" pitchFamily="34" charset="0"/>
                </a:rPr>
                <a:t>5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xmlns="" id="{64341C95-6029-476B-9396-9E927B0CCFCA}"/>
                </a:ext>
              </a:extLst>
            </p:cNvPr>
            <p:cNvSpPr txBox="1"/>
            <p:nvPr/>
          </p:nvSpPr>
          <p:spPr>
            <a:xfrm>
              <a:off x="2080155" y="801299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>
                  <a:cs typeface="Arial" panose="020B0604020202020204" pitchFamily="34" charset="0"/>
                </a:rPr>
                <a:t>0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xmlns="" id="{8F733477-7CF9-43C7-BA93-D6CA29D6A0EB}"/>
                </a:ext>
              </a:extLst>
            </p:cNvPr>
            <p:cNvSpPr txBox="1"/>
            <p:nvPr/>
          </p:nvSpPr>
          <p:spPr>
            <a:xfrm>
              <a:off x="1678749" y="8194511"/>
              <a:ext cx="10704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cs typeface="Arial" panose="020B0604020202020204" pitchFamily="34" charset="0"/>
                </a:rPr>
                <a:t>log2</a:t>
              </a:r>
              <a:r>
                <a:rPr kumimoji="1" lang="en-US" altLang="ja-JP" sz="1200" baseline="-25000" dirty="0">
                  <a:cs typeface="Arial" panose="020B0604020202020204" pitchFamily="34" charset="0"/>
                </a:rPr>
                <a:t> </a:t>
              </a:r>
              <a:r>
                <a:rPr kumimoji="1" lang="en-US" altLang="ja-JP" sz="1200" dirty="0">
                  <a:cs typeface="Arial" panose="020B0604020202020204" pitchFamily="34" charset="0"/>
                </a:rPr>
                <a:t>(M value)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pic>
          <p:nvPicPr>
            <p:cNvPr id="45" name="図 44">
              <a:extLst>
                <a:ext uri="{FF2B5EF4-FFF2-40B4-BE49-F238E27FC236}">
                  <a16:creationId xmlns:a16="http://schemas.microsoft.com/office/drawing/2014/main" xmlns="" id="{3742D1E1-05A2-4079-8497-47688B9DCEA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14450" y="7842250"/>
              <a:ext cx="1800000" cy="107570"/>
            </a:xfrm>
            <a:prstGeom prst="rect">
              <a:avLst/>
            </a:prstGeom>
          </p:spPr>
        </p:pic>
      </p:grpSp>
      <p:pic>
        <p:nvPicPr>
          <p:cNvPr id="46" name="図 45">
            <a:extLst>
              <a:ext uri="{FF2B5EF4-FFF2-40B4-BE49-F238E27FC236}">
                <a16:creationId xmlns:a16="http://schemas.microsoft.com/office/drawing/2014/main" xmlns="" id="{C7494E4D-A62F-4796-A0D4-0AB88C69D07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53210" y="2637303"/>
            <a:ext cx="655200" cy="3021648"/>
          </a:xfrm>
          <a:prstGeom prst="rect">
            <a:avLst/>
          </a:prstGeom>
        </p:spPr>
      </p:pic>
      <p:pic>
        <p:nvPicPr>
          <p:cNvPr id="47" name="図 46">
            <a:extLst>
              <a:ext uri="{FF2B5EF4-FFF2-40B4-BE49-F238E27FC236}">
                <a16:creationId xmlns:a16="http://schemas.microsoft.com/office/drawing/2014/main" xmlns="" id="{3768A7B6-CBEB-4E9E-B741-D4591B734EC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57758" y="2637303"/>
            <a:ext cx="655200" cy="3666840"/>
          </a:xfrm>
          <a:prstGeom prst="rect">
            <a:avLst/>
          </a:prstGeom>
        </p:spPr>
      </p:pic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xmlns="" id="{C52B5910-D606-4CA2-B9E8-38B657EF53BD}"/>
              </a:ext>
            </a:extLst>
          </p:cNvPr>
          <p:cNvSpPr/>
          <p:nvPr/>
        </p:nvSpPr>
        <p:spPr>
          <a:xfrm>
            <a:off x="12075" y="2577247"/>
            <a:ext cx="1524000" cy="313060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ts val="1700"/>
              </a:lnSpc>
            </a:pPr>
            <a:r>
              <a:rPr lang="en-US" altLang="ja-JP" sz="1200" b="1" dirty="0"/>
              <a:t>ABCC6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DSSL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KR1B10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PS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GFR4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GPX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HNF1A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NAMPT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LS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HROOM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10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8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VAV3</a:t>
            </a:r>
          </a:p>
        </p:txBody>
      </p: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xmlns="" id="{2AF0E08E-5CF7-41C3-AFE5-71088E1C399B}"/>
              </a:ext>
            </a:extLst>
          </p:cNvPr>
          <p:cNvSpPr/>
          <p:nvPr/>
        </p:nvSpPr>
        <p:spPr>
          <a:xfrm>
            <a:off x="2070482" y="2577247"/>
            <a:ext cx="1187276" cy="37846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ts val="1700"/>
              </a:lnSpc>
            </a:pPr>
            <a:r>
              <a:rPr lang="en-US" altLang="ja-JP" sz="1200" b="1" dirty="0"/>
              <a:t>AKAP1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LPK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NGPTL4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BCHE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BMP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CL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SF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TGF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XCL8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ECE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BN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GB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KIRREL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LAMA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XDN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ERPINE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LC2A1</a:t>
            </a:r>
          </a:p>
        </p:txBody>
      </p:sp>
      <p:pic>
        <p:nvPicPr>
          <p:cNvPr id="50" name="図 49">
            <a:extLst>
              <a:ext uri="{FF2B5EF4-FFF2-40B4-BE49-F238E27FC236}">
                <a16:creationId xmlns:a16="http://schemas.microsoft.com/office/drawing/2014/main" xmlns="" id="{44B978BB-2743-4D93-A02A-43147E3BF7E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15831" y="2637303"/>
            <a:ext cx="655200" cy="5602415"/>
          </a:xfrm>
          <a:prstGeom prst="rect">
            <a:avLst/>
          </a:prstGeom>
        </p:spPr>
      </p:pic>
      <p:pic>
        <p:nvPicPr>
          <p:cNvPr id="51" name="図 50">
            <a:extLst>
              <a:ext uri="{FF2B5EF4-FFF2-40B4-BE49-F238E27FC236}">
                <a16:creationId xmlns:a16="http://schemas.microsoft.com/office/drawing/2014/main" xmlns="" id="{156F0703-9176-4E33-8119-BE9C6EBF023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873532" y="2637303"/>
            <a:ext cx="655200" cy="9688630"/>
          </a:xfrm>
          <a:prstGeom prst="rect">
            <a:avLst/>
          </a:prstGeom>
        </p:spPr>
      </p:pic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xmlns="" id="{88FB7422-BF0C-4065-99CE-5BB189FD41C5}"/>
              </a:ext>
            </a:extLst>
          </p:cNvPr>
          <p:cNvSpPr/>
          <p:nvPr/>
        </p:nvSpPr>
        <p:spPr>
          <a:xfrm>
            <a:off x="5928202" y="2577247"/>
            <a:ext cx="1180823" cy="574670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ts val="1700"/>
              </a:lnSpc>
            </a:pPr>
            <a:r>
              <a:rPr lang="en-US" altLang="ja-JP" sz="1200" b="1" dirty="0"/>
              <a:t>ABCC6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DAMTS9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OBL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PS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EPB41L4A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GPX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HNF1A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IGFBP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ITG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KLF5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MAP2K6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MGLL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MYO1D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NAMPT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ART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ECR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KDCC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LCD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LEKHA6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RARB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HROOM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PATA17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TARD1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TNS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VAV3</a:t>
            </a:r>
          </a:p>
        </p:txBody>
      </p:sp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xmlns="" id="{B93D75FA-8965-49E5-845F-E6235BCEDFBE}"/>
              </a:ext>
            </a:extLst>
          </p:cNvPr>
          <p:cNvSpPr/>
          <p:nvPr/>
        </p:nvSpPr>
        <p:spPr>
          <a:xfrm>
            <a:off x="7373292" y="2578818"/>
            <a:ext cx="1501882" cy="98888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ts val="1700"/>
              </a:lnSpc>
            </a:pPr>
            <a:r>
              <a:rPr lang="en-US" altLang="ja-JP" sz="1200" b="1" dirty="0"/>
              <a:t>ADAM19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GR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KAP1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NGPTL4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TP8B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TRNL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BCAM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BCHE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BDNF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BMP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BMP5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ADM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CL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OL4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OL4A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SF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TGF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XCL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XCL8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DIO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DIP2A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ECE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2R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BN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BN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GB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IGFBP7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KITLG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LAMA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LMAN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LTBP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MT1X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MT2A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ADI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APPA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CDH9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DGFC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MEP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TGES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XDN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EMA3A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ERPINE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LC2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TENM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THSD4</a:t>
            </a:r>
          </a:p>
        </p:txBody>
      </p:sp>
    </p:spTree>
    <p:extLst>
      <p:ext uri="{BB962C8B-B14F-4D97-AF65-F5344CB8AC3E}">
        <p14:creationId xmlns:p14="http://schemas.microsoft.com/office/powerpoint/2010/main" val="24101347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0188" y="49294"/>
            <a:ext cx="2430473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b="1" dirty="0"/>
              <a:t>Suppl.</a:t>
            </a:r>
            <a:r>
              <a:rPr kumimoji="1" lang="ja-JP" altLang="en-US" sz="3200" b="1" dirty="0"/>
              <a:t> </a:t>
            </a:r>
            <a:r>
              <a:rPr kumimoji="1" lang="en-US" altLang="ja-JP" sz="3200" b="1" dirty="0"/>
              <a:t>Fig.</a:t>
            </a:r>
            <a:r>
              <a:rPr kumimoji="1" lang="ja-JP" altLang="en-US" sz="3200" b="1" dirty="0"/>
              <a:t> </a:t>
            </a:r>
            <a:r>
              <a:rPr kumimoji="1" lang="en-US" altLang="ja-JP" sz="3200" b="1" dirty="0" smtClean="0"/>
              <a:t>S</a:t>
            </a:r>
            <a:r>
              <a:rPr kumimoji="1" lang="en-US" altLang="ja-JP" sz="3200" b="1" dirty="0" smtClean="0"/>
              <a:t>3</a:t>
            </a:r>
            <a:endParaRPr kumimoji="1" lang="ja-JP" altLang="en-US" sz="3200" b="1" dirty="0"/>
          </a:p>
        </p:txBody>
      </p:sp>
      <p:sp>
        <p:nvSpPr>
          <p:cNvPr id="8" name="正方形/長方形 7"/>
          <p:cNvSpPr/>
          <p:nvPr/>
        </p:nvSpPr>
        <p:spPr>
          <a:xfrm>
            <a:off x="2085817" y="1886209"/>
            <a:ext cx="1064715" cy="2494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lnSpc>
                <a:spcPts val="1000"/>
              </a:lnSpc>
            </a:pPr>
            <a:r>
              <a:rPr lang="en-US" altLang="ja-JP" b="1" u="sng" dirty="0">
                <a:cs typeface="Arial" panose="020B0604020202020204" pitchFamily="34" charset="0"/>
              </a:rPr>
              <a:t>IMMUNE</a:t>
            </a:r>
          </a:p>
        </p:txBody>
      </p:sp>
      <p:sp>
        <p:nvSpPr>
          <p:cNvPr id="9" name="正方形/長方形 8"/>
          <p:cNvSpPr/>
          <p:nvPr/>
        </p:nvSpPr>
        <p:spPr>
          <a:xfrm>
            <a:off x="7099049" y="1886209"/>
            <a:ext cx="1735283" cy="2494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lnSpc>
                <a:spcPts val="1000"/>
              </a:lnSpc>
            </a:pPr>
            <a:r>
              <a:rPr lang="en-US" altLang="ja-JP" b="1" u="sng" dirty="0">
                <a:cs typeface="Arial" panose="020B0604020202020204" pitchFamily="34" charset="0"/>
              </a:rPr>
              <a:t>REPRODUCTION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634389" y="1441044"/>
            <a:ext cx="297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</a:t>
            </a:r>
            <a:endParaRPr kumimoji="1" lang="ja-JP" altLang="en-US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6250944" y="1441044"/>
            <a:ext cx="290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</a:t>
            </a:r>
            <a:endParaRPr kumimoji="1" lang="ja-JP" altLang="en-US" dirty="0"/>
          </a:p>
        </p:txBody>
      </p:sp>
      <p:grpSp>
        <p:nvGrpSpPr>
          <p:cNvPr id="12" name="グループ化 7">
            <a:extLst>
              <a:ext uri="{FF2B5EF4-FFF2-40B4-BE49-F238E27FC236}">
                <a16:creationId xmlns:a16="http://schemas.microsoft.com/office/drawing/2014/main" xmlns="" id="{D8622E5E-57AC-490D-B3AE-1EAD09F82916}"/>
              </a:ext>
            </a:extLst>
          </p:cNvPr>
          <p:cNvGrpSpPr/>
          <p:nvPr/>
        </p:nvGrpSpPr>
        <p:grpSpPr>
          <a:xfrm>
            <a:off x="1576565" y="9361100"/>
            <a:ext cx="2083218" cy="629260"/>
            <a:chOff x="1153701" y="7842250"/>
            <a:chExt cx="2083218" cy="629260"/>
          </a:xfrm>
        </p:grpSpPr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xmlns="" id="{812B0349-F2D5-4323-BF5C-427A37264551}"/>
                </a:ext>
              </a:extLst>
            </p:cNvPr>
            <p:cNvCxnSpPr/>
            <p:nvPr/>
          </p:nvCxnSpPr>
          <p:spPr>
            <a:xfrm rot="5400000" flipV="1">
              <a:off x="3047524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xmlns="" id="{F6FA3697-5C34-4CC4-89A9-6C6AC2D61436}"/>
                </a:ext>
              </a:extLst>
            </p:cNvPr>
            <p:cNvCxnSpPr/>
            <p:nvPr/>
          </p:nvCxnSpPr>
          <p:spPr>
            <a:xfrm rot="5400000" flipV="1">
              <a:off x="2173260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xmlns="" id="{1D16213B-AB8C-46E3-B692-B35CCBFA6D96}"/>
                </a:ext>
              </a:extLst>
            </p:cNvPr>
            <p:cNvCxnSpPr/>
            <p:nvPr/>
          </p:nvCxnSpPr>
          <p:spPr>
            <a:xfrm rot="5400000" flipV="1">
              <a:off x="1298999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xmlns="" id="{78623B60-ECAB-4996-AAA7-7E4490E52BD0}"/>
                </a:ext>
              </a:extLst>
            </p:cNvPr>
            <p:cNvCxnSpPr/>
            <p:nvPr/>
          </p:nvCxnSpPr>
          <p:spPr>
            <a:xfrm rot="5400000" flipV="1">
              <a:off x="2522966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xmlns="" id="{91663040-0A80-4C95-87F4-16E71C846B9A}"/>
                </a:ext>
              </a:extLst>
            </p:cNvPr>
            <p:cNvCxnSpPr/>
            <p:nvPr/>
          </p:nvCxnSpPr>
          <p:spPr>
            <a:xfrm rot="5400000" flipV="1">
              <a:off x="1823555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xmlns="" id="{D27E30E0-AF26-47A6-B4F6-EDD736919430}"/>
                </a:ext>
              </a:extLst>
            </p:cNvPr>
            <p:cNvCxnSpPr/>
            <p:nvPr/>
          </p:nvCxnSpPr>
          <p:spPr>
            <a:xfrm rot="5400000" flipV="1">
              <a:off x="1473851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xmlns="" id="{7C87A086-7BD0-4274-AB7F-D70E72ED02FE}"/>
                </a:ext>
              </a:extLst>
            </p:cNvPr>
            <p:cNvCxnSpPr/>
            <p:nvPr/>
          </p:nvCxnSpPr>
          <p:spPr>
            <a:xfrm rot="5400000" flipV="1">
              <a:off x="1998407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xmlns="" id="{1308360D-DB2B-4B77-A050-F3E0D37FD5A5}"/>
                </a:ext>
              </a:extLst>
            </p:cNvPr>
            <p:cNvCxnSpPr/>
            <p:nvPr/>
          </p:nvCxnSpPr>
          <p:spPr>
            <a:xfrm rot="5400000" flipV="1">
              <a:off x="2872672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xmlns="" id="{331A12DF-6A18-4EF4-B5F7-BE018160BEBC}"/>
                </a:ext>
              </a:extLst>
            </p:cNvPr>
            <p:cNvCxnSpPr/>
            <p:nvPr/>
          </p:nvCxnSpPr>
          <p:spPr>
            <a:xfrm rot="5400000" flipV="1">
              <a:off x="2348113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xmlns="" id="{D53D1600-5F16-4311-A069-EDE7461B776D}"/>
                </a:ext>
              </a:extLst>
            </p:cNvPr>
            <p:cNvCxnSpPr/>
            <p:nvPr/>
          </p:nvCxnSpPr>
          <p:spPr>
            <a:xfrm rot="5400000" flipV="1">
              <a:off x="1648703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xmlns="" id="{8C358A89-896F-49E3-A27F-43FB02D80B5D}"/>
                </a:ext>
              </a:extLst>
            </p:cNvPr>
            <p:cNvCxnSpPr/>
            <p:nvPr/>
          </p:nvCxnSpPr>
          <p:spPr>
            <a:xfrm rot="5400000" flipV="1">
              <a:off x="2697819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xmlns="" id="{BF7F50A3-7644-480E-84C6-60975B068BB1}"/>
                </a:ext>
              </a:extLst>
            </p:cNvPr>
            <p:cNvSpPr txBox="1"/>
            <p:nvPr/>
          </p:nvSpPr>
          <p:spPr>
            <a:xfrm>
              <a:off x="1153701" y="8012996"/>
              <a:ext cx="3214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>
                  <a:cs typeface="Arial" panose="020B0604020202020204" pitchFamily="34" charset="0"/>
                </a:rPr>
                <a:t>-5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xmlns="" id="{D8596C1C-70B3-4B4D-AA77-48DAD8C4E173}"/>
                </a:ext>
              </a:extLst>
            </p:cNvPr>
            <p:cNvSpPr txBox="1"/>
            <p:nvPr/>
          </p:nvSpPr>
          <p:spPr>
            <a:xfrm>
              <a:off x="2966668" y="801299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>
                  <a:cs typeface="Arial" panose="020B0604020202020204" pitchFamily="34" charset="0"/>
                </a:rPr>
                <a:t>5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xmlns="" id="{39D564F3-5E89-4696-9BFE-249D79800A84}"/>
                </a:ext>
              </a:extLst>
            </p:cNvPr>
            <p:cNvSpPr txBox="1"/>
            <p:nvPr/>
          </p:nvSpPr>
          <p:spPr>
            <a:xfrm>
              <a:off x="2080155" y="801299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>
                  <a:cs typeface="Arial" panose="020B0604020202020204" pitchFamily="34" charset="0"/>
                </a:rPr>
                <a:t>0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xmlns="" id="{C0AD047E-390E-464F-83FD-A5021884B1B3}"/>
                </a:ext>
              </a:extLst>
            </p:cNvPr>
            <p:cNvSpPr txBox="1"/>
            <p:nvPr/>
          </p:nvSpPr>
          <p:spPr>
            <a:xfrm>
              <a:off x="1678749" y="8194511"/>
              <a:ext cx="10704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cs typeface="Arial" panose="020B0604020202020204" pitchFamily="34" charset="0"/>
                </a:rPr>
                <a:t>log2</a:t>
              </a:r>
              <a:r>
                <a:rPr kumimoji="1" lang="en-US" altLang="ja-JP" sz="1200" baseline="-25000" dirty="0">
                  <a:cs typeface="Arial" panose="020B0604020202020204" pitchFamily="34" charset="0"/>
                </a:rPr>
                <a:t> </a:t>
              </a:r>
              <a:r>
                <a:rPr kumimoji="1" lang="en-US" altLang="ja-JP" sz="1200" dirty="0">
                  <a:cs typeface="Arial" panose="020B0604020202020204" pitchFamily="34" charset="0"/>
                </a:rPr>
                <a:t>(M value)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pic>
          <p:nvPicPr>
            <p:cNvPr id="28" name="図 27">
              <a:extLst>
                <a:ext uri="{FF2B5EF4-FFF2-40B4-BE49-F238E27FC236}">
                  <a16:creationId xmlns:a16="http://schemas.microsoft.com/office/drawing/2014/main" xmlns="" id="{27B5F4E3-C68E-448B-B772-0589148870F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14450" y="7842250"/>
              <a:ext cx="1800000" cy="107570"/>
            </a:xfrm>
            <a:prstGeom prst="rect">
              <a:avLst/>
            </a:prstGeom>
          </p:spPr>
        </p:pic>
      </p:grpSp>
      <p:grpSp>
        <p:nvGrpSpPr>
          <p:cNvPr id="29" name="グループ化 24">
            <a:extLst>
              <a:ext uri="{FF2B5EF4-FFF2-40B4-BE49-F238E27FC236}">
                <a16:creationId xmlns:a16="http://schemas.microsoft.com/office/drawing/2014/main" xmlns="" id="{6A136E39-FC75-4D5F-84C5-AD4A8ED4DFC6}"/>
              </a:ext>
            </a:extLst>
          </p:cNvPr>
          <p:cNvGrpSpPr/>
          <p:nvPr/>
        </p:nvGrpSpPr>
        <p:grpSpPr>
          <a:xfrm>
            <a:off x="6925081" y="6646680"/>
            <a:ext cx="2083218" cy="629260"/>
            <a:chOff x="1153701" y="7842250"/>
            <a:chExt cx="2083218" cy="629260"/>
          </a:xfrm>
        </p:grpSpPr>
        <p:cxnSp>
          <p:nvCxnSpPr>
            <p:cNvPr id="30" name="直線コネクタ 29">
              <a:extLst>
                <a:ext uri="{FF2B5EF4-FFF2-40B4-BE49-F238E27FC236}">
                  <a16:creationId xmlns:a16="http://schemas.microsoft.com/office/drawing/2014/main" xmlns="" id="{576C7BCF-FB62-4822-A4B5-94464B5A3EA4}"/>
                </a:ext>
              </a:extLst>
            </p:cNvPr>
            <p:cNvCxnSpPr/>
            <p:nvPr/>
          </p:nvCxnSpPr>
          <p:spPr>
            <a:xfrm rot="5400000" flipV="1">
              <a:off x="3047524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xmlns="" id="{AA5D86C6-37F8-4743-AA04-D987C3E1DF75}"/>
                </a:ext>
              </a:extLst>
            </p:cNvPr>
            <p:cNvCxnSpPr/>
            <p:nvPr/>
          </p:nvCxnSpPr>
          <p:spPr>
            <a:xfrm rot="5400000" flipV="1">
              <a:off x="2173260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xmlns="" id="{EE01C5A1-FBEF-403C-B9DB-AE44EC2EB32A}"/>
                </a:ext>
              </a:extLst>
            </p:cNvPr>
            <p:cNvCxnSpPr/>
            <p:nvPr/>
          </p:nvCxnSpPr>
          <p:spPr>
            <a:xfrm rot="5400000" flipV="1">
              <a:off x="1298999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xmlns="" id="{631B97BD-7829-4CE5-AA8A-2868E24EED44}"/>
                </a:ext>
              </a:extLst>
            </p:cNvPr>
            <p:cNvCxnSpPr/>
            <p:nvPr/>
          </p:nvCxnSpPr>
          <p:spPr>
            <a:xfrm rot="5400000" flipV="1">
              <a:off x="2522966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xmlns="" id="{D5E8ED24-B18D-485C-9B3A-14CB451CD2C6}"/>
                </a:ext>
              </a:extLst>
            </p:cNvPr>
            <p:cNvCxnSpPr/>
            <p:nvPr/>
          </p:nvCxnSpPr>
          <p:spPr>
            <a:xfrm rot="5400000" flipV="1">
              <a:off x="1823555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xmlns="" id="{B78E2CF8-ABF7-4278-BEB5-88B307D3808E}"/>
                </a:ext>
              </a:extLst>
            </p:cNvPr>
            <p:cNvCxnSpPr/>
            <p:nvPr/>
          </p:nvCxnSpPr>
          <p:spPr>
            <a:xfrm rot="5400000" flipV="1">
              <a:off x="1473851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xmlns="" id="{1BA8B8AA-8D48-4551-9679-A9790E684DD4}"/>
                </a:ext>
              </a:extLst>
            </p:cNvPr>
            <p:cNvCxnSpPr/>
            <p:nvPr/>
          </p:nvCxnSpPr>
          <p:spPr>
            <a:xfrm rot="5400000" flipV="1">
              <a:off x="1998407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xmlns="" id="{6DD5C7A9-4727-462D-80A7-12034856FD97}"/>
                </a:ext>
              </a:extLst>
            </p:cNvPr>
            <p:cNvCxnSpPr/>
            <p:nvPr/>
          </p:nvCxnSpPr>
          <p:spPr>
            <a:xfrm rot="5400000" flipV="1">
              <a:off x="2872672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xmlns="" id="{DBB3B4EA-CEDA-4CA8-847E-6F364077D880}"/>
                </a:ext>
              </a:extLst>
            </p:cNvPr>
            <p:cNvCxnSpPr/>
            <p:nvPr/>
          </p:nvCxnSpPr>
          <p:spPr>
            <a:xfrm rot="5400000" flipV="1">
              <a:off x="2348113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xmlns="" id="{9F5B9861-DF94-4A6F-A52F-4A63E592A432}"/>
                </a:ext>
              </a:extLst>
            </p:cNvPr>
            <p:cNvCxnSpPr/>
            <p:nvPr/>
          </p:nvCxnSpPr>
          <p:spPr>
            <a:xfrm rot="5400000" flipV="1">
              <a:off x="1648703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xmlns="" id="{B0B6A6E5-96FA-4A75-8CE2-2345F74D42A6}"/>
                </a:ext>
              </a:extLst>
            </p:cNvPr>
            <p:cNvCxnSpPr/>
            <p:nvPr/>
          </p:nvCxnSpPr>
          <p:spPr>
            <a:xfrm rot="5400000" flipV="1">
              <a:off x="2697819" y="7991622"/>
              <a:ext cx="81380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xmlns="" id="{FA6FECB4-7918-4B20-987E-0087DA8F3B69}"/>
                </a:ext>
              </a:extLst>
            </p:cNvPr>
            <p:cNvSpPr txBox="1"/>
            <p:nvPr/>
          </p:nvSpPr>
          <p:spPr>
            <a:xfrm>
              <a:off x="1153701" y="8012996"/>
              <a:ext cx="3214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>
                  <a:cs typeface="Arial" panose="020B0604020202020204" pitchFamily="34" charset="0"/>
                </a:rPr>
                <a:t>-5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xmlns="" id="{7FC7DC25-82B0-4BAB-8D80-038BFDEC9953}"/>
                </a:ext>
              </a:extLst>
            </p:cNvPr>
            <p:cNvSpPr txBox="1"/>
            <p:nvPr/>
          </p:nvSpPr>
          <p:spPr>
            <a:xfrm>
              <a:off x="2966668" y="801299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>
                  <a:cs typeface="Arial" panose="020B0604020202020204" pitchFamily="34" charset="0"/>
                </a:rPr>
                <a:t>5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xmlns="" id="{EA069E6A-4EF2-4AE0-BFA1-A2C4A35E2B7B}"/>
                </a:ext>
              </a:extLst>
            </p:cNvPr>
            <p:cNvSpPr txBox="1"/>
            <p:nvPr/>
          </p:nvSpPr>
          <p:spPr>
            <a:xfrm>
              <a:off x="2080155" y="8012997"/>
              <a:ext cx="270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>
                  <a:cs typeface="Arial" panose="020B0604020202020204" pitchFamily="34" charset="0"/>
                </a:rPr>
                <a:t>0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xmlns="" id="{BABCEF42-2821-48B1-B3AD-3ED1DA6B7490}"/>
                </a:ext>
              </a:extLst>
            </p:cNvPr>
            <p:cNvSpPr txBox="1"/>
            <p:nvPr/>
          </p:nvSpPr>
          <p:spPr>
            <a:xfrm>
              <a:off x="1678749" y="8194511"/>
              <a:ext cx="10704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cs typeface="Arial" panose="020B0604020202020204" pitchFamily="34" charset="0"/>
                </a:rPr>
                <a:t>log2</a:t>
              </a:r>
              <a:r>
                <a:rPr kumimoji="1" lang="en-US" altLang="ja-JP" sz="1200" baseline="-25000" dirty="0">
                  <a:cs typeface="Arial" panose="020B0604020202020204" pitchFamily="34" charset="0"/>
                </a:rPr>
                <a:t> </a:t>
              </a:r>
              <a:r>
                <a:rPr kumimoji="1" lang="en-US" altLang="ja-JP" sz="1200" dirty="0">
                  <a:cs typeface="Arial" panose="020B0604020202020204" pitchFamily="34" charset="0"/>
                </a:rPr>
                <a:t>(M value)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pic>
          <p:nvPicPr>
            <p:cNvPr id="45" name="図 44">
              <a:extLst>
                <a:ext uri="{FF2B5EF4-FFF2-40B4-BE49-F238E27FC236}">
                  <a16:creationId xmlns:a16="http://schemas.microsoft.com/office/drawing/2014/main" xmlns="" id="{CC6AB1B9-CD92-4107-8524-2A5B0D2DF2F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14450" y="7842250"/>
              <a:ext cx="1800000" cy="107570"/>
            </a:xfrm>
            <a:prstGeom prst="rect">
              <a:avLst/>
            </a:prstGeom>
          </p:spPr>
        </p:pic>
      </p:grpSp>
      <p:pic>
        <p:nvPicPr>
          <p:cNvPr id="46" name="図 45">
            <a:extLst>
              <a:ext uri="{FF2B5EF4-FFF2-40B4-BE49-F238E27FC236}">
                <a16:creationId xmlns:a16="http://schemas.microsoft.com/office/drawing/2014/main" xmlns="" id="{FC93D7F7-58F3-459C-A520-5E1E0D1557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67315" y="2538737"/>
            <a:ext cx="655200" cy="4957223"/>
          </a:xfrm>
          <a:prstGeom prst="rect">
            <a:avLst/>
          </a:prstGeom>
        </p:spPr>
      </p:pic>
      <p:pic>
        <p:nvPicPr>
          <p:cNvPr id="47" name="図 46">
            <a:extLst>
              <a:ext uri="{FF2B5EF4-FFF2-40B4-BE49-F238E27FC236}">
                <a16:creationId xmlns:a16="http://schemas.microsoft.com/office/drawing/2014/main" xmlns="" id="{5C3595D2-6919-4CA6-9B67-AAF3266FEC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37347" y="2538737"/>
            <a:ext cx="655200" cy="6247607"/>
          </a:xfrm>
          <a:prstGeom prst="rect">
            <a:avLst/>
          </a:prstGeom>
        </p:spPr>
      </p:pic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xmlns="" id="{16C79E48-D003-4212-B182-09938A825D07}"/>
              </a:ext>
            </a:extLst>
          </p:cNvPr>
          <p:cNvSpPr/>
          <p:nvPr/>
        </p:nvSpPr>
        <p:spPr>
          <a:xfrm>
            <a:off x="503793" y="2475064"/>
            <a:ext cx="1199248" cy="50926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ts val="1700"/>
              </a:lnSpc>
            </a:pPr>
            <a:r>
              <a:rPr lang="en-US" altLang="ja-JP" sz="1200" b="1" dirty="0"/>
              <a:t>ABCC6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DAMTS9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RRB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OBL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ORO2A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YP4F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GFR4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HNF1A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IGFBP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KRT8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MAP2K6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OAS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KDCC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RARB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RIPK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HROOM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LC9A3R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TNS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6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7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8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UGT1A9</a:t>
            </a:r>
          </a:p>
        </p:txBody>
      </p: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xmlns="" id="{F801B5E6-6CFF-4BB7-97CF-28ED297C3A18}"/>
              </a:ext>
            </a:extLst>
          </p:cNvPr>
          <p:cNvSpPr/>
          <p:nvPr/>
        </p:nvSpPr>
        <p:spPr>
          <a:xfrm>
            <a:off x="2201657" y="2481111"/>
            <a:ext cx="1045636" cy="64007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ts val="1700"/>
              </a:lnSpc>
            </a:pPr>
            <a:r>
              <a:rPr lang="en-US" altLang="ja-JP" sz="1200" b="1" dirty="0"/>
              <a:t>AGR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ATP8B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BCHE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BDNF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ADM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CL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OL18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OL4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SF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TGF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XCL8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DIO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2R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2RL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BN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BN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GB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STL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KIRREL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KITLG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LMAN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MFGE8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MUC5AC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EG10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MEP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RPS18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ERPINE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LC2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THSD4</a:t>
            </a:r>
          </a:p>
        </p:txBody>
      </p:sp>
      <p:pic>
        <p:nvPicPr>
          <p:cNvPr id="50" name="図 49">
            <a:extLst>
              <a:ext uri="{FF2B5EF4-FFF2-40B4-BE49-F238E27FC236}">
                <a16:creationId xmlns:a16="http://schemas.microsoft.com/office/drawing/2014/main" xmlns="" id="{5869F6F9-2D08-4E80-A888-DD18E188A17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03291" y="2538737"/>
            <a:ext cx="655200" cy="1086073"/>
          </a:xfrm>
          <a:prstGeom prst="rect">
            <a:avLst/>
          </a:prstGeom>
        </p:spPr>
      </p:pic>
      <p:pic>
        <p:nvPicPr>
          <p:cNvPr id="51" name="図 50">
            <a:extLst>
              <a:ext uri="{FF2B5EF4-FFF2-40B4-BE49-F238E27FC236}">
                <a16:creationId xmlns:a16="http://schemas.microsoft.com/office/drawing/2014/main" xmlns="" id="{09A17713-3F77-4184-8580-AF0BE75353B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636934" y="2538737"/>
            <a:ext cx="655200" cy="3666840"/>
          </a:xfrm>
          <a:prstGeom prst="rect">
            <a:avLst/>
          </a:prstGeom>
        </p:spPr>
      </p:pic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xmlns="" id="{5771ED29-7DFE-4EBB-8ECE-17C73A939ED4}"/>
              </a:ext>
            </a:extLst>
          </p:cNvPr>
          <p:cNvSpPr/>
          <p:nvPr/>
        </p:nvSpPr>
        <p:spPr>
          <a:xfrm>
            <a:off x="5573894" y="2484024"/>
            <a:ext cx="1517072" cy="11685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ts val="1700"/>
              </a:lnSpc>
            </a:pPr>
            <a:r>
              <a:rPr lang="pt-BR" altLang="ja-JP" sz="1200" b="1" dirty="0"/>
              <a:t>CPS1</a:t>
            </a:r>
          </a:p>
          <a:p>
            <a:pPr algn="r">
              <a:lnSpc>
                <a:spcPts val="1700"/>
              </a:lnSpc>
            </a:pPr>
            <a:r>
              <a:rPr lang="pt-BR" altLang="ja-JP" sz="1200" b="1" dirty="0"/>
              <a:t>GNG4</a:t>
            </a:r>
          </a:p>
          <a:p>
            <a:pPr algn="r">
              <a:lnSpc>
                <a:spcPts val="1700"/>
              </a:lnSpc>
            </a:pPr>
            <a:r>
              <a:rPr lang="pt-BR" altLang="ja-JP" sz="1200" b="1" dirty="0"/>
              <a:t>H19</a:t>
            </a:r>
          </a:p>
          <a:p>
            <a:pPr algn="r">
              <a:lnSpc>
                <a:spcPts val="1700"/>
              </a:lnSpc>
            </a:pPr>
            <a:r>
              <a:rPr lang="pt-BR" altLang="ja-JP" sz="1200" b="1" dirty="0"/>
              <a:t>SPATA17</a:t>
            </a:r>
          </a:p>
          <a:p>
            <a:pPr algn="r">
              <a:lnSpc>
                <a:spcPts val="1700"/>
              </a:lnSpc>
            </a:pPr>
            <a:r>
              <a:rPr lang="pt-BR" altLang="ja-JP" sz="1200" b="1" dirty="0"/>
              <a:t>UGT1A1</a:t>
            </a:r>
          </a:p>
        </p:txBody>
      </p:sp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xmlns="" id="{66A42F3B-C925-497C-AE7A-F7B963626EF6}"/>
              </a:ext>
            </a:extLst>
          </p:cNvPr>
          <p:cNvSpPr/>
          <p:nvPr/>
        </p:nvSpPr>
        <p:spPr>
          <a:xfrm>
            <a:off x="7319791" y="2484024"/>
            <a:ext cx="1343777" cy="37846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ts val="1700"/>
              </a:lnSpc>
            </a:pPr>
            <a:r>
              <a:rPr lang="en-US" altLang="ja-JP" sz="1200" b="1" dirty="0"/>
              <a:t>BDNF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BMP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CL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OL18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OL4A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OL4A2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SF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CXCL8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2R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FGB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KITLG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NFE2L3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APPA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DGFC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PTGES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SERPINE1</a:t>
            </a:r>
          </a:p>
          <a:p>
            <a:pPr algn="r">
              <a:lnSpc>
                <a:spcPts val="1700"/>
              </a:lnSpc>
            </a:pPr>
            <a:r>
              <a:rPr lang="en-US" altLang="ja-JP" sz="1200" b="1" dirty="0"/>
              <a:t>THSD4</a:t>
            </a:r>
          </a:p>
        </p:txBody>
      </p:sp>
    </p:spTree>
    <p:extLst>
      <p:ext uri="{BB962C8B-B14F-4D97-AF65-F5344CB8AC3E}">
        <p14:creationId xmlns:p14="http://schemas.microsoft.com/office/powerpoint/2010/main" val="38543647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8" name="グループ化 41">
            <a:extLst>
              <a:ext uri="{FF2B5EF4-FFF2-40B4-BE49-F238E27FC236}">
                <a16:creationId xmlns="" xmlns:a16="http://schemas.microsoft.com/office/drawing/2014/main" id="{27CAB428-02F6-BB4E-9C9C-F87D2DE78CE5}"/>
              </a:ext>
            </a:extLst>
          </p:cNvPr>
          <p:cNvGrpSpPr/>
          <p:nvPr/>
        </p:nvGrpSpPr>
        <p:grpSpPr>
          <a:xfrm>
            <a:off x="1700556" y="13138739"/>
            <a:ext cx="3866430" cy="2520000"/>
            <a:chOff x="1587762" y="2247428"/>
            <a:chExt cx="3866430" cy="2520000"/>
          </a:xfrm>
        </p:grpSpPr>
        <p:graphicFrame>
          <p:nvGraphicFramePr>
            <p:cNvPr id="101" name="Chart 39">
              <a:extLst>
                <a:ext uri="{FF2B5EF4-FFF2-40B4-BE49-F238E27FC236}">
                  <a16:creationId xmlns="" xmlns:a16="http://schemas.microsoft.com/office/drawing/2014/main" id="{251F79E3-1668-6540-A843-8E2262B67F30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070921742"/>
                </p:ext>
              </p:extLst>
            </p:nvPr>
          </p:nvGraphicFramePr>
          <p:xfrm>
            <a:off x="1897496" y="2247428"/>
            <a:ext cx="3556696" cy="25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02" name="TextBox 15">
              <a:extLst>
                <a:ext uri="{FF2B5EF4-FFF2-40B4-BE49-F238E27FC236}">
                  <a16:creationId xmlns="" xmlns:a16="http://schemas.microsoft.com/office/drawing/2014/main" id="{D8B4A1C4-D08A-1947-9731-2B2E3F433ABE}"/>
                </a:ext>
              </a:extLst>
            </p:cNvPr>
            <p:cNvSpPr txBox="1"/>
            <p:nvPr/>
          </p:nvSpPr>
          <p:spPr>
            <a:xfrm>
              <a:off x="3725995" y="2695104"/>
              <a:ext cx="234949" cy="192088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id-ID" sz="1200"/>
                <a:t>*</a:t>
              </a:r>
              <a:endParaRPr lang="en-US" sz="1200"/>
            </a:p>
          </p:txBody>
        </p:sp>
        <p:sp>
          <p:nvSpPr>
            <p:cNvPr id="103" name="TextBox 13">
              <a:extLst>
                <a:ext uri="{FF2B5EF4-FFF2-40B4-BE49-F238E27FC236}">
                  <a16:creationId xmlns="" xmlns:a16="http://schemas.microsoft.com/office/drawing/2014/main" id="{7F8E456F-586E-6A48-A7C8-FC09C01B52D5}"/>
                </a:ext>
              </a:extLst>
            </p:cNvPr>
            <p:cNvSpPr txBox="1"/>
            <p:nvPr/>
          </p:nvSpPr>
          <p:spPr>
            <a:xfrm>
              <a:off x="3003754" y="3740373"/>
              <a:ext cx="269875" cy="182562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id-ID" sz="1200" dirty="0"/>
                <a:t>*</a:t>
              </a:r>
              <a:endParaRPr lang="en-US" sz="1200" dirty="0"/>
            </a:p>
          </p:txBody>
        </p:sp>
        <p:sp>
          <p:nvSpPr>
            <p:cNvPr id="104" name="TextBox 14">
              <a:extLst>
                <a:ext uri="{FF2B5EF4-FFF2-40B4-BE49-F238E27FC236}">
                  <a16:creationId xmlns="" xmlns:a16="http://schemas.microsoft.com/office/drawing/2014/main" id="{03559919-B276-7641-9A74-5FBC451A6271}"/>
                </a:ext>
              </a:extLst>
            </p:cNvPr>
            <p:cNvSpPr txBox="1"/>
            <p:nvPr/>
          </p:nvSpPr>
          <p:spPr>
            <a:xfrm>
              <a:off x="3908250" y="2680698"/>
              <a:ext cx="269875" cy="22090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id-ID" sz="1200" dirty="0"/>
                <a:t>*</a:t>
              </a:r>
              <a:endParaRPr lang="en-US" sz="1200" dirty="0"/>
            </a:p>
          </p:txBody>
        </p:sp>
        <p:sp>
          <p:nvSpPr>
            <p:cNvPr id="105" name="TextBox 18">
              <a:extLst>
                <a:ext uri="{FF2B5EF4-FFF2-40B4-BE49-F238E27FC236}">
                  <a16:creationId xmlns="" xmlns:a16="http://schemas.microsoft.com/office/drawing/2014/main" id="{5CD8A3BE-8ACA-834D-83EB-F0CDEFB95E6E}"/>
                </a:ext>
              </a:extLst>
            </p:cNvPr>
            <p:cNvSpPr txBox="1"/>
            <p:nvPr/>
          </p:nvSpPr>
          <p:spPr>
            <a:xfrm>
              <a:off x="2760017" y="3678676"/>
              <a:ext cx="365124" cy="228643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id-ID" sz="1200" dirty="0" err="1"/>
                <a:t>ns</a:t>
              </a:r>
              <a:endParaRPr lang="en-US" sz="1200" dirty="0"/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="" xmlns:a16="http://schemas.microsoft.com/office/drawing/2014/main" id="{96C06B76-69A7-B641-A73A-C2E0627425DB}"/>
                </a:ext>
              </a:extLst>
            </p:cNvPr>
            <p:cNvSpPr txBox="1"/>
            <p:nvPr/>
          </p:nvSpPr>
          <p:spPr>
            <a:xfrm rot="16200000">
              <a:off x="1254818" y="3273181"/>
              <a:ext cx="9428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/>
                <a:t>Cell number</a:t>
              </a:r>
              <a:endParaRPr kumimoji="1" lang="ja-JP" altLang="en-US" sz="1200" dirty="0"/>
            </a:p>
          </p:txBody>
        </p:sp>
      </p:grpSp>
      <p:sp>
        <p:nvSpPr>
          <p:cNvPr id="100" name="テキスト ボックス 99">
            <a:extLst>
              <a:ext uri="{FF2B5EF4-FFF2-40B4-BE49-F238E27FC236}">
                <a16:creationId xmlns="" xmlns:a16="http://schemas.microsoft.com/office/drawing/2014/main" id="{0D8DF44F-948E-254E-805C-FEF349FCD47F}"/>
              </a:ext>
            </a:extLst>
          </p:cNvPr>
          <p:cNvSpPr txBox="1"/>
          <p:nvPr/>
        </p:nvSpPr>
        <p:spPr>
          <a:xfrm>
            <a:off x="2214362" y="15542879"/>
            <a:ext cx="2578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Days after medium change</a:t>
            </a:r>
            <a:endParaRPr kumimoji="1" lang="ja-JP" altLang="en-US" sz="1200" dirty="0"/>
          </a:p>
        </p:txBody>
      </p:sp>
      <p:sp>
        <p:nvSpPr>
          <p:cNvPr id="107" name="テキスト ボックス 106">
            <a:extLst>
              <a:ext uri="{FF2B5EF4-FFF2-40B4-BE49-F238E27FC236}">
                <a16:creationId xmlns="" xmlns:a16="http://schemas.microsoft.com/office/drawing/2014/main" id="{1720A757-DABA-E047-9CFE-BC26366B1A19}"/>
              </a:ext>
            </a:extLst>
          </p:cNvPr>
          <p:cNvSpPr txBox="1"/>
          <p:nvPr/>
        </p:nvSpPr>
        <p:spPr>
          <a:xfrm>
            <a:off x="2647032" y="12764291"/>
            <a:ext cx="17950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Growth (cell</a:t>
            </a:r>
            <a:r>
              <a:rPr kumimoji="1" lang="ja-JP" altLang="en-US" sz="1200" dirty="0"/>
              <a:t> </a:t>
            </a:r>
            <a:r>
              <a:rPr kumimoji="1" lang="en-US" altLang="ja-JP" sz="1200" dirty="0"/>
              <a:t>number)</a:t>
            </a:r>
            <a:endParaRPr kumimoji="1" lang="ja-JP" altLang="en-US" sz="1200" dirty="0"/>
          </a:p>
        </p:txBody>
      </p:sp>
      <p:grpSp>
        <p:nvGrpSpPr>
          <p:cNvPr id="2" name="図形グループ 1"/>
          <p:cNvGrpSpPr/>
          <p:nvPr/>
        </p:nvGrpSpPr>
        <p:grpSpPr>
          <a:xfrm>
            <a:off x="1700556" y="8174382"/>
            <a:ext cx="7973021" cy="3600000"/>
            <a:chOff x="1851748" y="4833455"/>
            <a:chExt cx="7973021" cy="3600000"/>
          </a:xfrm>
        </p:grpSpPr>
        <p:grpSp>
          <p:nvGrpSpPr>
            <p:cNvPr id="108" name="グループ化 30">
              <a:extLst>
                <a:ext uri="{FF2B5EF4-FFF2-40B4-BE49-F238E27FC236}">
                  <a16:creationId xmlns="" xmlns:a16="http://schemas.microsoft.com/office/drawing/2014/main" id="{BAADF07B-511A-0945-AADE-95028FD94075}"/>
                </a:ext>
              </a:extLst>
            </p:cNvPr>
            <p:cNvGrpSpPr/>
            <p:nvPr/>
          </p:nvGrpSpPr>
          <p:grpSpPr>
            <a:xfrm>
              <a:off x="1851748" y="4833455"/>
              <a:ext cx="3858815" cy="3600000"/>
              <a:chOff x="2131919" y="1879600"/>
              <a:chExt cx="3858815" cy="3600000"/>
            </a:xfrm>
          </p:grpSpPr>
          <p:pic>
            <p:nvPicPr>
              <p:cNvPr id="109" name="図 108">
                <a:extLst>
                  <a:ext uri="{FF2B5EF4-FFF2-40B4-BE49-F238E27FC236}">
                    <a16:creationId xmlns="" xmlns:a16="http://schemas.microsoft.com/office/drawing/2014/main" id="{BEFB481A-6C27-5447-AA82-D2CF1DFB14B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390734" y="1879600"/>
                <a:ext cx="3600000" cy="3600000"/>
              </a:xfrm>
              <a:prstGeom prst="rect">
                <a:avLst/>
              </a:prstGeom>
            </p:spPr>
          </p:pic>
          <p:sp>
            <p:nvSpPr>
              <p:cNvPr id="110" name="正方形/長方形 109">
                <a:extLst>
                  <a:ext uri="{FF2B5EF4-FFF2-40B4-BE49-F238E27FC236}">
                    <a16:creationId xmlns="" xmlns:a16="http://schemas.microsoft.com/office/drawing/2014/main" id="{800C4E83-B918-ED48-ADEF-4352712A218E}"/>
                  </a:ext>
                </a:extLst>
              </p:cNvPr>
              <p:cNvSpPr/>
              <p:nvPr/>
            </p:nvSpPr>
            <p:spPr>
              <a:xfrm>
                <a:off x="2303802" y="3190815"/>
                <a:ext cx="359187" cy="88388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1" name="テキスト ボックス 110">
                <a:extLst>
                  <a:ext uri="{FF2B5EF4-FFF2-40B4-BE49-F238E27FC236}">
                    <a16:creationId xmlns="" xmlns:a16="http://schemas.microsoft.com/office/drawing/2014/main" id="{222A2C82-BA69-6947-8CBE-C8FCD9D263F2}"/>
                  </a:ext>
                </a:extLst>
              </p:cNvPr>
              <p:cNvSpPr txBox="1"/>
              <p:nvPr/>
            </p:nvSpPr>
            <p:spPr>
              <a:xfrm>
                <a:off x="2304730" y="2240047"/>
                <a:ext cx="450861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kumimoji="1" lang="en-US" altLang="ja-JP" sz="1200" dirty="0"/>
                  <a:t>1.0</a:t>
                </a:r>
                <a:endParaRPr kumimoji="1" lang="ja-JP" altLang="en-US" sz="1200"/>
              </a:p>
            </p:txBody>
          </p:sp>
          <p:sp>
            <p:nvSpPr>
              <p:cNvPr id="112" name="テキスト ボックス 111">
                <a:extLst>
                  <a:ext uri="{FF2B5EF4-FFF2-40B4-BE49-F238E27FC236}">
                    <a16:creationId xmlns="" xmlns:a16="http://schemas.microsoft.com/office/drawing/2014/main" id="{8F699C79-F10F-FE44-B78D-1907EFB7E218}"/>
                  </a:ext>
                </a:extLst>
              </p:cNvPr>
              <p:cNvSpPr txBox="1"/>
              <p:nvPr/>
            </p:nvSpPr>
            <p:spPr>
              <a:xfrm>
                <a:off x="2304730" y="2913816"/>
                <a:ext cx="450861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kumimoji="1" lang="en-US" altLang="ja-JP" sz="1200" dirty="0"/>
                  <a:t>0.8</a:t>
                </a:r>
                <a:endParaRPr kumimoji="1" lang="ja-JP" altLang="en-US" sz="1200"/>
              </a:p>
            </p:txBody>
          </p:sp>
          <p:sp>
            <p:nvSpPr>
              <p:cNvPr id="113" name="テキスト ボックス 112">
                <a:extLst>
                  <a:ext uri="{FF2B5EF4-FFF2-40B4-BE49-F238E27FC236}">
                    <a16:creationId xmlns="" xmlns:a16="http://schemas.microsoft.com/office/drawing/2014/main" id="{19D4C3B5-8ED8-9747-8C37-58ED2C48B286}"/>
                  </a:ext>
                </a:extLst>
              </p:cNvPr>
              <p:cNvSpPr txBox="1"/>
              <p:nvPr/>
            </p:nvSpPr>
            <p:spPr>
              <a:xfrm>
                <a:off x="2304730" y="3567281"/>
                <a:ext cx="450861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kumimoji="1" lang="en-US" altLang="ja-JP" sz="1200" dirty="0"/>
                  <a:t>0.6</a:t>
                </a:r>
                <a:endParaRPr kumimoji="1" lang="ja-JP" altLang="en-US" sz="1200"/>
              </a:p>
            </p:txBody>
          </p:sp>
          <p:sp>
            <p:nvSpPr>
              <p:cNvPr id="114" name="テキスト ボックス 113">
                <a:extLst>
                  <a:ext uri="{FF2B5EF4-FFF2-40B4-BE49-F238E27FC236}">
                    <a16:creationId xmlns="" xmlns:a16="http://schemas.microsoft.com/office/drawing/2014/main" id="{A03DC361-11E9-C646-9D12-405CF7AED2DF}"/>
                  </a:ext>
                </a:extLst>
              </p:cNvPr>
              <p:cNvSpPr txBox="1"/>
              <p:nvPr/>
            </p:nvSpPr>
            <p:spPr>
              <a:xfrm>
                <a:off x="2304730" y="4236789"/>
                <a:ext cx="450861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kumimoji="1" lang="en-US" altLang="ja-JP" sz="1200" dirty="0"/>
                  <a:t>0.4</a:t>
                </a:r>
                <a:endParaRPr kumimoji="1" lang="ja-JP" altLang="en-US" sz="1200"/>
              </a:p>
            </p:txBody>
          </p:sp>
          <p:sp>
            <p:nvSpPr>
              <p:cNvPr id="115" name="テキスト ボックス 114">
                <a:extLst>
                  <a:ext uri="{FF2B5EF4-FFF2-40B4-BE49-F238E27FC236}">
                    <a16:creationId xmlns="" xmlns:a16="http://schemas.microsoft.com/office/drawing/2014/main" id="{96A4B83D-E0A4-B34A-8138-EEFF3655DC30}"/>
                  </a:ext>
                </a:extLst>
              </p:cNvPr>
              <p:cNvSpPr txBox="1"/>
              <p:nvPr/>
            </p:nvSpPr>
            <p:spPr>
              <a:xfrm rot="16200000">
                <a:off x="1436229" y="3541100"/>
                <a:ext cx="1668379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kumimoji="1" lang="en-US" altLang="ja-JP" sz="1200" dirty="0"/>
                  <a:t>Directionality</a:t>
                </a:r>
                <a:r>
                  <a:rPr kumimoji="1" lang="ja-JP" altLang="en-US" sz="1200" dirty="0"/>
                  <a:t> </a:t>
                </a:r>
                <a:r>
                  <a:rPr kumimoji="1" lang="en-US" altLang="ja-JP" sz="1200" dirty="0"/>
                  <a:t>(radian)</a:t>
                </a:r>
                <a:endParaRPr kumimoji="1" lang="ja-JP" altLang="en-US" sz="1200" dirty="0"/>
              </a:p>
            </p:txBody>
          </p:sp>
          <p:sp>
            <p:nvSpPr>
              <p:cNvPr id="116" name="テキスト ボックス 115">
                <a:extLst>
                  <a:ext uri="{FF2B5EF4-FFF2-40B4-BE49-F238E27FC236}">
                    <a16:creationId xmlns="" xmlns:a16="http://schemas.microsoft.com/office/drawing/2014/main" id="{07EC5078-2D18-914F-929E-42E0ADAD168C}"/>
                  </a:ext>
                </a:extLst>
              </p:cNvPr>
              <p:cNvSpPr txBox="1"/>
              <p:nvPr/>
            </p:nvSpPr>
            <p:spPr>
              <a:xfrm>
                <a:off x="3117785" y="5011896"/>
                <a:ext cx="526702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kumimoji="1" lang="en-US" altLang="ja-JP" sz="1200" dirty="0"/>
                  <a:t>GFP</a:t>
                </a:r>
                <a:endParaRPr kumimoji="1" lang="ja-JP" altLang="en-US" sz="1200" dirty="0"/>
              </a:p>
            </p:txBody>
          </p:sp>
          <p:sp>
            <p:nvSpPr>
              <p:cNvPr id="117" name="テキスト ボックス 116">
                <a:extLst>
                  <a:ext uri="{FF2B5EF4-FFF2-40B4-BE49-F238E27FC236}">
                    <a16:creationId xmlns="" xmlns:a16="http://schemas.microsoft.com/office/drawing/2014/main" id="{E1EB7381-39F4-D84D-B731-A867931968A2}"/>
                  </a:ext>
                </a:extLst>
              </p:cNvPr>
              <p:cNvSpPr txBox="1"/>
              <p:nvPr/>
            </p:nvSpPr>
            <p:spPr>
              <a:xfrm>
                <a:off x="4034183" y="5011896"/>
                <a:ext cx="526702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kumimoji="1" lang="en-US" altLang="ja-JP" sz="1200" dirty="0"/>
                  <a:t>AS#1</a:t>
                </a:r>
                <a:endParaRPr kumimoji="1" lang="ja-JP" altLang="en-US" sz="1200"/>
              </a:p>
            </p:txBody>
          </p:sp>
          <p:sp>
            <p:nvSpPr>
              <p:cNvPr id="118" name="テキスト ボックス 117">
                <a:extLst>
                  <a:ext uri="{FF2B5EF4-FFF2-40B4-BE49-F238E27FC236}">
                    <a16:creationId xmlns="" xmlns:a16="http://schemas.microsoft.com/office/drawing/2014/main" id="{86C4910A-BBF9-464F-94E0-65C827981CA0}"/>
                  </a:ext>
                </a:extLst>
              </p:cNvPr>
              <p:cNvSpPr txBox="1"/>
              <p:nvPr/>
            </p:nvSpPr>
            <p:spPr>
              <a:xfrm>
                <a:off x="4941709" y="5011896"/>
                <a:ext cx="526702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kumimoji="1" lang="en-US" altLang="ja-JP" sz="1200" dirty="0"/>
                  <a:t>AS#3</a:t>
                </a:r>
                <a:endParaRPr kumimoji="1" lang="ja-JP" altLang="en-US" sz="1200"/>
              </a:p>
            </p:txBody>
          </p:sp>
        </p:grpSp>
        <p:grpSp>
          <p:nvGrpSpPr>
            <p:cNvPr id="119" name="グループ化 29">
              <a:extLst>
                <a:ext uri="{FF2B5EF4-FFF2-40B4-BE49-F238E27FC236}">
                  <a16:creationId xmlns="" xmlns:a16="http://schemas.microsoft.com/office/drawing/2014/main" id="{86051C70-19AF-9347-9079-56F50CD6466C}"/>
                </a:ext>
              </a:extLst>
            </p:cNvPr>
            <p:cNvGrpSpPr/>
            <p:nvPr/>
          </p:nvGrpSpPr>
          <p:grpSpPr>
            <a:xfrm>
              <a:off x="5838667" y="4833455"/>
              <a:ext cx="3986102" cy="3600000"/>
              <a:chOff x="6598898" y="1879600"/>
              <a:chExt cx="3986102" cy="3600000"/>
            </a:xfrm>
          </p:grpSpPr>
          <p:pic>
            <p:nvPicPr>
              <p:cNvPr id="120" name="図 119">
                <a:extLst>
                  <a:ext uri="{FF2B5EF4-FFF2-40B4-BE49-F238E27FC236}">
                    <a16:creationId xmlns="" xmlns:a16="http://schemas.microsoft.com/office/drawing/2014/main" id="{0483C700-2444-9D44-8DFA-32DE49E38BC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6985000" y="1879600"/>
                <a:ext cx="3600000" cy="3600000"/>
              </a:xfrm>
              <a:prstGeom prst="rect">
                <a:avLst/>
              </a:prstGeom>
            </p:spPr>
          </p:pic>
          <p:sp>
            <p:nvSpPr>
              <p:cNvPr id="121" name="正方形/長方形 120">
                <a:extLst>
                  <a:ext uri="{FF2B5EF4-FFF2-40B4-BE49-F238E27FC236}">
                    <a16:creationId xmlns="" xmlns:a16="http://schemas.microsoft.com/office/drawing/2014/main" id="{E8D27FE9-1668-1C4A-9B00-53AF5B230D07}"/>
                  </a:ext>
                </a:extLst>
              </p:cNvPr>
              <p:cNvSpPr/>
              <p:nvPr/>
            </p:nvSpPr>
            <p:spPr>
              <a:xfrm>
                <a:off x="6777639" y="3344997"/>
                <a:ext cx="359187" cy="88388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2" name="テキスト ボックス 121">
                <a:extLst>
                  <a:ext uri="{FF2B5EF4-FFF2-40B4-BE49-F238E27FC236}">
                    <a16:creationId xmlns="" xmlns:a16="http://schemas.microsoft.com/office/drawing/2014/main" id="{10056EEC-5E70-EF42-AE4C-8E68D2F04123}"/>
                  </a:ext>
                </a:extLst>
              </p:cNvPr>
              <p:cNvSpPr txBox="1"/>
              <p:nvPr/>
            </p:nvSpPr>
            <p:spPr>
              <a:xfrm>
                <a:off x="6813690" y="2232026"/>
                <a:ext cx="54152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kumimoji="1" lang="en-US" altLang="ja-JP" sz="1200" dirty="0"/>
                  <a:t>0.030</a:t>
                </a:r>
                <a:endParaRPr kumimoji="1" lang="ja-JP" altLang="en-US" sz="1200"/>
              </a:p>
            </p:txBody>
          </p:sp>
          <p:sp>
            <p:nvSpPr>
              <p:cNvPr id="123" name="テキスト ボックス 122">
                <a:extLst>
                  <a:ext uri="{FF2B5EF4-FFF2-40B4-BE49-F238E27FC236}">
                    <a16:creationId xmlns="" xmlns:a16="http://schemas.microsoft.com/office/drawing/2014/main" id="{9875F10A-8412-934E-9853-7CA5490CC3C9}"/>
                  </a:ext>
                </a:extLst>
              </p:cNvPr>
              <p:cNvSpPr txBox="1"/>
              <p:nvPr/>
            </p:nvSpPr>
            <p:spPr>
              <a:xfrm>
                <a:off x="6813690" y="3207234"/>
                <a:ext cx="54152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kumimoji="1" lang="en-US" altLang="ja-JP" sz="1200" dirty="0"/>
                  <a:t>0.020</a:t>
                </a:r>
                <a:endParaRPr kumimoji="1" lang="ja-JP" altLang="en-US" sz="1200" dirty="0"/>
              </a:p>
            </p:txBody>
          </p:sp>
          <p:sp>
            <p:nvSpPr>
              <p:cNvPr id="124" name="テキスト ボックス 123">
                <a:extLst>
                  <a:ext uri="{FF2B5EF4-FFF2-40B4-BE49-F238E27FC236}">
                    <a16:creationId xmlns="" xmlns:a16="http://schemas.microsoft.com/office/drawing/2014/main" id="{8D795C61-B23F-1949-8BC7-37EB5FB1585F}"/>
                  </a:ext>
                </a:extLst>
              </p:cNvPr>
              <p:cNvSpPr txBox="1"/>
              <p:nvPr/>
            </p:nvSpPr>
            <p:spPr>
              <a:xfrm>
                <a:off x="6813690" y="2719630"/>
                <a:ext cx="54152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kumimoji="1" lang="en-US" altLang="ja-JP" sz="1200" dirty="0"/>
                  <a:t>0.025</a:t>
                </a:r>
                <a:endParaRPr kumimoji="1" lang="ja-JP" altLang="en-US" sz="1200"/>
              </a:p>
            </p:txBody>
          </p:sp>
          <p:sp>
            <p:nvSpPr>
              <p:cNvPr id="125" name="テキスト ボックス 124">
                <a:extLst>
                  <a:ext uri="{FF2B5EF4-FFF2-40B4-BE49-F238E27FC236}">
                    <a16:creationId xmlns="" xmlns:a16="http://schemas.microsoft.com/office/drawing/2014/main" id="{87079475-CBC5-A344-B9CF-4825BCABF222}"/>
                  </a:ext>
                </a:extLst>
              </p:cNvPr>
              <p:cNvSpPr txBox="1"/>
              <p:nvPr/>
            </p:nvSpPr>
            <p:spPr>
              <a:xfrm>
                <a:off x="6813690" y="3694838"/>
                <a:ext cx="54152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kumimoji="1" lang="en-US" altLang="ja-JP" sz="1200" dirty="0"/>
                  <a:t>0.015</a:t>
                </a:r>
                <a:endParaRPr kumimoji="1" lang="ja-JP" altLang="en-US" sz="1200"/>
              </a:p>
            </p:txBody>
          </p:sp>
          <p:sp>
            <p:nvSpPr>
              <p:cNvPr id="126" name="テキスト ボックス 125">
                <a:extLst>
                  <a:ext uri="{FF2B5EF4-FFF2-40B4-BE49-F238E27FC236}">
                    <a16:creationId xmlns="" xmlns:a16="http://schemas.microsoft.com/office/drawing/2014/main" id="{F206F6FB-F432-BB47-9CA6-68F28B1983B1}"/>
                  </a:ext>
                </a:extLst>
              </p:cNvPr>
              <p:cNvSpPr txBox="1"/>
              <p:nvPr/>
            </p:nvSpPr>
            <p:spPr>
              <a:xfrm>
                <a:off x="6813690" y="4182442"/>
                <a:ext cx="54152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kumimoji="1" lang="en-US" altLang="ja-JP" sz="1200" dirty="0"/>
                  <a:t>0.010</a:t>
                </a:r>
                <a:endParaRPr kumimoji="1" lang="ja-JP" altLang="en-US" sz="1200"/>
              </a:p>
            </p:txBody>
          </p:sp>
          <p:sp>
            <p:nvSpPr>
              <p:cNvPr id="127" name="テキスト ボックス 126">
                <a:extLst>
                  <a:ext uri="{FF2B5EF4-FFF2-40B4-BE49-F238E27FC236}">
                    <a16:creationId xmlns="" xmlns:a16="http://schemas.microsoft.com/office/drawing/2014/main" id="{B091E46E-CE16-8944-B905-DA2EB7E264D2}"/>
                  </a:ext>
                </a:extLst>
              </p:cNvPr>
              <p:cNvSpPr txBox="1"/>
              <p:nvPr/>
            </p:nvSpPr>
            <p:spPr>
              <a:xfrm>
                <a:off x="6813690" y="4670047"/>
                <a:ext cx="54152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kumimoji="1" lang="en-US" altLang="ja-JP" sz="1200" dirty="0"/>
                  <a:t>0.005</a:t>
                </a:r>
                <a:endParaRPr kumimoji="1" lang="ja-JP" altLang="en-US" sz="1200"/>
              </a:p>
            </p:txBody>
          </p:sp>
          <p:sp>
            <p:nvSpPr>
              <p:cNvPr id="128" name="テキスト ボックス 127">
                <a:extLst>
                  <a:ext uri="{FF2B5EF4-FFF2-40B4-BE49-F238E27FC236}">
                    <a16:creationId xmlns="" xmlns:a16="http://schemas.microsoft.com/office/drawing/2014/main" id="{2E7DAA78-FECC-ED4D-8B3A-06762B57643F}"/>
                  </a:ext>
                </a:extLst>
              </p:cNvPr>
              <p:cNvSpPr txBox="1"/>
              <p:nvPr/>
            </p:nvSpPr>
            <p:spPr>
              <a:xfrm rot="16200000">
                <a:off x="5903208" y="3541099"/>
                <a:ext cx="1668379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kumimoji="1" lang="en-US" altLang="ja-JP" sz="1200" dirty="0"/>
                  <a:t>Velocity (</a:t>
                </a:r>
                <a:r>
                  <a:rPr kumimoji="1" lang="en-US" altLang="ja-JP" sz="1200" dirty="0">
                    <a:latin typeface="Symbol" charset="2"/>
                    <a:cs typeface="Symbol" charset="2"/>
                  </a:rPr>
                  <a:t>m</a:t>
                </a:r>
                <a:r>
                  <a:rPr kumimoji="1" lang="en-US" altLang="ja-JP" sz="1200" dirty="0"/>
                  <a:t>m/min)</a:t>
                </a:r>
                <a:endParaRPr kumimoji="1" lang="ja-JP" altLang="en-US" sz="1200" dirty="0"/>
              </a:p>
            </p:txBody>
          </p:sp>
          <p:sp>
            <p:nvSpPr>
              <p:cNvPr id="129" name="テキスト ボックス 128">
                <a:extLst>
                  <a:ext uri="{FF2B5EF4-FFF2-40B4-BE49-F238E27FC236}">
                    <a16:creationId xmlns="" xmlns:a16="http://schemas.microsoft.com/office/drawing/2014/main" id="{9592B623-91E0-3A48-95C4-E60311F882EA}"/>
                  </a:ext>
                </a:extLst>
              </p:cNvPr>
              <p:cNvSpPr txBox="1"/>
              <p:nvPr/>
            </p:nvSpPr>
            <p:spPr>
              <a:xfrm>
                <a:off x="7713991" y="5011896"/>
                <a:ext cx="526702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kumimoji="1" lang="en-US" altLang="ja-JP" sz="1200" dirty="0"/>
                  <a:t>GFP</a:t>
                </a:r>
                <a:endParaRPr kumimoji="1" lang="ja-JP" altLang="en-US" sz="1200"/>
              </a:p>
            </p:txBody>
          </p:sp>
          <p:sp>
            <p:nvSpPr>
              <p:cNvPr id="130" name="テキスト ボックス 129">
                <a:extLst>
                  <a:ext uri="{FF2B5EF4-FFF2-40B4-BE49-F238E27FC236}">
                    <a16:creationId xmlns="" xmlns:a16="http://schemas.microsoft.com/office/drawing/2014/main" id="{18927B4D-0F2C-6642-8348-0B4D3BB61459}"/>
                  </a:ext>
                </a:extLst>
              </p:cNvPr>
              <p:cNvSpPr txBox="1"/>
              <p:nvPr/>
            </p:nvSpPr>
            <p:spPr>
              <a:xfrm>
                <a:off x="8630389" y="5011896"/>
                <a:ext cx="526702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kumimoji="1" lang="en-US" altLang="ja-JP" sz="1200" dirty="0"/>
                  <a:t>AS#1</a:t>
                </a:r>
                <a:endParaRPr kumimoji="1" lang="ja-JP" altLang="en-US" sz="1200"/>
              </a:p>
            </p:txBody>
          </p:sp>
          <p:sp>
            <p:nvSpPr>
              <p:cNvPr id="131" name="テキスト ボックス 130">
                <a:extLst>
                  <a:ext uri="{FF2B5EF4-FFF2-40B4-BE49-F238E27FC236}">
                    <a16:creationId xmlns="" xmlns:a16="http://schemas.microsoft.com/office/drawing/2014/main" id="{A581B6F8-F4A2-6F4C-87A4-DFB452ADEBC7}"/>
                  </a:ext>
                </a:extLst>
              </p:cNvPr>
              <p:cNvSpPr txBox="1"/>
              <p:nvPr/>
            </p:nvSpPr>
            <p:spPr>
              <a:xfrm>
                <a:off x="9537915" y="5011896"/>
                <a:ext cx="526702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kumimoji="1" lang="en-US" altLang="ja-JP" sz="1200" dirty="0"/>
                  <a:t>AS#3</a:t>
                </a:r>
                <a:endParaRPr kumimoji="1" lang="ja-JP" altLang="en-US" sz="1200"/>
              </a:p>
            </p:txBody>
          </p:sp>
        </p:grpSp>
      </p:grpSp>
      <p:sp>
        <p:nvSpPr>
          <p:cNvPr id="4" name="テキスト ボックス 3"/>
          <p:cNvSpPr txBox="1"/>
          <p:nvPr/>
        </p:nvSpPr>
        <p:spPr>
          <a:xfrm>
            <a:off x="50188" y="49294"/>
            <a:ext cx="2430473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b="1" dirty="0"/>
              <a:t>Suppl.</a:t>
            </a:r>
            <a:r>
              <a:rPr kumimoji="1" lang="ja-JP" altLang="en-US" sz="3200" b="1" dirty="0"/>
              <a:t> </a:t>
            </a:r>
            <a:r>
              <a:rPr kumimoji="1" lang="en-US" altLang="ja-JP" sz="3200" b="1" dirty="0"/>
              <a:t>Fig.</a:t>
            </a:r>
            <a:r>
              <a:rPr kumimoji="1" lang="ja-JP" altLang="en-US" sz="3200" b="1" dirty="0"/>
              <a:t> </a:t>
            </a:r>
            <a:r>
              <a:rPr kumimoji="1" lang="en-US" altLang="ja-JP" sz="3200" b="1" dirty="0" smtClean="0"/>
              <a:t>S</a:t>
            </a:r>
            <a:r>
              <a:rPr kumimoji="1" lang="en-US" altLang="ja-JP" sz="3200" b="1" dirty="0" smtClean="0"/>
              <a:t>4</a:t>
            </a:r>
            <a:endParaRPr kumimoji="1" lang="ja-JP" altLang="en-US" sz="3200" b="1" dirty="0"/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1183749" y="12807908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1183749" y="982248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grpSp>
        <p:nvGrpSpPr>
          <p:cNvPr id="3" name="図形グループ 2"/>
          <p:cNvGrpSpPr/>
          <p:nvPr/>
        </p:nvGrpSpPr>
        <p:grpSpPr>
          <a:xfrm>
            <a:off x="1577053" y="743215"/>
            <a:ext cx="9066343" cy="7209810"/>
            <a:chOff x="1611658" y="8318877"/>
            <a:chExt cx="9066343" cy="7209810"/>
          </a:xfrm>
        </p:grpSpPr>
        <p:pic>
          <p:nvPicPr>
            <p:cNvPr id="5" name="図 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328009" y="8780542"/>
              <a:ext cx="7875340" cy="6748145"/>
            </a:xfrm>
            <a:prstGeom prst="rect">
              <a:avLst/>
            </a:prstGeom>
          </p:spPr>
        </p:pic>
        <p:sp>
          <p:nvSpPr>
            <p:cNvPr id="7" name="テキスト ボックス 6"/>
            <p:cNvSpPr txBox="1"/>
            <p:nvPr/>
          </p:nvSpPr>
          <p:spPr>
            <a:xfrm>
              <a:off x="9599010" y="8318877"/>
              <a:ext cx="107899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Concentration</a:t>
              </a:r>
            </a:p>
            <a:p>
              <a:r>
                <a:rPr kumimoji="1" lang="en-US" altLang="ja-JP" sz="1200" dirty="0"/>
                <a:t>gradient</a:t>
              </a:r>
              <a:endParaRPr kumimoji="1" lang="ja-JP" altLang="en-US" sz="1200" dirty="0"/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3197449" y="8484077"/>
              <a:ext cx="4319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GFP</a:t>
              </a:r>
              <a:endParaRPr kumimoji="1" lang="ja-JP" altLang="en-US" sz="1200" dirty="0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5641511" y="8484077"/>
              <a:ext cx="4990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AS#1</a:t>
              </a:r>
              <a:endParaRPr kumimoji="1" lang="ja-JP" altLang="en-US" sz="1200" dirty="0"/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8115538" y="8484077"/>
              <a:ext cx="4990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AS#3</a:t>
              </a:r>
              <a:endParaRPr kumimoji="1" lang="ja-JP" altLang="en-US" sz="1200" dirty="0"/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1968741" y="9410629"/>
              <a:ext cx="2626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0</a:t>
              </a:r>
              <a:endParaRPr kumimoji="1" lang="ja-JP" altLang="en-US" sz="1200" dirty="0"/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1851747" y="11200390"/>
              <a:ext cx="3406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60</a:t>
              </a:r>
              <a:endParaRPr kumimoji="1" lang="ja-JP" altLang="en-US" sz="1200" dirty="0"/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734753" y="12947667"/>
              <a:ext cx="4186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120</a:t>
              </a:r>
              <a:endParaRPr kumimoji="1" lang="ja-JP" altLang="en-US" sz="1200" dirty="0"/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734753" y="14586965"/>
              <a:ext cx="4186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180</a:t>
              </a:r>
              <a:endParaRPr kumimoji="1" lang="ja-JP" altLang="en-US" sz="1200" dirty="0"/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1611658" y="9023658"/>
              <a:ext cx="5170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(min)</a:t>
              </a:r>
              <a:endParaRPr kumimoji="1" lang="ja-JP" alt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51098964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グループ化 46">
            <a:extLst>
              <a:ext uri="{FF2B5EF4-FFF2-40B4-BE49-F238E27FC236}">
                <a16:creationId xmlns="" xmlns:a16="http://schemas.microsoft.com/office/drawing/2014/main" id="{D5DE6F9E-6B20-B044-B25A-C4F2DB5ECCFD}"/>
              </a:ext>
            </a:extLst>
          </p:cNvPr>
          <p:cNvGrpSpPr/>
          <p:nvPr/>
        </p:nvGrpSpPr>
        <p:grpSpPr>
          <a:xfrm rot="879449">
            <a:off x="6981832" y="2137699"/>
            <a:ext cx="1728249" cy="1247608"/>
            <a:chOff x="3488203" y="1294083"/>
            <a:chExt cx="1728249" cy="1247608"/>
          </a:xfrm>
        </p:grpSpPr>
        <p:grpSp>
          <p:nvGrpSpPr>
            <p:cNvPr id="47" name="グループ化 47">
              <a:extLst>
                <a:ext uri="{FF2B5EF4-FFF2-40B4-BE49-F238E27FC236}">
                  <a16:creationId xmlns="" xmlns:a16="http://schemas.microsoft.com/office/drawing/2014/main" id="{593DD11B-86EB-9640-BAF6-0297F04B04C7}"/>
                </a:ext>
              </a:extLst>
            </p:cNvPr>
            <p:cNvGrpSpPr/>
            <p:nvPr/>
          </p:nvGrpSpPr>
          <p:grpSpPr>
            <a:xfrm rot="173173">
              <a:off x="3545715" y="1294083"/>
              <a:ext cx="1195970" cy="1247608"/>
              <a:chOff x="4457701" y="6505158"/>
              <a:chExt cx="686509" cy="752712"/>
            </a:xfrm>
          </p:grpSpPr>
          <p:sp>
            <p:nvSpPr>
              <p:cNvPr id="50" name="円/楕円 21">
                <a:extLst>
                  <a:ext uri="{FF2B5EF4-FFF2-40B4-BE49-F238E27FC236}">
                    <a16:creationId xmlns="" xmlns:a16="http://schemas.microsoft.com/office/drawing/2014/main" id="{299CC555-F3A4-B74A-B38C-1B591E11372B}"/>
                  </a:ext>
                </a:extLst>
              </p:cNvPr>
              <p:cNvSpPr/>
              <p:nvPr/>
            </p:nvSpPr>
            <p:spPr>
              <a:xfrm>
                <a:off x="4457701" y="6505158"/>
                <a:ext cx="686509" cy="752712"/>
              </a:xfrm>
              <a:custGeom>
                <a:avLst/>
                <a:gdLst>
                  <a:gd name="connsiteX0" fmla="*/ 0 w 494270"/>
                  <a:gd name="connsiteY0" fmla="*/ 245216 h 490432"/>
                  <a:gd name="connsiteX1" fmla="*/ 247135 w 494270"/>
                  <a:gd name="connsiteY1" fmla="*/ 0 h 490432"/>
                  <a:gd name="connsiteX2" fmla="*/ 494270 w 494270"/>
                  <a:gd name="connsiteY2" fmla="*/ 245216 h 490432"/>
                  <a:gd name="connsiteX3" fmla="*/ 247135 w 494270"/>
                  <a:gd name="connsiteY3" fmla="*/ 490432 h 490432"/>
                  <a:gd name="connsiteX4" fmla="*/ 0 w 494270"/>
                  <a:gd name="connsiteY4" fmla="*/ 245216 h 490432"/>
                  <a:gd name="connsiteX0" fmla="*/ 0 w 499027"/>
                  <a:gd name="connsiteY0" fmla="*/ 256664 h 501880"/>
                  <a:gd name="connsiteX1" fmla="*/ 247135 w 499027"/>
                  <a:gd name="connsiteY1" fmla="*/ 11448 h 501880"/>
                  <a:gd name="connsiteX2" fmla="*/ 397755 w 499027"/>
                  <a:gd name="connsiteY2" fmla="*/ 62388 h 501880"/>
                  <a:gd name="connsiteX3" fmla="*/ 494270 w 499027"/>
                  <a:gd name="connsiteY3" fmla="*/ 256664 h 501880"/>
                  <a:gd name="connsiteX4" fmla="*/ 247135 w 499027"/>
                  <a:gd name="connsiteY4" fmla="*/ 501880 h 501880"/>
                  <a:gd name="connsiteX5" fmla="*/ 0 w 499027"/>
                  <a:gd name="connsiteY5" fmla="*/ 256664 h 501880"/>
                  <a:gd name="connsiteX0" fmla="*/ 0 w 571108"/>
                  <a:gd name="connsiteY0" fmla="*/ 348680 h 593896"/>
                  <a:gd name="connsiteX1" fmla="*/ 247135 w 571108"/>
                  <a:gd name="connsiteY1" fmla="*/ 103464 h 593896"/>
                  <a:gd name="connsiteX2" fmla="*/ 559680 w 571108"/>
                  <a:gd name="connsiteY2" fmla="*/ 11529 h 593896"/>
                  <a:gd name="connsiteX3" fmla="*/ 494270 w 571108"/>
                  <a:gd name="connsiteY3" fmla="*/ 348680 h 593896"/>
                  <a:gd name="connsiteX4" fmla="*/ 247135 w 571108"/>
                  <a:gd name="connsiteY4" fmla="*/ 593896 h 593896"/>
                  <a:gd name="connsiteX5" fmla="*/ 0 w 571108"/>
                  <a:gd name="connsiteY5" fmla="*/ 348680 h 593896"/>
                  <a:gd name="connsiteX0" fmla="*/ 6782 w 577890"/>
                  <a:gd name="connsiteY0" fmla="*/ 348680 h 603774"/>
                  <a:gd name="connsiteX1" fmla="*/ 253917 w 577890"/>
                  <a:gd name="connsiteY1" fmla="*/ 103464 h 603774"/>
                  <a:gd name="connsiteX2" fmla="*/ 566462 w 577890"/>
                  <a:gd name="connsiteY2" fmla="*/ 11529 h 603774"/>
                  <a:gd name="connsiteX3" fmla="*/ 501052 w 577890"/>
                  <a:gd name="connsiteY3" fmla="*/ 348680 h 603774"/>
                  <a:gd name="connsiteX4" fmla="*/ 253917 w 577890"/>
                  <a:gd name="connsiteY4" fmla="*/ 593896 h 603774"/>
                  <a:gd name="connsiteX5" fmla="*/ 85449 w 577890"/>
                  <a:gd name="connsiteY5" fmla="*/ 535404 h 603774"/>
                  <a:gd name="connsiteX6" fmla="*/ 6782 w 577890"/>
                  <a:gd name="connsiteY6" fmla="*/ 348680 h 603774"/>
                  <a:gd name="connsiteX0" fmla="*/ 83008 w 654116"/>
                  <a:gd name="connsiteY0" fmla="*/ 348680 h 780479"/>
                  <a:gd name="connsiteX1" fmla="*/ 330143 w 654116"/>
                  <a:gd name="connsiteY1" fmla="*/ 103464 h 780479"/>
                  <a:gd name="connsiteX2" fmla="*/ 642688 w 654116"/>
                  <a:gd name="connsiteY2" fmla="*/ 11529 h 780479"/>
                  <a:gd name="connsiteX3" fmla="*/ 577278 w 654116"/>
                  <a:gd name="connsiteY3" fmla="*/ 348680 h 780479"/>
                  <a:gd name="connsiteX4" fmla="*/ 330143 w 654116"/>
                  <a:gd name="connsiteY4" fmla="*/ 593896 h 780479"/>
                  <a:gd name="connsiteX5" fmla="*/ 14037 w 654116"/>
                  <a:gd name="connsiteY5" fmla="*/ 773529 h 780479"/>
                  <a:gd name="connsiteX6" fmla="*/ 83008 w 654116"/>
                  <a:gd name="connsiteY6" fmla="*/ 348680 h 780479"/>
                  <a:gd name="connsiteX0" fmla="*/ 68971 w 640079"/>
                  <a:gd name="connsiteY0" fmla="*/ 348680 h 780479"/>
                  <a:gd name="connsiteX1" fmla="*/ 316106 w 640079"/>
                  <a:gd name="connsiteY1" fmla="*/ 103464 h 780479"/>
                  <a:gd name="connsiteX2" fmla="*/ 628651 w 640079"/>
                  <a:gd name="connsiteY2" fmla="*/ 11529 h 780479"/>
                  <a:gd name="connsiteX3" fmla="*/ 563241 w 640079"/>
                  <a:gd name="connsiteY3" fmla="*/ 348680 h 780479"/>
                  <a:gd name="connsiteX4" fmla="*/ 316106 w 640079"/>
                  <a:gd name="connsiteY4" fmla="*/ 593896 h 780479"/>
                  <a:gd name="connsiteX5" fmla="*/ 0 w 640079"/>
                  <a:gd name="connsiteY5" fmla="*/ 773529 h 780479"/>
                  <a:gd name="connsiteX6" fmla="*/ 68971 w 640079"/>
                  <a:gd name="connsiteY6" fmla="*/ 348680 h 780479"/>
                  <a:gd name="connsiteX0" fmla="*/ 173746 w 744854"/>
                  <a:gd name="connsiteY0" fmla="*/ 348680 h 953582"/>
                  <a:gd name="connsiteX1" fmla="*/ 420881 w 744854"/>
                  <a:gd name="connsiteY1" fmla="*/ 103464 h 953582"/>
                  <a:gd name="connsiteX2" fmla="*/ 733426 w 744854"/>
                  <a:gd name="connsiteY2" fmla="*/ 11529 h 953582"/>
                  <a:gd name="connsiteX3" fmla="*/ 668016 w 744854"/>
                  <a:gd name="connsiteY3" fmla="*/ 348680 h 953582"/>
                  <a:gd name="connsiteX4" fmla="*/ 420881 w 744854"/>
                  <a:gd name="connsiteY4" fmla="*/ 593896 h 953582"/>
                  <a:gd name="connsiteX5" fmla="*/ 0 w 744854"/>
                  <a:gd name="connsiteY5" fmla="*/ 949742 h 953582"/>
                  <a:gd name="connsiteX6" fmla="*/ 173746 w 744854"/>
                  <a:gd name="connsiteY6" fmla="*/ 348680 h 953582"/>
                  <a:gd name="connsiteX0" fmla="*/ 173746 w 744854"/>
                  <a:gd name="connsiteY0" fmla="*/ 337151 h 942053"/>
                  <a:gd name="connsiteX1" fmla="*/ 420881 w 744854"/>
                  <a:gd name="connsiteY1" fmla="*/ 91935 h 942053"/>
                  <a:gd name="connsiteX2" fmla="*/ 733426 w 744854"/>
                  <a:gd name="connsiteY2" fmla="*/ 0 h 942053"/>
                  <a:gd name="connsiteX3" fmla="*/ 668016 w 744854"/>
                  <a:gd name="connsiteY3" fmla="*/ 337151 h 942053"/>
                  <a:gd name="connsiteX4" fmla="*/ 420881 w 744854"/>
                  <a:gd name="connsiteY4" fmla="*/ 582367 h 942053"/>
                  <a:gd name="connsiteX5" fmla="*/ 0 w 744854"/>
                  <a:gd name="connsiteY5" fmla="*/ 938213 h 942053"/>
                  <a:gd name="connsiteX6" fmla="*/ 173746 w 744854"/>
                  <a:gd name="connsiteY6" fmla="*/ 337151 h 942053"/>
                  <a:gd name="connsiteX0" fmla="*/ 173746 w 914087"/>
                  <a:gd name="connsiteY0" fmla="*/ 384776 h 989678"/>
                  <a:gd name="connsiteX1" fmla="*/ 420881 w 914087"/>
                  <a:gd name="connsiteY1" fmla="*/ 139560 h 989678"/>
                  <a:gd name="connsiteX2" fmla="*/ 909638 w 914087"/>
                  <a:gd name="connsiteY2" fmla="*/ 0 h 989678"/>
                  <a:gd name="connsiteX3" fmla="*/ 668016 w 914087"/>
                  <a:gd name="connsiteY3" fmla="*/ 384776 h 989678"/>
                  <a:gd name="connsiteX4" fmla="*/ 420881 w 914087"/>
                  <a:gd name="connsiteY4" fmla="*/ 629992 h 989678"/>
                  <a:gd name="connsiteX5" fmla="*/ 0 w 914087"/>
                  <a:gd name="connsiteY5" fmla="*/ 985838 h 989678"/>
                  <a:gd name="connsiteX6" fmla="*/ 173746 w 914087"/>
                  <a:gd name="connsiteY6" fmla="*/ 384776 h 989678"/>
                  <a:gd name="connsiteX0" fmla="*/ 173746 w 909638"/>
                  <a:gd name="connsiteY0" fmla="*/ 384776 h 989678"/>
                  <a:gd name="connsiteX1" fmla="*/ 420881 w 909638"/>
                  <a:gd name="connsiteY1" fmla="*/ 139560 h 989678"/>
                  <a:gd name="connsiteX2" fmla="*/ 909638 w 909638"/>
                  <a:gd name="connsiteY2" fmla="*/ 0 h 989678"/>
                  <a:gd name="connsiteX3" fmla="*/ 668016 w 909638"/>
                  <a:gd name="connsiteY3" fmla="*/ 384776 h 989678"/>
                  <a:gd name="connsiteX4" fmla="*/ 420881 w 909638"/>
                  <a:gd name="connsiteY4" fmla="*/ 629992 h 989678"/>
                  <a:gd name="connsiteX5" fmla="*/ 0 w 909638"/>
                  <a:gd name="connsiteY5" fmla="*/ 985838 h 989678"/>
                  <a:gd name="connsiteX6" fmla="*/ 173746 w 909638"/>
                  <a:gd name="connsiteY6" fmla="*/ 384776 h 989678"/>
                  <a:gd name="connsiteX0" fmla="*/ 173746 w 947738"/>
                  <a:gd name="connsiteY0" fmla="*/ 403826 h 1008728"/>
                  <a:gd name="connsiteX1" fmla="*/ 420881 w 947738"/>
                  <a:gd name="connsiteY1" fmla="*/ 158610 h 1008728"/>
                  <a:gd name="connsiteX2" fmla="*/ 947738 w 947738"/>
                  <a:gd name="connsiteY2" fmla="*/ 0 h 1008728"/>
                  <a:gd name="connsiteX3" fmla="*/ 668016 w 947738"/>
                  <a:gd name="connsiteY3" fmla="*/ 403826 h 1008728"/>
                  <a:gd name="connsiteX4" fmla="*/ 420881 w 947738"/>
                  <a:gd name="connsiteY4" fmla="*/ 649042 h 1008728"/>
                  <a:gd name="connsiteX5" fmla="*/ 0 w 947738"/>
                  <a:gd name="connsiteY5" fmla="*/ 1004888 h 1008728"/>
                  <a:gd name="connsiteX6" fmla="*/ 173746 w 947738"/>
                  <a:gd name="connsiteY6" fmla="*/ 403826 h 1008728"/>
                  <a:gd name="connsiteX0" fmla="*/ 173746 w 947738"/>
                  <a:gd name="connsiteY0" fmla="*/ 403826 h 1008728"/>
                  <a:gd name="connsiteX1" fmla="*/ 420881 w 947738"/>
                  <a:gd name="connsiteY1" fmla="*/ 158610 h 1008728"/>
                  <a:gd name="connsiteX2" fmla="*/ 947738 w 947738"/>
                  <a:gd name="connsiteY2" fmla="*/ 0 h 1008728"/>
                  <a:gd name="connsiteX3" fmla="*/ 668016 w 947738"/>
                  <a:gd name="connsiteY3" fmla="*/ 403826 h 1008728"/>
                  <a:gd name="connsiteX4" fmla="*/ 420881 w 947738"/>
                  <a:gd name="connsiteY4" fmla="*/ 649042 h 1008728"/>
                  <a:gd name="connsiteX5" fmla="*/ 0 w 947738"/>
                  <a:gd name="connsiteY5" fmla="*/ 1004888 h 1008728"/>
                  <a:gd name="connsiteX6" fmla="*/ 173746 w 947738"/>
                  <a:gd name="connsiteY6" fmla="*/ 403826 h 1008728"/>
                  <a:gd name="connsiteX0" fmla="*/ 173746 w 947738"/>
                  <a:gd name="connsiteY0" fmla="*/ 403826 h 1008728"/>
                  <a:gd name="connsiteX1" fmla="*/ 401831 w 947738"/>
                  <a:gd name="connsiteY1" fmla="*/ 215760 h 1008728"/>
                  <a:gd name="connsiteX2" fmla="*/ 947738 w 947738"/>
                  <a:gd name="connsiteY2" fmla="*/ 0 h 1008728"/>
                  <a:gd name="connsiteX3" fmla="*/ 668016 w 947738"/>
                  <a:gd name="connsiteY3" fmla="*/ 403826 h 1008728"/>
                  <a:gd name="connsiteX4" fmla="*/ 420881 w 947738"/>
                  <a:gd name="connsiteY4" fmla="*/ 649042 h 1008728"/>
                  <a:gd name="connsiteX5" fmla="*/ 0 w 947738"/>
                  <a:gd name="connsiteY5" fmla="*/ 1004888 h 1008728"/>
                  <a:gd name="connsiteX6" fmla="*/ 173746 w 947738"/>
                  <a:gd name="connsiteY6" fmla="*/ 403826 h 1008728"/>
                  <a:gd name="connsiteX0" fmla="*/ 149934 w 947738"/>
                  <a:gd name="connsiteY0" fmla="*/ 537176 h 1008728"/>
                  <a:gd name="connsiteX1" fmla="*/ 401831 w 947738"/>
                  <a:gd name="connsiteY1" fmla="*/ 215760 h 1008728"/>
                  <a:gd name="connsiteX2" fmla="*/ 947738 w 947738"/>
                  <a:gd name="connsiteY2" fmla="*/ 0 h 1008728"/>
                  <a:gd name="connsiteX3" fmla="*/ 668016 w 947738"/>
                  <a:gd name="connsiteY3" fmla="*/ 403826 h 1008728"/>
                  <a:gd name="connsiteX4" fmla="*/ 420881 w 947738"/>
                  <a:gd name="connsiteY4" fmla="*/ 649042 h 1008728"/>
                  <a:gd name="connsiteX5" fmla="*/ 0 w 947738"/>
                  <a:gd name="connsiteY5" fmla="*/ 1004888 h 1008728"/>
                  <a:gd name="connsiteX6" fmla="*/ 149934 w 947738"/>
                  <a:gd name="connsiteY6" fmla="*/ 537176 h 1008728"/>
                  <a:gd name="connsiteX0" fmla="*/ 149934 w 947738"/>
                  <a:gd name="connsiteY0" fmla="*/ 537176 h 1008728"/>
                  <a:gd name="connsiteX1" fmla="*/ 401831 w 947738"/>
                  <a:gd name="connsiteY1" fmla="*/ 215760 h 1008728"/>
                  <a:gd name="connsiteX2" fmla="*/ 947738 w 947738"/>
                  <a:gd name="connsiteY2" fmla="*/ 0 h 1008728"/>
                  <a:gd name="connsiteX3" fmla="*/ 668016 w 947738"/>
                  <a:gd name="connsiteY3" fmla="*/ 403826 h 1008728"/>
                  <a:gd name="connsiteX4" fmla="*/ 420881 w 947738"/>
                  <a:gd name="connsiteY4" fmla="*/ 649042 h 1008728"/>
                  <a:gd name="connsiteX5" fmla="*/ 0 w 947738"/>
                  <a:gd name="connsiteY5" fmla="*/ 1004888 h 1008728"/>
                  <a:gd name="connsiteX6" fmla="*/ 149934 w 947738"/>
                  <a:gd name="connsiteY6" fmla="*/ 537176 h 1008728"/>
                  <a:gd name="connsiteX0" fmla="*/ 149934 w 947738"/>
                  <a:gd name="connsiteY0" fmla="*/ 537176 h 1008588"/>
                  <a:gd name="connsiteX1" fmla="*/ 401831 w 947738"/>
                  <a:gd name="connsiteY1" fmla="*/ 215760 h 1008588"/>
                  <a:gd name="connsiteX2" fmla="*/ 947738 w 947738"/>
                  <a:gd name="connsiteY2" fmla="*/ 0 h 1008588"/>
                  <a:gd name="connsiteX3" fmla="*/ 534666 w 947738"/>
                  <a:gd name="connsiteY3" fmla="*/ 480026 h 1008588"/>
                  <a:gd name="connsiteX4" fmla="*/ 420881 w 947738"/>
                  <a:gd name="connsiteY4" fmla="*/ 649042 h 1008588"/>
                  <a:gd name="connsiteX5" fmla="*/ 0 w 947738"/>
                  <a:gd name="connsiteY5" fmla="*/ 1004888 h 1008588"/>
                  <a:gd name="connsiteX6" fmla="*/ 149934 w 947738"/>
                  <a:gd name="connsiteY6" fmla="*/ 537176 h 1008588"/>
                  <a:gd name="connsiteX0" fmla="*/ 149934 w 947738"/>
                  <a:gd name="connsiteY0" fmla="*/ 537176 h 1008588"/>
                  <a:gd name="connsiteX1" fmla="*/ 401831 w 947738"/>
                  <a:gd name="connsiteY1" fmla="*/ 215760 h 1008588"/>
                  <a:gd name="connsiteX2" fmla="*/ 947738 w 947738"/>
                  <a:gd name="connsiteY2" fmla="*/ 0 h 1008588"/>
                  <a:gd name="connsiteX3" fmla="*/ 534666 w 947738"/>
                  <a:gd name="connsiteY3" fmla="*/ 480026 h 1008588"/>
                  <a:gd name="connsiteX4" fmla="*/ 420881 w 947738"/>
                  <a:gd name="connsiteY4" fmla="*/ 649042 h 1008588"/>
                  <a:gd name="connsiteX5" fmla="*/ 0 w 947738"/>
                  <a:gd name="connsiteY5" fmla="*/ 1004888 h 1008588"/>
                  <a:gd name="connsiteX6" fmla="*/ 149934 w 947738"/>
                  <a:gd name="connsiteY6" fmla="*/ 537176 h 1008588"/>
                  <a:gd name="connsiteX0" fmla="*/ 149934 w 947738"/>
                  <a:gd name="connsiteY0" fmla="*/ 537176 h 1009189"/>
                  <a:gd name="connsiteX1" fmla="*/ 401831 w 947738"/>
                  <a:gd name="connsiteY1" fmla="*/ 215760 h 1009189"/>
                  <a:gd name="connsiteX2" fmla="*/ 947738 w 947738"/>
                  <a:gd name="connsiteY2" fmla="*/ 0 h 1009189"/>
                  <a:gd name="connsiteX3" fmla="*/ 534666 w 947738"/>
                  <a:gd name="connsiteY3" fmla="*/ 480026 h 1009189"/>
                  <a:gd name="connsiteX4" fmla="*/ 335156 w 947738"/>
                  <a:gd name="connsiteY4" fmla="*/ 696667 h 1009189"/>
                  <a:gd name="connsiteX5" fmla="*/ 0 w 947738"/>
                  <a:gd name="connsiteY5" fmla="*/ 1004888 h 1009189"/>
                  <a:gd name="connsiteX6" fmla="*/ 149934 w 947738"/>
                  <a:gd name="connsiteY6" fmla="*/ 537176 h 1009189"/>
                  <a:gd name="connsiteX0" fmla="*/ 149934 w 947738"/>
                  <a:gd name="connsiteY0" fmla="*/ 537176 h 1009403"/>
                  <a:gd name="connsiteX1" fmla="*/ 401831 w 947738"/>
                  <a:gd name="connsiteY1" fmla="*/ 215760 h 1009403"/>
                  <a:gd name="connsiteX2" fmla="*/ 947738 w 947738"/>
                  <a:gd name="connsiteY2" fmla="*/ 0 h 1009403"/>
                  <a:gd name="connsiteX3" fmla="*/ 534666 w 947738"/>
                  <a:gd name="connsiteY3" fmla="*/ 480026 h 1009403"/>
                  <a:gd name="connsiteX4" fmla="*/ 335156 w 947738"/>
                  <a:gd name="connsiteY4" fmla="*/ 696667 h 1009403"/>
                  <a:gd name="connsiteX5" fmla="*/ 0 w 947738"/>
                  <a:gd name="connsiteY5" fmla="*/ 1004888 h 1009403"/>
                  <a:gd name="connsiteX6" fmla="*/ 149934 w 947738"/>
                  <a:gd name="connsiteY6" fmla="*/ 537176 h 1009403"/>
                  <a:gd name="connsiteX0" fmla="*/ 149934 w 947738"/>
                  <a:gd name="connsiteY0" fmla="*/ 537176 h 1009403"/>
                  <a:gd name="connsiteX1" fmla="*/ 401831 w 947738"/>
                  <a:gd name="connsiteY1" fmla="*/ 215760 h 1009403"/>
                  <a:gd name="connsiteX2" fmla="*/ 947738 w 947738"/>
                  <a:gd name="connsiteY2" fmla="*/ 0 h 1009403"/>
                  <a:gd name="connsiteX3" fmla="*/ 534666 w 947738"/>
                  <a:gd name="connsiteY3" fmla="*/ 480026 h 1009403"/>
                  <a:gd name="connsiteX4" fmla="*/ 335156 w 947738"/>
                  <a:gd name="connsiteY4" fmla="*/ 696667 h 1009403"/>
                  <a:gd name="connsiteX5" fmla="*/ 0 w 947738"/>
                  <a:gd name="connsiteY5" fmla="*/ 1004888 h 1009403"/>
                  <a:gd name="connsiteX6" fmla="*/ 149934 w 947738"/>
                  <a:gd name="connsiteY6" fmla="*/ 537176 h 1009403"/>
                  <a:gd name="connsiteX0" fmla="*/ 149934 w 947738"/>
                  <a:gd name="connsiteY0" fmla="*/ 537176 h 1009403"/>
                  <a:gd name="connsiteX1" fmla="*/ 401831 w 947738"/>
                  <a:gd name="connsiteY1" fmla="*/ 215760 h 1009403"/>
                  <a:gd name="connsiteX2" fmla="*/ 947738 w 947738"/>
                  <a:gd name="connsiteY2" fmla="*/ 0 h 1009403"/>
                  <a:gd name="connsiteX3" fmla="*/ 534666 w 947738"/>
                  <a:gd name="connsiteY3" fmla="*/ 480026 h 1009403"/>
                  <a:gd name="connsiteX4" fmla="*/ 335156 w 947738"/>
                  <a:gd name="connsiteY4" fmla="*/ 696667 h 1009403"/>
                  <a:gd name="connsiteX5" fmla="*/ 0 w 947738"/>
                  <a:gd name="connsiteY5" fmla="*/ 1004888 h 1009403"/>
                  <a:gd name="connsiteX6" fmla="*/ 149934 w 947738"/>
                  <a:gd name="connsiteY6" fmla="*/ 537176 h 1009403"/>
                  <a:gd name="connsiteX0" fmla="*/ 149934 w 957263"/>
                  <a:gd name="connsiteY0" fmla="*/ 499076 h 971303"/>
                  <a:gd name="connsiteX1" fmla="*/ 401831 w 957263"/>
                  <a:gd name="connsiteY1" fmla="*/ 177660 h 971303"/>
                  <a:gd name="connsiteX2" fmla="*/ 957263 w 957263"/>
                  <a:gd name="connsiteY2" fmla="*/ 0 h 971303"/>
                  <a:gd name="connsiteX3" fmla="*/ 534666 w 957263"/>
                  <a:gd name="connsiteY3" fmla="*/ 441926 h 971303"/>
                  <a:gd name="connsiteX4" fmla="*/ 335156 w 957263"/>
                  <a:gd name="connsiteY4" fmla="*/ 658567 h 971303"/>
                  <a:gd name="connsiteX5" fmla="*/ 0 w 957263"/>
                  <a:gd name="connsiteY5" fmla="*/ 966788 h 971303"/>
                  <a:gd name="connsiteX6" fmla="*/ 149934 w 957263"/>
                  <a:gd name="connsiteY6" fmla="*/ 499076 h 971303"/>
                  <a:gd name="connsiteX0" fmla="*/ 149934 w 957263"/>
                  <a:gd name="connsiteY0" fmla="*/ 499076 h 971303"/>
                  <a:gd name="connsiteX1" fmla="*/ 392306 w 957263"/>
                  <a:gd name="connsiteY1" fmla="*/ 220523 h 971303"/>
                  <a:gd name="connsiteX2" fmla="*/ 957263 w 957263"/>
                  <a:gd name="connsiteY2" fmla="*/ 0 h 971303"/>
                  <a:gd name="connsiteX3" fmla="*/ 534666 w 957263"/>
                  <a:gd name="connsiteY3" fmla="*/ 441926 h 971303"/>
                  <a:gd name="connsiteX4" fmla="*/ 335156 w 957263"/>
                  <a:gd name="connsiteY4" fmla="*/ 658567 h 971303"/>
                  <a:gd name="connsiteX5" fmla="*/ 0 w 957263"/>
                  <a:gd name="connsiteY5" fmla="*/ 966788 h 971303"/>
                  <a:gd name="connsiteX6" fmla="*/ 149934 w 957263"/>
                  <a:gd name="connsiteY6" fmla="*/ 499076 h 971303"/>
                  <a:gd name="connsiteX0" fmla="*/ 149934 w 957263"/>
                  <a:gd name="connsiteY0" fmla="*/ 500380 h 972607"/>
                  <a:gd name="connsiteX1" fmla="*/ 392306 w 957263"/>
                  <a:gd name="connsiteY1" fmla="*/ 221827 h 972607"/>
                  <a:gd name="connsiteX2" fmla="*/ 957263 w 957263"/>
                  <a:gd name="connsiteY2" fmla="*/ 1304 h 972607"/>
                  <a:gd name="connsiteX3" fmla="*/ 534666 w 957263"/>
                  <a:gd name="connsiteY3" fmla="*/ 443230 h 972607"/>
                  <a:gd name="connsiteX4" fmla="*/ 335156 w 957263"/>
                  <a:gd name="connsiteY4" fmla="*/ 659871 h 972607"/>
                  <a:gd name="connsiteX5" fmla="*/ 0 w 957263"/>
                  <a:gd name="connsiteY5" fmla="*/ 968092 h 972607"/>
                  <a:gd name="connsiteX6" fmla="*/ 149934 w 957263"/>
                  <a:gd name="connsiteY6" fmla="*/ 500380 h 972607"/>
                  <a:gd name="connsiteX0" fmla="*/ 149934 w 958572"/>
                  <a:gd name="connsiteY0" fmla="*/ 500380 h 972607"/>
                  <a:gd name="connsiteX1" fmla="*/ 392306 w 958572"/>
                  <a:gd name="connsiteY1" fmla="*/ 221827 h 972607"/>
                  <a:gd name="connsiteX2" fmla="*/ 957263 w 958572"/>
                  <a:gd name="connsiteY2" fmla="*/ 1304 h 972607"/>
                  <a:gd name="connsiteX3" fmla="*/ 534666 w 958572"/>
                  <a:gd name="connsiteY3" fmla="*/ 443230 h 972607"/>
                  <a:gd name="connsiteX4" fmla="*/ 335156 w 958572"/>
                  <a:gd name="connsiteY4" fmla="*/ 659871 h 972607"/>
                  <a:gd name="connsiteX5" fmla="*/ 0 w 958572"/>
                  <a:gd name="connsiteY5" fmla="*/ 968092 h 972607"/>
                  <a:gd name="connsiteX6" fmla="*/ 149934 w 958572"/>
                  <a:gd name="connsiteY6" fmla="*/ 500380 h 972607"/>
                  <a:gd name="connsiteX0" fmla="*/ 149934 w 958705"/>
                  <a:gd name="connsiteY0" fmla="*/ 500380 h 972497"/>
                  <a:gd name="connsiteX1" fmla="*/ 392306 w 958705"/>
                  <a:gd name="connsiteY1" fmla="*/ 221827 h 972497"/>
                  <a:gd name="connsiteX2" fmla="*/ 957263 w 958705"/>
                  <a:gd name="connsiteY2" fmla="*/ 1304 h 972497"/>
                  <a:gd name="connsiteX3" fmla="*/ 572766 w 958705"/>
                  <a:gd name="connsiteY3" fmla="*/ 400368 h 972497"/>
                  <a:gd name="connsiteX4" fmla="*/ 335156 w 958705"/>
                  <a:gd name="connsiteY4" fmla="*/ 659871 h 972497"/>
                  <a:gd name="connsiteX5" fmla="*/ 0 w 958705"/>
                  <a:gd name="connsiteY5" fmla="*/ 968092 h 972497"/>
                  <a:gd name="connsiteX6" fmla="*/ 149934 w 958705"/>
                  <a:gd name="connsiteY6" fmla="*/ 500380 h 972497"/>
                  <a:gd name="connsiteX0" fmla="*/ 149934 w 957263"/>
                  <a:gd name="connsiteY0" fmla="*/ 500380 h 972497"/>
                  <a:gd name="connsiteX1" fmla="*/ 392306 w 957263"/>
                  <a:gd name="connsiteY1" fmla="*/ 221827 h 972497"/>
                  <a:gd name="connsiteX2" fmla="*/ 957263 w 957263"/>
                  <a:gd name="connsiteY2" fmla="*/ 1304 h 972497"/>
                  <a:gd name="connsiteX3" fmla="*/ 572766 w 957263"/>
                  <a:gd name="connsiteY3" fmla="*/ 400368 h 972497"/>
                  <a:gd name="connsiteX4" fmla="*/ 335156 w 957263"/>
                  <a:gd name="connsiteY4" fmla="*/ 659871 h 972497"/>
                  <a:gd name="connsiteX5" fmla="*/ 0 w 957263"/>
                  <a:gd name="connsiteY5" fmla="*/ 968092 h 972497"/>
                  <a:gd name="connsiteX6" fmla="*/ 149934 w 957263"/>
                  <a:gd name="connsiteY6" fmla="*/ 500380 h 972497"/>
                  <a:gd name="connsiteX0" fmla="*/ 149934 w 957263"/>
                  <a:gd name="connsiteY0" fmla="*/ 501109 h 973226"/>
                  <a:gd name="connsiteX1" fmla="*/ 392306 w 957263"/>
                  <a:gd name="connsiteY1" fmla="*/ 222556 h 973226"/>
                  <a:gd name="connsiteX2" fmla="*/ 957263 w 957263"/>
                  <a:gd name="connsiteY2" fmla="*/ 2033 h 973226"/>
                  <a:gd name="connsiteX3" fmla="*/ 572766 w 957263"/>
                  <a:gd name="connsiteY3" fmla="*/ 401097 h 973226"/>
                  <a:gd name="connsiteX4" fmla="*/ 335156 w 957263"/>
                  <a:gd name="connsiteY4" fmla="*/ 660600 h 973226"/>
                  <a:gd name="connsiteX5" fmla="*/ 0 w 957263"/>
                  <a:gd name="connsiteY5" fmla="*/ 968821 h 973226"/>
                  <a:gd name="connsiteX6" fmla="*/ 149934 w 957263"/>
                  <a:gd name="connsiteY6" fmla="*/ 501109 h 973226"/>
                  <a:gd name="connsiteX0" fmla="*/ 149934 w 957263"/>
                  <a:gd name="connsiteY0" fmla="*/ 503388 h 975505"/>
                  <a:gd name="connsiteX1" fmla="*/ 611381 w 957263"/>
                  <a:gd name="connsiteY1" fmla="*/ 129585 h 975505"/>
                  <a:gd name="connsiteX2" fmla="*/ 957263 w 957263"/>
                  <a:gd name="connsiteY2" fmla="*/ 4312 h 975505"/>
                  <a:gd name="connsiteX3" fmla="*/ 572766 w 957263"/>
                  <a:gd name="connsiteY3" fmla="*/ 403376 h 975505"/>
                  <a:gd name="connsiteX4" fmla="*/ 335156 w 957263"/>
                  <a:gd name="connsiteY4" fmla="*/ 662879 h 975505"/>
                  <a:gd name="connsiteX5" fmla="*/ 0 w 957263"/>
                  <a:gd name="connsiteY5" fmla="*/ 971100 h 975505"/>
                  <a:gd name="connsiteX6" fmla="*/ 149934 w 957263"/>
                  <a:gd name="connsiteY6" fmla="*/ 503388 h 975505"/>
                  <a:gd name="connsiteX0" fmla="*/ 149934 w 957263"/>
                  <a:gd name="connsiteY0" fmla="*/ 503388 h 975505"/>
                  <a:gd name="connsiteX1" fmla="*/ 611381 w 957263"/>
                  <a:gd name="connsiteY1" fmla="*/ 129585 h 975505"/>
                  <a:gd name="connsiteX2" fmla="*/ 957263 w 957263"/>
                  <a:gd name="connsiteY2" fmla="*/ 4312 h 975505"/>
                  <a:gd name="connsiteX3" fmla="*/ 572766 w 957263"/>
                  <a:gd name="connsiteY3" fmla="*/ 403376 h 975505"/>
                  <a:gd name="connsiteX4" fmla="*/ 335156 w 957263"/>
                  <a:gd name="connsiteY4" fmla="*/ 662879 h 975505"/>
                  <a:gd name="connsiteX5" fmla="*/ 0 w 957263"/>
                  <a:gd name="connsiteY5" fmla="*/ 971100 h 975505"/>
                  <a:gd name="connsiteX6" fmla="*/ 149934 w 957263"/>
                  <a:gd name="connsiteY6" fmla="*/ 503388 h 975505"/>
                  <a:gd name="connsiteX0" fmla="*/ 149934 w 957263"/>
                  <a:gd name="connsiteY0" fmla="*/ 500498 h 972615"/>
                  <a:gd name="connsiteX1" fmla="*/ 368493 w 957263"/>
                  <a:gd name="connsiteY1" fmla="*/ 298145 h 972615"/>
                  <a:gd name="connsiteX2" fmla="*/ 957263 w 957263"/>
                  <a:gd name="connsiteY2" fmla="*/ 1422 h 972615"/>
                  <a:gd name="connsiteX3" fmla="*/ 572766 w 957263"/>
                  <a:gd name="connsiteY3" fmla="*/ 400486 h 972615"/>
                  <a:gd name="connsiteX4" fmla="*/ 335156 w 957263"/>
                  <a:gd name="connsiteY4" fmla="*/ 659989 h 972615"/>
                  <a:gd name="connsiteX5" fmla="*/ 0 w 957263"/>
                  <a:gd name="connsiteY5" fmla="*/ 968210 h 972615"/>
                  <a:gd name="connsiteX6" fmla="*/ 149934 w 957263"/>
                  <a:gd name="connsiteY6" fmla="*/ 500498 h 972615"/>
                  <a:gd name="connsiteX0" fmla="*/ 149934 w 957263"/>
                  <a:gd name="connsiteY0" fmla="*/ 502875 h 974992"/>
                  <a:gd name="connsiteX1" fmla="*/ 368493 w 957263"/>
                  <a:gd name="connsiteY1" fmla="*/ 300522 h 974992"/>
                  <a:gd name="connsiteX2" fmla="*/ 957263 w 957263"/>
                  <a:gd name="connsiteY2" fmla="*/ 3799 h 974992"/>
                  <a:gd name="connsiteX3" fmla="*/ 572766 w 957263"/>
                  <a:gd name="connsiteY3" fmla="*/ 402863 h 974992"/>
                  <a:gd name="connsiteX4" fmla="*/ 335156 w 957263"/>
                  <a:gd name="connsiteY4" fmla="*/ 662366 h 974992"/>
                  <a:gd name="connsiteX5" fmla="*/ 0 w 957263"/>
                  <a:gd name="connsiteY5" fmla="*/ 970587 h 974992"/>
                  <a:gd name="connsiteX6" fmla="*/ 149934 w 957263"/>
                  <a:gd name="connsiteY6" fmla="*/ 502875 h 974992"/>
                  <a:gd name="connsiteX0" fmla="*/ 149934 w 957263"/>
                  <a:gd name="connsiteY0" fmla="*/ 500553 h 972670"/>
                  <a:gd name="connsiteX1" fmla="*/ 368493 w 957263"/>
                  <a:gd name="connsiteY1" fmla="*/ 298200 h 972670"/>
                  <a:gd name="connsiteX2" fmla="*/ 957263 w 957263"/>
                  <a:gd name="connsiteY2" fmla="*/ 1477 h 972670"/>
                  <a:gd name="connsiteX3" fmla="*/ 572766 w 957263"/>
                  <a:gd name="connsiteY3" fmla="*/ 400541 h 972670"/>
                  <a:gd name="connsiteX4" fmla="*/ 335156 w 957263"/>
                  <a:gd name="connsiteY4" fmla="*/ 660044 h 972670"/>
                  <a:gd name="connsiteX5" fmla="*/ 0 w 957263"/>
                  <a:gd name="connsiteY5" fmla="*/ 968265 h 972670"/>
                  <a:gd name="connsiteX6" fmla="*/ 149934 w 957263"/>
                  <a:gd name="connsiteY6" fmla="*/ 500553 h 972670"/>
                  <a:gd name="connsiteX0" fmla="*/ 111834 w 957263"/>
                  <a:gd name="connsiteY0" fmla="*/ 605375 h 972717"/>
                  <a:gd name="connsiteX1" fmla="*/ 368493 w 957263"/>
                  <a:gd name="connsiteY1" fmla="*/ 298247 h 972717"/>
                  <a:gd name="connsiteX2" fmla="*/ 957263 w 957263"/>
                  <a:gd name="connsiteY2" fmla="*/ 1524 h 972717"/>
                  <a:gd name="connsiteX3" fmla="*/ 572766 w 957263"/>
                  <a:gd name="connsiteY3" fmla="*/ 400588 h 972717"/>
                  <a:gd name="connsiteX4" fmla="*/ 335156 w 957263"/>
                  <a:gd name="connsiteY4" fmla="*/ 660091 h 972717"/>
                  <a:gd name="connsiteX5" fmla="*/ 0 w 957263"/>
                  <a:gd name="connsiteY5" fmla="*/ 968312 h 972717"/>
                  <a:gd name="connsiteX6" fmla="*/ 111834 w 957263"/>
                  <a:gd name="connsiteY6" fmla="*/ 605375 h 972717"/>
                  <a:gd name="connsiteX0" fmla="*/ 111834 w 957263"/>
                  <a:gd name="connsiteY0" fmla="*/ 605375 h 972717"/>
                  <a:gd name="connsiteX1" fmla="*/ 368493 w 957263"/>
                  <a:gd name="connsiteY1" fmla="*/ 298247 h 972717"/>
                  <a:gd name="connsiteX2" fmla="*/ 957263 w 957263"/>
                  <a:gd name="connsiteY2" fmla="*/ 1524 h 972717"/>
                  <a:gd name="connsiteX3" fmla="*/ 572766 w 957263"/>
                  <a:gd name="connsiteY3" fmla="*/ 400588 h 972717"/>
                  <a:gd name="connsiteX4" fmla="*/ 335156 w 957263"/>
                  <a:gd name="connsiteY4" fmla="*/ 660091 h 972717"/>
                  <a:gd name="connsiteX5" fmla="*/ 0 w 957263"/>
                  <a:gd name="connsiteY5" fmla="*/ 968312 h 972717"/>
                  <a:gd name="connsiteX6" fmla="*/ 111834 w 957263"/>
                  <a:gd name="connsiteY6" fmla="*/ 605375 h 972717"/>
                  <a:gd name="connsiteX0" fmla="*/ 111834 w 960618"/>
                  <a:gd name="connsiteY0" fmla="*/ 624858 h 992200"/>
                  <a:gd name="connsiteX1" fmla="*/ 368493 w 960618"/>
                  <a:gd name="connsiteY1" fmla="*/ 317730 h 992200"/>
                  <a:gd name="connsiteX2" fmla="*/ 738187 w 960618"/>
                  <a:gd name="connsiteY2" fmla="*/ 83100 h 992200"/>
                  <a:gd name="connsiteX3" fmla="*/ 957263 w 960618"/>
                  <a:gd name="connsiteY3" fmla="*/ 21007 h 992200"/>
                  <a:gd name="connsiteX4" fmla="*/ 572766 w 960618"/>
                  <a:gd name="connsiteY4" fmla="*/ 420071 h 992200"/>
                  <a:gd name="connsiteX5" fmla="*/ 335156 w 960618"/>
                  <a:gd name="connsiteY5" fmla="*/ 679574 h 992200"/>
                  <a:gd name="connsiteX6" fmla="*/ 0 w 960618"/>
                  <a:gd name="connsiteY6" fmla="*/ 987795 h 992200"/>
                  <a:gd name="connsiteX7" fmla="*/ 111834 w 960618"/>
                  <a:gd name="connsiteY7" fmla="*/ 624858 h 992200"/>
                  <a:gd name="connsiteX0" fmla="*/ 111834 w 957263"/>
                  <a:gd name="connsiteY0" fmla="*/ 631030 h 998372"/>
                  <a:gd name="connsiteX1" fmla="*/ 368493 w 957263"/>
                  <a:gd name="connsiteY1" fmla="*/ 323902 h 998372"/>
                  <a:gd name="connsiteX2" fmla="*/ 738187 w 957263"/>
                  <a:gd name="connsiteY2" fmla="*/ 89272 h 998372"/>
                  <a:gd name="connsiteX3" fmla="*/ 957263 w 957263"/>
                  <a:gd name="connsiteY3" fmla="*/ 27179 h 998372"/>
                  <a:gd name="connsiteX4" fmla="*/ 572766 w 957263"/>
                  <a:gd name="connsiteY4" fmla="*/ 426243 h 998372"/>
                  <a:gd name="connsiteX5" fmla="*/ 335156 w 957263"/>
                  <a:gd name="connsiteY5" fmla="*/ 685746 h 998372"/>
                  <a:gd name="connsiteX6" fmla="*/ 0 w 957263"/>
                  <a:gd name="connsiteY6" fmla="*/ 993967 h 998372"/>
                  <a:gd name="connsiteX7" fmla="*/ 111834 w 957263"/>
                  <a:gd name="connsiteY7" fmla="*/ 631030 h 998372"/>
                  <a:gd name="connsiteX0" fmla="*/ 111834 w 957263"/>
                  <a:gd name="connsiteY0" fmla="*/ 639662 h 1007004"/>
                  <a:gd name="connsiteX1" fmla="*/ 368493 w 957263"/>
                  <a:gd name="connsiteY1" fmla="*/ 332534 h 1007004"/>
                  <a:gd name="connsiteX2" fmla="*/ 738187 w 957263"/>
                  <a:gd name="connsiteY2" fmla="*/ 97904 h 1007004"/>
                  <a:gd name="connsiteX3" fmla="*/ 957263 w 957263"/>
                  <a:gd name="connsiteY3" fmla="*/ 35811 h 1007004"/>
                  <a:gd name="connsiteX4" fmla="*/ 572766 w 957263"/>
                  <a:gd name="connsiteY4" fmla="*/ 434875 h 1007004"/>
                  <a:gd name="connsiteX5" fmla="*/ 335156 w 957263"/>
                  <a:gd name="connsiteY5" fmla="*/ 694378 h 1007004"/>
                  <a:gd name="connsiteX6" fmla="*/ 0 w 957263"/>
                  <a:gd name="connsiteY6" fmla="*/ 1002599 h 1007004"/>
                  <a:gd name="connsiteX7" fmla="*/ 111834 w 957263"/>
                  <a:gd name="connsiteY7" fmla="*/ 639662 h 1007004"/>
                  <a:gd name="connsiteX0" fmla="*/ 111834 w 957263"/>
                  <a:gd name="connsiteY0" fmla="*/ 639662 h 1007004"/>
                  <a:gd name="connsiteX1" fmla="*/ 368493 w 957263"/>
                  <a:gd name="connsiteY1" fmla="*/ 332534 h 1007004"/>
                  <a:gd name="connsiteX2" fmla="*/ 738187 w 957263"/>
                  <a:gd name="connsiteY2" fmla="*/ 97904 h 1007004"/>
                  <a:gd name="connsiteX3" fmla="*/ 957263 w 957263"/>
                  <a:gd name="connsiteY3" fmla="*/ 35811 h 1007004"/>
                  <a:gd name="connsiteX4" fmla="*/ 572766 w 957263"/>
                  <a:gd name="connsiteY4" fmla="*/ 434875 h 1007004"/>
                  <a:gd name="connsiteX5" fmla="*/ 335156 w 957263"/>
                  <a:gd name="connsiteY5" fmla="*/ 694378 h 1007004"/>
                  <a:gd name="connsiteX6" fmla="*/ 0 w 957263"/>
                  <a:gd name="connsiteY6" fmla="*/ 1002599 h 1007004"/>
                  <a:gd name="connsiteX7" fmla="*/ 111834 w 957263"/>
                  <a:gd name="connsiteY7" fmla="*/ 639662 h 1007004"/>
                  <a:gd name="connsiteX0" fmla="*/ 111834 w 957263"/>
                  <a:gd name="connsiteY0" fmla="*/ 603851 h 971193"/>
                  <a:gd name="connsiteX1" fmla="*/ 368493 w 957263"/>
                  <a:gd name="connsiteY1" fmla="*/ 296723 h 971193"/>
                  <a:gd name="connsiteX2" fmla="*/ 738187 w 957263"/>
                  <a:gd name="connsiteY2" fmla="*/ 62093 h 971193"/>
                  <a:gd name="connsiteX3" fmla="*/ 957263 w 957263"/>
                  <a:gd name="connsiteY3" fmla="*/ 0 h 971193"/>
                  <a:gd name="connsiteX4" fmla="*/ 572766 w 957263"/>
                  <a:gd name="connsiteY4" fmla="*/ 399064 h 971193"/>
                  <a:gd name="connsiteX5" fmla="*/ 335156 w 957263"/>
                  <a:gd name="connsiteY5" fmla="*/ 658567 h 971193"/>
                  <a:gd name="connsiteX6" fmla="*/ 0 w 957263"/>
                  <a:gd name="connsiteY6" fmla="*/ 966788 h 971193"/>
                  <a:gd name="connsiteX7" fmla="*/ 111834 w 957263"/>
                  <a:gd name="connsiteY7" fmla="*/ 603851 h 971193"/>
                  <a:gd name="connsiteX0" fmla="*/ 111834 w 848623"/>
                  <a:gd name="connsiteY0" fmla="*/ 565114 h 932456"/>
                  <a:gd name="connsiteX1" fmla="*/ 368493 w 848623"/>
                  <a:gd name="connsiteY1" fmla="*/ 257986 h 932456"/>
                  <a:gd name="connsiteX2" fmla="*/ 738187 w 848623"/>
                  <a:gd name="connsiteY2" fmla="*/ 23356 h 932456"/>
                  <a:gd name="connsiteX3" fmla="*/ 833438 w 848623"/>
                  <a:gd name="connsiteY3" fmla="*/ 127950 h 932456"/>
                  <a:gd name="connsiteX4" fmla="*/ 572766 w 848623"/>
                  <a:gd name="connsiteY4" fmla="*/ 360327 h 932456"/>
                  <a:gd name="connsiteX5" fmla="*/ 335156 w 848623"/>
                  <a:gd name="connsiteY5" fmla="*/ 619830 h 932456"/>
                  <a:gd name="connsiteX6" fmla="*/ 0 w 848623"/>
                  <a:gd name="connsiteY6" fmla="*/ 928051 h 932456"/>
                  <a:gd name="connsiteX7" fmla="*/ 111834 w 848623"/>
                  <a:gd name="connsiteY7" fmla="*/ 565114 h 932456"/>
                  <a:gd name="connsiteX0" fmla="*/ 111834 w 942976"/>
                  <a:gd name="connsiteY0" fmla="*/ 584485 h 951827"/>
                  <a:gd name="connsiteX1" fmla="*/ 368493 w 942976"/>
                  <a:gd name="connsiteY1" fmla="*/ 277357 h 951827"/>
                  <a:gd name="connsiteX2" fmla="*/ 738187 w 942976"/>
                  <a:gd name="connsiteY2" fmla="*/ 42727 h 951827"/>
                  <a:gd name="connsiteX3" fmla="*/ 942976 w 942976"/>
                  <a:gd name="connsiteY3" fmla="*/ 23496 h 951827"/>
                  <a:gd name="connsiteX4" fmla="*/ 572766 w 942976"/>
                  <a:gd name="connsiteY4" fmla="*/ 379698 h 951827"/>
                  <a:gd name="connsiteX5" fmla="*/ 335156 w 942976"/>
                  <a:gd name="connsiteY5" fmla="*/ 639201 h 951827"/>
                  <a:gd name="connsiteX6" fmla="*/ 0 w 942976"/>
                  <a:gd name="connsiteY6" fmla="*/ 947422 h 951827"/>
                  <a:gd name="connsiteX7" fmla="*/ 111834 w 942976"/>
                  <a:gd name="connsiteY7" fmla="*/ 584485 h 951827"/>
                  <a:gd name="connsiteX0" fmla="*/ 111834 w 972739"/>
                  <a:gd name="connsiteY0" fmla="*/ 624114 h 991456"/>
                  <a:gd name="connsiteX1" fmla="*/ 368493 w 972739"/>
                  <a:gd name="connsiteY1" fmla="*/ 316986 h 991456"/>
                  <a:gd name="connsiteX2" fmla="*/ 738187 w 972739"/>
                  <a:gd name="connsiteY2" fmla="*/ 82356 h 991456"/>
                  <a:gd name="connsiteX3" fmla="*/ 942976 w 972739"/>
                  <a:gd name="connsiteY3" fmla="*/ 63125 h 991456"/>
                  <a:gd name="connsiteX4" fmla="*/ 572766 w 972739"/>
                  <a:gd name="connsiteY4" fmla="*/ 419327 h 991456"/>
                  <a:gd name="connsiteX5" fmla="*/ 335156 w 972739"/>
                  <a:gd name="connsiteY5" fmla="*/ 678830 h 991456"/>
                  <a:gd name="connsiteX6" fmla="*/ 0 w 972739"/>
                  <a:gd name="connsiteY6" fmla="*/ 987051 h 991456"/>
                  <a:gd name="connsiteX7" fmla="*/ 111834 w 972739"/>
                  <a:gd name="connsiteY7" fmla="*/ 624114 h 991456"/>
                  <a:gd name="connsiteX0" fmla="*/ 111834 w 972739"/>
                  <a:gd name="connsiteY0" fmla="*/ 624114 h 991456"/>
                  <a:gd name="connsiteX1" fmla="*/ 368493 w 972739"/>
                  <a:gd name="connsiteY1" fmla="*/ 316986 h 991456"/>
                  <a:gd name="connsiteX2" fmla="*/ 738187 w 972739"/>
                  <a:gd name="connsiteY2" fmla="*/ 82356 h 991456"/>
                  <a:gd name="connsiteX3" fmla="*/ 942976 w 972739"/>
                  <a:gd name="connsiteY3" fmla="*/ 63125 h 991456"/>
                  <a:gd name="connsiteX4" fmla="*/ 572766 w 972739"/>
                  <a:gd name="connsiteY4" fmla="*/ 419327 h 991456"/>
                  <a:gd name="connsiteX5" fmla="*/ 335156 w 972739"/>
                  <a:gd name="connsiteY5" fmla="*/ 678830 h 991456"/>
                  <a:gd name="connsiteX6" fmla="*/ 0 w 972739"/>
                  <a:gd name="connsiteY6" fmla="*/ 987051 h 991456"/>
                  <a:gd name="connsiteX7" fmla="*/ 111834 w 972739"/>
                  <a:gd name="connsiteY7" fmla="*/ 624114 h 991456"/>
                  <a:gd name="connsiteX0" fmla="*/ 111834 w 942976"/>
                  <a:gd name="connsiteY0" fmla="*/ 614453 h 981795"/>
                  <a:gd name="connsiteX1" fmla="*/ 368493 w 942976"/>
                  <a:gd name="connsiteY1" fmla="*/ 307325 h 981795"/>
                  <a:gd name="connsiteX2" fmla="*/ 738187 w 942976"/>
                  <a:gd name="connsiteY2" fmla="*/ 72695 h 981795"/>
                  <a:gd name="connsiteX3" fmla="*/ 942976 w 942976"/>
                  <a:gd name="connsiteY3" fmla="*/ 53464 h 981795"/>
                  <a:gd name="connsiteX4" fmla="*/ 572766 w 942976"/>
                  <a:gd name="connsiteY4" fmla="*/ 409666 h 981795"/>
                  <a:gd name="connsiteX5" fmla="*/ 335156 w 942976"/>
                  <a:gd name="connsiteY5" fmla="*/ 669169 h 981795"/>
                  <a:gd name="connsiteX6" fmla="*/ 0 w 942976"/>
                  <a:gd name="connsiteY6" fmla="*/ 977390 h 981795"/>
                  <a:gd name="connsiteX7" fmla="*/ 111834 w 942976"/>
                  <a:gd name="connsiteY7" fmla="*/ 614453 h 981795"/>
                  <a:gd name="connsiteX0" fmla="*/ 111834 w 743692"/>
                  <a:gd name="connsiteY0" fmla="*/ 541758 h 909100"/>
                  <a:gd name="connsiteX1" fmla="*/ 368493 w 743692"/>
                  <a:gd name="connsiteY1" fmla="*/ 234630 h 909100"/>
                  <a:gd name="connsiteX2" fmla="*/ 738187 w 743692"/>
                  <a:gd name="connsiteY2" fmla="*/ 0 h 909100"/>
                  <a:gd name="connsiteX3" fmla="*/ 572766 w 743692"/>
                  <a:gd name="connsiteY3" fmla="*/ 336971 h 909100"/>
                  <a:gd name="connsiteX4" fmla="*/ 335156 w 743692"/>
                  <a:gd name="connsiteY4" fmla="*/ 596474 h 909100"/>
                  <a:gd name="connsiteX5" fmla="*/ 0 w 743692"/>
                  <a:gd name="connsiteY5" fmla="*/ 904695 h 909100"/>
                  <a:gd name="connsiteX6" fmla="*/ 111834 w 743692"/>
                  <a:gd name="connsiteY6" fmla="*/ 541758 h 909100"/>
                  <a:gd name="connsiteX0" fmla="*/ 111834 w 836886"/>
                  <a:gd name="connsiteY0" fmla="*/ 575095 h 942437"/>
                  <a:gd name="connsiteX1" fmla="*/ 368493 w 836886"/>
                  <a:gd name="connsiteY1" fmla="*/ 267967 h 942437"/>
                  <a:gd name="connsiteX2" fmla="*/ 833437 w 836886"/>
                  <a:gd name="connsiteY2" fmla="*/ 0 h 942437"/>
                  <a:gd name="connsiteX3" fmla="*/ 572766 w 836886"/>
                  <a:gd name="connsiteY3" fmla="*/ 370308 h 942437"/>
                  <a:gd name="connsiteX4" fmla="*/ 335156 w 836886"/>
                  <a:gd name="connsiteY4" fmla="*/ 629811 h 942437"/>
                  <a:gd name="connsiteX5" fmla="*/ 0 w 836886"/>
                  <a:gd name="connsiteY5" fmla="*/ 938032 h 942437"/>
                  <a:gd name="connsiteX6" fmla="*/ 111834 w 836886"/>
                  <a:gd name="connsiteY6" fmla="*/ 575095 h 942437"/>
                  <a:gd name="connsiteX0" fmla="*/ 111834 w 833437"/>
                  <a:gd name="connsiteY0" fmla="*/ 575095 h 942437"/>
                  <a:gd name="connsiteX1" fmla="*/ 368493 w 833437"/>
                  <a:gd name="connsiteY1" fmla="*/ 267967 h 942437"/>
                  <a:gd name="connsiteX2" fmla="*/ 833437 w 833437"/>
                  <a:gd name="connsiteY2" fmla="*/ 0 h 942437"/>
                  <a:gd name="connsiteX3" fmla="*/ 572766 w 833437"/>
                  <a:gd name="connsiteY3" fmla="*/ 370308 h 942437"/>
                  <a:gd name="connsiteX4" fmla="*/ 335156 w 833437"/>
                  <a:gd name="connsiteY4" fmla="*/ 629811 h 942437"/>
                  <a:gd name="connsiteX5" fmla="*/ 0 w 833437"/>
                  <a:gd name="connsiteY5" fmla="*/ 938032 h 942437"/>
                  <a:gd name="connsiteX6" fmla="*/ 111834 w 833437"/>
                  <a:gd name="connsiteY6" fmla="*/ 575095 h 942437"/>
                  <a:gd name="connsiteX0" fmla="*/ 111834 w 871537"/>
                  <a:gd name="connsiteY0" fmla="*/ 570333 h 937675"/>
                  <a:gd name="connsiteX1" fmla="*/ 368493 w 871537"/>
                  <a:gd name="connsiteY1" fmla="*/ 263205 h 937675"/>
                  <a:gd name="connsiteX2" fmla="*/ 871537 w 871537"/>
                  <a:gd name="connsiteY2" fmla="*/ 0 h 937675"/>
                  <a:gd name="connsiteX3" fmla="*/ 572766 w 871537"/>
                  <a:gd name="connsiteY3" fmla="*/ 365546 h 937675"/>
                  <a:gd name="connsiteX4" fmla="*/ 335156 w 871537"/>
                  <a:gd name="connsiteY4" fmla="*/ 625049 h 937675"/>
                  <a:gd name="connsiteX5" fmla="*/ 0 w 871537"/>
                  <a:gd name="connsiteY5" fmla="*/ 933270 h 937675"/>
                  <a:gd name="connsiteX6" fmla="*/ 111834 w 871537"/>
                  <a:gd name="connsiteY6" fmla="*/ 570333 h 937675"/>
                  <a:gd name="connsiteX0" fmla="*/ 111834 w 871537"/>
                  <a:gd name="connsiteY0" fmla="*/ 570333 h 933270"/>
                  <a:gd name="connsiteX1" fmla="*/ 368493 w 871537"/>
                  <a:gd name="connsiteY1" fmla="*/ 263205 h 933270"/>
                  <a:gd name="connsiteX2" fmla="*/ 871537 w 871537"/>
                  <a:gd name="connsiteY2" fmla="*/ 0 h 933270"/>
                  <a:gd name="connsiteX3" fmla="*/ 572766 w 871537"/>
                  <a:gd name="connsiteY3" fmla="*/ 365546 h 933270"/>
                  <a:gd name="connsiteX4" fmla="*/ 335156 w 871537"/>
                  <a:gd name="connsiteY4" fmla="*/ 625049 h 933270"/>
                  <a:gd name="connsiteX5" fmla="*/ 0 w 871537"/>
                  <a:gd name="connsiteY5" fmla="*/ 933270 h 933270"/>
                  <a:gd name="connsiteX6" fmla="*/ 111834 w 871537"/>
                  <a:gd name="connsiteY6" fmla="*/ 570333 h 933270"/>
                  <a:gd name="connsiteX0" fmla="*/ 111834 w 871537"/>
                  <a:gd name="connsiteY0" fmla="*/ 570333 h 933270"/>
                  <a:gd name="connsiteX1" fmla="*/ 368493 w 871537"/>
                  <a:gd name="connsiteY1" fmla="*/ 263205 h 933270"/>
                  <a:gd name="connsiteX2" fmla="*/ 871537 w 871537"/>
                  <a:gd name="connsiteY2" fmla="*/ 0 h 933270"/>
                  <a:gd name="connsiteX3" fmla="*/ 572766 w 871537"/>
                  <a:gd name="connsiteY3" fmla="*/ 365546 h 933270"/>
                  <a:gd name="connsiteX4" fmla="*/ 397068 w 871537"/>
                  <a:gd name="connsiteY4" fmla="*/ 558374 h 933270"/>
                  <a:gd name="connsiteX5" fmla="*/ 0 w 871537"/>
                  <a:gd name="connsiteY5" fmla="*/ 933270 h 933270"/>
                  <a:gd name="connsiteX6" fmla="*/ 111834 w 871537"/>
                  <a:gd name="connsiteY6" fmla="*/ 570333 h 93327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871537" h="933270">
                    <a:moveTo>
                      <a:pt x="111834" y="570333"/>
                    </a:moveTo>
                    <a:cubicBezTo>
                      <a:pt x="168487" y="439605"/>
                      <a:pt x="241876" y="358260"/>
                      <a:pt x="368493" y="263205"/>
                    </a:cubicBezTo>
                    <a:cubicBezTo>
                      <a:pt x="495110" y="168150"/>
                      <a:pt x="773409" y="49454"/>
                      <a:pt x="871537" y="0"/>
                    </a:cubicBezTo>
                    <a:cubicBezTo>
                      <a:pt x="724608" y="164694"/>
                      <a:pt x="639938" y="266134"/>
                      <a:pt x="572766" y="365546"/>
                    </a:cubicBezTo>
                    <a:cubicBezTo>
                      <a:pt x="495276" y="457845"/>
                      <a:pt x="492529" y="463753"/>
                      <a:pt x="397068" y="558374"/>
                    </a:cubicBezTo>
                    <a:cubicBezTo>
                      <a:pt x="301607" y="652995"/>
                      <a:pt x="188826" y="721727"/>
                      <a:pt x="0" y="933270"/>
                    </a:cubicBezTo>
                    <a:cubicBezTo>
                      <a:pt x="120736" y="601889"/>
                      <a:pt x="55181" y="701061"/>
                      <a:pt x="111834" y="570333"/>
                    </a:cubicBezTo>
                    <a:close/>
                  </a:path>
                </a:pathLst>
              </a:custGeom>
              <a:solidFill>
                <a:schemeClr val="accent2">
                  <a:lumMod val="20000"/>
                  <a:lumOff val="80000"/>
                </a:schemeClr>
              </a:solidFill>
              <a:ln w="19050" cmpd="sng">
                <a:solidFill>
                  <a:srgbClr val="FF0000"/>
                </a:solidFill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1" name="円/楕円 50">
                <a:extLst>
                  <a:ext uri="{FF2B5EF4-FFF2-40B4-BE49-F238E27FC236}">
                    <a16:creationId xmlns="" xmlns:a16="http://schemas.microsoft.com/office/drawing/2014/main" id="{8A7718B4-46A3-A94E-92B7-C6A9850B6077}"/>
                  </a:ext>
                </a:extLst>
              </p:cNvPr>
              <p:cNvSpPr/>
              <p:nvPr/>
            </p:nvSpPr>
            <p:spPr>
              <a:xfrm>
                <a:off x="4716047" y="6731120"/>
                <a:ext cx="143865" cy="138531"/>
              </a:xfrm>
              <a:prstGeom prst="ellipse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cxnSp>
          <p:nvCxnSpPr>
            <p:cNvPr id="48" name="直線矢印コネクタ 47">
              <a:extLst>
                <a:ext uri="{FF2B5EF4-FFF2-40B4-BE49-F238E27FC236}">
                  <a16:creationId xmlns="" xmlns:a16="http://schemas.microsoft.com/office/drawing/2014/main" id="{B0EDD728-9351-3C49-A5A0-BF12B77C89DB}"/>
                </a:ext>
              </a:extLst>
            </p:cNvPr>
            <p:cNvCxnSpPr>
              <a:cxnSpLocks/>
            </p:cNvCxnSpPr>
            <p:nvPr/>
          </p:nvCxnSpPr>
          <p:spPr>
            <a:xfrm rot="2790348">
              <a:off x="3751070" y="1978915"/>
              <a:ext cx="341483" cy="0"/>
            </a:xfrm>
            <a:prstGeom prst="straightConnector1">
              <a:avLst/>
            </a:prstGeom>
            <a:ln w="19050" cmpd="sng">
              <a:solidFill>
                <a:schemeClr val="tx1"/>
              </a:solidFill>
              <a:prstDash val="dot"/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線矢印コネクタ 48">
              <a:extLst>
                <a:ext uri="{FF2B5EF4-FFF2-40B4-BE49-F238E27FC236}">
                  <a16:creationId xmlns="" xmlns:a16="http://schemas.microsoft.com/office/drawing/2014/main" id="{6640B64C-9E1A-934F-81CE-1C10701A8122}"/>
                </a:ext>
              </a:extLst>
            </p:cNvPr>
            <p:cNvCxnSpPr>
              <a:cxnSpLocks/>
            </p:cNvCxnSpPr>
            <p:nvPr/>
          </p:nvCxnSpPr>
          <p:spPr>
            <a:xfrm rot="2790348" flipV="1">
              <a:off x="4352328" y="1167453"/>
              <a:ext cx="0" cy="1728249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olid"/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2" name="グループ化 52">
            <a:extLst>
              <a:ext uri="{FF2B5EF4-FFF2-40B4-BE49-F238E27FC236}">
                <a16:creationId xmlns="" xmlns:a16="http://schemas.microsoft.com/office/drawing/2014/main" id="{C95F83B4-8209-A148-B771-0A8069F59DD2}"/>
              </a:ext>
            </a:extLst>
          </p:cNvPr>
          <p:cNvGrpSpPr/>
          <p:nvPr/>
        </p:nvGrpSpPr>
        <p:grpSpPr>
          <a:xfrm rot="3401124">
            <a:off x="4017227" y="2349919"/>
            <a:ext cx="576199" cy="668999"/>
            <a:chOff x="8222719" y="8106986"/>
            <a:chExt cx="576199" cy="668999"/>
          </a:xfrm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grpSpPr>
        <p:grpSp>
          <p:nvGrpSpPr>
            <p:cNvPr id="53" name="グループ化 53">
              <a:extLst>
                <a:ext uri="{FF2B5EF4-FFF2-40B4-BE49-F238E27FC236}">
                  <a16:creationId xmlns="" xmlns:a16="http://schemas.microsoft.com/office/drawing/2014/main" id="{4FB9C102-9D3B-CF40-8FA9-1E856E270FA8}"/>
                </a:ext>
              </a:extLst>
            </p:cNvPr>
            <p:cNvGrpSpPr/>
            <p:nvPr/>
          </p:nvGrpSpPr>
          <p:grpSpPr>
            <a:xfrm rot="20891813">
              <a:off x="8222719" y="8119335"/>
              <a:ext cx="459307" cy="627794"/>
              <a:chOff x="3380460" y="6568262"/>
              <a:chExt cx="263651" cy="378763"/>
            </a:xfrm>
          </p:grpSpPr>
          <p:sp>
            <p:nvSpPr>
              <p:cNvPr id="56" name="円/楕円 24">
                <a:extLst>
                  <a:ext uri="{FF2B5EF4-FFF2-40B4-BE49-F238E27FC236}">
                    <a16:creationId xmlns="" xmlns:a16="http://schemas.microsoft.com/office/drawing/2014/main" id="{E7E670C6-39D1-9D49-B784-8060A2F7E42D}"/>
                  </a:ext>
                </a:extLst>
              </p:cNvPr>
              <p:cNvSpPr/>
              <p:nvPr/>
            </p:nvSpPr>
            <p:spPr>
              <a:xfrm>
                <a:off x="3380460" y="6568262"/>
                <a:ext cx="263651" cy="378763"/>
              </a:xfrm>
              <a:custGeom>
                <a:avLst/>
                <a:gdLst>
                  <a:gd name="connsiteX0" fmla="*/ 0 w 228600"/>
                  <a:gd name="connsiteY0" fmla="*/ 138113 h 276225"/>
                  <a:gd name="connsiteX1" fmla="*/ 114300 w 228600"/>
                  <a:gd name="connsiteY1" fmla="*/ 0 h 276225"/>
                  <a:gd name="connsiteX2" fmla="*/ 228600 w 228600"/>
                  <a:gd name="connsiteY2" fmla="*/ 138113 h 276225"/>
                  <a:gd name="connsiteX3" fmla="*/ 114300 w 228600"/>
                  <a:gd name="connsiteY3" fmla="*/ 276226 h 276225"/>
                  <a:gd name="connsiteX4" fmla="*/ 0 w 228600"/>
                  <a:gd name="connsiteY4" fmla="*/ 138113 h 276225"/>
                  <a:gd name="connsiteX0" fmla="*/ 0 w 257175"/>
                  <a:gd name="connsiteY0" fmla="*/ 138353 h 276864"/>
                  <a:gd name="connsiteX1" fmla="*/ 114300 w 257175"/>
                  <a:gd name="connsiteY1" fmla="*/ 240 h 276864"/>
                  <a:gd name="connsiteX2" fmla="*/ 257175 w 257175"/>
                  <a:gd name="connsiteY2" fmla="*/ 166928 h 276864"/>
                  <a:gd name="connsiteX3" fmla="*/ 114300 w 257175"/>
                  <a:gd name="connsiteY3" fmla="*/ 276466 h 276864"/>
                  <a:gd name="connsiteX4" fmla="*/ 0 w 257175"/>
                  <a:gd name="connsiteY4" fmla="*/ 138353 h 276864"/>
                  <a:gd name="connsiteX0" fmla="*/ 150 w 257325"/>
                  <a:gd name="connsiteY0" fmla="*/ 119265 h 257776"/>
                  <a:gd name="connsiteX1" fmla="*/ 138262 w 257325"/>
                  <a:gd name="connsiteY1" fmla="*/ 202 h 257776"/>
                  <a:gd name="connsiteX2" fmla="*/ 257325 w 257325"/>
                  <a:gd name="connsiteY2" fmla="*/ 147840 h 257776"/>
                  <a:gd name="connsiteX3" fmla="*/ 114450 w 257325"/>
                  <a:gd name="connsiteY3" fmla="*/ 257378 h 257776"/>
                  <a:gd name="connsiteX4" fmla="*/ 150 w 257325"/>
                  <a:gd name="connsiteY4" fmla="*/ 119265 h 257776"/>
                  <a:gd name="connsiteX0" fmla="*/ 1531 w 258706"/>
                  <a:gd name="connsiteY0" fmla="*/ 119273 h 281456"/>
                  <a:gd name="connsiteX1" fmla="*/ 139643 w 258706"/>
                  <a:gd name="connsiteY1" fmla="*/ 210 h 281456"/>
                  <a:gd name="connsiteX2" fmla="*/ 258706 w 258706"/>
                  <a:gd name="connsiteY2" fmla="*/ 147848 h 281456"/>
                  <a:gd name="connsiteX3" fmla="*/ 77731 w 258706"/>
                  <a:gd name="connsiteY3" fmla="*/ 281199 h 281456"/>
                  <a:gd name="connsiteX4" fmla="*/ 1531 w 258706"/>
                  <a:gd name="connsiteY4" fmla="*/ 119273 h 281456"/>
                  <a:gd name="connsiteX0" fmla="*/ 1774 w 250129"/>
                  <a:gd name="connsiteY0" fmla="*/ 142796 h 281003"/>
                  <a:gd name="connsiteX1" fmla="*/ 131066 w 250129"/>
                  <a:gd name="connsiteY1" fmla="*/ 6 h 281003"/>
                  <a:gd name="connsiteX2" fmla="*/ 250129 w 250129"/>
                  <a:gd name="connsiteY2" fmla="*/ 147644 h 281003"/>
                  <a:gd name="connsiteX3" fmla="*/ 69154 w 250129"/>
                  <a:gd name="connsiteY3" fmla="*/ 280995 h 281003"/>
                  <a:gd name="connsiteX4" fmla="*/ 1774 w 250129"/>
                  <a:gd name="connsiteY4" fmla="*/ 142796 h 281003"/>
                  <a:gd name="connsiteX0" fmla="*/ 11122 w 259477"/>
                  <a:gd name="connsiteY0" fmla="*/ 142796 h 281003"/>
                  <a:gd name="connsiteX1" fmla="*/ 140414 w 259477"/>
                  <a:gd name="connsiteY1" fmla="*/ 6 h 281003"/>
                  <a:gd name="connsiteX2" fmla="*/ 259477 w 259477"/>
                  <a:gd name="connsiteY2" fmla="*/ 147644 h 281003"/>
                  <a:gd name="connsiteX3" fmla="*/ 78502 w 259477"/>
                  <a:gd name="connsiteY3" fmla="*/ 280995 h 281003"/>
                  <a:gd name="connsiteX4" fmla="*/ 11122 w 259477"/>
                  <a:gd name="connsiteY4" fmla="*/ 142796 h 281003"/>
                  <a:gd name="connsiteX0" fmla="*/ 10744 w 237048"/>
                  <a:gd name="connsiteY0" fmla="*/ 142834 h 281096"/>
                  <a:gd name="connsiteX1" fmla="*/ 140036 w 237048"/>
                  <a:gd name="connsiteY1" fmla="*/ 44 h 281096"/>
                  <a:gd name="connsiteX2" fmla="*/ 237048 w 237048"/>
                  <a:gd name="connsiteY2" fmla="*/ 155591 h 281096"/>
                  <a:gd name="connsiteX3" fmla="*/ 78124 w 237048"/>
                  <a:gd name="connsiteY3" fmla="*/ 281033 h 281096"/>
                  <a:gd name="connsiteX4" fmla="*/ 10744 w 237048"/>
                  <a:gd name="connsiteY4" fmla="*/ 142834 h 28109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37048" h="281096">
                    <a:moveTo>
                      <a:pt x="10744" y="142834"/>
                    </a:moveTo>
                    <a:cubicBezTo>
                      <a:pt x="47525" y="72274"/>
                      <a:pt x="102319" y="-2082"/>
                      <a:pt x="140036" y="44"/>
                    </a:cubicBezTo>
                    <a:cubicBezTo>
                      <a:pt x="177753" y="2170"/>
                      <a:pt x="237048" y="79313"/>
                      <a:pt x="237048" y="155591"/>
                    </a:cubicBezTo>
                    <a:cubicBezTo>
                      <a:pt x="237048" y="231869"/>
                      <a:pt x="115841" y="283159"/>
                      <a:pt x="78124" y="281033"/>
                    </a:cubicBezTo>
                    <a:cubicBezTo>
                      <a:pt x="40407" y="278907"/>
                      <a:pt x="-26037" y="213394"/>
                      <a:pt x="10744" y="142834"/>
                    </a:cubicBezTo>
                    <a:close/>
                  </a:path>
                </a:pathLst>
              </a:custGeom>
              <a:solidFill>
                <a:schemeClr val="accent2">
                  <a:lumMod val="20000"/>
                  <a:lumOff val="80000"/>
                </a:schemeClr>
              </a:solidFill>
              <a:ln w="19050" cmpd="sng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7" name="円/楕円 56">
                <a:extLst>
                  <a:ext uri="{FF2B5EF4-FFF2-40B4-BE49-F238E27FC236}">
                    <a16:creationId xmlns="" xmlns:a16="http://schemas.microsoft.com/office/drawing/2014/main" id="{63CC987D-DC57-7546-88C2-5ED5B92A1D11}"/>
                  </a:ext>
                </a:extLst>
              </p:cNvPr>
              <p:cNvSpPr/>
              <p:nvPr/>
            </p:nvSpPr>
            <p:spPr>
              <a:xfrm>
                <a:off x="3426105" y="6788723"/>
                <a:ext cx="143865" cy="138531"/>
              </a:xfrm>
              <a:prstGeom prst="ellipse">
                <a:avLst/>
              </a:prstGeom>
              <a:solidFill>
                <a:schemeClr val="accent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cxnSp>
          <p:nvCxnSpPr>
            <p:cNvPr id="54" name="直線矢印コネクタ 53">
              <a:extLst>
                <a:ext uri="{FF2B5EF4-FFF2-40B4-BE49-F238E27FC236}">
                  <a16:creationId xmlns="" xmlns:a16="http://schemas.microsoft.com/office/drawing/2014/main" id="{05D97065-A6DF-144F-AC1F-5094C23C51A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798918" y="8106986"/>
              <a:ext cx="0" cy="668999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olid"/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矢印コネクタ 54">
              <a:extLst>
                <a:ext uri="{FF2B5EF4-FFF2-40B4-BE49-F238E27FC236}">
                  <a16:creationId xmlns="" xmlns:a16="http://schemas.microsoft.com/office/drawing/2014/main" id="{06ECF0E9-D49C-4F4B-8D48-D184D244104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248997" y="8441309"/>
              <a:ext cx="432000" cy="0"/>
            </a:xfrm>
            <a:prstGeom prst="straightConnector1">
              <a:avLst/>
            </a:prstGeom>
            <a:ln w="19050" cmpd="sng">
              <a:solidFill>
                <a:schemeClr val="tx1"/>
              </a:solidFill>
              <a:prstDash val="dot"/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8" name="グループ化 58">
            <a:extLst>
              <a:ext uri="{FF2B5EF4-FFF2-40B4-BE49-F238E27FC236}">
                <a16:creationId xmlns="" xmlns:a16="http://schemas.microsoft.com/office/drawing/2014/main" id="{1E9EE49C-E555-2D44-A41A-6E057D53E73B}"/>
              </a:ext>
            </a:extLst>
          </p:cNvPr>
          <p:cNvGrpSpPr/>
          <p:nvPr/>
        </p:nvGrpSpPr>
        <p:grpSpPr>
          <a:xfrm>
            <a:off x="2694912" y="3417994"/>
            <a:ext cx="6600047" cy="2705320"/>
            <a:chOff x="918978" y="8131450"/>
            <a:chExt cx="6600047" cy="2705320"/>
          </a:xfrm>
        </p:grpSpPr>
        <p:pic>
          <p:nvPicPr>
            <p:cNvPr id="59" name="図 58">
              <a:extLst>
                <a:ext uri="{FF2B5EF4-FFF2-40B4-BE49-F238E27FC236}">
                  <a16:creationId xmlns="" xmlns:a16="http://schemas.microsoft.com/office/drawing/2014/main" id="{A31FFF4E-8D88-0747-B8BC-B2FFF065D4D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95511" y="8131450"/>
              <a:ext cx="3223514" cy="2417636"/>
            </a:xfrm>
            <a:prstGeom prst="rect">
              <a:avLst/>
            </a:prstGeom>
            <a:ln cap="sq">
              <a:solidFill>
                <a:schemeClr val="tx1"/>
              </a:solidFill>
              <a:miter lim="800000"/>
            </a:ln>
          </p:spPr>
        </p:pic>
        <p:pic>
          <p:nvPicPr>
            <p:cNvPr id="60" name="図 59">
              <a:extLst>
                <a:ext uri="{FF2B5EF4-FFF2-40B4-BE49-F238E27FC236}">
                  <a16:creationId xmlns="" xmlns:a16="http://schemas.microsoft.com/office/drawing/2014/main" id="{5B57B42E-0B3D-9F44-AB74-56E65D0214A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18978" y="8131450"/>
              <a:ext cx="3223514" cy="2417636"/>
            </a:xfrm>
            <a:prstGeom prst="rect">
              <a:avLst/>
            </a:prstGeom>
            <a:ln cap="sq">
              <a:solidFill>
                <a:schemeClr val="tx1"/>
              </a:solidFill>
              <a:miter lim="800000"/>
            </a:ln>
          </p:spPr>
        </p:pic>
        <p:sp>
          <p:nvSpPr>
            <p:cNvPr id="61" name="テキスト ボックス 60">
              <a:extLst>
                <a:ext uri="{FF2B5EF4-FFF2-40B4-BE49-F238E27FC236}">
                  <a16:creationId xmlns="" xmlns:a16="http://schemas.microsoft.com/office/drawing/2014/main" id="{E04CAFD5-3CF4-C447-9DE7-DC9B318490C5}"/>
                </a:ext>
              </a:extLst>
            </p:cNvPr>
            <p:cNvSpPr txBox="1"/>
            <p:nvPr/>
          </p:nvSpPr>
          <p:spPr>
            <a:xfrm>
              <a:off x="1670123" y="10559771"/>
              <a:ext cx="17212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/>
                <a:t>A549 parental cells</a:t>
              </a:r>
              <a:endParaRPr kumimoji="1" lang="ja-JP" altLang="en-US" sz="1200"/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="" xmlns:a16="http://schemas.microsoft.com/office/drawing/2014/main" id="{885DD052-758E-9D49-B274-7CAC6B4C5FB1}"/>
                </a:ext>
              </a:extLst>
            </p:cNvPr>
            <p:cNvSpPr txBox="1"/>
            <p:nvPr/>
          </p:nvSpPr>
          <p:spPr>
            <a:xfrm>
              <a:off x="5046656" y="10559771"/>
              <a:ext cx="17212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/>
                <a:t>A549 clone AS#3</a:t>
              </a:r>
              <a:endParaRPr kumimoji="1" lang="ja-JP" altLang="en-US" sz="1200"/>
            </a:p>
          </p:txBody>
        </p:sp>
      </p:grpSp>
      <p:cxnSp>
        <p:nvCxnSpPr>
          <p:cNvPr id="64" name="直線矢印コネクタ 63">
            <a:extLst>
              <a:ext uri="{FF2B5EF4-FFF2-40B4-BE49-F238E27FC236}">
                <a16:creationId xmlns="" xmlns:a16="http://schemas.microsoft.com/office/drawing/2014/main" id="{AFE9A8B7-A7C1-5142-A567-4F2010088C45}"/>
              </a:ext>
            </a:extLst>
          </p:cNvPr>
          <p:cNvCxnSpPr>
            <a:cxnSpLocks/>
          </p:cNvCxnSpPr>
          <p:nvPr/>
        </p:nvCxnSpPr>
        <p:spPr>
          <a:xfrm>
            <a:off x="9523290" y="2710179"/>
            <a:ext cx="904478" cy="0"/>
          </a:xfrm>
          <a:prstGeom prst="straightConnector1">
            <a:avLst/>
          </a:prstGeom>
          <a:ln w="12700">
            <a:solidFill>
              <a:schemeClr val="tx1"/>
            </a:solidFill>
            <a:headEnd type="arrow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矢印コネクタ 64">
            <a:extLst>
              <a:ext uri="{FF2B5EF4-FFF2-40B4-BE49-F238E27FC236}">
                <a16:creationId xmlns="" xmlns:a16="http://schemas.microsoft.com/office/drawing/2014/main" id="{AF686D79-A596-0E4E-9998-A19D81652E7F}"/>
              </a:ext>
            </a:extLst>
          </p:cNvPr>
          <p:cNvCxnSpPr>
            <a:cxnSpLocks/>
          </p:cNvCxnSpPr>
          <p:nvPr/>
        </p:nvCxnSpPr>
        <p:spPr>
          <a:xfrm>
            <a:off x="9523290" y="3063672"/>
            <a:ext cx="386587" cy="0"/>
          </a:xfrm>
          <a:prstGeom prst="straightConnector1">
            <a:avLst/>
          </a:prstGeom>
          <a:ln w="19050" cmpd="sng">
            <a:solidFill>
              <a:schemeClr val="tx1"/>
            </a:solidFill>
            <a:prstDash val="dot"/>
            <a:headEnd type="arrow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テキスト ボックス 75">
            <a:extLst>
              <a:ext uri="{FF2B5EF4-FFF2-40B4-BE49-F238E27FC236}">
                <a16:creationId xmlns="" xmlns:a16="http://schemas.microsoft.com/office/drawing/2014/main" id="{B6B41BB1-D670-7749-98C3-2AF633F841CF}"/>
              </a:ext>
            </a:extLst>
          </p:cNvPr>
          <p:cNvSpPr txBox="1"/>
          <p:nvPr/>
        </p:nvSpPr>
        <p:spPr>
          <a:xfrm>
            <a:off x="8627672" y="2571680"/>
            <a:ext cx="847648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kumimoji="1" lang="en-US" altLang="ja-JP" sz="1200" dirty="0"/>
              <a:t>Major axis</a:t>
            </a:r>
            <a:endParaRPr kumimoji="1" lang="ja-JP" altLang="en-US" sz="1200" dirty="0"/>
          </a:p>
        </p:txBody>
      </p:sp>
      <p:sp>
        <p:nvSpPr>
          <p:cNvPr id="77" name="テキスト ボックス 76">
            <a:extLst>
              <a:ext uri="{FF2B5EF4-FFF2-40B4-BE49-F238E27FC236}">
                <a16:creationId xmlns="" xmlns:a16="http://schemas.microsoft.com/office/drawing/2014/main" id="{A4B7DDD8-7A51-4F4C-8FEB-8F5E1F1FE23A}"/>
              </a:ext>
            </a:extLst>
          </p:cNvPr>
          <p:cNvSpPr txBox="1"/>
          <p:nvPr/>
        </p:nvSpPr>
        <p:spPr>
          <a:xfrm>
            <a:off x="8622295" y="2925173"/>
            <a:ext cx="847648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kumimoji="1" lang="en-US" altLang="ja-JP" sz="1200" dirty="0"/>
              <a:t>Minor axis</a:t>
            </a:r>
            <a:endParaRPr kumimoji="1" lang="ja-JP" altLang="en-US" sz="1200"/>
          </a:p>
        </p:txBody>
      </p:sp>
      <p:sp>
        <p:nvSpPr>
          <p:cNvPr id="78" name="テキスト ボックス 77">
            <a:extLst>
              <a:ext uri="{FF2B5EF4-FFF2-40B4-BE49-F238E27FC236}">
                <a16:creationId xmlns="" xmlns:a16="http://schemas.microsoft.com/office/drawing/2014/main" id="{2BE311C2-59B2-F846-8516-5E85E19F58A8}"/>
              </a:ext>
            </a:extLst>
          </p:cNvPr>
          <p:cNvSpPr txBox="1"/>
          <p:nvPr/>
        </p:nvSpPr>
        <p:spPr>
          <a:xfrm>
            <a:off x="2861524" y="6496823"/>
            <a:ext cx="1721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Area (μm</a:t>
            </a:r>
            <a:r>
              <a:rPr kumimoji="1" lang="en-US" altLang="ja-JP" sz="1200" baseline="30000" dirty="0"/>
              <a:t>2</a:t>
            </a:r>
            <a:r>
              <a:rPr kumimoji="1" lang="en-US" altLang="ja-JP" sz="1200" dirty="0"/>
              <a:t>)</a:t>
            </a:r>
            <a:endParaRPr kumimoji="1" lang="ja-JP" altLang="en-US" sz="1200"/>
          </a:p>
        </p:txBody>
      </p:sp>
      <p:sp>
        <p:nvSpPr>
          <p:cNvPr id="79" name="テキスト ボックス 78">
            <a:extLst>
              <a:ext uri="{FF2B5EF4-FFF2-40B4-BE49-F238E27FC236}">
                <a16:creationId xmlns="" xmlns:a16="http://schemas.microsoft.com/office/drawing/2014/main" id="{0C54905D-CCB9-B64E-AFA2-BE7ADB2B3AE6}"/>
              </a:ext>
            </a:extLst>
          </p:cNvPr>
          <p:cNvSpPr txBox="1"/>
          <p:nvPr/>
        </p:nvSpPr>
        <p:spPr>
          <a:xfrm>
            <a:off x="5081607" y="6496823"/>
            <a:ext cx="1721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Major axis (</a:t>
            </a:r>
            <a:r>
              <a:rPr kumimoji="1" lang="en-US" altLang="ja-JP" sz="1200" dirty="0" err="1"/>
              <a:t>μm</a:t>
            </a:r>
            <a:r>
              <a:rPr kumimoji="1" lang="en-US" altLang="ja-JP" sz="1200" dirty="0"/>
              <a:t>)</a:t>
            </a:r>
            <a:endParaRPr kumimoji="1" lang="ja-JP" altLang="en-US" sz="1200"/>
          </a:p>
        </p:txBody>
      </p:sp>
      <p:sp>
        <p:nvSpPr>
          <p:cNvPr id="80" name="テキスト ボックス 79">
            <a:extLst>
              <a:ext uri="{FF2B5EF4-FFF2-40B4-BE49-F238E27FC236}">
                <a16:creationId xmlns="" xmlns:a16="http://schemas.microsoft.com/office/drawing/2014/main" id="{BDE7FADF-8DE7-BF41-A942-ACCDB30B504C}"/>
              </a:ext>
            </a:extLst>
          </p:cNvPr>
          <p:cNvSpPr txBox="1"/>
          <p:nvPr/>
        </p:nvSpPr>
        <p:spPr>
          <a:xfrm>
            <a:off x="7374578" y="6496823"/>
            <a:ext cx="1721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Minor axis (</a:t>
            </a:r>
            <a:r>
              <a:rPr kumimoji="1" lang="en-US" altLang="ja-JP" sz="1200" dirty="0" err="1"/>
              <a:t>μm</a:t>
            </a:r>
            <a:r>
              <a:rPr kumimoji="1" lang="en-US" altLang="ja-JP" sz="1200" dirty="0"/>
              <a:t>)</a:t>
            </a:r>
            <a:endParaRPr kumimoji="1" lang="ja-JP" altLang="en-US" sz="1200"/>
          </a:p>
        </p:txBody>
      </p:sp>
      <p:sp>
        <p:nvSpPr>
          <p:cNvPr id="81" name="テキスト ボックス 80">
            <a:extLst>
              <a:ext uri="{FF2B5EF4-FFF2-40B4-BE49-F238E27FC236}">
                <a16:creationId xmlns="" xmlns:a16="http://schemas.microsoft.com/office/drawing/2014/main" id="{E093243E-9E44-9643-B317-D2304713CAF3}"/>
              </a:ext>
            </a:extLst>
          </p:cNvPr>
          <p:cNvSpPr txBox="1"/>
          <p:nvPr/>
        </p:nvSpPr>
        <p:spPr>
          <a:xfrm>
            <a:off x="3879060" y="6820158"/>
            <a:ext cx="620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***</a:t>
            </a:r>
            <a:endParaRPr kumimoji="1" lang="ja-JP" altLang="en-US" sz="1200"/>
          </a:p>
        </p:txBody>
      </p:sp>
      <p:sp>
        <p:nvSpPr>
          <p:cNvPr id="82" name="テキスト ボックス 81">
            <a:extLst>
              <a:ext uri="{FF2B5EF4-FFF2-40B4-BE49-F238E27FC236}">
                <a16:creationId xmlns="" xmlns:a16="http://schemas.microsoft.com/office/drawing/2014/main" id="{466A24CB-234E-FB48-B1D7-CB000C66BDD4}"/>
              </a:ext>
            </a:extLst>
          </p:cNvPr>
          <p:cNvSpPr txBox="1"/>
          <p:nvPr/>
        </p:nvSpPr>
        <p:spPr>
          <a:xfrm>
            <a:off x="6156596" y="6820158"/>
            <a:ext cx="620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***</a:t>
            </a:r>
            <a:endParaRPr kumimoji="1" lang="ja-JP" altLang="en-US" sz="1200"/>
          </a:p>
        </p:txBody>
      </p:sp>
      <p:sp>
        <p:nvSpPr>
          <p:cNvPr id="83" name="テキスト ボックス 82">
            <a:extLst>
              <a:ext uri="{FF2B5EF4-FFF2-40B4-BE49-F238E27FC236}">
                <a16:creationId xmlns="" xmlns:a16="http://schemas.microsoft.com/office/drawing/2014/main" id="{937508C7-6FEA-8940-BB5B-2CA607136D6C}"/>
              </a:ext>
            </a:extLst>
          </p:cNvPr>
          <p:cNvSpPr txBox="1"/>
          <p:nvPr/>
        </p:nvSpPr>
        <p:spPr>
          <a:xfrm>
            <a:off x="8430944" y="6972442"/>
            <a:ext cx="620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*</a:t>
            </a:r>
            <a:endParaRPr kumimoji="1" lang="ja-JP" altLang="en-US" sz="1200"/>
          </a:p>
        </p:txBody>
      </p:sp>
      <p:sp>
        <p:nvSpPr>
          <p:cNvPr id="84" name="テキスト ボックス 83">
            <a:extLst>
              <a:ext uri="{FF2B5EF4-FFF2-40B4-BE49-F238E27FC236}">
                <a16:creationId xmlns="" xmlns:a16="http://schemas.microsoft.com/office/drawing/2014/main" id="{58A3B256-15C1-7549-A728-DA44684D75B9}"/>
              </a:ext>
            </a:extLst>
          </p:cNvPr>
          <p:cNvSpPr txBox="1"/>
          <p:nvPr/>
        </p:nvSpPr>
        <p:spPr>
          <a:xfrm>
            <a:off x="2730021" y="8444114"/>
            <a:ext cx="12931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A549</a:t>
            </a:r>
          </a:p>
          <a:p>
            <a:pPr algn="ctr"/>
            <a:r>
              <a:rPr kumimoji="1" lang="en-US" altLang="ja-JP" sz="1200" dirty="0"/>
              <a:t>parental cells</a:t>
            </a:r>
            <a:endParaRPr kumimoji="1" lang="ja-JP" altLang="en-US" sz="1200"/>
          </a:p>
        </p:txBody>
      </p:sp>
      <p:sp>
        <p:nvSpPr>
          <p:cNvPr id="85" name="テキスト ボックス 84">
            <a:extLst>
              <a:ext uri="{FF2B5EF4-FFF2-40B4-BE49-F238E27FC236}">
                <a16:creationId xmlns="" xmlns:a16="http://schemas.microsoft.com/office/drawing/2014/main" id="{61C97921-5332-1044-BB89-D46AEE323757}"/>
              </a:ext>
            </a:extLst>
          </p:cNvPr>
          <p:cNvSpPr txBox="1"/>
          <p:nvPr/>
        </p:nvSpPr>
        <p:spPr>
          <a:xfrm>
            <a:off x="3551385" y="8444114"/>
            <a:ext cx="12931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A549</a:t>
            </a:r>
          </a:p>
          <a:p>
            <a:pPr algn="ctr"/>
            <a:r>
              <a:rPr kumimoji="1" lang="en-US" altLang="ja-JP" sz="1200" dirty="0"/>
              <a:t>clone AS#3</a:t>
            </a:r>
            <a:endParaRPr kumimoji="1" lang="ja-JP" altLang="en-US" sz="1200"/>
          </a:p>
        </p:txBody>
      </p:sp>
      <p:sp>
        <p:nvSpPr>
          <p:cNvPr id="86" name="テキスト ボックス 85">
            <a:extLst>
              <a:ext uri="{FF2B5EF4-FFF2-40B4-BE49-F238E27FC236}">
                <a16:creationId xmlns="" xmlns:a16="http://schemas.microsoft.com/office/drawing/2014/main" id="{D5B8D254-E854-E94A-80BA-D57B30F654A1}"/>
              </a:ext>
            </a:extLst>
          </p:cNvPr>
          <p:cNvSpPr txBox="1"/>
          <p:nvPr/>
        </p:nvSpPr>
        <p:spPr>
          <a:xfrm>
            <a:off x="4982690" y="8444114"/>
            <a:ext cx="12931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A549</a:t>
            </a:r>
          </a:p>
          <a:p>
            <a:pPr algn="ctr"/>
            <a:r>
              <a:rPr kumimoji="1" lang="en-US" altLang="ja-JP" sz="1200" dirty="0"/>
              <a:t>parental cells</a:t>
            </a:r>
            <a:endParaRPr kumimoji="1" lang="ja-JP" altLang="en-US" sz="1200"/>
          </a:p>
        </p:txBody>
      </p:sp>
      <p:sp>
        <p:nvSpPr>
          <p:cNvPr id="87" name="テキスト ボックス 86">
            <a:extLst>
              <a:ext uri="{FF2B5EF4-FFF2-40B4-BE49-F238E27FC236}">
                <a16:creationId xmlns="" xmlns:a16="http://schemas.microsoft.com/office/drawing/2014/main" id="{EFE857F8-F54C-A44F-B5E4-5A9FA6E0D03A}"/>
              </a:ext>
            </a:extLst>
          </p:cNvPr>
          <p:cNvSpPr txBox="1"/>
          <p:nvPr/>
        </p:nvSpPr>
        <p:spPr>
          <a:xfrm>
            <a:off x="5831715" y="8444114"/>
            <a:ext cx="12931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A549</a:t>
            </a:r>
          </a:p>
          <a:p>
            <a:pPr algn="ctr"/>
            <a:r>
              <a:rPr kumimoji="1" lang="en-US" altLang="ja-JP" sz="1200" dirty="0"/>
              <a:t>clone AS#3</a:t>
            </a:r>
            <a:endParaRPr kumimoji="1" lang="ja-JP" altLang="en-US" sz="1200"/>
          </a:p>
        </p:txBody>
      </p:sp>
      <p:sp>
        <p:nvSpPr>
          <p:cNvPr id="88" name="テキスト ボックス 87">
            <a:extLst>
              <a:ext uri="{FF2B5EF4-FFF2-40B4-BE49-F238E27FC236}">
                <a16:creationId xmlns="" xmlns:a16="http://schemas.microsoft.com/office/drawing/2014/main" id="{AD8ADA85-FB1C-154C-AD94-D1D0982E44E3}"/>
              </a:ext>
            </a:extLst>
          </p:cNvPr>
          <p:cNvSpPr txBox="1"/>
          <p:nvPr/>
        </p:nvSpPr>
        <p:spPr>
          <a:xfrm>
            <a:off x="7263759" y="8444114"/>
            <a:ext cx="12931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A549</a:t>
            </a:r>
          </a:p>
          <a:p>
            <a:pPr algn="ctr"/>
            <a:r>
              <a:rPr kumimoji="1" lang="en-US" altLang="ja-JP" sz="1200" dirty="0"/>
              <a:t>parental cells</a:t>
            </a:r>
            <a:endParaRPr kumimoji="1" lang="ja-JP" altLang="en-US" sz="1200"/>
          </a:p>
        </p:txBody>
      </p:sp>
      <p:sp>
        <p:nvSpPr>
          <p:cNvPr id="89" name="テキスト ボックス 88">
            <a:extLst>
              <a:ext uri="{FF2B5EF4-FFF2-40B4-BE49-F238E27FC236}">
                <a16:creationId xmlns="" xmlns:a16="http://schemas.microsoft.com/office/drawing/2014/main" id="{8DDA012B-2CAA-0247-8FCE-19B99735BB22}"/>
              </a:ext>
            </a:extLst>
          </p:cNvPr>
          <p:cNvSpPr txBox="1"/>
          <p:nvPr/>
        </p:nvSpPr>
        <p:spPr>
          <a:xfrm>
            <a:off x="8102845" y="8444114"/>
            <a:ext cx="12931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/>
              <a:t>A549</a:t>
            </a:r>
          </a:p>
          <a:p>
            <a:pPr algn="ctr"/>
            <a:r>
              <a:rPr kumimoji="1" lang="en-US" altLang="ja-JP" sz="1200" dirty="0"/>
              <a:t>clone AS#3</a:t>
            </a:r>
            <a:endParaRPr kumimoji="1" lang="ja-JP" altLang="en-US" sz="1200"/>
          </a:p>
        </p:txBody>
      </p:sp>
      <p:graphicFrame>
        <p:nvGraphicFramePr>
          <p:cNvPr id="90" name="グラフ 89">
            <a:extLst>
              <a:ext uri="{FF2B5EF4-FFF2-40B4-BE49-F238E27FC236}">
                <a16:creationId xmlns="" xmlns:a16="http://schemas.microsoft.com/office/drawing/2014/main" id="{B381439B-F79E-BA4C-9013-BA5C8A36F1C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3410869"/>
              </p:ext>
            </p:extLst>
          </p:nvPr>
        </p:nvGraphicFramePr>
        <p:xfrm>
          <a:off x="2585592" y="6752196"/>
          <a:ext cx="2131200" cy="1846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1" name="グラフ 90">
            <a:extLst>
              <a:ext uri="{FF2B5EF4-FFF2-40B4-BE49-F238E27FC236}">
                <a16:creationId xmlns="" xmlns:a16="http://schemas.microsoft.com/office/drawing/2014/main" id="{B2158455-C6A6-8044-8184-25F3C7C9967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68492412"/>
              </p:ext>
            </p:extLst>
          </p:nvPr>
        </p:nvGraphicFramePr>
        <p:xfrm>
          <a:off x="4878563" y="6752196"/>
          <a:ext cx="2131200" cy="1846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2" name="グラフ 91">
            <a:extLst>
              <a:ext uri="{FF2B5EF4-FFF2-40B4-BE49-F238E27FC236}">
                <a16:creationId xmlns="" xmlns:a16="http://schemas.microsoft.com/office/drawing/2014/main" id="{54B56C0E-6B70-DF41-8194-727615E0910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5049479"/>
              </p:ext>
            </p:extLst>
          </p:nvPr>
        </p:nvGraphicFramePr>
        <p:xfrm>
          <a:off x="7167647" y="6752196"/>
          <a:ext cx="2131200" cy="1846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94" name="テキスト ボックス 93"/>
          <p:cNvSpPr txBox="1"/>
          <p:nvPr/>
        </p:nvSpPr>
        <p:spPr>
          <a:xfrm>
            <a:off x="50188" y="49294"/>
            <a:ext cx="2430473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b="1" dirty="0"/>
              <a:t>Suppl.</a:t>
            </a:r>
            <a:r>
              <a:rPr kumimoji="1" lang="ja-JP" altLang="en-US" sz="3200" b="1" dirty="0"/>
              <a:t> </a:t>
            </a:r>
            <a:r>
              <a:rPr kumimoji="1" lang="en-US" altLang="ja-JP" sz="3200" b="1" dirty="0"/>
              <a:t>Fig.</a:t>
            </a:r>
            <a:r>
              <a:rPr kumimoji="1" lang="ja-JP" altLang="en-US" sz="3200" b="1" dirty="0"/>
              <a:t> </a:t>
            </a:r>
            <a:r>
              <a:rPr kumimoji="1" lang="en-US" altLang="ja-JP" sz="3200" b="1" dirty="0" smtClean="0"/>
              <a:t>S</a:t>
            </a:r>
            <a:r>
              <a:rPr kumimoji="1" lang="en-US" altLang="ja-JP" sz="3200" b="1" dirty="0" smtClean="0"/>
              <a:t>5</a:t>
            </a:r>
            <a:endParaRPr kumimoji="1" lang="ja-JP" altLang="en-US" sz="3200" b="1" dirty="0"/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2131543" y="2741454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2131543" y="6119716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520998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テキスト ボックス 274"/>
          <p:cNvSpPr txBox="1"/>
          <p:nvPr/>
        </p:nvSpPr>
        <p:spPr>
          <a:xfrm>
            <a:off x="50188" y="49294"/>
            <a:ext cx="2430473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b="1" dirty="0"/>
              <a:t>Suppl.</a:t>
            </a:r>
            <a:r>
              <a:rPr kumimoji="1" lang="ja-JP" altLang="en-US" sz="3200" b="1" dirty="0"/>
              <a:t> </a:t>
            </a:r>
            <a:r>
              <a:rPr kumimoji="1" lang="en-US" altLang="ja-JP" sz="3200" b="1" dirty="0"/>
              <a:t>Fig.</a:t>
            </a:r>
            <a:r>
              <a:rPr kumimoji="1" lang="ja-JP" altLang="en-US" sz="3200" b="1" dirty="0"/>
              <a:t> </a:t>
            </a:r>
            <a:r>
              <a:rPr kumimoji="1" lang="en-US" altLang="ja-JP" sz="3200" b="1" dirty="0" smtClean="0"/>
              <a:t>S</a:t>
            </a:r>
            <a:r>
              <a:rPr kumimoji="1" lang="en-US" altLang="ja-JP" sz="3200" b="1" dirty="0" smtClean="0"/>
              <a:t>6</a:t>
            </a:r>
            <a:endParaRPr kumimoji="1" lang="ja-JP" altLang="en-US" sz="3200" b="1" dirty="0"/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258088" y="1599083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7179646" y="1599083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</a:t>
            </a:r>
            <a:endParaRPr kumimoji="1" lang="ja-JP" altLang="en-US" dirty="0"/>
          </a:p>
        </p:txBody>
      </p:sp>
      <p:sp>
        <p:nvSpPr>
          <p:cNvPr id="29" name="正方形/長方形 28"/>
          <p:cNvSpPr/>
          <p:nvPr/>
        </p:nvSpPr>
        <p:spPr>
          <a:xfrm>
            <a:off x="9208594" y="7118331"/>
            <a:ext cx="2347468" cy="1202542"/>
          </a:xfrm>
          <a:prstGeom prst="rect">
            <a:avLst/>
          </a:prstGeom>
          <a:solidFill>
            <a:srgbClr val="D9D9D9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8400837" y="3359106"/>
            <a:ext cx="77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PDEF</a:t>
            </a:r>
            <a:endParaRPr kumimoji="1" lang="ja-JP" altLang="en-US" dirty="0"/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8841565" y="5837519"/>
            <a:ext cx="6480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ZEB2</a:t>
            </a:r>
            <a:endParaRPr kumimoji="1" lang="ja-JP" altLang="en-US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9839809" y="7224624"/>
            <a:ext cx="11332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EMT</a:t>
            </a:r>
          </a:p>
          <a:p>
            <a:r>
              <a:rPr kumimoji="1" lang="en-US" altLang="ja-JP" b="1" dirty="0"/>
              <a:t>Migration</a:t>
            </a:r>
            <a:endParaRPr kumimoji="1" lang="ja-JP" altLang="en-US" b="1" dirty="0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9265350" y="7879363"/>
            <a:ext cx="22396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Cancer dissemination</a:t>
            </a:r>
          </a:p>
          <a:p>
            <a:endParaRPr kumimoji="1" lang="ja-JP" altLang="en-US" b="1" dirty="0"/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8330336" y="2577464"/>
            <a:ext cx="923262" cy="36933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rgbClr val="3366FF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NPTN-</a:t>
            </a:r>
            <a:r>
              <a:rPr kumimoji="1" lang="en-US" altLang="ja-JP" b="1" dirty="0">
                <a:latin typeface="Symbol" charset="2"/>
                <a:cs typeface="Symbol" charset="2"/>
              </a:rPr>
              <a:t>b</a:t>
            </a:r>
            <a:endParaRPr kumimoji="1" lang="ja-JP" altLang="en-US" b="1" dirty="0">
              <a:latin typeface="Symbol" charset="2"/>
              <a:cs typeface="Symbol" charset="2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7354883" y="7237210"/>
            <a:ext cx="174487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Cancer suppressive events</a:t>
            </a:r>
            <a:endParaRPr kumimoji="1" lang="ja-JP" altLang="en-US" dirty="0"/>
          </a:p>
        </p:txBody>
      </p:sp>
      <p:grpSp>
        <p:nvGrpSpPr>
          <p:cNvPr id="9" name="図形グループ 8"/>
          <p:cNvGrpSpPr/>
          <p:nvPr/>
        </p:nvGrpSpPr>
        <p:grpSpPr>
          <a:xfrm>
            <a:off x="7806694" y="3543772"/>
            <a:ext cx="420625" cy="3512909"/>
            <a:chOff x="8706704" y="2920255"/>
            <a:chExt cx="420625" cy="3512909"/>
          </a:xfrm>
        </p:grpSpPr>
        <p:cxnSp>
          <p:nvCxnSpPr>
            <p:cNvPr id="6" name="直線コネクタ 5"/>
            <p:cNvCxnSpPr/>
            <p:nvPr/>
          </p:nvCxnSpPr>
          <p:spPr>
            <a:xfrm flipH="1">
              <a:off x="8706704" y="2920255"/>
              <a:ext cx="420625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矢印コネクタ 7"/>
            <p:cNvCxnSpPr/>
            <p:nvPr/>
          </p:nvCxnSpPr>
          <p:spPr>
            <a:xfrm>
              <a:off x="8706704" y="2920255"/>
              <a:ext cx="0" cy="3512909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3" name="図形グループ 72"/>
          <p:cNvGrpSpPr/>
          <p:nvPr/>
        </p:nvGrpSpPr>
        <p:grpSpPr>
          <a:xfrm flipH="1">
            <a:off x="9217441" y="3543772"/>
            <a:ext cx="420625" cy="3512909"/>
            <a:chOff x="8706704" y="2920255"/>
            <a:chExt cx="420625" cy="3512909"/>
          </a:xfrm>
        </p:grpSpPr>
        <p:cxnSp>
          <p:nvCxnSpPr>
            <p:cNvPr id="74" name="直線コネクタ 73"/>
            <p:cNvCxnSpPr/>
            <p:nvPr/>
          </p:nvCxnSpPr>
          <p:spPr>
            <a:xfrm flipH="1">
              <a:off x="8706704" y="2920255"/>
              <a:ext cx="420625" cy="0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矢印コネクタ 74"/>
            <p:cNvCxnSpPr/>
            <p:nvPr/>
          </p:nvCxnSpPr>
          <p:spPr>
            <a:xfrm>
              <a:off x="8706704" y="2920255"/>
              <a:ext cx="0" cy="3512909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1" name="直線矢印コネクタ 10"/>
          <p:cNvCxnSpPr/>
          <p:nvPr/>
        </p:nvCxnSpPr>
        <p:spPr>
          <a:xfrm>
            <a:off x="8779607" y="2934466"/>
            <a:ext cx="0" cy="47319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テキスト ボックス 64"/>
          <p:cNvSpPr txBox="1"/>
          <p:nvPr/>
        </p:nvSpPr>
        <p:spPr>
          <a:xfrm>
            <a:off x="9036044" y="4416980"/>
            <a:ext cx="1370387" cy="369332"/>
          </a:xfrm>
          <a:prstGeom prst="rect">
            <a:avLst/>
          </a:prstGeom>
          <a:solidFill>
            <a:srgbClr val="D9D9D9"/>
          </a:solidFill>
          <a:ln>
            <a:solidFill>
              <a:srgbClr val="3366FF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LC22A18AS</a:t>
            </a:r>
            <a:endParaRPr kumimoji="1" lang="ja-JP" altLang="en-US" b="1" dirty="0"/>
          </a:p>
        </p:txBody>
      </p:sp>
      <p:cxnSp>
        <p:nvCxnSpPr>
          <p:cNvPr id="14" name="直線矢印コネクタ 13"/>
          <p:cNvCxnSpPr/>
          <p:nvPr/>
        </p:nvCxnSpPr>
        <p:spPr>
          <a:xfrm flipV="1">
            <a:off x="9516278" y="5862353"/>
            <a:ext cx="0" cy="311931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>
            <a:off x="9353079" y="2803287"/>
            <a:ext cx="597945" cy="0"/>
          </a:xfrm>
          <a:prstGeom prst="line">
            <a:avLst/>
          </a:prstGeom>
          <a:ln>
            <a:prstDash val="sys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直線矢印コネクタ 19"/>
          <p:cNvCxnSpPr/>
          <p:nvPr/>
        </p:nvCxnSpPr>
        <p:spPr>
          <a:xfrm>
            <a:off x="9951024" y="2803287"/>
            <a:ext cx="0" cy="1600531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直線矢印コネクタ 21"/>
          <p:cNvCxnSpPr/>
          <p:nvPr/>
        </p:nvCxnSpPr>
        <p:spPr>
          <a:xfrm>
            <a:off x="9638066" y="3548471"/>
            <a:ext cx="0" cy="859717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/>
          <p:cNvSpPr txBox="1"/>
          <p:nvPr/>
        </p:nvSpPr>
        <p:spPr>
          <a:xfrm>
            <a:off x="9914765" y="3669271"/>
            <a:ext cx="3510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/>
              <a:t>?</a:t>
            </a:r>
            <a:endParaRPr kumimoji="1" lang="ja-JP" altLang="en-US" sz="2800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11139221" y="1910926"/>
            <a:ext cx="710451" cy="1169551"/>
          </a:xfrm>
          <a:prstGeom prst="rect">
            <a:avLst/>
          </a:prstGeom>
          <a:solidFill>
            <a:srgbClr val="FFFFFF"/>
          </a:solidFill>
          <a:ln>
            <a:solidFill>
              <a:srgbClr val="3366FF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FGFR4</a:t>
            </a:r>
          </a:p>
          <a:p>
            <a:r>
              <a:rPr kumimoji="1" lang="en-US" altLang="ja-JP" sz="1400" dirty="0"/>
              <a:t>IGFBP2</a:t>
            </a:r>
          </a:p>
          <a:p>
            <a:r>
              <a:rPr kumimoji="1" lang="en-US" altLang="ja-JP" sz="1400" dirty="0"/>
              <a:t>ITGA1</a:t>
            </a:r>
          </a:p>
          <a:p>
            <a:r>
              <a:rPr kumimoji="1" lang="en-US" altLang="ja-JP" sz="1400" dirty="0"/>
              <a:t>ITGB4</a:t>
            </a:r>
          </a:p>
          <a:p>
            <a:r>
              <a:rPr kumimoji="1" lang="en-US" altLang="ja-JP" sz="1400" dirty="0"/>
              <a:t>KLF5</a:t>
            </a:r>
            <a:endParaRPr kumimoji="1" lang="ja-JP" altLang="en-US" sz="1400" dirty="0"/>
          </a:p>
        </p:txBody>
      </p:sp>
      <p:sp>
        <p:nvSpPr>
          <p:cNvPr id="226" name="テキスト ボックス 225"/>
          <p:cNvSpPr txBox="1"/>
          <p:nvPr/>
        </p:nvSpPr>
        <p:spPr>
          <a:xfrm>
            <a:off x="11219182" y="3020218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1C</a:t>
            </a:r>
            <a:endParaRPr kumimoji="1" lang="ja-JP" altLang="en-US" dirty="0"/>
          </a:p>
        </p:txBody>
      </p:sp>
      <p:cxnSp>
        <p:nvCxnSpPr>
          <p:cNvPr id="233" name="直線矢印コネクタ 232"/>
          <p:cNvCxnSpPr/>
          <p:nvPr/>
        </p:nvCxnSpPr>
        <p:spPr>
          <a:xfrm flipV="1">
            <a:off x="9353079" y="2330909"/>
            <a:ext cx="1650560" cy="317827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3" name="テキスト ボックス 112"/>
          <p:cNvSpPr txBox="1"/>
          <p:nvPr/>
        </p:nvSpPr>
        <p:spPr>
          <a:xfrm>
            <a:off x="10771984" y="3205218"/>
            <a:ext cx="3510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/>
              <a:t>?</a:t>
            </a:r>
            <a:endParaRPr kumimoji="1" lang="ja-JP" altLang="en-US" sz="2800" dirty="0"/>
          </a:p>
        </p:txBody>
      </p:sp>
      <p:cxnSp>
        <p:nvCxnSpPr>
          <p:cNvPr id="235" name="直線矢印コネクタ 234"/>
          <p:cNvCxnSpPr/>
          <p:nvPr/>
        </p:nvCxnSpPr>
        <p:spPr>
          <a:xfrm>
            <a:off x="11139221" y="3178179"/>
            <a:ext cx="0" cy="3878502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7" name="テキスト ボックス 236"/>
          <p:cNvSpPr txBox="1"/>
          <p:nvPr/>
        </p:nvSpPr>
        <p:spPr>
          <a:xfrm>
            <a:off x="9638066" y="4828279"/>
            <a:ext cx="11123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LC22A18</a:t>
            </a:r>
            <a:endParaRPr kumimoji="1" lang="ja-JP" altLang="en-US" dirty="0"/>
          </a:p>
        </p:txBody>
      </p:sp>
      <p:cxnSp>
        <p:nvCxnSpPr>
          <p:cNvPr id="118" name="直線矢印コネクタ 117"/>
          <p:cNvCxnSpPr/>
          <p:nvPr/>
        </p:nvCxnSpPr>
        <p:spPr>
          <a:xfrm>
            <a:off x="10768856" y="4875569"/>
            <a:ext cx="0" cy="311931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9" name="直線矢印コネクタ 238"/>
          <p:cNvCxnSpPr/>
          <p:nvPr/>
        </p:nvCxnSpPr>
        <p:spPr>
          <a:xfrm flipH="1">
            <a:off x="10518326" y="3084505"/>
            <a:ext cx="551748" cy="412248"/>
          </a:xfrm>
          <a:prstGeom prst="straightConnector1">
            <a:avLst/>
          </a:prstGeom>
          <a:ln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2" name="直線コネクタ 251"/>
          <p:cNvCxnSpPr/>
          <p:nvPr/>
        </p:nvCxnSpPr>
        <p:spPr>
          <a:xfrm>
            <a:off x="7832364" y="8918681"/>
            <a:ext cx="2574067" cy="565655"/>
          </a:xfrm>
          <a:prstGeom prst="line">
            <a:avLst/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4" name="二等辺三角形 253"/>
          <p:cNvSpPr/>
          <p:nvPr/>
        </p:nvSpPr>
        <p:spPr>
          <a:xfrm>
            <a:off x="8904937" y="9225399"/>
            <a:ext cx="428920" cy="271268"/>
          </a:xfrm>
          <a:prstGeom prst="triangle">
            <a:avLst/>
          </a:prstGeom>
          <a:noFill/>
          <a:ln w="28575" cmpd="sng"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5" name="下矢印 254"/>
          <p:cNvSpPr/>
          <p:nvPr/>
        </p:nvSpPr>
        <p:spPr>
          <a:xfrm>
            <a:off x="9811400" y="8918681"/>
            <a:ext cx="512351" cy="360663"/>
          </a:xfrm>
          <a:prstGeom prst="down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45" name="グループ化 44">
            <a:extLst>
              <a:ext uri="{FF2B5EF4-FFF2-40B4-BE49-F238E27FC236}">
                <a16:creationId xmlns="" xmlns:a16="http://schemas.microsoft.com/office/drawing/2014/main" id="{405E701E-8A7F-5148-8E66-D30CDB67446F}"/>
              </a:ext>
            </a:extLst>
          </p:cNvPr>
          <p:cNvGrpSpPr/>
          <p:nvPr/>
        </p:nvGrpSpPr>
        <p:grpSpPr>
          <a:xfrm>
            <a:off x="779225" y="2365633"/>
            <a:ext cx="1348314" cy="1266272"/>
            <a:chOff x="1990191" y="1586776"/>
            <a:chExt cx="1348314" cy="1266272"/>
          </a:xfrm>
        </p:grpSpPr>
        <p:pic>
          <p:nvPicPr>
            <p:cNvPr id="21" name="グラフィックス 20" descr="肺">
              <a:extLst>
                <a:ext uri="{FF2B5EF4-FFF2-40B4-BE49-F238E27FC236}">
                  <a16:creationId xmlns="" xmlns:a16="http://schemas.microsoft.com/office/drawing/2014/main" id="{9E6B3A65-C1E2-6649-8B52-329203BBAFA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96DAC541-7B7A-43D3-8B79-37D633B846F1}">
                  <asvg:svgBlip xmlns=""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2072233" y="1586776"/>
              <a:ext cx="1266272" cy="1266272"/>
            </a:xfrm>
            <a:prstGeom prst="rect">
              <a:avLst/>
            </a:prstGeom>
          </p:spPr>
        </p:pic>
        <p:sp>
          <p:nvSpPr>
            <p:cNvPr id="25" name="フリーフォーム 24">
              <a:extLst>
                <a:ext uri="{FF2B5EF4-FFF2-40B4-BE49-F238E27FC236}">
                  <a16:creationId xmlns="" xmlns:a16="http://schemas.microsoft.com/office/drawing/2014/main" id="{1C0FC5CD-169F-394A-9218-556F1BB8F27B}"/>
                </a:ext>
              </a:extLst>
            </p:cNvPr>
            <p:cNvSpPr/>
            <p:nvPr/>
          </p:nvSpPr>
          <p:spPr>
            <a:xfrm>
              <a:off x="2254515" y="1960622"/>
              <a:ext cx="903557" cy="531291"/>
            </a:xfrm>
            <a:custGeom>
              <a:avLst/>
              <a:gdLst>
                <a:gd name="connsiteX0" fmla="*/ 18071 w 903557"/>
                <a:gd name="connsiteY0" fmla="*/ 531291 h 531291"/>
                <a:gd name="connsiteX1" fmla="*/ 18071 w 903557"/>
                <a:gd name="connsiteY1" fmla="*/ 531291 h 531291"/>
                <a:gd name="connsiteX2" fmla="*/ 0 w 903557"/>
                <a:gd name="connsiteY2" fmla="*/ 484306 h 531291"/>
                <a:gd name="connsiteX3" fmla="*/ 3614 w 903557"/>
                <a:gd name="connsiteY3" fmla="*/ 469849 h 531291"/>
                <a:gd name="connsiteX4" fmla="*/ 7228 w 903557"/>
                <a:gd name="connsiteY4" fmla="*/ 448164 h 531291"/>
                <a:gd name="connsiteX5" fmla="*/ 18071 w 903557"/>
                <a:gd name="connsiteY5" fmla="*/ 397565 h 531291"/>
                <a:gd name="connsiteX6" fmla="*/ 28914 w 903557"/>
                <a:gd name="connsiteY6" fmla="*/ 365037 h 531291"/>
                <a:gd name="connsiteX7" fmla="*/ 32528 w 903557"/>
                <a:gd name="connsiteY7" fmla="*/ 354194 h 531291"/>
                <a:gd name="connsiteX8" fmla="*/ 36142 w 903557"/>
                <a:gd name="connsiteY8" fmla="*/ 343351 h 531291"/>
                <a:gd name="connsiteX9" fmla="*/ 32528 w 903557"/>
                <a:gd name="connsiteY9" fmla="*/ 318052 h 531291"/>
                <a:gd name="connsiteX10" fmla="*/ 28914 w 903557"/>
                <a:gd name="connsiteY10" fmla="*/ 307209 h 531291"/>
                <a:gd name="connsiteX11" fmla="*/ 18071 w 903557"/>
                <a:gd name="connsiteY11" fmla="*/ 299981 h 531291"/>
                <a:gd name="connsiteX12" fmla="*/ 10842 w 903557"/>
                <a:gd name="connsiteY12" fmla="*/ 292752 h 531291"/>
                <a:gd name="connsiteX13" fmla="*/ 3614 w 903557"/>
                <a:gd name="connsiteY13" fmla="*/ 271067 h 531291"/>
                <a:gd name="connsiteX14" fmla="*/ 0 w 903557"/>
                <a:gd name="connsiteY14" fmla="*/ 260224 h 531291"/>
                <a:gd name="connsiteX15" fmla="*/ 3614 w 903557"/>
                <a:gd name="connsiteY15" fmla="*/ 245767 h 531291"/>
                <a:gd name="connsiteX16" fmla="*/ 10842 w 903557"/>
                <a:gd name="connsiteY16" fmla="*/ 206011 h 531291"/>
                <a:gd name="connsiteX17" fmla="*/ 18071 w 903557"/>
                <a:gd name="connsiteY17" fmla="*/ 184325 h 531291"/>
                <a:gd name="connsiteX18" fmla="*/ 43371 w 903557"/>
                <a:gd name="connsiteY18" fmla="*/ 155411 h 531291"/>
                <a:gd name="connsiteX19" fmla="*/ 54213 w 903557"/>
                <a:gd name="connsiteY19" fmla="*/ 148183 h 531291"/>
                <a:gd name="connsiteX20" fmla="*/ 75899 w 903557"/>
                <a:gd name="connsiteY20" fmla="*/ 140954 h 531291"/>
                <a:gd name="connsiteX21" fmla="*/ 97584 w 903557"/>
                <a:gd name="connsiteY21" fmla="*/ 130112 h 531291"/>
                <a:gd name="connsiteX22" fmla="*/ 119269 w 903557"/>
                <a:gd name="connsiteY22" fmla="*/ 108426 h 531291"/>
                <a:gd name="connsiteX23" fmla="*/ 126498 w 903557"/>
                <a:gd name="connsiteY23" fmla="*/ 101198 h 531291"/>
                <a:gd name="connsiteX24" fmla="*/ 133726 w 903557"/>
                <a:gd name="connsiteY24" fmla="*/ 93969 h 531291"/>
                <a:gd name="connsiteX25" fmla="*/ 140955 w 903557"/>
                <a:gd name="connsiteY25" fmla="*/ 72284 h 531291"/>
                <a:gd name="connsiteX26" fmla="*/ 148183 w 903557"/>
                <a:gd name="connsiteY26" fmla="*/ 61441 h 531291"/>
                <a:gd name="connsiteX27" fmla="*/ 159026 w 903557"/>
                <a:gd name="connsiteY27" fmla="*/ 43370 h 531291"/>
                <a:gd name="connsiteX28" fmla="*/ 166254 w 903557"/>
                <a:gd name="connsiteY28" fmla="*/ 28913 h 531291"/>
                <a:gd name="connsiteX29" fmla="*/ 180711 w 903557"/>
                <a:gd name="connsiteY29" fmla="*/ 14456 h 531291"/>
                <a:gd name="connsiteX30" fmla="*/ 198782 w 903557"/>
                <a:gd name="connsiteY30" fmla="*/ 0 h 531291"/>
                <a:gd name="connsiteX31" fmla="*/ 209625 w 903557"/>
                <a:gd name="connsiteY31" fmla="*/ 3614 h 531291"/>
                <a:gd name="connsiteX32" fmla="*/ 227696 w 903557"/>
                <a:gd name="connsiteY32" fmla="*/ 14456 h 531291"/>
                <a:gd name="connsiteX33" fmla="*/ 234925 w 903557"/>
                <a:gd name="connsiteY33" fmla="*/ 21685 h 531291"/>
                <a:gd name="connsiteX34" fmla="*/ 245767 w 903557"/>
                <a:gd name="connsiteY34" fmla="*/ 28913 h 531291"/>
                <a:gd name="connsiteX35" fmla="*/ 249382 w 903557"/>
                <a:gd name="connsiteY35" fmla="*/ 39756 h 531291"/>
                <a:gd name="connsiteX36" fmla="*/ 256610 w 903557"/>
                <a:gd name="connsiteY36" fmla="*/ 46985 h 531291"/>
                <a:gd name="connsiteX37" fmla="*/ 260224 w 903557"/>
                <a:gd name="connsiteY37" fmla="*/ 57827 h 531291"/>
                <a:gd name="connsiteX38" fmla="*/ 267453 w 903557"/>
                <a:gd name="connsiteY38" fmla="*/ 68670 h 531291"/>
                <a:gd name="connsiteX39" fmla="*/ 289138 w 903557"/>
                <a:gd name="connsiteY39" fmla="*/ 79513 h 531291"/>
                <a:gd name="connsiteX40" fmla="*/ 375880 w 903557"/>
                <a:gd name="connsiteY40" fmla="*/ 72284 h 531291"/>
                <a:gd name="connsiteX41" fmla="*/ 408408 w 903557"/>
                <a:gd name="connsiteY41" fmla="*/ 61441 h 531291"/>
                <a:gd name="connsiteX42" fmla="*/ 419250 w 903557"/>
                <a:gd name="connsiteY42" fmla="*/ 57827 h 531291"/>
                <a:gd name="connsiteX43" fmla="*/ 578276 w 903557"/>
                <a:gd name="connsiteY43" fmla="*/ 61441 h 531291"/>
                <a:gd name="connsiteX44" fmla="*/ 589119 w 903557"/>
                <a:gd name="connsiteY44" fmla="*/ 65056 h 531291"/>
                <a:gd name="connsiteX45" fmla="*/ 614419 w 903557"/>
                <a:gd name="connsiteY45" fmla="*/ 57827 h 531291"/>
                <a:gd name="connsiteX46" fmla="*/ 625261 w 903557"/>
                <a:gd name="connsiteY46" fmla="*/ 50599 h 531291"/>
                <a:gd name="connsiteX47" fmla="*/ 636104 w 903557"/>
                <a:gd name="connsiteY47" fmla="*/ 46985 h 531291"/>
                <a:gd name="connsiteX48" fmla="*/ 650561 w 903557"/>
                <a:gd name="connsiteY48" fmla="*/ 28913 h 531291"/>
                <a:gd name="connsiteX49" fmla="*/ 665018 w 903557"/>
                <a:gd name="connsiteY49" fmla="*/ 14456 h 531291"/>
                <a:gd name="connsiteX50" fmla="*/ 675861 w 903557"/>
                <a:gd name="connsiteY50" fmla="*/ 7228 h 531291"/>
                <a:gd name="connsiteX51" fmla="*/ 697546 w 903557"/>
                <a:gd name="connsiteY51" fmla="*/ 0 h 531291"/>
                <a:gd name="connsiteX52" fmla="*/ 719231 w 903557"/>
                <a:gd name="connsiteY52" fmla="*/ 7228 h 531291"/>
                <a:gd name="connsiteX53" fmla="*/ 733688 w 903557"/>
                <a:gd name="connsiteY53" fmla="*/ 21685 h 531291"/>
                <a:gd name="connsiteX54" fmla="*/ 740917 w 903557"/>
                <a:gd name="connsiteY54" fmla="*/ 43370 h 531291"/>
                <a:gd name="connsiteX55" fmla="*/ 744531 w 903557"/>
                <a:gd name="connsiteY55" fmla="*/ 97584 h 531291"/>
                <a:gd name="connsiteX56" fmla="*/ 762602 w 903557"/>
                <a:gd name="connsiteY56" fmla="*/ 104812 h 531291"/>
                <a:gd name="connsiteX57" fmla="*/ 798744 w 903557"/>
                <a:gd name="connsiteY57" fmla="*/ 112041 h 531291"/>
                <a:gd name="connsiteX58" fmla="*/ 816816 w 903557"/>
                <a:gd name="connsiteY58" fmla="*/ 115655 h 531291"/>
                <a:gd name="connsiteX59" fmla="*/ 827658 w 903557"/>
                <a:gd name="connsiteY59" fmla="*/ 119269 h 531291"/>
                <a:gd name="connsiteX60" fmla="*/ 842115 w 903557"/>
                <a:gd name="connsiteY60" fmla="*/ 137340 h 531291"/>
                <a:gd name="connsiteX61" fmla="*/ 860186 w 903557"/>
                <a:gd name="connsiteY61" fmla="*/ 151797 h 531291"/>
                <a:gd name="connsiteX62" fmla="*/ 881872 w 903557"/>
                <a:gd name="connsiteY62" fmla="*/ 180711 h 531291"/>
                <a:gd name="connsiteX63" fmla="*/ 885486 w 903557"/>
                <a:gd name="connsiteY63" fmla="*/ 231310 h 531291"/>
                <a:gd name="connsiteX64" fmla="*/ 881872 w 903557"/>
                <a:gd name="connsiteY64" fmla="*/ 242153 h 531291"/>
                <a:gd name="connsiteX65" fmla="*/ 874643 w 903557"/>
                <a:gd name="connsiteY65" fmla="*/ 249381 h 531291"/>
                <a:gd name="connsiteX66" fmla="*/ 852958 w 903557"/>
                <a:gd name="connsiteY66" fmla="*/ 256610 h 531291"/>
                <a:gd name="connsiteX67" fmla="*/ 852958 w 903557"/>
                <a:gd name="connsiteY67" fmla="*/ 307209 h 531291"/>
                <a:gd name="connsiteX68" fmla="*/ 860186 w 903557"/>
                <a:gd name="connsiteY68" fmla="*/ 318052 h 531291"/>
                <a:gd name="connsiteX69" fmla="*/ 867415 w 903557"/>
                <a:gd name="connsiteY69" fmla="*/ 339737 h 531291"/>
                <a:gd name="connsiteX70" fmla="*/ 878257 w 903557"/>
                <a:gd name="connsiteY70" fmla="*/ 361422 h 531291"/>
                <a:gd name="connsiteX71" fmla="*/ 885486 w 903557"/>
                <a:gd name="connsiteY71" fmla="*/ 372265 h 531291"/>
                <a:gd name="connsiteX72" fmla="*/ 896329 w 903557"/>
                <a:gd name="connsiteY72" fmla="*/ 390336 h 531291"/>
                <a:gd name="connsiteX73" fmla="*/ 903557 w 903557"/>
                <a:gd name="connsiteY73" fmla="*/ 415636 h 531291"/>
                <a:gd name="connsiteX74" fmla="*/ 899943 w 903557"/>
                <a:gd name="connsiteY74" fmla="*/ 430093 h 531291"/>
                <a:gd name="connsiteX75" fmla="*/ 896329 w 903557"/>
                <a:gd name="connsiteY75" fmla="*/ 440935 h 531291"/>
                <a:gd name="connsiteX76" fmla="*/ 889100 w 903557"/>
                <a:gd name="connsiteY76" fmla="*/ 484306 h 531291"/>
                <a:gd name="connsiteX77" fmla="*/ 881872 w 903557"/>
                <a:gd name="connsiteY77" fmla="*/ 505992 h 531291"/>
                <a:gd name="connsiteX78" fmla="*/ 860186 w 903557"/>
                <a:gd name="connsiteY78" fmla="*/ 516834 h 531291"/>
                <a:gd name="connsiteX79" fmla="*/ 827658 w 903557"/>
                <a:gd name="connsiteY79" fmla="*/ 513220 h 531291"/>
                <a:gd name="connsiteX80" fmla="*/ 816816 w 903557"/>
                <a:gd name="connsiteY80" fmla="*/ 505992 h 531291"/>
                <a:gd name="connsiteX81" fmla="*/ 802359 w 903557"/>
                <a:gd name="connsiteY81" fmla="*/ 487920 h 531291"/>
                <a:gd name="connsiteX82" fmla="*/ 798744 w 903557"/>
                <a:gd name="connsiteY82" fmla="*/ 477078 h 531291"/>
                <a:gd name="connsiteX83" fmla="*/ 791516 w 903557"/>
                <a:gd name="connsiteY83" fmla="*/ 469849 h 531291"/>
                <a:gd name="connsiteX84" fmla="*/ 769831 w 903557"/>
                <a:gd name="connsiteY84" fmla="*/ 440935 h 531291"/>
                <a:gd name="connsiteX85" fmla="*/ 762602 w 903557"/>
                <a:gd name="connsiteY85" fmla="*/ 433707 h 531291"/>
                <a:gd name="connsiteX86" fmla="*/ 740917 w 903557"/>
                <a:gd name="connsiteY86" fmla="*/ 451778 h 531291"/>
                <a:gd name="connsiteX87" fmla="*/ 719231 w 903557"/>
                <a:gd name="connsiteY87" fmla="*/ 466235 h 531291"/>
                <a:gd name="connsiteX88" fmla="*/ 697546 w 903557"/>
                <a:gd name="connsiteY88" fmla="*/ 473464 h 531291"/>
                <a:gd name="connsiteX89" fmla="*/ 686703 w 903557"/>
                <a:gd name="connsiteY89" fmla="*/ 477078 h 531291"/>
                <a:gd name="connsiteX90" fmla="*/ 672246 w 903557"/>
                <a:gd name="connsiteY90" fmla="*/ 459007 h 531291"/>
                <a:gd name="connsiteX91" fmla="*/ 668632 w 903557"/>
                <a:gd name="connsiteY91" fmla="*/ 448164 h 531291"/>
                <a:gd name="connsiteX92" fmla="*/ 657790 w 903557"/>
                <a:gd name="connsiteY92" fmla="*/ 422864 h 531291"/>
                <a:gd name="connsiteX93" fmla="*/ 665018 w 903557"/>
                <a:gd name="connsiteY93" fmla="*/ 386722 h 531291"/>
                <a:gd name="connsiteX94" fmla="*/ 672246 w 903557"/>
                <a:gd name="connsiteY94" fmla="*/ 365037 h 531291"/>
                <a:gd name="connsiteX95" fmla="*/ 675861 w 903557"/>
                <a:gd name="connsiteY95" fmla="*/ 354194 h 531291"/>
                <a:gd name="connsiteX96" fmla="*/ 672246 w 903557"/>
                <a:gd name="connsiteY96" fmla="*/ 343351 h 531291"/>
                <a:gd name="connsiteX97" fmla="*/ 650561 w 903557"/>
                <a:gd name="connsiteY97" fmla="*/ 350580 h 531291"/>
                <a:gd name="connsiteX98" fmla="*/ 639718 w 903557"/>
                <a:gd name="connsiteY98" fmla="*/ 354194 h 531291"/>
                <a:gd name="connsiteX99" fmla="*/ 603576 w 903557"/>
                <a:gd name="connsiteY99" fmla="*/ 350580 h 531291"/>
                <a:gd name="connsiteX100" fmla="*/ 589119 w 903557"/>
                <a:gd name="connsiteY100" fmla="*/ 336123 h 531291"/>
                <a:gd name="connsiteX101" fmla="*/ 581891 w 903557"/>
                <a:gd name="connsiteY101" fmla="*/ 299981 h 531291"/>
                <a:gd name="connsiteX102" fmla="*/ 578276 w 903557"/>
                <a:gd name="connsiteY102" fmla="*/ 281909 h 531291"/>
                <a:gd name="connsiteX103" fmla="*/ 571048 w 903557"/>
                <a:gd name="connsiteY103" fmla="*/ 224082 h 531291"/>
                <a:gd name="connsiteX104" fmla="*/ 549363 w 903557"/>
                <a:gd name="connsiteY104" fmla="*/ 198782 h 531291"/>
                <a:gd name="connsiteX105" fmla="*/ 538520 w 903557"/>
                <a:gd name="connsiteY105" fmla="*/ 195168 h 531291"/>
                <a:gd name="connsiteX106" fmla="*/ 509606 w 903557"/>
                <a:gd name="connsiteY106" fmla="*/ 187939 h 531291"/>
                <a:gd name="connsiteX107" fmla="*/ 469850 w 903557"/>
                <a:gd name="connsiteY107" fmla="*/ 180711 h 531291"/>
                <a:gd name="connsiteX108" fmla="*/ 437322 w 903557"/>
                <a:gd name="connsiteY108" fmla="*/ 184325 h 531291"/>
                <a:gd name="connsiteX109" fmla="*/ 422865 w 903557"/>
                <a:gd name="connsiteY109" fmla="*/ 191554 h 531291"/>
                <a:gd name="connsiteX110" fmla="*/ 408408 w 903557"/>
                <a:gd name="connsiteY110" fmla="*/ 195168 h 531291"/>
                <a:gd name="connsiteX111" fmla="*/ 386722 w 903557"/>
                <a:gd name="connsiteY111" fmla="*/ 202396 h 531291"/>
                <a:gd name="connsiteX112" fmla="*/ 372265 w 903557"/>
                <a:gd name="connsiteY112" fmla="*/ 220468 h 531291"/>
                <a:gd name="connsiteX113" fmla="*/ 361423 w 903557"/>
                <a:gd name="connsiteY113" fmla="*/ 238539 h 531291"/>
                <a:gd name="connsiteX114" fmla="*/ 357808 w 903557"/>
                <a:gd name="connsiteY114" fmla="*/ 249381 h 531291"/>
                <a:gd name="connsiteX115" fmla="*/ 350580 w 903557"/>
                <a:gd name="connsiteY115" fmla="*/ 256610 h 531291"/>
                <a:gd name="connsiteX116" fmla="*/ 343352 w 903557"/>
                <a:gd name="connsiteY116" fmla="*/ 278295 h 531291"/>
                <a:gd name="connsiteX117" fmla="*/ 336123 w 903557"/>
                <a:gd name="connsiteY117" fmla="*/ 299981 h 531291"/>
                <a:gd name="connsiteX118" fmla="*/ 332509 w 903557"/>
                <a:gd name="connsiteY118" fmla="*/ 310823 h 531291"/>
                <a:gd name="connsiteX119" fmla="*/ 321666 w 903557"/>
                <a:gd name="connsiteY119" fmla="*/ 339737 h 531291"/>
                <a:gd name="connsiteX120" fmla="*/ 303595 w 903557"/>
                <a:gd name="connsiteY120" fmla="*/ 350580 h 531291"/>
                <a:gd name="connsiteX121" fmla="*/ 281910 w 903557"/>
                <a:gd name="connsiteY121" fmla="*/ 361422 h 531291"/>
                <a:gd name="connsiteX122" fmla="*/ 274681 w 903557"/>
                <a:gd name="connsiteY122" fmla="*/ 383108 h 531291"/>
                <a:gd name="connsiteX123" fmla="*/ 271067 w 903557"/>
                <a:gd name="connsiteY123" fmla="*/ 397565 h 531291"/>
                <a:gd name="connsiteX124" fmla="*/ 256610 w 903557"/>
                <a:gd name="connsiteY124" fmla="*/ 419250 h 531291"/>
                <a:gd name="connsiteX125" fmla="*/ 242153 w 903557"/>
                <a:gd name="connsiteY125" fmla="*/ 437321 h 531291"/>
                <a:gd name="connsiteX126" fmla="*/ 216854 w 903557"/>
                <a:gd name="connsiteY126" fmla="*/ 455392 h 531291"/>
                <a:gd name="connsiteX127" fmla="*/ 209625 w 903557"/>
                <a:gd name="connsiteY127" fmla="*/ 462621 h 531291"/>
                <a:gd name="connsiteX128" fmla="*/ 202397 w 903557"/>
                <a:gd name="connsiteY128" fmla="*/ 473464 h 531291"/>
                <a:gd name="connsiteX129" fmla="*/ 191554 w 903557"/>
                <a:gd name="connsiteY129" fmla="*/ 480692 h 531291"/>
                <a:gd name="connsiteX130" fmla="*/ 166254 w 903557"/>
                <a:gd name="connsiteY130" fmla="*/ 498763 h 531291"/>
                <a:gd name="connsiteX131" fmla="*/ 151797 w 903557"/>
                <a:gd name="connsiteY131" fmla="*/ 502377 h 531291"/>
                <a:gd name="connsiteX132" fmla="*/ 93970 w 903557"/>
                <a:gd name="connsiteY132" fmla="*/ 505992 h 531291"/>
                <a:gd name="connsiteX133" fmla="*/ 75899 w 903557"/>
                <a:gd name="connsiteY133" fmla="*/ 509606 h 531291"/>
                <a:gd name="connsiteX134" fmla="*/ 54213 w 903557"/>
                <a:gd name="connsiteY134" fmla="*/ 516834 h 531291"/>
                <a:gd name="connsiteX135" fmla="*/ 18071 w 903557"/>
                <a:gd name="connsiteY135" fmla="*/ 531291 h 53129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</a:cxnLst>
              <a:rect l="l" t="t" r="r" b="b"/>
              <a:pathLst>
                <a:path w="903557" h="531291">
                  <a:moveTo>
                    <a:pt x="18071" y="531291"/>
                  </a:moveTo>
                  <a:lnTo>
                    <a:pt x="18071" y="531291"/>
                  </a:lnTo>
                  <a:cubicBezTo>
                    <a:pt x="10913" y="516975"/>
                    <a:pt x="0" y="501489"/>
                    <a:pt x="0" y="484306"/>
                  </a:cubicBezTo>
                  <a:cubicBezTo>
                    <a:pt x="0" y="479339"/>
                    <a:pt x="2640" y="474720"/>
                    <a:pt x="3614" y="469849"/>
                  </a:cubicBezTo>
                  <a:cubicBezTo>
                    <a:pt x="5051" y="462663"/>
                    <a:pt x="6192" y="455418"/>
                    <a:pt x="7228" y="448164"/>
                  </a:cubicBezTo>
                  <a:cubicBezTo>
                    <a:pt x="12927" y="408266"/>
                    <a:pt x="6876" y="431150"/>
                    <a:pt x="18071" y="397565"/>
                  </a:cubicBezTo>
                  <a:lnTo>
                    <a:pt x="28914" y="365037"/>
                  </a:lnTo>
                  <a:lnTo>
                    <a:pt x="32528" y="354194"/>
                  </a:lnTo>
                  <a:lnTo>
                    <a:pt x="36142" y="343351"/>
                  </a:lnTo>
                  <a:cubicBezTo>
                    <a:pt x="34937" y="334918"/>
                    <a:pt x="34199" y="326405"/>
                    <a:pt x="32528" y="318052"/>
                  </a:cubicBezTo>
                  <a:cubicBezTo>
                    <a:pt x="31781" y="314316"/>
                    <a:pt x="31294" y="310184"/>
                    <a:pt x="28914" y="307209"/>
                  </a:cubicBezTo>
                  <a:cubicBezTo>
                    <a:pt x="26200" y="303817"/>
                    <a:pt x="21463" y="302694"/>
                    <a:pt x="18071" y="299981"/>
                  </a:cubicBezTo>
                  <a:cubicBezTo>
                    <a:pt x="15410" y="297852"/>
                    <a:pt x="13252" y="295162"/>
                    <a:pt x="10842" y="292752"/>
                  </a:cubicBezTo>
                  <a:lnTo>
                    <a:pt x="3614" y="271067"/>
                  </a:lnTo>
                  <a:lnTo>
                    <a:pt x="0" y="260224"/>
                  </a:lnTo>
                  <a:cubicBezTo>
                    <a:pt x="1205" y="255405"/>
                    <a:pt x="2640" y="250638"/>
                    <a:pt x="3614" y="245767"/>
                  </a:cubicBezTo>
                  <a:cubicBezTo>
                    <a:pt x="5679" y="235440"/>
                    <a:pt x="7936" y="216667"/>
                    <a:pt x="10842" y="206011"/>
                  </a:cubicBezTo>
                  <a:cubicBezTo>
                    <a:pt x="12847" y="198660"/>
                    <a:pt x="13844" y="190665"/>
                    <a:pt x="18071" y="184325"/>
                  </a:cubicBezTo>
                  <a:cubicBezTo>
                    <a:pt x="25713" y="172862"/>
                    <a:pt x="30685" y="163868"/>
                    <a:pt x="43371" y="155411"/>
                  </a:cubicBezTo>
                  <a:cubicBezTo>
                    <a:pt x="46985" y="153002"/>
                    <a:pt x="50244" y="149947"/>
                    <a:pt x="54213" y="148183"/>
                  </a:cubicBezTo>
                  <a:cubicBezTo>
                    <a:pt x="61176" y="145088"/>
                    <a:pt x="69559" y="145181"/>
                    <a:pt x="75899" y="140954"/>
                  </a:cubicBezTo>
                  <a:cubicBezTo>
                    <a:pt x="89911" y="131613"/>
                    <a:pt x="82620" y="135099"/>
                    <a:pt x="97584" y="130112"/>
                  </a:cubicBezTo>
                  <a:lnTo>
                    <a:pt x="119269" y="108426"/>
                  </a:lnTo>
                  <a:lnTo>
                    <a:pt x="126498" y="101198"/>
                  </a:lnTo>
                  <a:lnTo>
                    <a:pt x="133726" y="93969"/>
                  </a:lnTo>
                  <a:cubicBezTo>
                    <a:pt x="136136" y="86741"/>
                    <a:pt x="136729" y="78624"/>
                    <a:pt x="140955" y="72284"/>
                  </a:cubicBezTo>
                  <a:cubicBezTo>
                    <a:pt x="143364" y="68670"/>
                    <a:pt x="146240" y="65326"/>
                    <a:pt x="148183" y="61441"/>
                  </a:cubicBezTo>
                  <a:cubicBezTo>
                    <a:pt x="157565" y="42675"/>
                    <a:pt x="144907" y="57489"/>
                    <a:pt x="159026" y="43370"/>
                  </a:cubicBezTo>
                  <a:cubicBezTo>
                    <a:pt x="161435" y="38551"/>
                    <a:pt x="163021" y="33223"/>
                    <a:pt x="166254" y="28913"/>
                  </a:cubicBezTo>
                  <a:cubicBezTo>
                    <a:pt x="170343" y="23461"/>
                    <a:pt x="175892" y="19275"/>
                    <a:pt x="180711" y="14456"/>
                  </a:cubicBezTo>
                  <a:cubicBezTo>
                    <a:pt x="191009" y="4159"/>
                    <a:pt x="185108" y="9116"/>
                    <a:pt x="198782" y="0"/>
                  </a:cubicBezTo>
                  <a:cubicBezTo>
                    <a:pt x="202396" y="1205"/>
                    <a:pt x="206358" y="1654"/>
                    <a:pt x="209625" y="3614"/>
                  </a:cubicBezTo>
                  <a:cubicBezTo>
                    <a:pt x="234433" y="18497"/>
                    <a:pt x="196980" y="4217"/>
                    <a:pt x="227696" y="14456"/>
                  </a:cubicBezTo>
                  <a:cubicBezTo>
                    <a:pt x="230106" y="16866"/>
                    <a:pt x="232264" y="19556"/>
                    <a:pt x="234925" y="21685"/>
                  </a:cubicBezTo>
                  <a:cubicBezTo>
                    <a:pt x="238317" y="24398"/>
                    <a:pt x="243054" y="25521"/>
                    <a:pt x="245767" y="28913"/>
                  </a:cubicBezTo>
                  <a:cubicBezTo>
                    <a:pt x="248147" y="31888"/>
                    <a:pt x="247422" y="36489"/>
                    <a:pt x="249382" y="39756"/>
                  </a:cubicBezTo>
                  <a:cubicBezTo>
                    <a:pt x="251135" y="42678"/>
                    <a:pt x="254201" y="44575"/>
                    <a:pt x="256610" y="46985"/>
                  </a:cubicBezTo>
                  <a:cubicBezTo>
                    <a:pt x="257815" y="50599"/>
                    <a:pt x="258520" y="54420"/>
                    <a:pt x="260224" y="57827"/>
                  </a:cubicBezTo>
                  <a:cubicBezTo>
                    <a:pt x="262167" y="61712"/>
                    <a:pt x="264381" y="65598"/>
                    <a:pt x="267453" y="68670"/>
                  </a:cubicBezTo>
                  <a:cubicBezTo>
                    <a:pt x="274458" y="75675"/>
                    <a:pt x="280320" y="76573"/>
                    <a:pt x="289138" y="79513"/>
                  </a:cubicBezTo>
                  <a:cubicBezTo>
                    <a:pt x="313941" y="78207"/>
                    <a:pt x="348732" y="79687"/>
                    <a:pt x="375880" y="72284"/>
                  </a:cubicBezTo>
                  <a:cubicBezTo>
                    <a:pt x="375918" y="72274"/>
                    <a:pt x="402969" y="63254"/>
                    <a:pt x="408408" y="61441"/>
                  </a:cubicBezTo>
                  <a:lnTo>
                    <a:pt x="419250" y="57827"/>
                  </a:lnTo>
                  <a:lnTo>
                    <a:pt x="578276" y="61441"/>
                  </a:lnTo>
                  <a:cubicBezTo>
                    <a:pt x="582082" y="61603"/>
                    <a:pt x="585309" y="65056"/>
                    <a:pt x="589119" y="65056"/>
                  </a:cubicBezTo>
                  <a:cubicBezTo>
                    <a:pt x="593653" y="65056"/>
                    <a:pt x="609309" y="59530"/>
                    <a:pt x="614419" y="57827"/>
                  </a:cubicBezTo>
                  <a:cubicBezTo>
                    <a:pt x="618033" y="55418"/>
                    <a:pt x="621376" y="52541"/>
                    <a:pt x="625261" y="50599"/>
                  </a:cubicBezTo>
                  <a:cubicBezTo>
                    <a:pt x="628669" y="48895"/>
                    <a:pt x="632837" y="48945"/>
                    <a:pt x="636104" y="46985"/>
                  </a:cubicBezTo>
                  <a:cubicBezTo>
                    <a:pt x="643343" y="42642"/>
                    <a:pt x="645345" y="34998"/>
                    <a:pt x="650561" y="28913"/>
                  </a:cubicBezTo>
                  <a:cubicBezTo>
                    <a:pt x="654996" y="23739"/>
                    <a:pt x="659347" y="18236"/>
                    <a:pt x="665018" y="14456"/>
                  </a:cubicBezTo>
                  <a:cubicBezTo>
                    <a:pt x="668632" y="12047"/>
                    <a:pt x="671892" y="8992"/>
                    <a:pt x="675861" y="7228"/>
                  </a:cubicBezTo>
                  <a:cubicBezTo>
                    <a:pt x="682824" y="4134"/>
                    <a:pt x="697546" y="0"/>
                    <a:pt x="697546" y="0"/>
                  </a:cubicBezTo>
                  <a:cubicBezTo>
                    <a:pt x="704774" y="2409"/>
                    <a:pt x="713843" y="1840"/>
                    <a:pt x="719231" y="7228"/>
                  </a:cubicBezTo>
                  <a:lnTo>
                    <a:pt x="733688" y="21685"/>
                  </a:lnTo>
                  <a:cubicBezTo>
                    <a:pt x="736098" y="28913"/>
                    <a:pt x="740410" y="35767"/>
                    <a:pt x="740917" y="43370"/>
                  </a:cubicBezTo>
                  <a:cubicBezTo>
                    <a:pt x="742122" y="61441"/>
                    <a:pt x="738503" y="80505"/>
                    <a:pt x="744531" y="97584"/>
                  </a:cubicBezTo>
                  <a:cubicBezTo>
                    <a:pt x="746690" y="103702"/>
                    <a:pt x="756333" y="103140"/>
                    <a:pt x="762602" y="104812"/>
                  </a:cubicBezTo>
                  <a:cubicBezTo>
                    <a:pt x="774473" y="107978"/>
                    <a:pt x="786697" y="109631"/>
                    <a:pt x="798744" y="112041"/>
                  </a:cubicBezTo>
                  <a:cubicBezTo>
                    <a:pt x="804768" y="113246"/>
                    <a:pt x="810988" y="113712"/>
                    <a:pt x="816816" y="115655"/>
                  </a:cubicBezTo>
                  <a:lnTo>
                    <a:pt x="827658" y="119269"/>
                  </a:lnTo>
                  <a:cubicBezTo>
                    <a:pt x="845113" y="136724"/>
                    <a:pt x="823877" y="114543"/>
                    <a:pt x="842115" y="137340"/>
                  </a:cubicBezTo>
                  <a:cubicBezTo>
                    <a:pt x="848001" y="144697"/>
                    <a:pt x="852135" y="146430"/>
                    <a:pt x="860186" y="151797"/>
                  </a:cubicBezTo>
                  <a:cubicBezTo>
                    <a:pt x="876533" y="176318"/>
                    <a:pt x="868499" y="167340"/>
                    <a:pt x="881872" y="180711"/>
                  </a:cubicBezTo>
                  <a:cubicBezTo>
                    <a:pt x="891120" y="208455"/>
                    <a:pt x="891386" y="198858"/>
                    <a:pt x="885486" y="231310"/>
                  </a:cubicBezTo>
                  <a:cubicBezTo>
                    <a:pt x="884805" y="235058"/>
                    <a:pt x="883832" y="238886"/>
                    <a:pt x="881872" y="242153"/>
                  </a:cubicBezTo>
                  <a:cubicBezTo>
                    <a:pt x="880119" y="245075"/>
                    <a:pt x="877691" y="247857"/>
                    <a:pt x="874643" y="249381"/>
                  </a:cubicBezTo>
                  <a:cubicBezTo>
                    <a:pt x="867828" y="252789"/>
                    <a:pt x="852958" y="256610"/>
                    <a:pt x="852958" y="256610"/>
                  </a:cubicBezTo>
                  <a:cubicBezTo>
                    <a:pt x="846072" y="277267"/>
                    <a:pt x="845729" y="273470"/>
                    <a:pt x="852958" y="307209"/>
                  </a:cubicBezTo>
                  <a:cubicBezTo>
                    <a:pt x="853868" y="311456"/>
                    <a:pt x="858422" y="314083"/>
                    <a:pt x="860186" y="318052"/>
                  </a:cubicBezTo>
                  <a:cubicBezTo>
                    <a:pt x="863281" y="325015"/>
                    <a:pt x="863189" y="333397"/>
                    <a:pt x="867415" y="339737"/>
                  </a:cubicBezTo>
                  <a:cubicBezTo>
                    <a:pt x="888137" y="370822"/>
                    <a:pt x="863289" y="331487"/>
                    <a:pt x="878257" y="361422"/>
                  </a:cubicBezTo>
                  <a:cubicBezTo>
                    <a:pt x="880200" y="365307"/>
                    <a:pt x="883076" y="368651"/>
                    <a:pt x="885486" y="372265"/>
                  </a:cubicBezTo>
                  <a:cubicBezTo>
                    <a:pt x="895724" y="402982"/>
                    <a:pt x="881445" y="365530"/>
                    <a:pt x="896329" y="390336"/>
                  </a:cubicBezTo>
                  <a:cubicBezTo>
                    <a:pt x="898551" y="394039"/>
                    <a:pt x="902882" y="412937"/>
                    <a:pt x="903557" y="415636"/>
                  </a:cubicBezTo>
                  <a:cubicBezTo>
                    <a:pt x="902352" y="420455"/>
                    <a:pt x="901308" y="425317"/>
                    <a:pt x="899943" y="430093"/>
                  </a:cubicBezTo>
                  <a:cubicBezTo>
                    <a:pt x="898896" y="433756"/>
                    <a:pt x="897076" y="437199"/>
                    <a:pt x="896329" y="440935"/>
                  </a:cubicBezTo>
                  <a:cubicBezTo>
                    <a:pt x="893455" y="455307"/>
                    <a:pt x="893734" y="470402"/>
                    <a:pt x="889100" y="484306"/>
                  </a:cubicBezTo>
                  <a:cubicBezTo>
                    <a:pt x="886691" y="491535"/>
                    <a:pt x="888212" y="501766"/>
                    <a:pt x="881872" y="505992"/>
                  </a:cubicBezTo>
                  <a:cubicBezTo>
                    <a:pt x="867859" y="515333"/>
                    <a:pt x="875150" y="511846"/>
                    <a:pt x="860186" y="516834"/>
                  </a:cubicBezTo>
                  <a:cubicBezTo>
                    <a:pt x="849343" y="515629"/>
                    <a:pt x="838242" y="515866"/>
                    <a:pt x="827658" y="513220"/>
                  </a:cubicBezTo>
                  <a:cubicBezTo>
                    <a:pt x="823444" y="512167"/>
                    <a:pt x="820208" y="508705"/>
                    <a:pt x="816816" y="505992"/>
                  </a:cubicBezTo>
                  <a:cubicBezTo>
                    <a:pt x="811212" y="501509"/>
                    <a:pt x="805491" y="494184"/>
                    <a:pt x="802359" y="487920"/>
                  </a:cubicBezTo>
                  <a:cubicBezTo>
                    <a:pt x="800655" y="484513"/>
                    <a:pt x="800704" y="480345"/>
                    <a:pt x="798744" y="477078"/>
                  </a:cubicBezTo>
                  <a:cubicBezTo>
                    <a:pt x="796991" y="474156"/>
                    <a:pt x="793925" y="472259"/>
                    <a:pt x="791516" y="469849"/>
                  </a:cubicBezTo>
                  <a:cubicBezTo>
                    <a:pt x="785208" y="450926"/>
                    <a:pt x="790595" y="461699"/>
                    <a:pt x="769831" y="440935"/>
                  </a:cubicBezTo>
                  <a:lnTo>
                    <a:pt x="762602" y="433707"/>
                  </a:lnTo>
                  <a:cubicBezTo>
                    <a:pt x="736843" y="459466"/>
                    <a:pt x="766077" y="431650"/>
                    <a:pt x="740917" y="451778"/>
                  </a:cubicBezTo>
                  <a:cubicBezTo>
                    <a:pt x="727126" y="462811"/>
                    <a:pt x="741087" y="457492"/>
                    <a:pt x="719231" y="466235"/>
                  </a:cubicBezTo>
                  <a:cubicBezTo>
                    <a:pt x="712157" y="469065"/>
                    <a:pt x="704774" y="471054"/>
                    <a:pt x="697546" y="473464"/>
                  </a:cubicBezTo>
                  <a:lnTo>
                    <a:pt x="686703" y="477078"/>
                  </a:lnTo>
                  <a:cubicBezTo>
                    <a:pt x="679982" y="470356"/>
                    <a:pt x="676804" y="468122"/>
                    <a:pt x="672246" y="459007"/>
                  </a:cubicBezTo>
                  <a:cubicBezTo>
                    <a:pt x="670542" y="455599"/>
                    <a:pt x="670133" y="451666"/>
                    <a:pt x="668632" y="448164"/>
                  </a:cubicBezTo>
                  <a:cubicBezTo>
                    <a:pt x="655234" y="416901"/>
                    <a:pt x="666266" y="448293"/>
                    <a:pt x="657790" y="422864"/>
                  </a:cubicBezTo>
                  <a:cubicBezTo>
                    <a:pt x="660232" y="408211"/>
                    <a:pt x="660975" y="400200"/>
                    <a:pt x="665018" y="386722"/>
                  </a:cubicBezTo>
                  <a:cubicBezTo>
                    <a:pt x="667207" y="379424"/>
                    <a:pt x="669837" y="372265"/>
                    <a:pt x="672246" y="365037"/>
                  </a:cubicBezTo>
                  <a:lnTo>
                    <a:pt x="675861" y="354194"/>
                  </a:lnTo>
                  <a:cubicBezTo>
                    <a:pt x="674656" y="350580"/>
                    <a:pt x="676018" y="343890"/>
                    <a:pt x="672246" y="343351"/>
                  </a:cubicBezTo>
                  <a:cubicBezTo>
                    <a:pt x="664703" y="342274"/>
                    <a:pt x="657789" y="348170"/>
                    <a:pt x="650561" y="350580"/>
                  </a:cubicBezTo>
                  <a:lnTo>
                    <a:pt x="639718" y="354194"/>
                  </a:lnTo>
                  <a:cubicBezTo>
                    <a:pt x="627671" y="352989"/>
                    <a:pt x="614978" y="354652"/>
                    <a:pt x="603576" y="350580"/>
                  </a:cubicBezTo>
                  <a:cubicBezTo>
                    <a:pt x="597158" y="348288"/>
                    <a:pt x="589119" y="336123"/>
                    <a:pt x="589119" y="336123"/>
                  </a:cubicBezTo>
                  <a:cubicBezTo>
                    <a:pt x="582192" y="315339"/>
                    <a:pt x="587429" y="333209"/>
                    <a:pt x="581891" y="299981"/>
                  </a:cubicBezTo>
                  <a:cubicBezTo>
                    <a:pt x="580881" y="293921"/>
                    <a:pt x="579145" y="287991"/>
                    <a:pt x="578276" y="281909"/>
                  </a:cubicBezTo>
                  <a:cubicBezTo>
                    <a:pt x="575529" y="262679"/>
                    <a:pt x="581823" y="240246"/>
                    <a:pt x="571048" y="224082"/>
                  </a:cubicBezTo>
                  <a:cubicBezTo>
                    <a:pt x="566423" y="217144"/>
                    <a:pt x="556876" y="201286"/>
                    <a:pt x="549363" y="198782"/>
                  </a:cubicBezTo>
                  <a:cubicBezTo>
                    <a:pt x="545749" y="197577"/>
                    <a:pt x="542196" y="196170"/>
                    <a:pt x="538520" y="195168"/>
                  </a:cubicBezTo>
                  <a:cubicBezTo>
                    <a:pt x="528935" y="192554"/>
                    <a:pt x="519348" y="189887"/>
                    <a:pt x="509606" y="187939"/>
                  </a:cubicBezTo>
                  <a:cubicBezTo>
                    <a:pt x="484349" y="182888"/>
                    <a:pt x="497594" y="185335"/>
                    <a:pt x="469850" y="180711"/>
                  </a:cubicBezTo>
                  <a:cubicBezTo>
                    <a:pt x="459007" y="181916"/>
                    <a:pt x="447952" y="181872"/>
                    <a:pt x="437322" y="184325"/>
                  </a:cubicBezTo>
                  <a:cubicBezTo>
                    <a:pt x="432072" y="185537"/>
                    <a:pt x="427910" y="189662"/>
                    <a:pt x="422865" y="191554"/>
                  </a:cubicBezTo>
                  <a:cubicBezTo>
                    <a:pt x="418214" y="193298"/>
                    <a:pt x="413166" y="193741"/>
                    <a:pt x="408408" y="195168"/>
                  </a:cubicBezTo>
                  <a:cubicBezTo>
                    <a:pt x="401110" y="197357"/>
                    <a:pt x="386722" y="202396"/>
                    <a:pt x="386722" y="202396"/>
                  </a:cubicBezTo>
                  <a:cubicBezTo>
                    <a:pt x="380000" y="209119"/>
                    <a:pt x="376824" y="211351"/>
                    <a:pt x="372265" y="220468"/>
                  </a:cubicBezTo>
                  <a:cubicBezTo>
                    <a:pt x="362880" y="239236"/>
                    <a:pt x="375542" y="224418"/>
                    <a:pt x="361423" y="238539"/>
                  </a:cubicBezTo>
                  <a:cubicBezTo>
                    <a:pt x="360218" y="242153"/>
                    <a:pt x="359768" y="246114"/>
                    <a:pt x="357808" y="249381"/>
                  </a:cubicBezTo>
                  <a:cubicBezTo>
                    <a:pt x="356055" y="252303"/>
                    <a:pt x="352104" y="253562"/>
                    <a:pt x="350580" y="256610"/>
                  </a:cubicBezTo>
                  <a:cubicBezTo>
                    <a:pt x="347173" y="263425"/>
                    <a:pt x="345761" y="271067"/>
                    <a:pt x="343352" y="278295"/>
                  </a:cubicBezTo>
                  <a:lnTo>
                    <a:pt x="336123" y="299981"/>
                  </a:lnTo>
                  <a:cubicBezTo>
                    <a:pt x="334918" y="303595"/>
                    <a:pt x="333256" y="307087"/>
                    <a:pt x="332509" y="310823"/>
                  </a:cubicBezTo>
                  <a:cubicBezTo>
                    <a:pt x="329045" y="328142"/>
                    <a:pt x="331594" y="327327"/>
                    <a:pt x="321666" y="339737"/>
                  </a:cubicBezTo>
                  <a:cubicBezTo>
                    <a:pt x="312253" y="351504"/>
                    <a:pt x="317102" y="343827"/>
                    <a:pt x="303595" y="350580"/>
                  </a:cubicBezTo>
                  <a:cubicBezTo>
                    <a:pt x="275567" y="364593"/>
                    <a:pt x="309164" y="352337"/>
                    <a:pt x="281910" y="361422"/>
                  </a:cubicBezTo>
                  <a:cubicBezTo>
                    <a:pt x="279500" y="368651"/>
                    <a:pt x="276529" y="375716"/>
                    <a:pt x="274681" y="383108"/>
                  </a:cubicBezTo>
                  <a:cubicBezTo>
                    <a:pt x="273476" y="387927"/>
                    <a:pt x="273288" y="393122"/>
                    <a:pt x="271067" y="397565"/>
                  </a:cubicBezTo>
                  <a:cubicBezTo>
                    <a:pt x="267182" y="405335"/>
                    <a:pt x="256610" y="419250"/>
                    <a:pt x="256610" y="419250"/>
                  </a:cubicBezTo>
                  <a:cubicBezTo>
                    <a:pt x="250530" y="437492"/>
                    <a:pt x="257412" y="424243"/>
                    <a:pt x="242153" y="437321"/>
                  </a:cubicBezTo>
                  <a:cubicBezTo>
                    <a:pt x="220324" y="456031"/>
                    <a:pt x="236777" y="448751"/>
                    <a:pt x="216854" y="455392"/>
                  </a:cubicBezTo>
                  <a:cubicBezTo>
                    <a:pt x="214444" y="457802"/>
                    <a:pt x="211754" y="459960"/>
                    <a:pt x="209625" y="462621"/>
                  </a:cubicBezTo>
                  <a:cubicBezTo>
                    <a:pt x="206912" y="466013"/>
                    <a:pt x="205469" y="470392"/>
                    <a:pt x="202397" y="473464"/>
                  </a:cubicBezTo>
                  <a:cubicBezTo>
                    <a:pt x="199325" y="476536"/>
                    <a:pt x="194852" y="477865"/>
                    <a:pt x="191554" y="480692"/>
                  </a:cubicBezTo>
                  <a:cubicBezTo>
                    <a:pt x="172694" y="496857"/>
                    <a:pt x="184518" y="493545"/>
                    <a:pt x="166254" y="498763"/>
                  </a:cubicBezTo>
                  <a:cubicBezTo>
                    <a:pt x="161478" y="500128"/>
                    <a:pt x="156740" y="501883"/>
                    <a:pt x="151797" y="502377"/>
                  </a:cubicBezTo>
                  <a:cubicBezTo>
                    <a:pt x="132580" y="504299"/>
                    <a:pt x="113246" y="504787"/>
                    <a:pt x="93970" y="505992"/>
                  </a:cubicBezTo>
                  <a:cubicBezTo>
                    <a:pt x="87946" y="507197"/>
                    <a:pt x="81826" y="507990"/>
                    <a:pt x="75899" y="509606"/>
                  </a:cubicBezTo>
                  <a:cubicBezTo>
                    <a:pt x="68548" y="511611"/>
                    <a:pt x="61795" y="516076"/>
                    <a:pt x="54213" y="516834"/>
                  </a:cubicBezTo>
                  <a:cubicBezTo>
                    <a:pt x="15673" y="520689"/>
                    <a:pt x="24095" y="528882"/>
                    <a:pt x="18071" y="531291"/>
                  </a:cubicBez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" name="円/楕円 25">
              <a:extLst>
                <a:ext uri="{FF2B5EF4-FFF2-40B4-BE49-F238E27FC236}">
                  <a16:creationId xmlns="" xmlns:a16="http://schemas.microsoft.com/office/drawing/2014/main" id="{E55AC3BE-9B14-E84A-9A22-0FD4906CB109}"/>
                </a:ext>
              </a:extLst>
            </p:cNvPr>
            <p:cNvSpPr/>
            <p:nvPr/>
          </p:nvSpPr>
          <p:spPr>
            <a:xfrm>
              <a:off x="2312025" y="2157475"/>
              <a:ext cx="128550" cy="130753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12" name="グラフィックス 11" descr="はさみ">
              <a:extLst>
                <a:ext uri="{FF2B5EF4-FFF2-40B4-BE49-F238E27FC236}">
                  <a16:creationId xmlns="" xmlns:a16="http://schemas.microsoft.com/office/drawing/2014/main" id="{63264CC9-2DF7-4246-8627-71D389F9BC8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96DAC541-7B7A-43D3-8B79-37D633B846F1}">
                  <asvg:svgBlip xmlns=""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 rot="16200000">
              <a:off x="1990191" y="1898365"/>
              <a:ext cx="438786" cy="438786"/>
            </a:xfrm>
            <a:prstGeom prst="rect">
              <a:avLst/>
            </a:prstGeom>
          </p:spPr>
        </p:pic>
      </p:grpSp>
      <p:grpSp>
        <p:nvGrpSpPr>
          <p:cNvPr id="61" name="グループ化 60">
            <a:extLst>
              <a:ext uri="{FF2B5EF4-FFF2-40B4-BE49-F238E27FC236}">
                <a16:creationId xmlns="" xmlns:a16="http://schemas.microsoft.com/office/drawing/2014/main" id="{1018C1C8-20B2-144A-AF13-FB80E1FA7674}"/>
              </a:ext>
            </a:extLst>
          </p:cNvPr>
          <p:cNvGrpSpPr/>
          <p:nvPr/>
        </p:nvGrpSpPr>
        <p:grpSpPr>
          <a:xfrm>
            <a:off x="1331095" y="5240257"/>
            <a:ext cx="306000" cy="686238"/>
            <a:chOff x="3528948" y="2384593"/>
            <a:chExt cx="306000" cy="686238"/>
          </a:xfrm>
        </p:grpSpPr>
        <p:sp>
          <p:nvSpPr>
            <p:cNvPr id="160" name="円柱 159">
              <a:extLst>
                <a:ext uri="{FF2B5EF4-FFF2-40B4-BE49-F238E27FC236}">
                  <a16:creationId xmlns="" xmlns:a16="http://schemas.microsoft.com/office/drawing/2014/main" id="{394BA80C-9EB2-AF4C-B14B-4D88A401CA06}"/>
                </a:ext>
              </a:extLst>
            </p:cNvPr>
            <p:cNvSpPr>
              <a:spLocks/>
            </p:cNvSpPr>
            <p:nvPr/>
          </p:nvSpPr>
          <p:spPr>
            <a:xfrm>
              <a:off x="3564949" y="2404765"/>
              <a:ext cx="234000" cy="61200"/>
            </a:xfrm>
            <a:prstGeom prst="can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7" name="グループ化 56">
              <a:extLst>
                <a:ext uri="{FF2B5EF4-FFF2-40B4-BE49-F238E27FC236}">
                  <a16:creationId xmlns="" xmlns:a16="http://schemas.microsoft.com/office/drawing/2014/main" id="{9B51F52A-6ED7-6A47-ABDE-DCD1A25FBC8B}"/>
                </a:ext>
              </a:extLst>
            </p:cNvPr>
            <p:cNvGrpSpPr/>
            <p:nvPr/>
          </p:nvGrpSpPr>
          <p:grpSpPr>
            <a:xfrm>
              <a:off x="3556152" y="2417206"/>
              <a:ext cx="251594" cy="653625"/>
              <a:chOff x="3556152" y="2417206"/>
              <a:chExt cx="251594" cy="653625"/>
            </a:xfrm>
          </p:grpSpPr>
          <p:sp>
            <p:nvSpPr>
              <p:cNvPr id="56" name="三角形 55">
                <a:extLst>
                  <a:ext uri="{FF2B5EF4-FFF2-40B4-BE49-F238E27FC236}">
                    <a16:creationId xmlns="" xmlns:a16="http://schemas.microsoft.com/office/drawing/2014/main" id="{647307F1-9DF6-304C-A895-18F7C8D47B67}"/>
                  </a:ext>
                </a:extLst>
              </p:cNvPr>
              <p:cNvSpPr/>
              <p:nvPr/>
            </p:nvSpPr>
            <p:spPr>
              <a:xfrm rot="10800000">
                <a:off x="3564101" y="2902060"/>
                <a:ext cx="233998" cy="156743"/>
              </a:xfrm>
              <a:prstGeom prst="triangle">
                <a:avLst>
                  <a:gd name="adj" fmla="val 48553"/>
                </a:avLst>
              </a:prstGeom>
              <a:solidFill>
                <a:srgbClr val="0070C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61" name="グループ化 160">
                <a:extLst>
                  <a:ext uri="{FF2B5EF4-FFF2-40B4-BE49-F238E27FC236}">
                    <a16:creationId xmlns="" xmlns:a16="http://schemas.microsoft.com/office/drawing/2014/main" id="{FAC352BE-803B-EC44-83E1-0325C33C502C}"/>
                  </a:ext>
                </a:extLst>
              </p:cNvPr>
              <p:cNvGrpSpPr/>
              <p:nvPr/>
            </p:nvGrpSpPr>
            <p:grpSpPr>
              <a:xfrm>
                <a:off x="3556152" y="2417206"/>
                <a:ext cx="251594" cy="653625"/>
                <a:chOff x="3036647" y="2061319"/>
                <a:chExt cx="251594" cy="653625"/>
              </a:xfrm>
            </p:grpSpPr>
            <p:cxnSp>
              <p:nvCxnSpPr>
                <p:cNvPr id="170" name="直線コネクタ 169">
                  <a:extLst>
                    <a:ext uri="{FF2B5EF4-FFF2-40B4-BE49-F238E27FC236}">
                      <a16:creationId xmlns="" xmlns:a16="http://schemas.microsoft.com/office/drawing/2014/main" id="{21752B96-49B2-4B40-917B-10F4EB9A25D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036647" y="2061319"/>
                  <a:ext cx="0" cy="469075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1" name="直線コネクタ 170">
                  <a:extLst>
                    <a:ext uri="{FF2B5EF4-FFF2-40B4-BE49-F238E27FC236}">
                      <a16:creationId xmlns="" xmlns:a16="http://schemas.microsoft.com/office/drawing/2014/main" id="{79FE4506-50C5-EC43-BAEE-54EB6536E6E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88241" y="2061319"/>
                  <a:ext cx="0" cy="469075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2" name="直線コネクタ 171">
                  <a:extLst>
                    <a:ext uri="{FF2B5EF4-FFF2-40B4-BE49-F238E27FC236}">
                      <a16:creationId xmlns="" xmlns:a16="http://schemas.microsoft.com/office/drawing/2014/main" id="{F54E6272-B65A-B141-B742-C7BECE16971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036647" y="2530301"/>
                  <a:ext cx="125796" cy="184643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3" name="直線コネクタ 172">
                  <a:extLst>
                    <a:ext uri="{FF2B5EF4-FFF2-40B4-BE49-F238E27FC236}">
                      <a16:creationId xmlns="" xmlns:a16="http://schemas.microsoft.com/office/drawing/2014/main" id="{BB40EB4B-ADAA-834E-B966-8CDA011959A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162444" y="2530301"/>
                  <a:ext cx="125797" cy="184643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59" name="円/楕円 158">
              <a:extLst>
                <a:ext uri="{FF2B5EF4-FFF2-40B4-BE49-F238E27FC236}">
                  <a16:creationId xmlns="" xmlns:a16="http://schemas.microsoft.com/office/drawing/2014/main" id="{0A6A4F22-C030-1444-9EB9-1653B441085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528948" y="2384593"/>
              <a:ext cx="306000" cy="5475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pic>
        <p:nvPicPr>
          <p:cNvPr id="64" name="グラフィックス 63" descr="線矢印: 直線">
            <a:extLst>
              <a:ext uri="{FF2B5EF4-FFF2-40B4-BE49-F238E27FC236}">
                <a16:creationId xmlns="" xmlns:a16="http://schemas.microsoft.com/office/drawing/2014/main" id="{6E7B6447-D5A1-4B49-B7F3-62F2C0A2BEB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=""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 rot="16200000">
            <a:off x="1274739" y="4698709"/>
            <a:ext cx="417573" cy="472457"/>
          </a:xfrm>
          <a:prstGeom prst="rect">
            <a:avLst/>
          </a:prstGeom>
        </p:spPr>
      </p:pic>
      <p:grpSp>
        <p:nvGrpSpPr>
          <p:cNvPr id="68" name="グループ化 67">
            <a:extLst>
              <a:ext uri="{FF2B5EF4-FFF2-40B4-BE49-F238E27FC236}">
                <a16:creationId xmlns="" xmlns:a16="http://schemas.microsoft.com/office/drawing/2014/main" id="{819B7A1C-BF18-9B43-B1A5-4DB6F12E41D4}"/>
              </a:ext>
            </a:extLst>
          </p:cNvPr>
          <p:cNvGrpSpPr/>
          <p:nvPr/>
        </p:nvGrpSpPr>
        <p:grpSpPr>
          <a:xfrm>
            <a:off x="1360330" y="3829674"/>
            <a:ext cx="580188" cy="786827"/>
            <a:chOff x="2709444" y="2284004"/>
            <a:chExt cx="580188" cy="786827"/>
          </a:xfrm>
        </p:grpSpPr>
        <p:sp>
          <p:nvSpPr>
            <p:cNvPr id="190" name="三角形 189">
              <a:extLst>
                <a:ext uri="{FF2B5EF4-FFF2-40B4-BE49-F238E27FC236}">
                  <a16:creationId xmlns="" xmlns:a16="http://schemas.microsoft.com/office/drawing/2014/main" id="{C065F817-3696-2046-847A-E21795831321}"/>
                </a:ext>
              </a:extLst>
            </p:cNvPr>
            <p:cNvSpPr/>
            <p:nvPr/>
          </p:nvSpPr>
          <p:spPr>
            <a:xfrm rot="10800000">
              <a:off x="2716211" y="2903759"/>
              <a:ext cx="233998" cy="156743"/>
            </a:xfrm>
            <a:prstGeom prst="triangle">
              <a:avLst>
                <a:gd name="adj" fmla="val 48553"/>
              </a:avLst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2" name="グループ化 51">
              <a:extLst>
                <a:ext uri="{FF2B5EF4-FFF2-40B4-BE49-F238E27FC236}">
                  <a16:creationId xmlns="" xmlns:a16="http://schemas.microsoft.com/office/drawing/2014/main" id="{CF11593B-CDDF-914D-B119-EE73E8607763}"/>
                </a:ext>
              </a:extLst>
            </p:cNvPr>
            <p:cNvGrpSpPr/>
            <p:nvPr/>
          </p:nvGrpSpPr>
          <p:grpSpPr>
            <a:xfrm>
              <a:off x="2709444" y="2284004"/>
              <a:ext cx="580188" cy="786827"/>
              <a:chOff x="3034704" y="1928117"/>
              <a:chExt cx="580188" cy="786827"/>
            </a:xfrm>
          </p:grpSpPr>
          <p:sp>
            <p:nvSpPr>
              <p:cNvPr id="128" name="円/楕円 127">
                <a:extLst>
                  <a:ext uri="{FF2B5EF4-FFF2-40B4-BE49-F238E27FC236}">
                    <a16:creationId xmlns="" xmlns:a16="http://schemas.microsoft.com/office/drawing/2014/main" id="{283E3BD8-C4FE-5B46-825F-06F3259AA1B2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9604473">
                <a:off x="3308892" y="1958289"/>
                <a:ext cx="306000" cy="54759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3" name="円柱 132">
                <a:extLst>
                  <a:ext uri="{FF2B5EF4-FFF2-40B4-BE49-F238E27FC236}">
                    <a16:creationId xmlns="" xmlns:a16="http://schemas.microsoft.com/office/drawing/2014/main" id="{BD452CAD-B96E-024E-A66D-E4A42BF875A2}"/>
                  </a:ext>
                </a:extLst>
              </p:cNvPr>
              <p:cNvSpPr>
                <a:spLocks/>
              </p:cNvSpPr>
              <p:nvPr/>
            </p:nvSpPr>
            <p:spPr>
              <a:xfrm rot="20360346">
                <a:off x="3343067" y="1932014"/>
                <a:ext cx="216000" cy="61200"/>
              </a:xfrm>
              <a:prstGeom prst="can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42" name="グループ化 41">
                <a:extLst>
                  <a:ext uri="{FF2B5EF4-FFF2-40B4-BE49-F238E27FC236}">
                    <a16:creationId xmlns="" xmlns:a16="http://schemas.microsoft.com/office/drawing/2014/main" id="{67C2FD2B-90F8-DA4C-96D9-4B61E9704365}"/>
                  </a:ext>
                </a:extLst>
              </p:cNvPr>
              <p:cNvGrpSpPr/>
              <p:nvPr/>
            </p:nvGrpSpPr>
            <p:grpSpPr>
              <a:xfrm>
                <a:off x="3034704" y="2037746"/>
                <a:ext cx="283347" cy="677198"/>
                <a:chOff x="3034704" y="2037746"/>
                <a:chExt cx="283347" cy="677198"/>
              </a:xfrm>
            </p:grpSpPr>
            <p:cxnSp>
              <p:nvCxnSpPr>
                <p:cNvPr id="32" name="直線コネクタ 31">
                  <a:extLst>
                    <a:ext uri="{FF2B5EF4-FFF2-40B4-BE49-F238E27FC236}">
                      <a16:creationId xmlns="" xmlns:a16="http://schemas.microsoft.com/office/drawing/2014/main" id="{06C1A8A2-7345-BB4D-8944-FED04CB8AD4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036647" y="2061319"/>
                  <a:ext cx="0" cy="469075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9" name="直線コネクタ 118">
                  <a:extLst>
                    <a:ext uri="{FF2B5EF4-FFF2-40B4-BE49-F238E27FC236}">
                      <a16:creationId xmlns="" xmlns:a16="http://schemas.microsoft.com/office/drawing/2014/main" id="{6B6F513A-E779-EB41-A5AF-4165A243A0C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88241" y="2061319"/>
                  <a:ext cx="0" cy="469075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0" name="直線コネクタ 119">
                  <a:extLst>
                    <a:ext uri="{FF2B5EF4-FFF2-40B4-BE49-F238E27FC236}">
                      <a16:creationId xmlns="" xmlns:a16="http://schemas.microsoft.com/office/drawing/2014/main" id="{07E88210-FF6A-CC43-9243-C37227F6A60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036647" y="2530301"/>
                  <a:ext cx="125796" cy="184643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1" name="直線コネクタ 120">
                  <a:extLst>
                    <a:ext uri="{FF2B5EF4-FFF2-40B4-BE49-F238E27FC236}">
                      <a16:creationId xmlns="" xmlns:a16="http://schemas.microsoft.com/office/drawing/2014/main" id="{00CBF4CF-AA54-3749-9E3B-1980BC4E253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162444" y="2530301"/>
                  <a:ext cx="125797" cy="184643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8" name="円/楕円 37">
                  <a:extLst>
                    <a:ext uri="{FF2B5EF4-FFF2-40B4-BE49-F238E27FC236}">
                      <a16:creationId xmlns="" xmlns:a16="http://schemas.microsoft.com/office/drawing/2014/main" id="{9274E71C-4633-764D-B0F9-E05FCC69ECD6}"/>
                    </a:ext>
                  </a:extLst>
                </p:cNvPr>
                <p:cNvSpPr/>
                <p:nvPr/>
              </p:nvSpPr>
              <p:spPr>
                <a:xfrm>
                  <a:off x="3034704" y="2037746"/>
                  <a:ext cx="255480" cy="45719"/>
                </a:xfrm>
                <a:prstGeom prst="ellipse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cxnSp>
              <p:nvCxnSpPr>
                <p:cNvPr id="41" name="直線コネクタ 40">
                  <a:extLst>
                    <a:ext uri="{FF2B5EF4-FFF2-40B4-BE49-F238E27FC236}">
                      <a16:creationId xmlns="" xmlns:a16="http://schemas.microsoft.com/office/drawing/2014/main" id="{54243955-2DF7-D84D-A8DF-E9AAB3965A57}"/>
                    </a:ext>
                  </a:extLst>
                </p:cNvPr>
                <p:cNvCxnSpPr>
                  <a:stCxn id="38" idx="6"/>
                  <a:endCxn id="128" idx="6"/>
                </p:cNvCxnSpPr>
                <p:nvPr/>
              </p:nvCxnSpPr>
              <p:spPr>
                <a:xfrm flipV="1">
                  <a:off x="3290184" y="2037810"/>
                  <a:ext cx="27867" cy="2279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4" name="円/楕円 133">
                <a:extLst>
                  <a:ext uri="{FF2B5EF4-FFF2-40B4-BE49-F238E27FC236}">
                    <a16:creationId xmlns="" xmlns:a16="http://schemas.microsoft.com/office/drawing/2014/main" id="{E0B1F54F-2073-6C45-9311-D51ED7434B7E}"/>
                  </a:ext>
                </a:extLst>
              </p:cNvPr>
              <p:cNvSpPr/>
              <p:nvPr/>
            </p:nvSpPr>
            <p:spPr>
              <a:xfrm>
                <a:off x="3098169" y="1928117"/>
                <a:ext cx="128550" cy="130753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sp>
        <p:nvSpPr>
          <p:cNvPr id="229" name="テキスト ボックス 228">
            <a:extLst>
              <a:ext uri="{FF2B5EF4-FFF2-40B4-BE49-F238E27FC236}">
                <a16:creationId xmlns="" xmlns:a16="http://schemas.microsoft.com/office/drawing/2014/main" id="{8602EF64-8FDC-0249-8EDB-CA3CDE98F3C1}"/>
              </a:ext>
            </a:extLst>
          </p:cNvPr>
          <p:cNvSpPr txBox="1"/>
          <p:nvPr/>
        </p:nvSpPr>
        <p:spPr>
          <a:xfrm>
            <a:off x="1225945" y="2012245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GFP</a:t>
            </a:r>
          </a:p>
        </p:txBody>
      </p:sp>
      <p:grpSp>
        <p:nvGrpSpPr>
          <p:cNvPr id="198" name="グループ化 197">
            <a:extLst>
              <a:ext uri="{FF2B5EF4-FFF2-40B4-BE49-F238E27FC236}">
                <a16:creationId xmlns="" xmlns:a16="http://schemas.microsoft.com/office/drawing/2014/main" id="{3C0D974F-A6CB-874A-935A-76E22CB137C9}"/>
              </a:ext>
            </a:extLst>
          </p:cNvPr>
          <p:cNvGrpSpPr/>
          <p:nvPr/>
        </p:nvGrpSpPr>
        <p:grpSpPr>
          <a:xfrm>
            <a:off x="3019259" y="5240257"/>
            <a:ext cx="306000" cy="686238"/>
            <a:chOff x="3528948" y="2384593"/>
            <a:chExt cx="306000" cy="686238"/>
          </a:xfrm>
        </p:grpSpPr>
        <p:sp>
          <p:nvSpPr>
            <p:cNvPr id="213" name="円柱 212">
              <a:extLst>
                <a:ext uri="{FF2B5EF4-FFF2-40B4-BE49-F238E27FC236}">
                  <a16:creationId xmlns="" xmlns:a16="http://schemas.microsoft.com/office/drawing/2014/main" id="{72E2D186-2A0D-1E4D-BEF1-B2FAE260F070}"/>
                </a:ext>
              </a:extLst>
            </p:cNvPr>
            <p:cNvSpPr>
              <a:spLocks/>
            </p:cNvSpPr>
            <p:nvPr/>
          </p:nvSpPr>
          <p:spPr>
            <a:xfrm>
              <a:off x="3564949" y="2404765"/>
              <a:ext cx="234000" cy="61200"/>
            </a:xfrm>
            <a:prstGeom prst="can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14" name="グループ化 213">
              <a:extLst>
                <a:ext uri="{FF2B5EF4-FFF2-40B4-BE49-F238E27FC236}">
                  <a16:creationId xmlns="" xmlns:a16="http://schemas.microsoft.com/office/drawing/2014/main" id="{087BEA41-3BCC-7A45-A664-744081E17446}"/>
                </a:ext>
              </a:extLst>
            </p:cNvPr>
            <p:cNvGrpSpPr/>
            <p:nvPr/>
          </p:nvGrpSpPr>
          <p:grpSpPr>
            <a:xfrm>
              <a:off x="3556152" y="2417206"/>
              <a:ext cx="251594" cy="653625"/>
              <a:chOff x="3556152" y="2417206"/>
              <a:chExt cx="251594" cy="653625"/>
            </a:xfrm>
          </p:grpSpPr>
          <p:sp>
            <p:nvSpPr>
              <p:cNvPr id="216" name="三角形 215">
                <a:extLst>
                  <a:ext uri="{FF2B5EF4-FFF2-40B4-BE49-F238E27FC236}">
                    <a16:creationId xmlns="" xmlns:a16="http://schemas.microsoft.com/office/drawing/2014/main" id="{32FE8EDE-E8AA-E845-BF29-358DF1EB2F0E}"/>
                  </a:ext>
                </a:extLst>
              </p:cNvPr>
              <p:cNvSpPr/>
              <p:nvPr/>
            </p:nvSpPr>
            <p:spPr>
              <a:xfrm rot="10800000">
                <a:off x="3564101" y="2902060"/>
                <a:ext cx="233998" cy="156743"/>
              </a:xfrm>
              <a:prstGeom prst="triangle">
                <a:avLst>
                  <a:gd name="adj" fmla="val 48553"/>
                </a:avLst>
              </a:prstGeom>
              <a:solidFill>
                <a:srgbClr val="0070C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217" name="グループ化 216">
                <a:extLst>
                  <a:ext uri="{FF2B5EF4-FFF2-40B4-BE49-F238E27FC236}">
                    <a16:creationId xmlns="" xmlns:a16="http://schemas.microsoft.com/office/drawing/2014/main" id="{9929CC3C-B193-F940-840E-0FE921236F01}"/>
                  </a:ext>
                </a:extLst>
              </p:cNvPr>
              <p:cNvGrpSpPr/>
              <p:nvPr/>
            </p:nvGrpSpPr>
            <p:grpSpPr>
              <a:xfrm>
                <a:off x="3556152" y="2417206"/>
                <a:ext cx="251594" cy="653625"/>
                <a:chOff x="3036647" y="2061319"/>
                <a:chExt cx="251594" cy="653625"/>
              </a:xfrm>
            </p:grpSpPr>
            <p:cxnSp>
              <p:nvCxnSpPr>
                <p:cNvPr id="218" name="直線コネクタ 217">
                  <a:extLst>
                    <a:ext uri="{FF2B5EF4-FFF2-40B4-BE49-F238E27FC236}">
                      <a16:creationId xmlns="" xmlns:a16="http://schemas.microsoft.com/office/drawing/2014/main" id="{4A033038-3A6A-BE43-8B71-B95EF5B1063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036647" y="2061319"/>
                  <a:ext cx="0" cy="469075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9" name="直線コネクタ 218">
                  <a:extLst>
                    <a:ext uri="{FF2B5EF4-FFF2-40B4-BE49-F238E27FC236}">
                      <a16:creationId xmlns="" xmlns:a16="http://schemas.microsoft.com/office/drawing/2014/main" id="{B63A634E-D610-6C41-AF9C-A5834EE9AEC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88241" y="2061319"/>
                  <a:ext cx="0" cy="469075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0" name="直線コネクタ 219">
                  <a:extLst>
                    <a:ext uri="{FF2B5EF4-FFF2-40B4-BE49-F238E27FC236}">
                      <a16:creationId xmlns="" xmlns:a16="http://schemas.microsoft.com/office/drawing/2014/main" id="{97F0387A-8BDC-3E49-A4DC-8CB8A05BB90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036647" y="2530301"/>
                  <a:ext cx="125796" cy="184643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1" name="直線コネクタ 220">
                  <a:extLst>
                    <a:ext uri="{FF2B5EF4-FFF2-40B4-BE49-F238E27FC236}">
                      <a16:creationId xmlns="" xmlns:a16="http://schemas.microsoft.com/office/drawing/2014/main" id="{B33D33FC-3E13-354B-AD92-6648F0E8291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162444" y="2530301"/>
                  <a:ext cx="125797" cy="184643"/>
                </a:xfrm>
                <a:prstGeom prst="line">
                  <a:avLst/>
                </a:prstGeom>
                <a:ln w="12700" cap="rnd"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15" name="円/楕円 214">
              <a:extLst>
                <a:ext uri="{FF2B5EF4-FFF2-40B4-BE49-F238E27FC236}">
                  <a16:creationId xmlns="" xmlns:a16="http://schemas.microsoft.com/office/drawing/2014/main" id="{B607626A-E3E5-684A-9F30-0D4DADD92D1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528948" y="2384593"/>
              <a:ext cx="306000" cy="54759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pic>
        <p:nvPicPr>
          <p:cNvPr id="199" name="グラフィックス 198" descr="線矢印: 直線">
            <a:extLst>
              <a:ext uri="{FF2B5EF4-FFF2-40B4-BE49-F238E27FC236}">
                <a16:creationId xmlns="" xmlns:a16="http://schemas.microsoft.com/office/drawing/2014/main" id="{5C82D098-3ED8-A646-8669-4F138591F2F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96DAC541-7B7A-43D3-8B79-37D633B846F1}">
                <asvg:svgBlip xmlns="" xmlns:asvg="http://schemas.microsoft.com/office/drawing/2016/SVG/main" r:embed="rId8"/>
              </a:ext>
            </a:extLst>
          </a:blip>
          <a:stretch>
            <a:fillRect/>
          </a:stretch>
        </p:blipFill>
        <p:spPr>
          <a:xfrm rot="16200000">
            <a:off x="2946494" y="4698709"/>
            <a:ext cx="417573" cy="472457"/>
          </a:xfrm>
          <a:prstGeom prst="rect">
            <a:avLst/>
          </a:prstGeom>
        </p:spPr>
      </p:pic>
      <p:grpSp>
        <p:nvGrpSpPr>
          <p:cNvPr id="44" name="グループ化 43">
            <a:extLst>
              <a:ext uri="{FF2B5EF4-FFF2-40B4-BE49-F238E27FC236}">
                <a16:creationId xmlns="" xmlns:a16="http://schemas.microsoft.com/office/drawing/2014/main" id="{2DD33BD7-F11D-F148-B454-E9F58C4E486A}"/>
              </a:ext>
            </a:extLst>
          </p:cNvPr>
          <p:cNvGrpSpPr/>
          <p:nvPr/>
        </p:nvGrpSpPr>
        <p:grpSpPr>
          <a:xfrm>
            <a:off x="3029951" y="3829674"/>
            <a:ext cx="580188" cy="786827"/>
            <a:chOff x="3959557" y="3206220"/>
            <a:chExt cx="580188" cy="786827"/>
          </a:xfrm>
        </p:grpSpPr>
        <p:grpSp>
          <p:nvGrpSpPr>
            <p:cNvPr id="200" name="グループ化 199">
              <a:extLst>
                <a:ext uri="{FF2B5EF4-FFF2-40B4-BE49-F238E27FC236}">
                  <a16:creationId xmlns="" xmlns:a16="http://schemas.microsoft.com/office/drawing/2014/main" id="{B0CB229C-7AD1-974B-BA24-19FF11576603}"/>
                </a:ext>
              </a:extLst>
            </p:cNvPr>
            <p:cNvGrpSpPr/>
            <p:nvPr/>
          </p:nvGrpSpPr>
          <p:grpSpPr>
            <a:xfrm>
              <a:off x="3959557" y="3206220"/>
              <a:ext cx="580188" cy="786827"/>
              <a:chOff x="2709444" y="2284004"/>
              <a:chExt cx="580188" cy="786827"/>
            </a:xfrm>
          </p:grpSpPr>
          <p:sp>
            <p:nvSpPr>
              <p:cNvPr id="201" name="三角形 200">
                <a:extLst>
                  <a:ext uri="{FF2B5EF4-FFF2-40B4-BE49-F238E27FC236}">
                    <a16:creationId xmlns="" xmlns:a16="http://schemas.microsoft.com/office/drawing/2014/main" id="{15EA78A2-F651-8843-9364-2F0ED0293409}"/>
                  </a:ext>
                </a:extLst>
              </p:cNvPr>
              <p:cNvSpPr/>
              <p:nvPr/>
            </p:nvSpPr>
            <p:spPr>
              <a:xfrm rot="10800000">
                <a:off x="2716211" y="2903759"/>
                <a:ext cx="233998" cy="156743"/>
              </a:xfrm>
              <a:prstGeom prst="triangle">
                <a:avLst>
                  <a:gd name="adj" fmla="val 48553"/>
                </a:avLst>
              </a:prstGeom>
              <a:solidFill>
                <a:srgbClr val="0070C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202" name="グループ化 201">
                <a:extLst>
                  <a:ext uri="{FF2B5EF4-FFF2-40B4-BE49-F238E27FC236}">
                    <a16:creationId xmlns="" xmlns:a16="http://schemas.microsoft.com/office/drawing/2014/main" id="{F1992996-34CA-1943-8E8C-F1538F2DDA4B}"/>
                  </a:ext>
                </a:extLst>
              </p:cNvPr>
              <p:cNvGrpSpPr/>
              <p:nvPr/>
            </p:nvGrpSpPr>
            <p:grpSpPr>
              <a:xfrm>
                <a:off x="2709444" y="2284004"/>
                <a:ext cx="580188" cy="786827"/>
                <a:chOff x="3034704" y="1928117"/>
                <a:chExt cx="580188" cy="786827"/>
              </a:xfrm>
            </p:grpSpPr>
            <p:sp>
              <p:nvSpPr>
                <p:cNvPr id="203" name="円/楕円 202">
                  <a:extLst>
                    <a:ext uri="{FF2B5EF4-FFF2-40B4-BE49-F238E27FC236}">
                      <a16:creationId xmlns="" xmlns:a16="http://schemas.microsoft.com/office/drawing/2014/main" id="{E1897619-3D47-0A4F-88E7-4B45FAE5CD7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9604473">
                  <a:off x="3308892" y="1958289"/>
                  <a:ext cx="306000" cy="54759"/>
                </a:xfrm>
                <a:prstGeom prst="ellipse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204" name="円柱 203">
                  <a:extLst>
                    <a:ext uri="{FF2B5EF4-FFF2-40B4-BE49-F238E27FC236}">
                      <a16:creationId xmlns="" xmlns:a16="http://schemas.microsoft.com/office/drawing/2014/main" id="{493C3AC1-5580-4E44-AD60-E2B9AF0288B7}"/>
                    </a:ext>
                  </a:extLst>
                </p:cNvPr>
                <p:cNvSpPr>
                  <a:spLocks/>
                </p:cNvSpPr>
                <p:nvPr/>
              </p:nvSpPr>
              <p:spPr>
                <a:xfrm rot="20360346">
                  <a:off x="3343067" y="1932014"/>
                  <a:ext cx="216000" cy="61200"/>
                </a:xfrm>
                <a:prstGeom prst="can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grpSp>
              <p:nvGrpSpPr>
                <p:cNvPr id="205" name="グループ化 204">
                  <a:extLst>
                    <a:ext uri="{FF2B5EF4-FFF2-40B4-BE49-F238E27FC236}">
                      <a16:creationId xmlns="" xmlns:a16="http://schemas.microsoft.com/office/drawing/2014/main" id="{EDC65348-5773-DE43-987C-7B0EF629E7D9}"/>
                    </a:ext>
                  </a:extLst>
                </p:cNvPr>
                <p:cNvGrpSpPr/>
                <p:nvPr/>
              </p:nvGrpSpPr>
              <p:grpSpPr>
                <a:xfrm>
                  <a:off x="3034704" y="2037746"/>
                  <a:ext cx="283347" cy="677198"/>
                  <a:chOff x="3034704" y="2037746"/>
                  <a:chExt cx="283347" cy="677198"/>
                </a:xfrm>
              </p:grpSpPr>
              <p:cxnSp>
                <p:nvCxnSpPr>
                  <p:cNvPr id="207" name="直線コネクタ 206">
                    <a:extLst>
                      <a:ext uri="{FF2B5EF4-FFF2-40B4-BE49-F238E27FC236}">
                        <a16:creationId xmlns="" xmlns:a16="http://schemas.microsoft.com/office/drawing/2014/main" id="{D61AFBDA-E86A-AC43-BA1B-3C7A64E463F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036647" y="2061319"/>
                    <a:ext cx="0" cy="469075"/>
                  </a:xfrm>
                  <a:prstGeom prst="line">
                    <a:avLst/>
                  </a:prstGeom>
                  <a:ln w="12700" cap="rnd">
                    <a:solidFill>
                      <a:schemeClr val="tx1"/>
                    </a:solidFill>
                    <a:round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8" name="直線コネクタ 207">
                    <a:extLst>
                      <a:ext uri="{FF2B5EF4-FFF2-40B4-BE49-F238E27FC236}">
                        <a16:creationId xmlns="" xmlns:a16="http://schemas.microsoft.com/office/drawing/2014/main" id="{92D10CFD-D04A-FF48-9413-FFE864C0998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288241" y="2061319"/>
                    <a:ext cx="0" cy="469075"/>
                  </a:xfrm>
                  <a:prstGeom prst="line">
                    <a:avLst/>
                  </a:prstGeom>
                  <a:ln w="12700" cap="rnd">
                    <a:solidFill>
                      <a:schemeClr val="tx1"/>
                    </a:solidFill>
                    <a:round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9" name="直線コネクタ 208">
                    <a:extLst>
                      <a:ext uri="{FF2B5EF4-FFF2-40B4-BE49-F238E27FC236}">
                        <a16:creationId xmlns="" xmlns:a16="http://schemas.microsoft.com/office/drawing/2014/main" id="{216BEE94-8DF5-5549-8F46-253ACBB0E56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036647" y="2530301"/>
                    <a:ext cx="125796" cy="184643"/>
                  </a:xfrm>
                  <a:prstGeom prst="line">
                    <a:avLst/>
                  </a:prstGeom>
                  <a:ln w="12700" cap="rnd">
                    <a:solidFill>
                      <a:schemeClr val="tx1"/>
                    </a:solidFill>
                    <a:round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0" name="直線コネクタ 209">
                    <a:extLst>
                      <a:ext uri="{FF2B5EF4-FFF2-40B4-BE49-F238E27FC236}">
                        <a16:creationId xmlns="" xmlns:a16="http://schemas.microsoft.com/office/drawing/2014/main" id="{03147ED1-96DA-6D4E-9AB1-2D6B31C7BC1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3162444" y="2530301"/>
                    <a:ext cx="125797" cy="184643"/>
                  </a:xfrm>
                  <a:prstGeom prst="line">
                    <a:avLst/>
                  </a:prstGeom>
                  <a:ln w="12700" cap="rnd">
                    <a:solidFill>
                      <a:schemeClr val="tx1"/>
                    </a:solidFill>
                    <a:round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11" name="円/楕円 210">
                    <a:extLst>
                      <a:ext uri="{FF2B5EF4-FFF2-40B4-BE49-F238E27FC236}">
                        <a16:creationId xmlns="" xmlns:a16="http://schemas.microsoft.com/office/drawing/2014/main" id="{E5FB5DC0-2F07-434D-986C-2D665BEB5BDC}"/>
                      </a:ext>
                    </a:extLst>
                  </p:cNvPr>
                  <p:cNvSpPr/>
                  <p:nvPr/>
                </p:nvSpPr>
                <p:spPr>
                  <a:xfrm>
                    <a:off x="3034704" y="2037746"/>
                    <a:ext cx="255480" cy="45719"/>
                  </a:xfrm>
                  <a:prstGeom prst="ellipse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cxnSp>
                <p:nvCxnSpPr>
                  <p:cNvPr id="212" name="直線コネクタ 211">
                    <a:extLst>
                      <a:ext uri="{FF2B5EF4-FFF2-40B4-BE49-F238E27FC236}">
                        <a16:creationId xmlns="" xmlns:a16="http://schemas.microsoft.com/office/drawing/2014/main" id="{8DDE82FD-726B-D64C-A334-4AA940D2F2F3}"/>
                      </a:ext>
                    </a:extLst>
                  </p:cNvPr>
                  <p:cNvCxnSpPr>
                    <a:stCxn id="211" idx="6"/>
                    <a:endCxn id="203" idx="6"/>
                  </p:cNvCxnSpPr>
                  <p:nvPr/>
                </p:nvCxnSpPr>
                <p:spPr>
                  <a:xfrm flipV="1">
                    <a:off x="3290184" y="2037810"/>
                    <a:ext cx="27867" cy="22796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06" name="円/楕円 205">
                  <a:extLst>
                    <a:ext uri="{FF2B5EF4-FFF2-40B4-BE49-F238E27FC236}">
                      <a16:creationId xmlns="" xmlns:a16="http://schemas.microsoft.com/office/drawing/2014/main" id="{2D137406-B531-8B46-8452-18E41219080B}"/>
                    </a:ext>
                  </a:extLst>
                </p:cNvPr>
                <p:cNvSpPr/>
                <p:nvPr/>
              </p:nvSpPr>
              <p:spPr>
                <a:xfrm>
                  <a:off x="3098169" y="1928117"/>
                  <a:ext cx="128550" cy="130753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</p:grpSp>
        <p:sp>
          <p:nvSpPr>
            <p:cNvPr id="227" name="円/楕円 226">
              <a:extLst>
                <a:ext uri="{FF2B5EF4-FFF2-40B4-BE49-F238E27FC236}">
                  <a16:creationId xmlns="" xmlns:a16="http://schemas.microsoft.com/office/drawing/2014/main" id="{651C5443-77F4-724B-9470-B7FA309BEB86}"/>
                </a:ext>
              </a:extLst>
            </p:cNvPr>
            <p:cNvSpPr/>
            <p:nvPr/>
          </p:nvSpPr>
          <p:spPr>
            <a:xfrm>
              <a:off x="4019657" y="3667593"/>
              <a:ext cx="128550" cy="130753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8" name="円/楕円 227">
              <a:extLst>
                <a:ext uri="{FF2B5EF4-FFF2-40B4-BE49-F238E27FC236}">
                  <a16:creationId xmlns="" xmlns:a16="http://schemas.microsoft.com/office/drawing/2014/main" id="{835A1324-B368-AC45-BAA0-97EA23AC0076}"/>
                </a:ext>
              </a:extLst>
            </p:cNvPr>
            <p:cNvSpPr/>
            <p:nvPr/>
          </p:nvSpPr>
          <p:spPr>
            <a:xfrm>
              <a:off x="4019657" y="3457373"/>
              <a:ext cx="128550" cy="130753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30" name="テキスト ボックス 229">
            <a:extLst>
              <a:ext uri="{FF2B5EF4-FFF2-40B4-BE49-F238E27FC236}">
                <a16:creationId xmlns="" xmlns:a16="http://schemas.microsoft.com/office/drawing/2014/main" id="{9BBF90D8-B6C7-EE40-9323-2ADEF5FAFC9D}"/>
              </a:ext>
            </a:extLst>
          </p:cNvPr>
          <p:cNvSpPr txBox="1"/>
          <p:nvPr/>
        </p:nvSpPr>
        <p:spPr>
          <a:xfrm>
            <a:off x="2847017" y="2012245"/>
            <a:ext cx="6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/>
              <a:t>AS#3</a:t>
            </a:r>
            <a:endParaRPr kumimoji="1" lang="ja-JP" altLang="en-US" dirty="0"/>
          </a:p>
        </p:txBody>
      </p:sp>
      <p:grpSp>
        <p:nvGrpSpPr>
          <p:cNvPr id="46" name="グループ化 45">
            <a:extLst>
              <a:ext uri="{FF2B5EF4-FFF2-40B4-BE49-F238E27FC236}">
                <a16:creationId xmlns="" xmlns:a16="http://schemas.microsoft.com/office/drawing/2014/main" id="{E2633DCC-A4C0-A34F-8CF4-F72D1B56BFE9}"/>
              </a:ext>
            </a:extLst>
          </p:cNvPr>
          <p:cNvGrpSpPr/>
          <p:nvPr/>
        </p:nvGrpSpPr>
        <p:grpSpPr>
          <a:xfrm>
            <a:off x="2452215" y="2365633"/>
            <a:ext cx="1348314" cy="1266272"/>
            <a:chOff x="1990191" y="2909776"/>
            <a:chExt cx="1348314" cy="1266272"/>
          </a:xfrm>
        </p:grpSpPr>
        <p:pic>
          <p:nvPicPr>
            <p:cNvPr id="192" name="グラフィックス 191" descr="肺">
              <a:extLst>
                <a:ext uri="{FF2B5EF4-FFF2-40B4-BE49-F238E27FC236}">
                  <a16:creationId xmlns="" xmlns:a16="http://schemas.microsoft.com/office/drawing/2014/main" id="{65B82A43-9D10-7A4A-B3F8-FD99EA70D64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96DAC541-7B7A-43D3-8B79-37D633B846F1}">
                  <asvg:svgBlip xmlns="" xmlns:asvg="http://schemas.microsoft.com/office/drawing/2016/SVG/main" r:embed="rId9"/>
                </a:ext>
              </a:extLst>
            </a:blip>
            <a:stretch>
              <a:fillRect/>
            </a:stretch>
          </p:blipFill>
          <p:spPr>
            <a:xfrm>
              <a:off x="2072233" y="2909776"/>
              <a:ext cx="1266272" cy="1266272"/>
            </a:xfrm>
            <a:prstGeom prst="rect">
              <a:avLst/>
            </a:prstGeom>
          </p:spPr>
        </p:pic>
        <p:sp>
          <p:nvSpPr>
            <p:cNvPr id="193" name="フリーフォーム 192">
              <a:extLst>
                <a:ext uri="{FF2B5EF4-FFF2-40B4-BE49-F238E27FC236}">
                  <a16:creationId xmlns="" xmlns:a16="http://schemas.microsoft.com/office/drawing/2014/main" id="{1C7A0A79-79AC-1447-AF10-EBA8523B98CF}"/>
                </a:ext>
              </a:extLst>
            </p:cNvPr>
            <p:cNvSpPr/>
            <p:nvPr/>
          </p:nvSpPr>
          <p:spPr>
            <a:xfrm>
              <a:off x="2254515" y="3283622"/>
              <a:ext cx="903557" cy="531291"/>
            </a:xfrm>
            <a:custGeom>
              <a:avLst/>
              <a:gdLst>
                <a:gd name="connsiteX0" fmla="*/ 18071 w 903557"/>
                <a:gd name="connsiteY0" fmla="*/ 531291 h 531291"/>
                <a:gd name="connsiteX1" fmla="*/ 18071 w 903557"/>
                <a:gd name="connsiteY1" fmla="*/ 531291 h 531291"/>
                <a:gd name="connsiteX2" fmla="*/ 0 w 903557"/>
                <a:gd name="connsiteY2" fmla="*/ 484306 h 531291"/>
                <a:gd name="connsiteX3" fmla="*/ 3614 w 903557"/>
                <a:gd name="connsiteY3" fmla="*/ 469849 h 531291"/>
                <a:gd name="connsiteX4" fmla="*/ 7228 w 903557"/>
                <a:gd name="connsiteY4" fmla="*/ 448164 h 531291"/>
                <a:gd name="connsiteX5" fmla="*/ 18071 w 903557"/>
                <a:gd name="connsiteY5" fmla="*/ 397565 h 531291"/>
                <a:gd name="connsiteX6" fmla="*/ 28914 w 903557"/>
                <a:gd name="connsiteY6" fmla="*/ 365037 h 531291"/>
                <a:gd name="connsiteX7" fmla="*/ 32528 w 903557"/>
                <a:gd name="connsiteY7" fmla="*/ 354194 h 531291"/>
                <a:gd name="connsiteX8" fmla="*/ 36142 w 903557"/>
                <a:gd name="connsiteY8" fmla="*/ 343351 h 531291"/>
                <a:gd name="connsiteX9" fmla="*/ 32528 w 903557"/>
                <a:gd name="connsiteY9" fmla="*/ 318052 h 531291"/>
                <a:gd name="connsiteX10" fmla="*/ 28914 w 903557"/>
                <a:gd name="connsiteY10" fmla="*/ 307209 h 531291"/>
                <a:gd name="connsiteX11" fmla="*/ 18071 w 903557"/>
                <a:gd name="connsiteY11" fmla="*/ 299981 h 531291"/>
                <a:gd name="connsiteX12" fmla="*/ 10842 w 903557"/>
                <a:gd name="connsiteY12" fmla="*/ 292752 h 531291"/>
                <a:gd name="connsiteX13" fmla="*/ 3614 w 903557"/>
                <a:gd name="connsiteY13" fmla="*/ 271067 h 531291"/>
                <a:gd name="connsiteX14" fmla="*/ 0 w 903557"/>
                <a:gd name="connsiteY14" fmla="*/ 260224 h 531291"/>
                <a:gd name="connsiteX15" fmla="*/ 3614 w 903557"/>
                <a:gd name="connsiteY15" fmla="*/ 245767 h 531291"/>
                <a:gd name="connsiteX16" fmla="*/ 10842 w 903557"/>
                <a:gd name="connsiteY16" fmla="*/ 206011 h 531291"/>
                <a:gd name="connsiteX17" fmla="*/ 18071 w 903557"/>
                <a:gd name="connsiteY17" fmla="*/ 184325 h 531291"/>
                <a:gd name="connsiteX18" fmla="*/ 43371 w 903557"/>
                <a:gd name="connsiteY18" fmla="*/ 155411 h 531291"/>
                <a:gd name="connsiteX19" fmla="*/ 54213 w 903557"/>
                <a:gd name="connsiteY19" fmla="*/ 148183 h 531291"/>
                <a:gd name="connsiteX20" fmla="*/ 75899 w 903557"/>
                <a:gd name="connsiteY20" fmla="*/ 140954 h 531291"/>
                <a:gd name="connsiteX21" fmla="*/ 97584 w 903557"/>
                <a:gd name="connsiteY21" fmla="*/ 130112 h 531291"/>
                <a:gd name="connsiteX22" fmla="*/ 119269 w 903557"/>
                <a:gd name="connsiteY22" fmla="*/ 108426 h 531291"/>
                <a:gd name="connsiteX23" fmla="*/ 126498 w 903557"/>
                <a:gd name="connsiteY23" fmla="*/ 101198 h 531291"/>
                <a:gd name="connsiteX24" fmla="*/ 133726 w 903557"/>
                <a:gd name="connsiteY24" fmla="*/ 93969 h 531291"/>
                <a:gd name="connsiteX25" fmla="*/ 140955 w 903557"/>
                <a:gd name="connsiteY25" fmla="*/ 72284 h 531291"/>
                <a:gd name="connsiteX26" fmla="*/ 148183 w 903557"/>
                <a:gd name="connsiteY26" fmla="*/ 61441 h 531291"/>
                <a:gd name="connsiteX27" fmla="*/ 159026 w 903557"/>
                <a:gd name="connsiteY27" fmla="*/ 43370 h 531291"/>
                <a:gd name="connsiteX28" fmla="*/ 166254 w 903557"/>
                <a:gd name="connsiteY28" fmla="*/ 28913 h 531291"/>
                <a:gd name="connsiteX29" fmla="*/ 180711 w 903557"/>
                <a:gd name="connsiteY29" fmla="*/ 14456 h 531291"/>
                <a:gd name="connsiteX30" fmla="*/ 198782 w 903557"/>
                <a:gd name="connsiteY30" fmla="*/ 0 h 531291"/>
                <a:gd name="connsiteX31" fmla="*/ 209625 w 903557"/>
                <a:gd name="connsiteY31" fmla="*/ 3614 h 531291"/>
                <a:gd name="connsiteX32" fmla="*/ 227696 w 903557"/>
                <a:gd name="connsiteY32" fmla="*/ 14456 h 531291"/>
                <a:gd name="connsiteX33" fmla="*/ 234925 w 903557"/>
                <a:gd name="connsiteY33" fmla="*/ 21685 h 531291"/>
                <a:gd name="connsiteX34" fmla="*/ 245767 w 903557"/>
                <a:gd name="connsiteY34" fmla="*/ 28913 h 531291"/>
                <a:gd name="connsiteX35" fmla="*/ 249382 w 903557"/>
                <a:gd name="connsiteY35" fmla="*/ 39756 h 531291"/>
                <a:gd name="connsiteX36" fmla="*/ 256610 w 903557"/>
                <a:gd name="connsiteY36" fmla="*/ 46985 h 531291"/>
                <a:gd name="connsiteX37" fmla="*/ 260224 w 903557"/>
                <a:gd name="connsiteY37" fmla="*/ 57827 h 531291"/>
                <a:gd name="connsiteX38" fmla="*/ 267453 w 903557"/>
                <a:gd name="connsiteY38" fmla="*/ 68670 h 531291"/>
                <a:gd name="connsiteX39" fmla="*/ 289138 w 903557"/>
                <a:gd name="connsiteY39" fmla="*/ 79513 h 531291"/>
                <a:gd name="connsiteX40" fmla="*/ 375880 w 903557"/>
                <a:gd name="connsiteY40" fmla="*/ 72284 h 531291"/>
                <a:gd name="connsiteX41" fmla="*/ 408408 w 903557"/>
                <a:gd name="connsiteY41" fmla="*/ 61441 h 531291"/>
                <a:gd name="connsiteX42" fmla="*/ 419250 w 903557"/>
                <a:gd name="connsiteY42" fmla="*/ 57827 h 531291"/>
                <a:gd name="connsiteX43" fmla="*/ 578276 w 903557"/>
                <a:gd name="connsiteY43" fmla="*/ 61441 h 531291"/>
                <a:gd name="connsiteX44" fmla="*/ 589119 w 903557"/>
                <a:gd name="connsiteY44" fmla="*/ 65056 h 531291"/>
                <a:gd name="connsiteX45" fmla="*/ 614419 w 903557"/>
                <a:gd name="connsiteY45" fmla="*/ 57827 h 531291"/>
                <a:gd name="connsiteX46" fmla="*/ 625261 w 903557"/>
                <a:gd name="connsiteY46" fmla="*/ 50599 h 531291"/>
                <a:gd name="connsiteX47" fmla="*/ 636104 w 903557"/>
                <a:gd name="connsiteY47" fmla="*/ 46985 h 531291"/>
                <a:gd name="connsiteX48" fmla="*/ 650561 w 903557"/>
                <a:gd name="connsiteY48" fmla="*/ 28913 h 531291"/>
                <a:gd name="connsiteX49" fmla="*/ 665018 w 903557"/>
                <a:gd name="connsiteY49" fmla="*/ 14456 h 531291"/>
                <a:gd name="connsiteX50" fmla="*/ 675861 w 903557"/>
                <a:gd name="connsiteY50" fmla="*/ 7228 h 531291"/>
                <a:gd name="connsiteX51" fmla="*/ 697546 w 903557"/>
                <a:gd name="connsiteY51" fmla="*/ 0 h 531291"/>
                <a:gd name="connsiteX52" fmla="*/ 719231 w 903557"/>
                <a:gd name="connsiteY52" fmla="*/ 7228 h 531291"/>
                <a:gd name="connsiteX53" fmla="*/ 733688 w 903557"/>
                <a:gd name="connsiteY53" fmla="*/ 21685 h 531291"/>
                <a:gd name="connsiteX54" fmla="*/ 740917 w 903557"/>
                <a:gd name="connsiteY54" fmla="*/ 43370 h 531291"/>
                <a:gd name="connsiteX55" fmla="*/ 744531 w 903557"/>
                <a:gd name="connsiteY55" fmla="*/ 97584 h 531291"/>
                <a:gd name="connsiteX56" fmla="*/ 762602 w 903557"/>
                <a:gd name="connsiteY56" fmla="*/ 104812 h 531291"/>
                <a:gd name="connsiteX57" fmla="*/ 798744 w 903557"/>
                <a:gd name="connsiteY57" fmla="*/ 112041 h 531291"/>
                <a:gd name="connsiteX58" fmla="*/ 816816 w 903557"/>
                <a:gd name="connsiteY58" fmla="*/ 115655 h 531291"/>
                <a:gd name="connsiteX59" fmla="*/ 827658 w 903557"/>
                <a:gd name="connsiteY59" fmla="*/ 119269 h 531291"/>
                <a:gd name="connsiteX60" fmla="*/ 842115 w 903557"/>
                <a:gd name="connsiteY60" fmla="*/ 137340 h 531291"/>
                <a:gd name="connsiteX61" fmla="*/ 860186 w 903557"/>
                <a:gd name="connsiteY61" fmla="*/ 151797 h 531291"/>
                <a:gd name="connsiteX62" fmla="*/ 881872 w 903557"/>
                <a:gd name="connsiteY62" fmla="*/ 180711 h 531291"/>
                <a:gd name="connsiteX63" fmla="*/ 885486 w 903557"/>
                <a:gd name="connsiteY63" fmla="*/ 231310 h 531291"/>
                <a:gd name="connsiteX64" fmla="*/ 881872 w 903557"/>
                <a:gd name="connsiteY64" fmla="*/ 242153 h 531291"/>
                <a:gd name="connsiteX65" fmla="*/ 874643 w 903557"/>
                <a:gd name="connsiteY65" fmla="*/ 249381 h 531291"/>
                <a:gd name="connsiteX66" fmla="*/ 852958 w 903557"/>
                <a:gd name="connsiteY66" fmla="*/ 256610 h 531291"/>
                <a:gd name="connsiteX67" fmla="*/ 852958 w 903557"/>
                <a:gd name="connsiteY67" fmla="*/ 307209 h 531291"/>
                <a:gd name="connsiteX68" fmla="*/ 860186 w 903557"/>
                <a:gd name="connsiteY68" fmla="*/ 318052 h 531291"/>
                <a:gd name="connsiteX69" fmla="*/ 867415 w 903557"/>
                <a:gd name="connsiteY69" fmla="*/ 339737 h 531291"/>
                <a:gd name="connsiteX70" fmla="*/ 878257 w 903557"/>
                <a:gd name="connsiteY70" fmla="*/ 361422 h 531291"/>
                <a:gd name="connsiteX71" fmla="*/ 885486 w 903557"/>
                <a:gd name="connsiteY71" fmla="*/ 372265 h 531291"/>
                <a:gd name="connsiteX72" fmla="*/ 896329 w 903557"/>
                <a:gd name="connsiteY72" fmla="*/ 390336 h 531291"/>
                <a:gd name="connsiteX73" fmla="*/ 903557 w 903557"/>
                <a:gd name="connsiteY73" fmla="*/ 415636 h 531291"/>
                <a:gd name="connsiteX74" fmla="*/ 899943 w 903557"/>
                <a:gd name="connsiteY74" fmla="*/ 430093 h 531291"/>
                <a:gd name="connsiteX75" fmla="*/ 896329 w 903557"/>
                <a:gd name="connsiteY75" fmla="*/ 440935 h 531291"/>
                <a:gd name="connsiteX76" fmla="*/ 889100 w 903557"/>
                <a:gd name="connsiteY76" fmla="*/ 484306 h 531291"/>
                <a:gd name="connsiteX77" fmla="*/ 881872 w 903557"/>
                <a:gd name="connsiteY77" fmla="*/ 505992 h 531291"/>
                <a:gd name="connsiteX78" fmla="*/ 860186 w 903557"/>
                <a:gd name="connsiteY78" fmla="*/ 516834 h 531291"/>
                <a:gd name="connsiteX79" fmla="*/ 827658 w 903557"/>
                <a:gd name="connsiteY79" fmla="*/ 513220 h 531291"/>
                <a:gd name="connsiteX80" fmla="*/ 816816 w 903557"/>
                <a:gd name="connsiteY80" fmla="*/ 505992 h 531291"/>
                <a:gd name="connsiteX81" fmla="*/ 802359 w 903557"/>
                <a:gd name="connsiteY81" fmla="*/ 487920 h 531291"/>
                <a:gd name="connsiteX82" fmla="*/ 798744 w 903557"/>
                <a:gd name="connsiteY82" fmla="*/ 477078 h 531291"/>
                <a:gd name="connsiteX83" fmla="*/ 791516 w 903557"/>
                <a:gd name="connsiteY83" fmla="*/ 469849 h 531291"/>
                <a:gd name="connsiteX84" fmla="*/ 769831 w 903557"/>
                <a:gd name="connsiteY84" fmla="*/ 440935 h 531291"/>
                <a:gd name="connsiteX85" fmla="*/ 762602 w 903557"/>
                <a:gd name="connsiteY85" fmla="*/ 433707 h 531291"/>
                <a:gd name="connsiteX86" fmla="*/ 740917 w 903557"/>
                <a:gd name="connsiteY86" fmla="*/ 451778 h 531291"/>
                <a:gd name="connsiteX87" fmla="*/ 719231 w 903557"/>
                <a:gd name="connsiteY87" fmla="*/ 466235 h 531291"/>
                <a:gd name="connsiteX88" fmla="*/ 697546 w 903557"/>
                <a:gd name="connsiteY88" fmla="*/ 473464 h 531291"/>
                <a:gd name="connsiteX89" fmla="*/ 686703 w 903557"/>
                <a:gd name="connsiteY89" fmla="*/ 477078 h 531291"/>
                <a:gd name="connsiteX90" fmla="*/ 672246 w 903557"/>
                <a:gd name="connsiteY90" fmla="*/ 459007 h 531291"/>
                <a:gd name="connsiteX91" fmla="*/ 668632 w 903557"/>
                <a:gd name="connsiteY91" fmla="*/ 448164 h 531291"/>
                <a:gd name="connsiteX92" fmla="*/ 657790 w 903557"/>
                <a:gd name="connsiteY92" fmla="*/ 422864 h 531291"/>
                <a:gd name="connsiteX93" fmla="*/ 665018 w 903557"/>
                <a:gd name="connsiteY93" fmla="*/ 386722 h 531291"/>
                <a:gd name="connsiteX94" fmla="*/ 672246 w 903557"/>
                <a:gd name="connsiteY94" fmla="*/ 365037 h 531291"/>
                <a:gd name="connsiteX95" fmla="*/ 675861 w 903557"/>
                <a:gd name="connsiteY95" fmla="*/ 354194 h 531291"/>
                <a:gd name="connsiteX96" fmla="*/ 672246 w 903557"/>
                <a:gd name="connsiteY96" fmla="*/ 343351 h 531291"/>
                <a:gd name="connsiteX97" fmla="*/ 650561 w 903557"/>
                <a:gd name="connsiteY97" fmla="*/ 350580 h 531291"/>
                <a:gd name="connsiteX98" fmla="*/ 639718 w 903557"/>
                <a:gd name="connsiteY98" fmla="*/ 354194 h 531291"/>
                <a:gd name="connsiteX99" fmla="*/ 603576 w 903557"/>
                <a:gd name="connsiteY99" fmla="*/ 350580 h 531291"/>
                <a:gd name="connsiteX100" fmla="*/ 589119 w 903557"/>
                <a:gd name="connsiteY100" fmla="*/ 336123 h 531291"/>
                <a:gd name="connsiteX101" fmla="*/ 581891 w 903557"/>
                <a:gd name="connsiteY101" fmla="*/ 299981 h 531291"/>
                <a:gd name="connsiteX102" fmla="*/ 578276 w 903557"/>
                <a:gd name="connsiteY102" fmla="*/ 281909 h 531291"/>
                <a:gd name="connsiteX103" fmla="*/ 571048 w 903557"/>
                <a:gd name="connsiteY103" fmla="*/ 224082 h 531291"/>
                <a:gd name="connsiteX104" fmla="*/ 549363 w 903557"/>
                <a:gd name="connsiteY104" fmla="*/ 198782 h 531291"/>
                <a:gd name="connsiteX105" fmla="*/ 538520 w 903557"/>
                <a:gd name="connsiteY105" fmla="*/ 195168 h 531291"/>
                <a:gd name="connsiteX106" fmla="*/ 509606 w 903557"/>
                <a:gd name="connsiteY106" fmla="*/ 187939 h 531291"/>
                <a:gd name="connsiteX107" fmla="*/ 469850 w 903557"/>
                <a:gd name="connsiteY107" fmla="*/ 180711 h 531291"/>
                <a:gd name="connsiteX108" fmla="*/ 437322 w 903557"/>
                <a:gd name="connsiteY108" fmla="*/ 184325 h 531291"/>
                <a:gd name="connsiteX109" fmla="*/ 422865 w 903557"/>
                <a:gd name="connsiteY109" fmla="*/ 191554 h 531291"/>
                <a:gd name="connsiteX110" fmla="*/ 408408 w 903557"/>
                <a:gd name="connsiteY110" fmla="*/ 195168 h 531291"/>
                <a:gd name="connsiteX111" fmla="*/ 386722 w 903557"/>
                <a:gd name="connsiteY111" fmla="*/ 202396 h 531291"/>
                <a:gd name="connsiteX112" fmla="*/ 372265 w 903557"/>
                <a:gd name="connsiteY112" fmla="*/ 220468 h 531291"/>
                <a:gd name="connsiteX113" fmla="*/ 361423 w 903557"/>
                <a:gd name="connsiteY113" fmla="*/ 238539 h 531291"/>
                <a:gd name="connsiteX114" fmla="*/ 357808 w 903557"/>
                <a:gd name="connsiteY114" fmla="*/ 249381 h 531291"/>
                <a:gd name="connsiteX115" fmla="*/ 350580 w 903557"/>
                <a:gd name="connsiteY115" fmla="*/ 256610 h 531291"/>
                <a:gd name="connsiteX116" fmla="*/ 343352 w 903557"/>
                <a:gd name="connsiteY116" fmla="*/ 278295 h 531291"/>
                <a:gd name="connsiteX117" fmla="*/ 336123 w 903557"/>
                <a:gd name="connsiteY117" fmla="*/ 299981 h 531291"/>
                <a:gd name="connsiteX118" fmla="*/ 332509 w 903557"/>
                <a:gd name="connsiteY118" fmla="*/ 310823 h 531291"/>
                <a:gd name="connsiteX119" fmla="*/ 321666 w 903557"/>
                <a:gd name="connsiteY119" fmla="*/ 339737 h 531291"/>
                <a:gd name="connsiteX120" fmla="*/ 303595 w 903557"/>
                <a:gd name="connsiteY120" fmla="*/ 350580 h 531291"/>
                <a:gd name="connsiteX121" fmla="*/ 281910 w 903557"/>
                <a:gd name="connsiteY121" fmla="*/ 361422 h 531291"/>
                <a:gd name="connsiteX122" fmla="*/ 274681 w 903557"/>
                <a:gd name="connsiteY122" fmla="*/ 383108 h 531291"/>
                <a:gd name="connsiteX123" fmla="*/ 271067 w 903557"/>
                <a:gd name="connsiteY123" fmla="*/ 397565 h 531291"/>
                <a:gd name="connsiteX124" fmla="*/ 256610 w 903557"/>
                <a:gd name="connsiteY124" fmla="*/ 419250 h 531291"/>
                <a:gd name="connsiteX125" fmla="*/ 242153 w 903557"/>
                <a:gd name="connsiteY125" fmla="*/ 437321 h 531291"/>
                <a:gd name="connsiteX126" fmla="*/ 216854 w 903557"/>
                <a:gd name="connsiteY126" fmla="*/ 455392 h 531291"/>
                <a:gd name="connsiteX127" fmla="*/ 209625 w 903557"/>
                <a:gd name="connsiteY127" fmla="*/ 462621 h 531291"/>
                <a:gd name="connsiteX128" fmla="*/ 202397 w 903557"/>
                <a:gd name="connsiteY128" fmla="*/ 473464 h 531291"/>
                <a:gd name="connsiteX129" fmla="*/ 191554 w 903557"/>
                <a:gd name="connsiteY129" fmla="*/ 480692 h 531291"/>
                <a:gd name="connsiteX130" fmla="*/ 166254 w 903557"/>
                <a:gd name="connsiteY130" fmla="*/ 498763 h 531291"/>
                <a:gd name="connsiteX131" fmla="*/ 151797 w 903557"/>
                <a:gd name="connsiteY131" fmla="*/ 502377 h 531291"/>
                <a:gd name="connsiteX132" fmla="*/ 93970 w 903557"/>
                <a:gd name="connsiteY132" fmla="*/ 505992 h 531291"/>
                <a:gd name="connsiteX133" fmla="*/ 75899 w 903557"/>
                <a:gd name="connsiteY133" fmla="*/ 509606 h 531291"/>
                <a:gd name="connsiteX134" fmla="*/ 54213 w 903557"/>
                <a:gd name="connsiteY134" fmla="*/ 516834 h 531291"/>
                <a:gd name="connsiteX135" fmla="*/ 18071 w 903557"/>
                <a:gd name="connsiteY135" fmla="*/ 531291 h 53129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</a:cxnLst>
              <a:rect l="l" t="t" r="r" b="b"/>
              <a:pathLst>
                <a:path w="903557" h="531291">
                  <a:moveTo>
                    <a:pt x="18071" y="531291"/>
                  </a:moveTo>
                  <a:lnTo>
                    <a:pt x="18071" y="531291"/>
                  </a:lnTo>
                  <a:cubicBezTo>
                    <a:pt x="10913" y="516975"/>
                    <a:pt x="0" y="501489"/>
                    <a:pt x="0" y="484306"/>
                  </a:cubicBezTo>
                  <a:cubicBezTo>
                    <a:pt x="0" y="479339"/>
                    <a:pt x="2640" y="474720"/>
                    <a:pt x="3614" y="469849"/>
                  </a:cubicBezTo>
                  <a:cubicBezTo>
                    <a:pt x="5051" y="462663"/>
                    <a:pt x="6192" y="455418"/>
                    <a:pt x="7228" y="448164"/>
                  </a:cubicBezTo>
                  <a:cubicBezTo>
                    <a:pt x="12927" y="408266"/>
                    <a:pt x="6876" y="431150"/>
                    <a:pt x="18071" y="397565"/>
                  </a:cubicBezTo>
                  <a:lnTo>
                    <a:pt x="28914" y="365037"/>
                  </a:lnTo>
                  <a:lnTo>
                    <a:pt x="32528" y="354194"/>
                  </a:lnTo>
                  <a:lnTo>
                    <a:pt x="36142" y="343351"/>
                  </a:lnTo>
                  <a:cubicBezTo>
                    <a:pt x="34937" y="334918"/>
                    <a:pt x="34199" y="326405"/>
                    <a:pt x="32528" y="318052"/>
                  </a:cubicBezTo>
                  <a:cubicBezTo>
                    <a:pt x="31781" y="314316"/>
                    <a:pt x="31294" y="310184"/>
                    <a:pt x="28914" y="307209"/>
                  </a:cubicBezTo>
                  <a:cubicBezTo>
                    <a:pt x="26200" y="303817"/>
                    <a:pt x="21463" y="302694"/>
                    <a:pt x="18071" y="299981"/>
                  </a:cubicBezTo>
                  <a:cubicBezTo>
                    <a:pt x="15410" y="297852"/>
                    <a:pt x="13252" y="295162"/>
                    <a:pt x="10842" y="292752"/>
                  </a:cubicBezTo>
                  <a:lnTo>
                    <a:pt x="3614" y="271067"/>
                  </a:lnTo>
                  <a:lnTo>
                    <a:pt x="0" y="260224"/>
                  </a:lnTo>
                  <a:cubicBezTo>
                    <a:pt x="1205" y="255405"/>
                    <a:pt x="2640" y="250638"/>
                    <a:pt x="3614" y="245767"/>
                  </a:cubicBezTo>
                  <a:cubicBezTo>
                    <a:pt x="5679" y="235440"/>
                    <a:pt x="7936" y="216667"/>
                    <a:pt x="10842" y="206011"/>
                  </a:cubicBezTo>
                  <a:cubicBezTo>
                    <a:pt x="12847" y="198660"/>
                    <a:pt x="13844" y="190665"/>
                    <a:pt x="18071" y="184325"/>
                  </a:cubicBezTo>
                  <a:cubicBezTo>
                    <a:pt x="25713" y="172862"/>
                    <a:pt x="30685" y="163868"/>
                    <a:pt x="43371" y="155411"/>
                  </a:cubicBezTo>
                  <a:cubicBezTo>
                    <a:pt x="46985" y="153002"/>
                    <a:pt x="50244" y="149947"/>
                    <a:pt x="54213" y="148183"/>
                  </a:cubicBezTo>
                  <a:cubicBezTo>
                    <a:pt x="61176" y="145088"/>
                    <a:pt x="69559" y="145181"/>
                    <a:pt x="75899" y="140954"/>
                  </a:cubicBezTo>
                  <a:cubicBezTo>
                    <a:pt x="89911" y="131613"/>
                    <a:pt x="82620" y="135099"/>
                    <a:pt x="97584" y="130112"/>
                  </a:cubicBezTo>
                  <a:lnTo>
                    <a:pt x="119269" y="108426"/>
                  </a:lnTo>
                  <a:lnTo>
                    <a:pt x="126498" y="101198"/>
                  </a:lnTo>
                  <a:lnTo>
                    <a:pt x="133726" y="93969"/>
                  </a:lnTo>
                  <a:cubicBezTo>
                    <a:pt x="136136" y="86741"/>
                    <a:pt x="136729" y="78624"/>
                    <a:pt x="140955" y="72284"/>
                  </a:cubicBezTo>
                  <a:cubicBezTo>
                    <a:pt x="143364" y="68670"/>
                    <a:pt x="146240" y="65326"/>
                    <a:pt x="148183" y="61441"/>
                  </a:cubicBezTo>
                  <a:cubicBezTo>
                    <a:pt x="157565" y="42675"/>
                    <a:pt x="144907" y="57489"/>
                    <a:pt x="159026" y="43370"/>
                  </a:cubicBezTo>
                  <a:cubicBezTo>
                    <a:pt x="161435" y="38551"/>
                    <a:pt x="163021" y="33223"/>
                    <a:pt x="166254" y="28913"/>
                  </a:cubicBezTo>
                  <a:cubicBezTo>
                    <a:pt x="170343" y="23461"/>
                    <a:pt x="175892" y="19275"/>
                    <a:pt x="180711" y="14456"/>
                  </a:cubicBezTo>
                  <a:cubicBezTo>
                    <a:pt x="191009" y="4159"/>
                    <a:pt x="185108" y="9116"/>
                    <a:pt x="198782" y="0"/>
                  </a:cubicBezTo>
                  <a:cubicBezTo>
                    <a:pt x="202396" y="1205"/>
                    <a:pt x="206358" y="1654"/>
                    <a:pt x="209625" y="3614"/>
                  </a:cubicBezTo>
                  <a:cubicBezTo>
                    <a:pt x="234433" y="18497"/>
                    <a:pt x="196980" y="4217"/>
                    <a:pt x="227696" y="14456"/>
                  </a:cubicBezTo>
                  <a:cubicBezTo>
                    <a:pt x="230106" y="16866"/>
                    <a:pt x="232264" y="19556"/>
                    <a:pt x="234925" y="21685"/>
                  </a:cubicBezTo>
                  <a:cubicBezTo>
                    <a:pt x="238317" y="24398"/>
                    <a:pt x="243054" y="25521"/>
                    <a:pt x="245767" y="28913"/>
                  </a:cubicBezTo>
                  <a:cubicBezTo>
                    <a:pt x="248147" y="31888"/>
                    <a:pt x="247422" y="36489"/>
                    <a:pt x="249382" y="39756"/>
                  </a:cubicBezTo>
                  <a:cubicBezTo>
                    <a:pt x="251135" y="42678"/>
                    <a:pt x="254201" y="44575"/>
                    <a:pt x="256610" y="46985"/>
                  </a:cubicBezTo>
                  <a:cubicBezTo>
                    <a:pt x="257815" y="50599"/>
                    <a:pt x="258520" y="54420"/>
                    <a:pt x="260224" y="57827"/>
                  </a:cubicBezTo>
                  <a:cubicBezTo>
                    <a:pt x="262167" y="61712"/>
                    <a:pt x="264381" y="65598"/>
                    <a:pt x="267453" y="68670"/>
                  </a:cubicBezTo>
                  <a:cubicBezTo>
                    <a:pt x="274458" y="75675"/>
                    <a:pt x="280320" y="76573"/>
                    <a:pt x="289138" y="79513"/>
                  </a:cubicBezTo>
                  <a:cubicBezTo>
                    <a:pt x="313941" y="78207"/>
                    <a:pt x="348732" y="79687"/>
                    <a:pt x="375880" y="72284"/>
                  </a:cubicBezTo>
                  <a:cubicBezTo>
                    <a:pt x="375918" y="72274"/>
                    <a:pt x="402969" y="63254"/>
                    <a:pt x="408408" y="61441"/>
                  </a:cubicBezTo>
                  <a:lnTo>
                    <a:pt x="419250" y="57827"/>
                  </a:lnTo>
                  <a:lnTo>
                    <a:pt x="578276" y="61441"/>
                  </a:lnTo>
                  <a:cubicBezTo>
                    <a:pt x="582082" y="61603"/>
                    <a:pt x="585309" y="65056"/>
                    <a:pt x="589119" y="65056"/>
                  </a:cubicBezTo>
                  <a:cubicBezTo>
                    <a:pt x="593653" y="65056"/>
                    <a:pt x="609309" y="59530"/>
                    <a:pt x="614419" y="57827"/>
                  </a:cubicBezTo>
                  <a:cubicBezTo>
                    <a:pt x="618033" y="55418"/>
                    <a:pt x="621376" y="52541"/>
                    <a:pt x="625261" y="50599"/>
                  </a:cubicBezTo>
                  <a:cubicBezTo>
                    <a:pt x="628669" y="48895"/>
                    <a:pt x="632837" y="48945"/>
                    <a:pt x="636104" y="46985"/>
                  </a:cubicBezTo>
                  <a:cubicBezTo>
                    <a:pt x="643343" y="42642"/>
                    <a:pt x="645345" y="34998"/>
                    <a:pt x="650561" y="28913"/>
                  </a:cubicBezTo>
                  <a:cubicBezTo>
                    <a:pt x="654996" y="23739"/>
                    <a:pt x="659347" y="18236"/>
                    <a:pt x="665018" y="14456"/>
                  </a:cubicBezTo>
                  <a:cubicBezTo>
                    <a:pt x="668632" y="12047"/>
                    <a:pt x="671892" y="8992"/>
                    <a:pt x="675861" y="7228"/>
                  </a:cubicBezTo>
                  <a:cubicBezTo>
                    <a:pt x="682824" y="4134"/>
                    <a:pt x="697546" y="0"/>
                    <a:pt x="697546" y="0"/>
                  </a:cubicBezTo>
                  <a:cubicBezTo>
                    <a:pt x="704774" y="2409"/>
                    <a:pt x="713843" y="1840"/>
                    <a:pt x="719231" y="7228"/>
                  </a:cubicBezTo>
                  <a:lnTo>
                    <a:pt x="733688" y="21685"/>
                  </a:lnTo>
                  <a:cubicBezTo>
                    <a:pt x="736098" y="28913"/>
                    <a:pt x="740410" y="35767"/>
                    <a:pt x="740917" y="43370"/>
                  </a:cubicBezTo>
                  <a:cubicBezTo>
                    <a:pt x="742122" y="61441"/>
                    <a:pt x="738503" y="80505"/>
                    <a:pt x="744531" y="97584"/>
                  </a:cubicBezTo>
                  <a:cubicBezTo>
                    <a:pt x="746690" y="103702"/>
                    <a:pt x="756333" y="103140"/>
                    <a:pt x="762602" y="104812"/>
                  </a:cubicBezTo>
                  <a:cubicBezTo>
                    <a:pt x="774473" y="107978"/>
                    <a:pt x="786697" y="109631"/>
                    <a:pt x="798744" y="112041"/>
                  </a:cubicBezTo>
                  <a:cubicBezTo>
                    <a:pt x="804768" y="113246"/>
                    <a:pt x="810988" y="113712"/>
                    <a:pt x="816816" y="115655"/>
                  </a:cubicBezTo>
                  <a:lnTo>
                    <a:pt x="827658" y="119269"/>
                  </a:lnTo>
                  <a:cubicBezTo>
                    <a:pt x="845113" y="136724"/>
                    <a:pt x="823877" y="114543"/>
                    <a:pt x="842115" y="137340"/>
                  </a:cubicBezTo>
                  <a:cubicBezTo>
                    <a:pt x="848001" y="144697"/>
                    <a:pt x="852135" y="146430"/>
                    <a:pt x="860186" y="151797"/>
                  </a:cubicBezTo>
                  <a:cubicBezTo>
                    <a:pt x="876533" y="176318"/>
                    <a:pt x="868499" y="167340"/>
                    <a:pt x="881872" y="180711"/>
                  </a:cubicBezTo>
                  <a:cubicBezTo>
                    <a:pt x="891120" y="208455"/>
                    <a:pt x="891386" y="198858"/>
                    <a:pt x="885486" y="231310"/>
                  </a:cubicBezTo>
                  <a:cubicBezTo>
                    <a:pt x="884805" y="235058"/>
                    <a:pt x="883832" y="238886"/>
                    <a:pt x="881872" y="242153"/>
                  </a:cubicBezTo>
                  <a:cubicBezTo>
                    <a:pt x="880119" y="245075"/>
                    <a:pt x="877691" y="247857"/>
                    <a:pt x="874643" y="249381"/>
                  </a:cubicBezTo>
                  <a:cubicBezTo>
                    <a:pt x="867828" y="252789"/>
                    <a:pt x="852958" y="256610"/>
                    <a:pt x="852958" y="256610"/>
                  </a:cubicBezTo>
                  <a:cubicBezTo>
                    <a:pt x="846072" y="277267"/>
                    <a:pt x="845729" y="273470"/>
                    <a:pt x="852958" y="307209"/>
                  </a:cubicBezTo>
                  <a:cubicBezTo>
                    <a:pt x="853868" y="311456"/>
                    <a:pt x="858422" y="314083"/>
                    <a:pt x="860186" y="318052"/>
                  </a:cubicBezTo>
                  <a:cubicBezTo>
                    <a:pt x="863281" y="325015"/>
                    <a:pt x="863189" y="333397"/>
                    <a:pt x="867415" y="339737"/>
                  </a:cubicBezTo>
                  <a:cubicBezTo>
                    <a:pt x="888137" y="370822"/>
                    <a:pt x="863289" y="331487"/>
                    <a:pt x="878257" y="361422"/>
                  </a:cubicBezTo>
                  <a:cubicBezTo>
                    <a:pt x="880200" y="365307"/>
                    <a:pt x="883076" y="368651"/>
                    <a:pt x="885486" y="372265"/>
                  </a:cubicBezTo>
                  <a:cubicBezTo>
                    <a:pt x="895724" y="402982"/>
                    <a:pt x="881445" y="365530"/>
                    <a:pt x="896329" y="390336"/>
                  </a:cubicBezTo>
                  <a:cubicBezTo>
                    <a:pt x="898551" y="394039"/>
                    <a:pt x="902882" y="412937"/>
                    <a:pt x="903557" y="415636"/>
                  </a:cubicBezTo>
                  <a:cubicBezTo>
                    <a:pt x="902352" y="420455"/>
                    <a:pt x="901308" y="425317"/>
                    <a:pt x="899943" y="430093"/>
                  </a:cubicBezTo>
                  <a:cubicBezTo>
                    <a:pt x="898896" y="433756"/>
                    <a:pt x="897076" y="437199"/>
                    <a:pt x="896329" y="440935"/>
                  </a:cubicBezTo>
                  <a:cubicBezTo>
                    <a:pt x="893455" y="455307"/>
                    <a:pt x="893734" y="470402"/>
                    <a:pt x="889100" y="484306"/>
                  </a:cubicBezTo>
                  <a:cubicBezTo>
                    <a:pt x="886691" y="491535"/>
                    <a:pt x="888212" y="501766"/>
                    <a:pt x="881872" y="505992"/>
                  </a:cubicBezTo>
                  <a:cubicBezTo>
                    <a:pt x="867859" y="515333"/>
                    <a:pt x="875150" y="511846"/>
                    <a:pt x="860186" y="516834"/>
                  </a:cubicBezTo>
                  <a:cubicBezTo>
                    <a:pt x="849343" y="515629"/>
                    <a:pt x="838242" y="515866"/>
                    <a:pt x="827658" y="513220"/>
                  </a:cubicBezTo>
                  <a:cubicBezTo>
                    <a:pt x="823444" y="512167"/>
                    <a:pt x="820208" y="508705"/>
                    <a:pt x="816816" y="505992"/>
                  </a:cubicBezTo>
                  <a:cubicBezTo>
                    <a:pt x="811212" y="501509"/>
                    <a:pt x="805491" y="494184"/>
                    <a:pt x="802359" y="487920"/>
                  </a:cubicBezTo>
                  <a:cubicBezTo>
                    <a:pt x="800655" y="484513"/>
                    <a:pt x="800704" y="480345"/>
                    <a:pt x="798744" y="477078"/>
                  </a:cubicBezTo>
                  <a:cubicBezTo>
                    <a:pt x="796991" y="474156"/>
                    <a:pt x="793925" y="472259"/>
                    <a:pt x="791516" y="469849"/>
                  </a:cubicBezTo>
                  <a:cubicBezTo>
                    <a:pt x="785208" y="450926"/>
                    <a:pt x="790595" y="461699"/>
                    <a:pt x="769831" y="440935"/>
                  </a:cubicBezTo>
                  <a:lnTo>
                    <a:pt x="762602" y="433707"/>
                  </a:lnTo>
                  <a:cubicBezTo>
                    <a:pt x="736843" y="459466"/>
                    <a:pt x="766077" y="431650"/>
                    <a:pt x="740917" y="451778"/>
                  </a:cubicBezTo>
                  <a:cubicBezTo>
                    <a:pt x="727126" y="462811"/>
                    <a:pt x="741087" y="457492"/>
                    <a:pt x="719231" y="466235"/>
                  </a:cubicBezTo>
                  <a:cubicBezTo>
                    <a:pt x="712157" y="469065"/>
                    <a:pt x="704774" y="471054"/>
                    <a:pt x="697546" y="473464"/>
                  </a:cubicBezTo>
                  <a:lnTo>
                    <a:pt x="686703" y="477078"/>
                  </a:lnTo>
                  <a:cubicBezTo>
                    <a:pt x="679982" y="470356"/>
                    <a:pt x="676804" y="468122"/>
                    <a:pt x="672246" y="459007"/>
                  </a:cubicBezTo>
                  <a:cubicBezTo>
                    <a:pt x="670542" y="455599"/>
                    <a:pt x="670133" y="451666"/>
                    <a:pt x="668632" y="448164"/>
                  </a:cubicBezTo>
                  <a:cubicBezTo>
                    <a:pt x="655234" y="416901"/>
                    <a:pt x="666266" y="448293"/>
                    <a:pt x="657790" y="422864"/>
                  </a:cubicBezTo>
                  <a:cubicBezTo>
                    <a:pt x="660232" y="408211"/>
                    <a:pt x="660975" y="400200"/>
                    <a:pt x="665018" y="386722"/>
                  </a:cubicBezTo>
                  <a:cubicBezTo>
                    <a:pt x="667207" y="379424"/>
                    <a:pt x="669837" y="372265"/>
                    <a:pt x="672246" y="365037"/>
                  </a:cubicBezTo>
                  <a:lnTo>
                    <a:pt x="675861" y="354194"/>
                  </a:lnTo>
                  <a:cubicBezTo>
                    <a:pt x="674656" y="350580"/>
                    <a:pt x="676018" y="343890"/>
                    <a:pt x="672246" y="343351"/>
                  </a:cubicBezTo>
                  <a:cubicBezTo>
                    <a:pt x="664703" y="342274"/>
                    <a:pt x="657789" y="348170"/>
                    <a:pt x="650561" y="350580"/>
                  </a:cubicBezTo>
                  <a:lnTo>
                    <a:pt x="639718" y="354194"/>
                  </a:lnTo>
                  <a:cubicBezTo>
                    <a:pt x="627671" y="352989"/>
                    <a:pt x="614978" y="354652"/>
                    <a:pt x="603576" y="350580"/>
                  </a:cubicBezTo>
                  <a:cubicBezTo>
                    <a:pt x="597158" y="348288"/>
                    <a:pt x="589119" y="336123"/>
                    <a:pt x="589119" y="336123"/>
                  </a:cubicBezTo>
                  <a:cubicBezTo>
                    <a:pt x="582192" y="315339"/>
                    <a:pt x="587429" y="333209"/>
                    <a:pt x="581891" y="299981"/>
                  </a:cubicBezTo>
                  <a:cubicBezTo>
                    <a:pt x="580881" y="293921"/>
                    <a:pt x="579145" y="287991"/>
                    <a:pt x="578276" y="281909"/>
                  </a:cubicBezTo>
                  <a:cubicBezTo>
                    <a:pt x="575529" y="262679"/>
                    <a:pt x="581823" y="240246"/>
                    <a:pt x="571048" y="224082"/>
                  </a:cubicBezTo>
                  <a:cubicBezTo>
                    <a:pt x="566423" y="217144"/>
                    <a:pt x="556876" y="201286"/>
                    <a:pt x="549363" y="198782"/>
                  </a:cubicBezTo>
                  <a:cubicBezTo>
                    <a:pt x="545749" y="197577"/>
                    <a:pt x="542196" y="196170"/>
                    <a:pt x="538520" y="195168"/>
                  </a:cubicBezTo>
                  <a:cubicBezTo>
                    <a:pt x="528935" y="192554"/>
                    <a:pt x="519348" y="189887"/>
                    <a:pt x="509606" y="187939"/>
                  </a:cubicBezTo>
                  <a:cubicBezTo>
                    <a:pt x="484349" y="182888"/>
                    <a:pt x="497594" y="185335"/>
                    <a:pt x="469850" y="180711"/>
                  </a:cubicBezTo>
                  <a:cubicBezTo>
                    <a:pt x="459007" y="181916"/>
                    <a:pt x="447952" y="181872"/>
                    <a:pt x="437322" y="184325"/>
                  </a:cubicBezTo>
                  <a:cubicBezTo>
                    <a:pt x="432072" y="185537"/>
                    <a:pt x="427910" y="189662"/>
                    <a:pt x="422865" y="191554"/>
                  </a:cubicBezTo>
                  <a:cubicBezTo>
                    <a:pt x="418214" y="193298"/>
                    <a:pt x="413166" y="193741"/>
                    <a:pt x="408408" y="195168"/>
                  </a:cubicBezTo>
                  <a:cubicBezTo>
                    <a:pt x="401110" y="197357"/>
                    <a:pt x="386722" y="202396"/>
                    <a:pt x="386722" y="202396"/>
                  </a:cubicBezTo>
                  <a:cubicBezTo>
                    <a:pt x="380000" y="209119"/>
                    <a:pt x="376824" y="211351"/>
                    <a:pt x="372265" y="220468"/>
                  </a:cubicBezTo>
                  <a:cubicBezTo>
                    <a:pt x="362880" y="239236"/>
                    <a:pt x="375542" y="224418"/>
                    <a:pt x="361423" y="238539"/>
                  </a:cubicBezTo>
                  <a:cubicBezTo>
                    <a:pt x="360218" y="242153"/>
                    <a:pt x="359768" y="246114"/>
                    <a:pt x="357808" y="249381"/>
                  </a:cubicBezTo>
                  <a:cubicBezTo>
                    <a:pt x="356055" y="252303"/>
                    <a:pt x="352104" y="253562"/>
                    <a:pt x="350580" y="256610"/>
                  </a:cubicBezTo>
                  <a:cubicBezTo>
                    <a:pt x="347173" y="263425"/>
                    <a:pt x="345761" y="271067"/>
                    <a:pt x="343352" y="278295"/>
                  </a:cubicBezTo>
                  <a:lnTo>
                    <a:pt x="336123" y="299981"/>
                  </a:lnTo>
                  <a:cubicBezTo>
                    <a:pt x="334918" y="303595"/>
                    <a:pt x="333256" y="307087"/>
                    <a:pt x="332509" y="310823"/>
                  </a:cubicBezTo>
                  <a:cubicBezTo>
                    <a:pt x="329045" y="328142"/>
                    <a:pt x="331594" y="327327"/>
                    <a:pt x="321666" y="339737"/>
                  </a:cubicBezTo>
                  <a:cubicBezTo>
                    <a:pt x="312253" y="351504"/>
                    <a:pt x="317102" y="343827"/>
                    <a:pt x="303595" y="350580"/>
                  </a:cubicBezTo>
                  <a:cubicBezTo>
                    <a:pt x="275567" y="364593"/>
                    <a:pt x="309164" y="352337"/>
                    <a:pt x="281910" y="361422"/>
                  </a:cubicBezTo>
                  <a:cubicBezTo>
                    <a:pt x="279500" y="368651"/>
                    <a:pt x="276529" y="375716"/>
                    <a:pt x="274681" y="383108"/>
                  </a:cubicBezTo>
                  <a:cubicBezTo>
                    <a:pt x="273476" y="387927"/>
                    <a:pt x="273288" y="393122"/>
                    <a:pt x="271067" y="397565"/>
                  </a:cubicBezTo>
                  <a:cubicBezTo>
                    <a:pt x="267182" y="405335"/>
                    <a:pt x="256610" y="419250"/>
                    <a:pt x="256610" y="419250"/>
                  </a:cubicBezTo>
                  <a:cubicBezTo>
                    <a:pt x="250530" y="437492"/>
                    <a:pt x="257412" y="424243"/>
                    <a:pt x="242153" y="437321"/>
                  </a:cubicBezTo>
                  <a:cubicBezTo>
                    <a:pt x="220324" y="456031"/>
                    <a:pt x="236777" y="448751"/>
                    <a:pt x="216854" y="455392"/>
                  </a:cubicBezTo>
                  <a:cubicBezTo>
                    <a:pt x="214444" y="457802"/>
                    <a:pt x="211754" y="459960"/>
                    <a:pt x="209625" y="462621"/>
                  </a:cubicBezTo>
                  <a:cubicBezTo>
                    <a:pt x="206912" y="466013"/>
                    <a:pt x="205469" y="470392"/>
                    <a:pt x="202397" y="473464"/>
                  </a:cubicBezTo>
                  <a:cubicBezTo>
                    <a:pt x="199325" y="476536"/>
                    <a:pt x="194852" y="477865"/>
                    <a:pt x="191554" y="480692"/>
                  </a:cubicBezTo>
                  <a:cubicBezTo>
                    <a:pt x="172694" y="496857"/>
                    <a:pt x="184518" y="493545"/>
                    <a:pt x="166254" y="498763"/>
                  </a:cubicBezTo>
                  <a:cubicBezTo>
                    <a:pt x="161478" y="500128"/>
                    <a:pt x="156740" y="501883"/>
                    <a:pt x="151797" y="502377"/>
                  </a:cubicBezTo>
                  <a:cubicBezTo>
                    <a:pt x="132580" y="504299"/>
                    <a:pt x="113246" y="504787"/>
                    <a:pt x="93970" y="505992"/>
                  </a:cubicBezTo>
                  <a:cubicBezTo>
                    <a:pt x="87946" y="507197"/>
                    <a:pt x="81826" y="507990"/>
                    <a:pt x="75899" y="509606"/>
                  </a:cubicBezTo>
                  <a:cubicBezTo>
                    <a:pt x="68548" y="511611"/>
                    <a:pt x="61795" y="516076"/>
                    <a:pt x="54213" y="516834"/>
                  </a:cubicBezTo>
                  <a:cubicBezTo>
                    <a:pt x="15673" y="520689"/>
                    <a:pt x="24095" y="528882"/>
                    <a:pt x="18071" y="531291"/>
                  </a:cubicBezTo>
                  <a:close/>
                </a:path>
              </a:pathLst>
            </a:cu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94" name="円/楕円 193">
              <a:extLst>
                <a:ext uri="{FF2B5EF4-FFF2-40B4-BE49-F238E27FC236}">
                  <a16:creationId xmlns="" xmlns:a16="http://schemas.microsoft.com/office/drawing/2014/main" id="{947DFD4F-DF32-ED45-B259-D5B811D61874}"/>
                </a:ext>
              </a:extLst>
            </p:cNvPr>
            <p:cNvSpPr/>
            <p:nvPr/>
          </p:nvSpPr>
          <p:spPr>
            <a:xfrm>
              <a:off x="2312025" y="3480475"/>
              <a:ext cx="128550" cy="130753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95" name="円/楕円 194">
              <a:extLst>
                <a:ext uri="{FF2B5EF4-FFF2-40B4-BE49-F238E27FC236}">
                  <a16:creationId xmlns="" xmlns:a16="http://schemas.microsoft.com/office/drawing/2014/main" id="{DB218EC8-4FFA-0C47-9B6A-1FA9228B0C36}"/>
                </a:ext>
              </a:extLst>
            </p:cNvPr>
            <p:cNvSpPr/>
            <p:nvPr/>
          </p:nvSpPr>
          <p:spPr>
            <a:xfrm>
              <a:off x="2792013" y="3429310"/>
              <a:ext cx="128550" cy="130753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96" name="円/楕円 195">
              <a:extLst>
                <a:ext uri="{FF2B5EF4-FFF2-40B4-BE49-F238E27FC236}">
                  <a16:creationId xmlns="" xmlns:a16="http://schemas.microsoft.com/office/drawing/2014/main" id="{121F75A4-7BEC-BA44-BE71-782E85D9DF10}"/>
                </a:ext>
              </a:extLst>
            </p:cNvPr>
            <p:cNvSpPr/>
            <p:nvPr/>
          </p:nvSpPr>
          <p:spPr>
            <a:xfrm>
              <a:off x="2959561" y="3578747"/>
              <a:ext cx="128550" cy="130753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197" name="グラフィックス 196" descr="はさみ">
              <a:extLst>
                <a:ext uri="{FF2B5EF4-FFF2-40B4-BE49-F238E27FC236}">
                  <a16:creationId xmlns="" xmlns:a16="http://schemas.microsoft.com/office/drawing/2014/main" id="{CDD853BA-3BED-5448-9421-F1DC3D4260D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96DAC541-7B7A-43D3-8B79-37D633B846F1}">
                  <asvg:svgBlip xmlns=""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 rot="16200000">
              <a:off x="1990191" y="3221365"/>
              <a:ext cx="438786" cy="438786"/>
            </a:xfrm>
            <a:prstGeom prst="rect">
              <a:avLst/>
            </a:prstGeom>
          </p:spPr>
        </p:pic>
        <p:sp>
          <p:nvSpPr>
            <p:cNvPr id="222" name="円/楕円 221">
              <a:extLst>
                <a:ext uri="{FF2B5EF4-FFF2-40B4-BE49-F238E27FC236}">
                  <a16:creationId xmlns="" xmlns:a16="http://schemas.microsoft.com/office/drawing/2014/main" id="{0A74649D-F903-E94C-B4A2-3107DF0131F7}"/>
                </a:ext>
              </a:extLst>
            </p:cNvPr>
            <p:cNvSpPr/>
            <p:nvPr/>
          </p:nvSpPr>
          <p:spPr>
            <a:xfrm>
              <a:off x="2202040" y="3792054"/>
              <a:ext cx="128550" cy="130753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3" name="円/楕円 222">
              <a:extLst>
                <a:ext uri="{FF2B5EF4-FFF2-40B4-BE49-F238E27FC236}">
                  <a16:creationId xmlns="" xmlns:a16="http://schemas.microsoft.com/office/drawing/2014/main" id="{F8402EA0-F23F-E943-92B2-7FE32EC812D6}"/>
                </a:ext>
              </a:extLst>
            </p:cNvPr>
            <p:cNvSpPr/>
            <p:nvPr/>
          </p:nvSpPr>
          <p:spPr>
            <a:xfrm>
              <a:off x="2456905" y="3638593"/>
              <a:ext cx="128550" cy="130753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4" name="円/楕円 223">
              <a:extLst>
                <a:ext uri="{FF2B5EF4-FFF2-40B4-BE49-F238E27FC236}">
                  <a16:creationId xmlns="" xmlns:a16="http://schemas.microsoft.com/office/drawing/2014/main" id="{28C75D61-DEB5-3846-8A2C-A057D8E56D9D}"/>
                </a:ext>
              </a:extLst>
            </p:cNvPr>
            <p:cNvSpPr/>
            <p:nvPr/>
          </p:nvSpPr>
          <p:spPr>
            <a:xfrm>
              <a:off x="2515315" y="3375995"/>
              <a:ext cx="128550" cy="130753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1" name="円/楕円 230">
              <a:extLst>
                <a:ext uri="{FF2B5EF4-FFF2-40B4-BE49-F238E27FC236}">
                  <a16:creationId xmlns="" xmlns:a16="http://schemas.microsoft.com/office/drawing/2014/main" id="{89D00E8D-730C-BC47-AD97-5EC1611B2EF0}"/>
                </a:ext>
              </a:extLst>
            </p:cNvPr>
            <p:cNvSpPr/>
            <p:nvPr/>
          </p:nvSpPr>
          <p:spPr>
            <a:xfrm>
              <a:off x="3038967" y="3875184"/>
              <a:ext cx="128550" cy="130753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25" name="グループ化 1">
            <a:extLst>
              <a:ext uri="{FF2B5EF4-FFF2-40B4-BE49-F238E27FC236}">
                <a16:creationId xmlns="" xmlns:a16="http://schemas.microsoft.com/office/drawing/2014/main" id="{4FE69DB3-C072-4247-B2CE-9953108563C4}"/>
              </a:ext>
            </a:extLst>
          </p:cNvPr>
          <p:cNvGrpSpPr/>
          <p:nvPr/>
        </p:nvGrpSpPr>
        <p:grpSpPr>
          <a:xfrm>
            <a:off x="842028" y="7223957"/>
            <a:ext cx="1443818" cy="2141595"/>
            <a:chOff x="5999578" y="1211014"/>
            <a:chExt cx="1443818" cy="2141595"/>
          </a:xfrm>
        </p:grpSpPr>
        <p:sp>
          <p:nvSpPr>
            <p:cNvPr id="126" name="テキスト ボックス 125">
              <a:extLst>
                <a:ext uri="{FF2B5EF4-FFF2-40B4-BE49-F238E27FC236}">
                  <a16:creationId xmlns="" xmlns:a16="http://schemas.microsoft.com/office/drawing/2014/main" id="{2EB6DD62-3309-6144-9FEB-B0E4BB91545D}"/>
                </a:ext>
              </a:extLst>
            </p:cNvPr>
            <p:cNvSpPr txBox="1"/>
            <p:nvPr/>
          </p:nvSpPr>
          <p:spPr>
            <a:xfrm rot="16200000">
              <a:off x="6807771" y="2878120"/>
              <a:ext cx="6719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 err="1">
                  <a:cs typeface="Arial" panose="020B0604020202020204" pitchFamily="34" charset="0"/>
                </a:rPr>
                <a:t>siSPDEF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127" name="テキスト ボックス 126">
              <a:extLst>
                <a:ext uri="{FF2B5EF4-FFF2-40B4-BE49-F238E27FC236}">
                  <a16:creationId xmlns="" xmlns:a16="http://schemas.microsoft.com/office/drawing/2014/main" id="{FAFFE1F2-672E-4447-BC6A-F16CC1C5C5A2}"/>
                </a:ext>
              </a:extLst>
            </p:cNvPr>
            <p:cNvSpPr txBox="1"/>
            <p:nvPr/>
          </p:nvSpPr>
          <p:spPr>
            <a:xfrm rot="16200000">
              <a:off x="5445580" y="1878723"/>
              <a:ext cx="13849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>
                  <a:cs typeface="Arial" panose="020B0604020202020204" pitchFamily="34" charset="0"/>
                </a:rPr>
                <a:t>Relative expression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129" name="テキスト ボックス 128">
              <a:extLst>
                <a:ext uri="{FF2B5EF4-FFF2-40B4-BE49-F238E27FC236}">
                  <a16:creationId xmlns="" xmlns:a16="http://schemas.microsoft.com/office/drawing/2014/main" id="{3F85A855-509F-924C-849D-A0629C03BFCE}"/>
                </a:ext>
              </a:extLst>
            </p:cNvPr>
            <p:cNvSpPr txBox="1"/>
            <p:nvPr/>
          </p:nvSpPr>
          <p:spPr>
            <a:xfrm rot="16200000">
              <a:off x="6492888" y="2861417"/>
              <a:ext cx="6385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 err="1">
                  <a:cs typeface="Arial" panose="020B0604020202020204" pitchFamily="34" charset="0"/>
                </a:rPr>
                <a:t>siCONT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graphicFrame>
          <p:nvGraphicFramePr>
            <p:cNvPr id="130" name="グラフ 129">
              <a:extLst>
                <a:ext uri="{FF2B5EF4-FFF2-40B4-BE49-F238E27FC236}">
                  <a16:creationId xmlns="" xmlns:a16="http://schemas.microsoft.com/office/drawing/2014/main" id="{2529D089-4113-8F46-92A6-1C598FDD7FC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52083491"/>
                </p:ext>
              </p:extLst>
            </p:nvPr>
          </p:nvGraphicFramePr>
          <p:xfrm>
            <a:off x="6291396" y="1211014"/>
            <a:ext cx="1152000" cy="16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131" name="テキスト ボックス 130">
              <a:extLst>
                <a:ext uri="{FF2B5EF4-FFF2-40B4-BE49-F238E27FC236}">
                  <a16:creationId xmlns="" xmlns:a16="http://schemas.microsoft.com/office/drawing/2014/main" id="{5138515E-97FA-8E4B-8F45-7B8283B474E6}"/>
                </a:ext>
              </a:extLst>
            </p:cNvPr>
            <p:cNvSpPr txBox="1"/>
            <p:nvPr/>
          </p:nvSpPr>
          <p:spPr>
            <a:xfrm>
              <a:off x="6941925" y="2368249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cs typeface="Arial" panose="020B0604020202020204" pitchFamily="34" charset="0"/>
                </a:rPr>
                <a:t>***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</p:grpSp>
      <p:sp>
        <p:nvSpPr>
          <p:cNvPr id="145" name="テキスト ボックス 144">
            <a:extLst>
              <a:ext uri="{FF2B5EF4-FFF2-40B4-BE49-F238E27FC236}">
                <a16:creationId xmlns="" xmlns:a16="http://schemas.microsoft.com/office/drawing/2014/main" id="{78027375-CA24-1847-B2F9-BBF53FF94F88}"/>
              </a:ext>
            </a:extLst>
          </p:cNvPr>
          <p:cNvSpPr txBox="1"/>
          <p:nvPr/>
        </p:nvSpPr>
        <p:spPr>
          <a:xfrm>
            <a:off x="3852060" y="8060492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cs typeface="Arial" panose="020B0604020202020204" pitchFamily="34" charset="0"/>
              </a:rPr>
              <a:t>*</a:t>
            </a:r>
            <a:endParaRPr kumimoji="1" lang="ja-JP" altLang="en-US" sz="1200" dirty="0">
              <a:cs typeface="Arial" panose="020B0604020202020204" pitchFamily="34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="" xmlns:a16="http://schemas.microsoft.com/office/drawing/2014/main" id="{E2676D77-A142-3A49-8A63-76EB19F4A22D}"/>
              </a:ext>
            </a:extLst>
          </p:cNvPr>
          <p:cNvSpPr txBox="1"/>
          <p:nvPr/>
        </p:nvSpPr>
        <p:spPr>
          <a:xfrm>
            <a:off x="5352903" y="7300044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cs typeface="Arial" panose="020B0604020202020204" pitchFamily="34" charset="0"/>
              </a:rPr>
              <a:t>ns</a:t>
            </a:r>
            <a:endParaRPr kumimoji="1" lang="ja-JP" altLang="en-US" sz="1200" dirty="0">
              <a:cs typeface="Arial" panose="020B0604020202020204" pitchFamily="34" charset="0"/>
            </a:endParaRPr>
          </a:p>
        </p:txBody>
      </p:sp>
      <p:graphicFrame>
        <p:nvGraphicFramePr>
          <p:cNvPr id="153" name="グラフ 152">
            <a:extLst>
              <a:ext uri="{FF2B5EF4-FFF2-40B4-BE49-F238E27FC236}">
                <a16:creationId xmlns="" xmlns:a16="http://schemas.microsoft.com/office/drawing/2014/main" id="{9ADB055C-ADDA-7C47-B688-DF108B8915F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8302815"/>
              </p:ext>
            </p:extLst>
          </p:nvPr>
        </p:nvGraphicFramePr>
        <p:xfrm>
          <a:off x="3131793" y="7251952"/>
          <a:ext cx="1152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58" name="グラフ 157">
            <a:extLst>
              <a:ext uri="{FF2B5EF4-FFF2-40B4-BE49-F238E27FC236}">
                <a16:creationId xmlns="" xmlns:a16="http://schemas.microsoft.com/office/drawing/2014/main" id="{4D8488DC-550A-054C-B736-000E611F0FA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5848093"/>
              </p:ext>
            </p:extLst>
          </p:nvPr>
        </p:nvGraphicFramePr>
        <p:xfrm>
          <a:off x="4663661" y="7239951"/>
          <a:ext cx="1152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pSp>
        <p:nvGrpSpPr>
          <p:cNvPr id="164" name="グループ化 145">
            <a:extLst>
              <a:ext uri="{FF2B5EF4-FFF2-40B4-BE49-F238E27FC236}">
                <a16:creationId xmlns="" xmlns:a16="http://schemas.microsoft.com/office/drawing/2014/main" id="{571D5A08-C676-B54C-8E07-D139E5497069}"/>
              </a:ext>
            </a:extLst>
          </p:cNvPr>
          <p:cNvGrpSpPr/>
          <p:nvPr/>
        </p:nvGrpSpPr>
        <p:grpSpPr>
          <a:xfrm>
            <a:off x="3523530" y="8693157"/>
            <a:ext cx="604662" cy="671979"/>
            <a:chOff x="2113094" y="9490918"/>
            <a:chExt cx="604662" cy="671979"/>
          </a:xfrm>
        </p:grpSpPr>
        <p:sp>
          <p:nvSpPr>
            <p:cNvPr id="186" name="テキスト ボックス 185">
              <a:extLst>
                <a:ext uri="{FF2B5EF4-FFF2-40B4-BE49-F238E27FC236}">
                  <a16:creationId xmlns="" xmlns:a16="http://schemas.microsoft.com/office/drawing/2014/main" id="{B9D42A03-9080-E14C-81CA-D07EA145ACAE}"/>
                </a:ext>
              </a:extLst>
            </p:cNvPr>
            <p:cNvSpPr txBox="1"/>
            <p:nvPr/>
          </p:nvSpPr>
          <p:spPr>
            <a:xfrm rot="16200000">
              <a:off x="2243267" y="9688408"/>
              <a:ext cx="6719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 err="1">
                  <a:cs typeface="Arial" panose="020B0604020202020204" pitchFamily="34" charset="0"/>
                </a:rPr>
                <a:t>siSPDEF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187" name="テキスト ボックス 186">
              <a:extLst>
                <a:ext uri="{FF2B5EF4-FFF2-40B4-BE49-F238E27FC236}">
                  <a16:creationId xmlns="" xmlns:a16="http://schemas.microsoft.com/office/drawing/2014/main" id="{07B1DEED-88D5-D74D-91B5-2F240F38FDA1}"/>
                </a:ext>
              </a:extLst>
            </p:cNvPr>
            <p:cNvSpPr txBox="1"/>
            <p:nvPr/>
          </p:nvSpPr>
          <p:spPr>
            <a:xfrm rot="16200000">
              <a:off x="1932307" y="9671705"/>
              <a:ext cx="6385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 err="1">
                  <a:cs typeface="Arial" panose="020B0604020202020204" pitchFamily="34" charset="0"/>
                </a:rPr>
                <a:t>siCONT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</p:grpSp>
      <p:grpSp>
        <p:nvGrpSpPr>
          <p:cNvPr id="169" name="グループ化 160">
            <a:extLst>
              <a:ext uri="{FF2B5EF4-FFF2-40B4-BE49-F238E27FC236}">
                <a16:creationId xmlns="" xmlns:a16="http://schemas.microsoft.com/office/drawing/2014/main" id="{6C02A509-895E-C143-A96B-7285B34907D9}"/>
              </a:ext>
            </a:extLst>
          </p:cNvPr>
          <p:cNvGrpSpPr/>
          <p:nvPr/>
        </p:nvGrpSpPr>
        <p:grpSpPr>
          <a:xfrm>
            <a:off x="5046145" y="8693157"/>
            <a:ext cx="604662" cy="671979"/>
            <a:chOff x="2113094" y="9502919"/>
            <a:chExt cx="604662" cy="671979"/>
          </a:xfrm>
        </p:grpSpPr>
        <p:sp>
          <p:nvSpPr>
            <p:cNvPr id="176" name="テキスト ボックス 175">
              <a:extLst>
                <a:ext uri="{FF2B5EF4-FFF2-40B4-BE49-F238E27FC236}">
                  <a16:creationId xmlns="" xmlns:a16="http://schemas.microsoft.com/office/drawing/2014/main" id="{54FC0D0C-4608-5E44-BE88-D074D0206815}"/>
                </a:ext>
              </a:extLst>
            </p:cNvPr>
            <p:cNvSpPr txBox="1"/>
            <p:nvPr/>
          </p:nvSpPr>
          <p:spPr>
            <a:xfrm rot="16200000">
              <a:off x="2243267" y="9700409"/>
              <a:ext cx="6719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 err="1">
                  <a:cs typeface="Arial" panose="020B0604020202020204" pitchFamily="34" charset="0"/>
                </a:rPr>
                <a:t>siSPDEF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  <p:sp>
          <p:nvSpPr>
            <p:cNvPr id="177" name="テキスト ボックス 176">
              <a:extLst>
                <a:ext uri="{FF2B5EF4-FFF2-40B4-BE49-F238E27FC236}">
                  <a16:creationId xmlns="" xmlns:a16="http://schemas.microsoft.com/office/drawing/2014/main" id="{DB6D0AA8-0535-604B-8C38-8AF39D0F42BA}"/>
                </a:ext>
              </a:extLst>
            </p:cNvPr>
            <p:cNvSpPr txBox="1"/>
            <p:nvPr/>
          </p:nvSpPr>
          <p:spPr>
            <a:xfrm rot="16200000">
              <a:off x="1932307" y="9683706"/>
              <a:ext cx="6385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200" dirty="0" err="1">
                  <a:cs typeface="Arial" panose="020B0604020202020204" pitchFamily="34" charset="0"/>
                </a:rPr>
                <a:t>siCONT</a:t>
              </a:r>
              <a:endParaRPr kumimoji="1" lang="ja-JP" altLang="en-US" sz="1200" dirty="0">
                <a:cs typeface="Arial" panose="020B0604020202020204" pitchFamily="34" charset="0"/>
              </a:endParaRPr>
            </a:p>
          </p:txBody>
        </p:sp>
      </p:grpSp>
      <p:sp>
        <p:nvSpPr>
          <p:cNvPr id="246" name="テキスト ボックス 245"/>
          <p:cNvSpPr txBox="1"/>
          <p:nvPr/>
        </p:nvSpPr>
        <p:spPr>
          <a:xfrm>
            <a:off x="3454065" y="6759625"/>
            <a:ext cx="590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ZEB2</a:t>
            </a:r>
            <a:endParaRPr kumimoji="1" lang="ja-JP" altLang="en-US" sz="1400" i="1" dirty="0"/>
          </a:p>
        </p:txBody>
      </p:sp>
      <p:sp>
        <p:nvSpPr>
          <p:cNvPr id="248" name="テキスト ボックス 247"/>
          <p:cNvSpPr txBox="1"/>
          <p:nvPr/>
        </p:nvSpPr>
        <p:spPr>
          <a:xfrm>
            <a:off x="4927004" y="6759625"/>
            <a:ext cx="7427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SNAIL2</a:t>
            </a:r>
            <a:endParaRPr kumimoji="1" lang="ja-JP" altLang="en-US" sz="1400" i="1" dirty="0"/>
          </a:p>
        </p:txBody>
      </p:sp>
      <p:sp>
        <p:nvSpPr>
          <p:cNvPr id="273" name="テキスト ボックス 272"/>
          <p:cNvSpPr txBox="1"/>
          <p:nvPr/>
        </p:nvSpPr>
        <p:spPr>
          <a:xfrm>
            <a:off x="5029744" y="6938582"/>
            <a:ext cx="5373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(</a:t>
            </a:r>
            <a:r>
              <a:rPr lang="en-US" altLang="ja-JP" sz="1200" dirty="0"/>
              <a:t>Slug</a:t>
            </a:r>
            <a:r>
              <a:rPr kumimoji="1" lang="en-US" altLang="ja-JP" sz="1200" dirty="0"/>
              <a:t>)</a:t>
            </a:r>
            <a:endParaRPr kumimoji="1" lang="ja-JP" altLang="en-US" sz="1200" dirty="0"/>
          </a:p>
        </p:txBody>
      </p:sp>
      <p:sp>
        <p:nvSpPr>
          <p:cNvPr id="274" name="テキスト ボックス 273">
            <a:extLst>
              <a:ext uri="{FF2B5EF4-FFF2-40B4-BE49-F238E27FC236}">
                <a16:creationId xmlns="" xmlns:a16="http://schemas.microsoft.com/office/drawing/2014/main" id="{2B9F8A85-FDF2-2B43-B439-EDEF35A4C59C}"/>
              </a:ext>
            </a:extLst>
          </p:cNvPr>
          <p:cNvSpPr txBox="1"/>
          <p:nvPr/>
        </p:nvSpPr>
        <p:spPr>
          <a:xfrm>
            <a:off x="1172443" y="6809480"/>
            <a:ext cx="1027430" cy="3077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kumimoji="1" lang="en-US" altLang="ja-JP" sz="1400" i="1" dirty="0"/>
              <a:t>SPDEF</a:t>
            </a:r>
            <a:endParaRPr kumimoji="1" lang="ja-JP" altLang="en-US" sz="1400" i="1" dirty="0"/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258088" y="6323795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5" name="正方形/長方形 4"/>
          <p:cNvSpPr/>
          <p:nvPr/>
        </p:nvSpPr>
        <p:spPr>
          <a:xfrm>
            <a:off x="2896586" y="6624570"/>
            <a:ext cx="3376171" cy="3160511"/>
          </a:xfrm>
          <a:prstGeom prst="rect">
            <a:avLst/>
          </a:prstGeom>
          <a:noFill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右矢印 18"/>
          <p:cNvSpPr/>
          <p:nvPr/>
        </p:nvSpPr>
        <p:spPr>
          <a:xfrm>
            <a:off x="2355315" y="7896324"/>
            <a:ext cx="330940" cy="484868"/>
          </a:xfrm>
          <a:prstGeom prst="right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50" name="グループ化 49">
            <a:extLst>
              <a:ext uri="{FF2B5EF4-FFF2-40B4-BE49-F238E27FC236}">
                <a16:creationId xmlns="" xmlns:a16="http://schemas.microsoft.com/office/drawing/2014/main" id="{BCCC4B10-2DA8-7149-B12D-536E5EC3BACE}"/>
              </a:ext>
            </a:extLst>
          </p:cNvPr>
          <p:cNvGrpSpPr/>
          <p:nvPr/>
        </p:nvGrpSpPr>
        <p:grpSpPr>
          <a:xfrm>
            <a:off x="4353894" y="2697279"/>
            <a:ext cx="1812212" cy="2919794"/>
            <a:chOff x="4353894" y="2697279"/>
            <a:chExt cx="1812212" cy="2919794"/>
          </a:xfrm>
        </p:grpSpPr>
        <p:sp>
          <p:nvSpPr>
            <p:cNvPr id="149" name="テキスト ボックス 148">
              <a:extLst>
                <a:ext uri="{FF2B5EF4-FFF2-40B4-BE49-F238E27FC236}">
                  <a16:creationId xmlns="" xmlns:a16="http://schemas.microsoft.com/office/drawing/2014/main" id="{6DE9418F-F810-BF4D-99E0-BC7126AEA613}"/>
                </a:ext>
              </a:extLst>
            </p:cNvPr>
            <p:cNvSpPr txBox="1"/>
            <p:nvPr/>
          </p:nvSpPr>
          <p:spPr>
            <a:xfrm>
              <a:off x="4555994" y="4778986"/>
              <a:ext cx="5373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/>
                <a:t>(</a:t>
              </a:r>
              <a:r>
                <a:rPr lang="en-US" altLang="ja-JP" sz="1200" dirty="0"/>
                <a:t>Slug</a:t>
              </a:r>
              <a:r>
                <a:rPr kumimoji="1" lang="en-US" altLang="ja-JP" sz="1200" dirty="0"/>
                <a:t>)</a:t>
              </a:r>
              <a:endParaRPr kumimoji="1" lang="ja-JP" altLang="en-US" sz="1200" dirty="0"/>
            </a:p>
          </p:txBody>
        </p:sp>
        <p:grpSp>
          <p:nvGrpSpPr>
            <p:cNvPr id="39" name="グループ化 38">
              <a:extLst>
                <a:ext uri="{FF2B5EF4-FFF2-40B4-BE49-F238E27FC236}">
                  <a16:creationId xmlns="" xmlns:a16="http://schemas.microsoft.com/office/drawing/2014/main" id="{DBEF6863-9C3E-8244-B44A-B75D9A22C2C3}"/>
                </a:ext>
              </a:extLst>
            </p:cNvPr>
            <p:cNvGrpSpPr/>
            <p:nvPr/>
          </p:nvGrpSpPr>
          <p:grpSpPr>
            <a:xfrm>
              <a:off x="4564529" y="3278587"/>
              <a:ext cx="1597654" cy="514549"/>
              <a:chOff x="1129943" y="6436672"/>
              <a:chExt cx="1597654" cy="514549"/>
            </a:xfrm>
          </p:grpSpPr>
          <p:pic>
            <p:nvPicPr>
              <p:cNvPr id="35" name="図 34">
                <a:extLst>
                  <a:ext uri="{FF2B5EF4-FFF2-40B4-BE49-F238E27FC236}">
                    <a16:creationId xmlns="" xmlns:a16="http://schemas.microsoft.com/office/drawing/2014/main" id="{95C719A7-3688-A34F-8C5A-3D357C80478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>
                <a:grayscl/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bright="20000"/>
                        </a14:imgEffect>
                      </a14:imgLayer>
                    </a14:imgProps>
                  </a:ext>
                </a:extLst>
              </a:blip>
              <a:srcRect l="10703" t="43228" r="24249" b="28830"/>
              <a:stretch/>
            </p:blipFill>
            <p:spPr>
              <a:xfrm>
                <a:off x="1719737" y="6436672"/>
                <a:ext cx="1007860" cy="514549"/>
              </a:xfrm>
              <a:prstGeom prst="rect">
                <a:avLst/>
              </a:prstGeom>
              <a:ln w="6350" cap="sq">
                <a:solidFill>
                  <a:schemeClr val="tx1"/>
                </a:solidFill>
                <a:miter lim="800000"/>
              </a:ln>
            </p:spPr>
          </p:pic>
          <p:sp>
            <p:nvSpPr>
              <p:cNvPr id="147" name="テキスト ボックス 146">
                <a:extLst>
                  <a:ext uri="{FF2B5EF4-FFF2-40B4-BE49-F238E27FC236}">
                    <a16:creationId xmlns="" xmlns:a16="http://schemas.microsoft.com/office/drawing/2014/main" id="{AFF4B10B-A2F7-3B46-8A61-803A16B1CD53}"/>
                  </a:ext>
                </a:extLst>
              </p:cNvPr>
              <p:cNvSpPr txBox="1"/>
              <p:nvPr/>
            </p:nvSpPr>
            <p:spPr>
              <a:xfrm>
                <a:off x="1129943" y="6540058"/>
                <a:ext cx="54534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ZEB2</a:t>
                </a:r>
                <a:endParaRPr kumimoji="1" lang="ja-JP" altLang="en-US" sz="1400" dirty="0"/>
              </a:p>
            </p:txBody>
          </p:sp>
        </p:grpSp>
        <p:grpSp>
          <p:nvGrpSpPr>
            <p:cNvPr id="43" name="グループ化 42">
              <a:extLst>
                <a:ext uri="{FF2B5EF4-FFF2-40B4-BE49-F238E27FC236}">
                  <a16:creationId xmlns="" xmlns:a16="http://schemas.microsoft.com/office/drawing/2014/main" id="{54BE9407-8EB9-4144-85EE-8A948ECAE961}"/>
                </a:ext>
              </a:extLst>
            </p:cNvPr>
            <p:cNvGrpSpPr/>
            <p:nvPr/>
          </p:nvGrpSpPr>
          <p:grpSpPr>
            <a:xfrm>
              <a:off x="4389870" y="4496373"/>
              <a:ext cx="1776236" cy="511038"/>
              <a:chOff x="955284" y="7767137"/>
              <a:chExt cx="1776236" cy="511038"/>
            </a:xfrm>
          </p:grpSpPr>
          <p:pic>
            <p:nvPicPr>
              <p:cNvPr id="17" name="図 16">
                <a:extLst>
                  <a:ext uri="{FF2B5EF4-FFF2-40B4-BE49-F238E27FC236}">
                    <a16:creationId xmlns="" xmlns:a16="http://schemas.microsoft.com/office/drawing/2014/main" id="{7A078F66-A308-784E-935B-1314AA638AC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grayscl/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20000"/>
                        </a14:imgEffect>
                      </a14:imgLayer>
                    </a14:imgProps>
                  </a:ext>
                </a:extLst>
              </a:blip>
              <a:srcRect l="12720" t="63074" r="15507" b="12685"/>
              <a:stretch/>
            </p:blipFill>
            <p:spPr>
              <a:xfrm>
                <a:off x="1719736" y="7767137"/>
                <a:ext cx="1011784" cy="511038"/>
              </a:xfrm>
              <a:prstGeom prst="rect">
                <a:avLst/>
              </a:prstGeom>
              <a:ln w="6350" cap="sq">
                <a:solidFill>
                  <a:schemeClr val="tx1"/>
                </a:solidFill>
                <a:miter lim="800000"/>
              </a:ln>
            </p:spPr>
          </p:pic>
          <p:sp>
            <p:nvSpPr>
              <p:cNvPr id="148" name="テキスト ボックス 147">
                <a:extLst>
                  <a:ext uri="{FF2B5EF4-FFF2-40B4-BE49-F238E27FC236}">
                    <a16:creationId xmlns="" xmlns:a16="http://schemas.microsoft.com/office/drawing/2014/main" id="{6E070CFA-CCB4-C347-8A1E-467E5CFBF14F}"/>
                  </a:ext>
                </a:extLst>
              </p:cNvPr>
              <p:cNvSpPr txBox="1"/>
              <p:nvPr/>
            </p:nvSpPr>
            <p:spPr>
              <a:xfrm>
                <a:off x="955284" y="7868768"/>
                <a:ext cx="72000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SNAIL2</a:t>
                </a:r>
                <a:endParaRPr kumimoji="1" lang="ja-JP" altLang="en-US" sz="1400" dirty="0"/>
              </a:p>
            </p:txBody>
          </p:sp>
        </p:grpSp>
        <p:grpSp>
          <p:nvGrpSpPr>
            <p:cNvPr id="37" name="グループ化 36">
              <a:extLst>
                <a:ext uri="{FF2B5EF4-FFF2-40B4-BE49-F238E27FC236}">
                  <a16:creationId xmlns="" xmlns:a16="http://schemas.microsoft.com/office/drawing/2014/main" id="{DF370B8B-3D30-E24C-9924-FFCDD75A1727}"/>
                </a:ext>
              </a:extLst>
            </p:cNvPr>
            <p:cNvGrpSpPr/>
            <p:nvPr/>
          </p:nvGrpSpPr>
          <p:grpSpPr>
            <a:xfrm>
              <a:off x="4389870" y="2697279"/>
              <a:ext cx="1772312" cy="486964"/>
              <a:chOff x="955284" y="5901169"/>
              <a:chExt cx="1772312" cy="486964"/>
            </a:xfrm>
          </p:grpSpPr>
          <p:pic>
            <p:nvPicPr>
              <p:cNvPr id="33" name="図 32">
                <a:extLst>
                  <a:ext uri="{FF2B5EF4-FFF2-40B4-BE49-F238E27FC236}">
                    <a16:creationId xmlns="" xmlns:a16="http://schemas.microsoft.com/office/drawing/2014/main" id="{51BB1034-E69E-2A4C-B958-667B136F243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>
                <a:grayscl/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rightnessContrast bright="20000"/>
                        </a14:imgEffect>
                      </a14:imgLayer>
                    </a14:imgProps>
                  </a:ext>
                </a:extLst>
              </a:blip>
              <a:srcRect l="5285" t="64421" r="34135" b="4150"/>
              <a:stretch/>
            </p:blipFill>
            <p:spPr>
              <a:xfrm>
                <a:off x="1719737" y="5901169"/>
                <a:ext cx="1007859" cy="486964"/>
              </a:xfrm>
              <a:prstGeom prst="rect">
                <a:avLst/>
              </a:prstGeom>
              <a:ln w="6350" cap="sq">
                <a:solidFill>
                  <a:schemeClr val="tx1"/>
                </a:solidFill>
                <a:miter lim="800000"/>
              </a:ln>
            </p:spPr>
          </p:pic>
          <p:sp>
            <p:nvSpPr>
              <p:cNvPr id="151" name="テキスト ボックス 150">
                <a:extLst>
                  <a:ext uri="{FF2B5EF4-FFF2-40B4-BE49-F238E27FC236}">
                    <a16:creationId xmlns="" xmlns:a16="http://schemas.microsoft.com/office/drawing/2014/main" id="{4CDAF99E-7AF1-7F45-9DE8-AA70BBFB4E47}"/>
                  </a:ext>
                </a:extLst>
              </p:cNvPr>
              <p:cNvSpPr txBox="1"/>
              <p:nvPr/>
            </p:nvSpPr>
            <p:spPr>
              <a:xfrm>
                <a:off x="955284" y="5990763"/>
                <a:ext cx="720000" cy="307777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kumimoji="1" lang="en-US" altLang="ja-JP" sz="1400" dirty="0"/>
                  <a:t>ZEB1</a:t>
                </a:r>
                <a:endParaRPr kumimoji="1" lang="ja-JP" altLang="en-US" sz="1400" dirty="0"/>
              </a:p>
            </p:txBody>
          </p:sp>
        </p:grpSp>
        <p:grpSp>
          <p:nvGrpSpPr>
            <p:cNvPr id="40" name="グループ化 39">
              <a:extLst>
                <a:ext uri="{FF2B5EF4-FFF2-40B4-BE49-F238E27FC236}">
                  <a16:creationId xmlns="" xmlns:a16="http://schemas.microsoft.com/office/drawing/2014/main" id="{C8C54F7E-EE22-034A-97C6-2B7D736CE613}"/>
                </a:ext>
              </a:extLst>
            </p:cNvPr>
            <p:cNvGrpSpPr/>
            <p:nvPr/>
          </p:nvGrpSpPr>
          <p:grpSpPr>
            <a:xfrm>
              <a:off x="4389870" y="3887480"/>
              <a:ext cx="1768388" cy="514549"/>
              <a:chOff x="955284" y="7034803"/>
              <a:chExt cx="1768388" cy="514549"/>
            </a:xfrm>
          </p:grpSpPr>
          <p:pic>
            <p:nvPicPr>
              <p:cNvPr id="15" name="図 14">
                <a:extLst>
                  <a:ext uri="{FF2B5EF4-FFF2-40B4-BE49-F238E27FC236}">
                    <a16:creationId xmlns="" xmlns:a16="http://schemas.microsoft.com/office/drawing/2014/main" id="{CB6BBDD3-F9A7-6F49-B85E-FCD85B6286E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>
                <a:grayscl/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brightnessContrast bright="20000"/>
                        </a14:imgEffect>
                      </a14:imgLayer>
                    </a14:imgProps>
                  </a:ext>
                </a:extLst>
              </a:blip>
              <a:srcRect l="7342" t="45172" r="35973" b="24816"/>
              <a:stretch/>
            </p:blipFill>
            <p:spPr>
              <a:xfrm>
                <a:off x="1715812" y="7034803"/>
                <a:ext cx="1007860" cy="514549"/>
              </a:xfrm>
              <a:prstGeom prst="rect">
                <a:avLst/>
              </a:prstGeom>
              <a:ln w="6350" cap="sq">
                <a:solidFill>
                  <a:schemeClr val="tx1"/>
                </a:solidFill>
                <a:miter lim="800000"/>
              </a:ln>
            </p:spPr>
          </p:pic>
          <p:sp>
            <p:nvSpPr>
              <p:cNvPr id="152" name="テキスト ボックス 151">
                <a:extLst>
                  <a:ext uri="{FF2B5EF4-FFF2-40B4-BE49-F238E27FC236}">
                    <a16:creationId xmlns="" xmlns:a16="http://schemas.microsoft.com/office/drawing/2014/main" id="{C68012F2-6448-E741-869A-122EDB6ECA21}"/>
                  </a:ext>
                </a:extLst>
              </p:cNvPr>
              <p:cNvSpPr txBox="1"/>
              <p:nvPr/>
            </p:nvSpPr>
            <p:spPr>
              <a:xfrm>
                <a:off x="955284" y="7138189"/>
                <a:ext cx="72000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SNAIL1</a:t>
                </a:r>
                <a:endParaRPr kumimoji="1" lang="ja-JP" altLang="en-US" sz="1400" dirty="0"/>
              </a:p>
            </p:txBody>
          </p:sp>
        </p:grpSp>
        <p:grpSp>
          <p:nvGrpSpPr>
            <p:cNvPr id="36" name="グループ化 35">
              <a:extLst>
                <a:ext uri="{FF2B5EF4-FFF2-40B4-BE49-F238E27FC236}">
                  <a16:creationId xmlns="" xmlns:a16="http://schemas.microsoft.com/office/drawing/2014/main" id="{99B222E8-003C-D74D-82C6-15E5D10CC2D6}"/>
                </a:ext>
              </a:extLst>
            </p:cNvPr>
            <p:cNvGrpSpPr/>
            <p:nvPr/>
          </p:nvGrpSpPr>
          <p:grpSpPr>
            <a:xfrm>
              <a:off x="4353894" y="5086257"/>
              <a:ext cx="1808288" cy="530816"/>
              <a:chOff x="919308" y="5337098"/>
              <a:chExt cx="1808288" cy="530816"/>
            </a:xfrm>
          </p:grpSpPr>
          <p:pic>
            <p:nvPicPr>
              <p:cNvPr id="10" name="図 9">
                <a:extLst>
                  <a:ext uri="{FF2B5EF4-FFF2-40B4-BE49-F238E27FC236}">
                    <a16:creationId xmlns="" xmlns:a16="http://schemas.microsoft.com/office/drawing/2014/main" id="{A6FF9084-E9F1-8644-8497-C4EF069F021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/>
              <a:srcRect l="6452" t="55722" r="9124" b="5635"/>
              <a:stretch/>
            </p:blipFill>
            <p:spPr>
              <a:xfrm>
                <a:off x="1719737" y="5352595"/>
                <a:ext cx="1007859" cy="515319"/>
              </a:xfrm>
              <a:prstGeom prst="rect">
                <a:avLst/>
              </a:prstGeom>
              <a:ln w="6350" cap="sq">
                <a:solidFill>
                  <a:schemeClr val="tx1"/>
                </a:solidFill>
                <a:miter lim="800000"/>
              </a:ln>
            </p:spPr>
          </p:pic>
          <p:sp>
            <p:nvSpPr>
              <p:cNvPr id="154" name="テキスト ボックス 153">
                <a:extLst>
                  <a:ext uri="{FF2B5EF4-FFF2-40B4-BE49-F238E27FC236}">
                    <a16:creationId xmlns="" xmlns:a16="http://schemas.microsoft.com/office/drawing/2014/main" id="{1683CA90-ADF4-D841-9374-1CFCEC9A6187}"/>
                  </a:ext>
                </a:extLst>
              </p:cNvPr>
              <p:cNvSpPr txBox="1"/>
              <p:nvPr/>
            </p:nvSpPr>
            <p:spPr>
              <a:xfrm>
                <a:off x="919308" y="5337098"/>
                <a:ext cx="755976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1400" dirty="0"/>
                  <a:t>CBB</a:t>
                </a:r>
              </a:p>
              <a:p>
                <a:pPr algn="r"/>
                <a:r>
                  <a:rPr kumimoji="1" lang="en-US" altLang="ja-JP" sz="1400" dirty="0"/>
                  <a:t>staining</a:t>
                </a:r>
                <a:endParaRPr kumimoji="1" lang="ja-JP" altLang="en-US" sz="1400" dirty="0"/>
              </a:p>
            </p:txBody>
          </p:sp>
        </p:grpSp>
      </p:grpSp>
      <p:pic>
        <p:nvPicPr>
          <p:cNvPr id="28" name="グラフィックス 27" descr="線矢印: 時計回りの曲線">
            <a:extLst>
              <a:ext uri="{FF2B5EF4-FFF2-40B4-BE49-F238E27FC236}">
                <a16:creationId xmlns="" xmlns:a16="http://schemas.microsoft.com/office/drawing/2014/main" id="{982BE003-5C0D-0C46-B028-BED79A4673C1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96DAC541-7B7A-43D3-8B79-37D633B846F1}">
                <asvg:svgBlip xmlns="" xmlns:asvg="http://schemas.microsoft.com/office/drawing/2016/SVG/main" r:embed="rId23"/>
              </a:ext>
            </a:extLst>
          </a:blip>
          <a:stretch>
            <a:fillRect/>
          </a:stretch>
        </p:blipFill>
        <p:spPr>
          <a:xfrm rot="9111412" flipH="1">
            <a:off x="637920" y="3047065"/>
            <a:ext cx="773094" cy="1031560"/>
          </a:xfrm>
          <a:prstGeom prst="rect">
            <a:avLst/>
          </a:prstGeom>
        </p:spPr>
      </p:pic>
      <p:pic>
        <p:nvPicPr>
          <p:cNvPr id="167" name="グラフィックス 166" descr="線矢印: 時計回りの曲線">
            <a:extLst>
              <a:ext uri="{FF2B5EF4-FFF2-40B4-BE49-F238E27FC236}">
                <a16:creationId xmlns="" xmlns:a16="http://schemas.microsoft.com/office/drawing/2014/main" id="{58BB8CDE-0DF4-1942-B8DF-188C34DC0D0C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96DAC541-7B7A-43D3-8B79-37D633B846F1}">
                <asvg:svgBlip xmlns="" xmlns:asvg="http://schemas.microsoft.com/office/drawing/2016/SVG/main" r:embed="rId23"/>
              </a:ext>
            </a:extLst>
          </a:blip>
          <a:stretch>
            <a:fillRect/>
          </a:stretch>
        </p:blipFill>
        <p:spPr>
          <a:xfrm rot="9111412" flipH="1">
            <a:off x="2309820" y="3047065"/>
            <a:ext cx="773094" cy="1031560"/>
          </a:xfrm>
          <a:prstGeom prst="rect">
            <a:avLst/>
          </a:prstGeom>
        </p:spPr>
      </p:pic>
      <p:sp>
        <p:nvSpPr>
          <p:cNvPr id="178" name="テキスト ボックス 177">
            <a:extLst>
              <a:ext uri="{FF2B5EF4-FFF2-40B4-BE49-F238E27FC236}">
                <a16:creationId xmlns="" xmlns:a16="http://schemas.microsoft.com/office/drawing/2014/main" id="{06522CD1-A1EF-1E45-B099-5226440C66F8}"/>
              </a:ext>
            </a:extLst>
          </p:cNvPr>
          <p:cNvSpPr txBox="1"/>
          <p:nvPr/>
        </p:nvSpPr>
        <p:spPr>
          <a:xfrm rot="16200000">
            <a:off x="5100115" y="2287115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GFP</a:t>
            </a:r>
            <a:endParaRPr kumimoji="1" lang="ja-JP" altLang="en-US" sz="1400" dirty="0"/>
          </a:p>
        </p:txBody>
      </p:sp>
      <p:sp>
        <p:nvSpPr>
          <p:cNvPr id="179" name="テキスト ボックス 178">
            <a:extLst>
              <a:ext uri="{FF2B5EF4-FFF2-40B4-BE49-F238E27FC236}">
                <a16:creationId xmlns="" xmlns:a16="http://schemas.microsoft.com/office/drawing/2014/main" id="{362DC7FB-7D6B-F34D-B22B-27B72646F925}"/>
              </a:ext>
            </a:extLst>
          </p:cNvPr>
          <p:cNvSpPr txBox="1"/>
          <p:nvPr/>
        </p:nvSpPr>
        <p:spPr>
          <a:xfrm rot="16200000">
            <a:off x="5387625" y="2247841"/>
            <a:ext cx="5517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AS#3</a:t>
            </a:r>
            <a:endParaRPr kumimoji="1" lang="ja-JP" altLang="en-US" sz="1400" dirty="0"/>
          </a:p>
        </p:txBody>
      </p:sp>
      <p:sp>
        <p:nvSpPr>
          <p:cNvPr id="180" name="テキスト ボックス 179">
            <a:extLst>
              <a:ext uri="{FF2B5EF4-FFF2-40B4-BE49-F238E27FC236}">
                <a16:creationId xmlns="" xmlns:a16="http://schemas.microsoft.com/office/drawing/2014/main" id="{73738DCA-768F-5547-B032-83F4F5DC71AC}"/>
              </a:ext>
            </a:extLst>
          </p:cNvPr>
          <p:cNvSpPr txBox="1"/>
          <p:nvPr/>
        </p:nvSpPr>
        <p:spPr>
          <a:xfrm rot="16200000">
            <a:off x="5756760" y="2290193"/>
            <a:ext cx="4670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BSA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40854498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 テーマ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 テーマ">
    <a:majorFont>
      <a:latin typeface="Calibri Light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 テーマ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00</TotalTime>
  <Words>785</Words>
  <Application>Microsoft Macintosh PowerPoint</Application>
  <PresentationFormat>ユーザー設定</PresentationFormat>
  <Paragraphs>515</Paragraphs>
  <Slides>9</Slides>
  <Notes>2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9</vt:i4>
      </vt:variant>
    </vt:vector>
  </HeadingPairs>
  <TitlesOfParts>
    <vt:vector size="10" baseType="lpstr"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友信 奈保子</dc:creator>
  <cp:lastModifiedBy>阪口 政清</cp:lastModifiedBy>
  <cp:revision>128</cp:revision>
  <dcterms:created xsi:type="dcterms:W3CDTF">2020-01-15T04:42:11Z</dcterms:created>
  <dcterms:modified xsi:type="dcterms:W3CDTF">2020-03-23T06:04:13Z</dcterms:modified>
</cp:coreProperties>
</file>